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5897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4E1FF"/>
    <a:srgbClr val="FF7E79"/>
    <a:srgbClr val="0096FF"/>
    <a:srgbClr val="0432FF"/>
    <a:srgbClr val="008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6"/>
    <p:restoredTop sz="96197"/>
  </p:normalViewPr>
  <p:slideViewPr>
    <p:cSldViewPr snapToGrid="0" snapToObjects="1">
      <p:cViewPr varScale="1">
        <p:scale>
          <a:sx n="81" d="100"/>
          <a:sy n="81" d="100"/>
        </p:scale>
        <p:origin x="279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\jobburt\Library\Containers\com.apple.mail\Data\Library\Mail%20Downloads\9C5363A1-A477-415C-9397-82D5944A7F55\VW%20window%20for%20fast%20SWATH%20v1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727574903264291"/>
          <c:y val="7.4137449530757821E-2"/>
          <c:w val="0.40272102644364349"/>
          <c:h val="0.59461416061396588"/>
        </c:manualLayout>
      </c:layout>
      <c:scatterChart>
        <c:scatterStyle val="lineMarker"/>
        <c:varyColors val="0"/>
        <c:ser>
          <c:idx val="0"/>
          <c:order val="0"/>
          <c:tx>
            <c:v>Protein Density</c:v>
          </c:tx>
          <c:marker>
            <c:symbol val="none"/>
          </c:marker>
          <c:xVal>
            <c:numRef>
              <c:f>'VW_40 Cell micro'!$M$3:$M$2002</c:f>
              <c:numCache>
                <c:formatCode>General</c:formatCode>
                <c:ptCount val="2000"/>
                <c:pt idx="0">
                  <c:v>400.27499999999998</c:v>
                </c:pt>
                <c:pt idx="1">
                  <c:v>400.82500000000005</c:v>
                </c:pt>
                <c:pt idx="2">
                  <c:v>401.375</c:v>
                </c:pt>
                <c:pt idx="3">
                  <c:v>401.92500000000007</c:v>
                </c:pt>
                <c:pt idx="4">
                  <c:v>402.47500000000002</c:v>
                </c:pt>
                <c:pt idx="5">
                  <c:v>403.02500000000009</c:v>
                </c:pt>
                <c:pt idx="6">
                  <c:v>403.57500000000005</c:v>
                </c:pt>
                <c:pt idx="7">
                  <c:v>404.12500000000011</c:v>
                </c:pt>
                <c:pt idx="8">
                  <c:v>404.67500000000007</c:v>
                </c:pt>
                <c:pt idx="9">
                  <c:v>405.22500000000014</c:v>
                </c:pt>
                <c:pt idx="10">
                  <c:v>405.77500000000009</c:v>
                </c:pt>
                <c:pt idx="11">
                  <c:v>406.32500000000016</c:v>
                </c:pt>
                <c:pt idx="12">
                  <c:v>406.87500000000011</c:v>
                </c:pt>
                <c:pt idx="13">
                  <c:v>407.42500000000018</c:v>
                </c:pt>
                <c:pt idx="14">
                  <c:v>407.97500000000014</c:v>
                </c:pt>
                <c:pt idx="15">
                  <c:v>408.5250000000002</c:v>
                </c:pt>
                <c:pt idx="16">
                  <c:v>409.07500000000016</c:v>
                </c:pt>
                <c:pt idx="17">
                  <c:v>409.62500000000023</c:v>
                </c:pt>
                <c:pt idx="18">
                  <c:v>410.17500000000018</c:v>
                </c:pt>
                <c:pt idx="19">
                  <c:v>410.72500000000025</c:v>
                </c:pt>
                <c:pt idx="20">
                  <c:v>411.2750000000002</c:v>
                </c:pt>
                <c:pt idx="21">
                  <c:v>411.82500000000027</c:v>
                </c:pt>
                <c:pt idx="22">
                  <c:v>412.37500000000023</c:v>
                </c:pt>
                <c:pt idx="23">
                  <c:v>412.9250000000003</c:v>
                </c:pt>
                <c:pt idx="24">
                  <c:v>413.47500000000025</c:v>
                </c:pt>
                <c:pt idx="25">
                  <c:v>414.02500000000032</c:v>
                </c:pt>
                <c:pt idx="26">
                  <c:v>414.57500000000027</c:v>
                </c:pt>
                <c:pt idx="27">
                  <c:v>415.12500000000034</c:v>
                </c:pt>
                <c:pt idx="28">
                  <c:v>415.6750000000003</c:v>
                </c:pt>
                <c:pt idx="29">
                  <c:v>416.22500000000036</c:v>
                </c:pt>
                <c:pt idx="30">
                  <c:v>416.77500000000032</c:v>
                </c:pt>
                <c:pt idx="31">
                  <c:v>417.32500000000039</c:v>
                </c:pt>
                <c:pt idx="32">
                  <c:v>417.87500000000034</c:v>
                </c:pt>
                <c:pt idx="33">
                  <c:v>418.42500000000041</c:v>
                </c:pt>
                <c:pt idx="34">
                  <c:v>418.97500000000036</c:v>
                </c:pt>
                <c:pt idx="35">
                  <c:v>419.52500000000043</c:v>
                </c:pt>
                <c:pt idx="36">
                  <c:v>420.07500000000039</c:v>
                </c:pt>
                <c:pt idx="37">
                  <c:v>420.62500000000045</c:v>
                </c:pt>
                <c:pt idx="38">
                  <c:v>421.17500000000041</c:v>
                </c:pt>
                <c:pt idx="39">
                  <c:v>421.72500000000048</c:v>
                </c:pt>
                <c:pt idx="40">
                  <c:v>422.27500000000043</c:v>
                </c:pt>
                <c:pt idx="41">
                  <c:v>422.8250000000005</c:v>
                </c:pt>
                <c:pt idx="42">
                  <c:v>423.37500000000045</c:v>
                </c:pt>
                <c:pt idx="43">
                  <c:v>423.92500000000052</c:v>
                </c:pt>
                <c:pt idx="44">
                  <c:v>424.47500000000048</c:v>
                </c:pt>
                <c:pt idx="45">
                  <c:v>425.02500000000055</c:v>
                </c:pt>
                <c:pt idx="46">
                  <c:v>425.5750000000005</c:v>
                </c:pt>
                <c:pt idx="47">
                  <c:v>426.12500000000057</c:v>
                </c:pt>
                <c:pt idx="48">
                  <c:v>426.67500000000052</c:v>
                </c:pt>
                <c:pt idx="49">
                  <c:v>427.22500000000059</c:v>
                </c:pt>
                <c:pt idx="50">
                  <c:v>427.77500000000055</c:v>
                </c:pt>
                <c:pt idx="51">
                  <c:v>428.32500000000061</c:v>
                </c:pt>
                <c:pt idx="52">
                  <c:v>428.87500000000057</c:v>
                </c:pt>
                <c:pt idx="53">
                  <c:v>429.42500000000064</c:v>
                </c:pt>
                <c:pt idx="54">
                  <c:v>429.97500000000059</c:v>
                </c:pt>
                <c:pt idx="55">
                  <c:v>430.52500000000066</c:v>
                </c:pt>
                <c:pt idx="56">
                  <c:v>431.07500000000061</c:v>
                </c:pt>
                <c:pt idx="57">
                  <c:v>431.62500000000068</c:v>
                </c:pt>
                <c:pt idx="58">
                  <c:v>432.17500000000064</c:v>
                </c:pt>
                <c:pt idx="59">
                  <c:v>432.7250000000007</c:v>
                </c:pt>
                <c:pt idx="60">
                  <c:v>433.27500000000066</c:v>
                </c:pt>
                <c:pt idx="61">
                  <c:v>433.82500000000073</c:v>
                </c:pt>
                <c:pt idx="62">
                  <c:v>434.37500000000068</c:v>
                </c:pt>
                <c:pt idx="63">
                  <c:v>434.92500000000075</c:v>
                </c:pt>
                <c:pt idx="64">
                  <c:v>435.4750000000007</c:v>
                </c:pt>
                <c:pt idx="65">
                  <c:v>436.02500000000077</c:v>
                </c:pt>
                <c:pt idx="66">
                  <c:v>436.57500000000073</c:v>
                </c:pt>
                <c:pt idx="67">
                  <c:v>437.1250000000008</c:v>
                </c:pt>
                <c:pt idx="68">
                  <c:v>437.67500000000075</c:v>
                </c:pt>
                <c:pt idx="69">
                  <c:v>438.22500000000082</c:v>
                </c:pt>
                <c:pt idx="70">
                  <c:v>438.77500000000077</c:v>
                </c:pt>
                <c:pt idx="71">
                  <c:v>439.32500000000084</c:v>
                </c:pt>
                <c:pt idx="72">
                  <c:v>439.8750000000008</c:v>
                </c:pt>
                <c:pt idx="73">
                  <c:v>440.42500000000086</c:v>
                </c:pt>
                <c:pt idx="74">
                  <c:v>440.97500000000082</c:v>
                </c:pt>
                <c:pt idx="75">
                  <c:v>441.52500000000089</c:v>
                </c:pt>
                <c:pt idx="76">
                  <c:v>442.07500000000084</c:v>
                </c:pt>
                <c:pt idx="77">
                  <c:v>442.62500000000091</c:v>
                </c:pt>
                <c:pt idx="78">
                  <c:v>443.17500000000086</c:v>
                </c:pt>
                <c:pt idx="79">
                  <c:v>443.72500000000093</c:v>
                </c:pt>
                <c:pt idx="80">
                  <c:v>444.27500000000089</c:v>
                </c:pt>
                <c:pt idx="81">
                  <c:v>444.82500000000095</c:v>
                </c:pt>
                <c:pt idx="82">
                  <c:v>445.37500000000091</c:v>
                </c:pt>
                <c:pt idx="83">
                  <c:v>445.92500000000098</c:v>
                </c:pt>
                <c:pt idx="84">
                  <c:v>446.47500000000093</c:v>
                </c:pt>
                <c:pt idx="85">
                  <c:v>447.025000000001</c:v>
                </c:pt>
                <c:pt idx="86">
                  <c:v>447.57500000000095</c:v>
                </c:pt>
                <c:pt idx="87">
                  <c:v>448.12500000000102</c:v>
                </c:pt>
                <c:pt idx="88">
                  <c:v>448.67500000000098</c:v>
                </c:pt>
                <c:pt idx="89">
                  <c:v>449.22500000000105</c:v>
                </c:pt>
                <c:pt idx="90">
                  <c:v>449.775000000001</c:v>
                </c:pt>
                <c:pt idx="91">
                  <c:v>450.32500000000107</c:v>
                </c:pt>
                <c:pt idx="92">
                  <c:v>450.87500000000102</c:v>
                </c:pt>
                <c:pt idx="93">
                  <c:v>451.42500000000109</c:v>
                </c:pt>
                <c:pt idx="94">
                  <c:v>451.97500000000105</c:v>
                </c:pt>
                <c:pt idx="95">
                  <c:v>452.52500000000111</c:v>
                </c:pt>
                <c:pt idx="96">
                  <c:v>453.07500000000107</c:v>
                </c:pt>
                <c:pt idx="97">
                  <c:v>453.62500000000114</c:v>
                </c:pt>
                <c:pt idx="98">
                  <c:v>454.17500000000109</c:v>
                </c:pt>
                <c:pt idx="99">
                  <c:v>454.72500000000116</c:v>
                </c:pt>
                <c:pt idx="100">
                  <c:v>455.27500000000111</c:v>
                </c:pt>
                <c:pt idx="101">
                  <c:v>455.82500000000118</c:v>
                </c:pt>
                <c:pt idx="102">
                  <c:v>456.37500000000114</c:v>
                </c:pt>
                <c:pt idx="103">
                  <c:v>456.92500000000121</c:v>
                </c:pt>
                <c:pt idx="104">
                  <c:v>457.47500000000116</c:v>
                </c:pt>
                <c:pt idx="105">
                  <c:v>458.02500000000123</c:v>
                </c:pt>
                <c:pt idx="106">
                  <c:v>458.57500000000118</c:v>
                </c:pt>
                <c:pt idx="107">
                  <c:v>459.12500000000125</c:v>
                </c:pt>
                <c:pt idx="108">
                  <c:v>459.67500000000121</c:v>
                </c:pt>
                <c:pt idx="109">
                  <c:v>460.22500000000127</c:v>
                </c:pt>
                <c:pt idx="110">
                  <c:v>460.77500000000123</c:v>
                </c:pt>
                <c:pt idx="111">
                  <c:v>461.3250000000013</c:v>
                </c:pt>
                <c:pt idx="112">
                  <c:v>461.87500000000125</c:v>
                </c:pt>
                <c:pt idx="113">
                  <c:v>462.42500000000132</c:v>
                </c:pt>
                <c:pt idx="114">
                  <c:v>462.97500000000127</c:v>
                </c:pt>
                <c:pt idx="115">
                  <c:v>463.52500000000134</c:v>
                </c:pt>
                <c:pt idx="116">
                  <c:v>464.0750000000013</c:v>
                </c:pt>
                <c:pt idx="117">
                  <c:v>464.62500000000136</c:v>
                </c:pt>
                <c:pt idx="118">
                  <c:v>465.17500000000132</c:v>
                </c:pt>
                <c:pt idx="119">
                  <c:v>465.72500000000139</c:v>
                </c:pt>
                <c:pt idx="120">
                  <c:v>466.27500000000134</c:v>
                </c:pt>
                <c:pt idx="121">
                  <c:v>466.82500000000141</c:v>
                </c:pt>
                <c:pt idx="122">
                  <c:v>467.37500000000136</c:v>
                </c:pt>
                <c:pt idx="123">
                  <c:v>467.92500000000143</c:v>
                </c:pt>
                <c:pt idx="124">
                  <c:v>468.47500000000139</c:v>
                </c:pt>
                <c:pt idx="125">
                  <c:v>469.02500000000146</c:v>
                </c:pt>
                <c:pt idx="126">
                  <c:v>469.57500000000141</c:v>
                </c:pt>
                <c:pt idx="127">
                  <c:v>470.12500000000148</c:v>
                </c:pt>
                <c:pt idx="128">
                  <c:v>470.67500000000143</c:v>
                </c:pt>
                <c:pt idx="129">
                  <c:v>471.2250000000015</c:v>
                </c:pt>
                <c:pt idx="130">
                  <c:v>471.77500000000146</c:v>
                </c:pt>
                <c:pt idx="131">
                  <c:v>472.32500000000152</c:v>
                </c:pt>
                <c:pt idx="132">
                  <c:v>472.87500000000148</c:v>
                </c:pt>
                <c:pt idx="133">
                  <c:v>473.42500000000155</c:v>
                </c:pt>
                <c:pt idx="134">
                  <c:v>473.9750000000015</c:v>
                </c:pt>
                <c:pt idx="135">
                  <c:v>474.52500000000157</c:v>
                </c:pt>
                <c:pt idx="136">
                  <c:v>475.07500000000152</c:v>
                </c:pt>
                <c:pt idx="137">
                  <c:v>475.62500000000159</c:v>
                </c:pt>
                <c:pt idx="138">
                  <c:v>476.17500000000155</c:v>
                </c:pt>
                <c:pt idx="139">
                  <c:v>476.72500000000161</c:v>
                </c:pt>
                <c:pt idx="140">
                  <c:v>477.27500000000157</c:v>
                </c:pt>
                <c:pt idx="141">
                  <c:v>477.82500000000164</c:v>
                </c:pt>
                <c:pt idx="142">
                  <c:v>478.37500000000159</c:v>
                </c:pt>
                <c:pt idx="143">
                  <c:v>478.92500000000166</c:v>
                </c:pt>
                <c:pt idx="144">
                  <c:v>479.47500000000161</c:v>
                </c:pt>
                <c:pt idx="145">
                  <c:v>480.02500000000168</c:v>
                </c:pt>
                <c:pt idx="146">
                  <c:v>480.57500000000164</c:v>
                </c:pt>
                <c:pt idx="147">
                  <c:v>481.12500000000171</c:v>
                </c:pt>
                <c:pt idx="148">
                  <c:v>481.67500000000166</c:v>
                </c:pt>
                <c:pt idx="149">
                  <c:v>482.22500000000173</c:v>
                </c:pt>
                <c:pt idx="150">
                  <c:v>482.77500000000168</c:v>
                </c:pt>
                <c:pt idx="151">
                  <c:v>483.32500000000175</c:v>
                </c:pt>
                <c:pt idx="152">
                  <c:v>483.87500000000171</c:v>
                </c:pt>
                <c:pt idx="153">
                  <c:v>484.42500000000177</c:v>
                </c:pt>
                <c:pt idx="154">
                  <c:v>484.97500000000173</c:v>
                </c:pt>
                <c:pt idx="155">
                  <c:v>485.5250000000018</c:v>
                </c:pt>
                <c:pt idx="156">
                  <c:v>486.07500000000175</c:v>
                </c:pt>
                <c:pt idx="157">
                  <c:v>486.62500000000182</c:v>
                </c:pt>
                <c:pt idx="158">
                  <c:v>487.17500000000177</c:v>
                </c:pt>
                <c:pt idx="159">
                  <c:v>487.72500000000184</c:v>
                </c:pt>
                <c:pt idx="160">
                  <c:v>488.2750000000018</c:v>
                </c:pt>
                <c:pt idx="161">
                  <c:v>488.82500000000186</c:v>
                </c:pt>
                <c:pt idx="162">
                  <c:v>489.37500000000182</c:v>
                </c:pt>
                <c:pt idx="163">
                  <c:v>489.92500000000189</c:v>
                </c:pt>
                <c:pt idx="164">
                  <c:v>490.47500000000184</c:v>
                </c:pt>
                <c:pt idx="165">
                  <c:v>491.02500000000191</c:v>
                </c:pt>
                <c:pt idx="166">
                  <c:v>491.57500000000186</c:v>
                </c:pt>
                <c:pt idx="167">
                  <c:v>492.12500000000193</c:v>
                </c:pt>
                <c:pt idx="168">
                  <c:v>492.67500000000189</c:v>
                </c:pt>
                <c:pt idx="169">
                  <c:v>493.22500000000196</c:v>
                </c:pt>
                <c:pt idx="170">
                  <c:v>493.77500000000191</c:v>
                </c:pt>
                <c:pt idx="171">
                  <c:v>494.32500000000198</c:v>
                </c:pt>
                <c:pt idx="172">
                  <c:v>494.87500000000193</c:v>
                </c:pt>
                <c:pt idx="173">
                  <c:v>495.425000000002</c:v>
                </c:pt>
                <c:pt idx="174">
                  <c:v>495.97500000000196</c:v>
                </c:pt>
                <c:pt idx="175">
                  <c:v>496.52500000000202</c:v>
                </c:pt>
                <c:pt idx="176">
                  <c:v>497.07500000000198</c:v>
                </c:pt>
                <c:pt idx="177">
                  <c:v>497.62500000000205</c:v>
                </c:pt>
                <c:pt idx="178">
                  <c:v>498.175000000002</c:v>
                </c:pt>
                <c:pt idx="179">
                  <c:v>498.72500000000207</c:v>
                </c:pt>
                <c:pt idx="180">
                  <c:v>499.27500000000202</c:v>
                </c:pt>
                <c:pt idx="181">
                  <c:v>499.82500000000209</c:v>
                </c:pt>
                <c:pt idx="182">
                  <c:v>500.37500000000205</c:v>
                </c:pt>
                <c:pt idx="183">
                  <c:v>500.92500000000211</c:v>
                </c:pt>
                <c:pt idx="184">
                  <c:v>501.47500000000207</c:v>
                </c:pt>
                <c:pt idx="185">
                  <c:v>502.02500000000214</c:v>
                </c:pt>
                <c:pt idx="186">
                  <c:v>502.57500000000209</c:v>
                </c:pt>
                <c:pt idx="187">
                  <c:v>503.12500000000216</c:v>
                </c:pt>
                <c:pt idx="188">
                  <c:v>503.67500000000211</c:v>
                </c:pt>
                <c:pt idx="189">
                  <c:v>504.22500000000218</c:v>
                </c:pt>
                <c:pt idx="190">
                  <c:v>504.77500000000214</c:v>
                </c:pt>
                <c:pt idx="191">
                  <c:v>505.32500000000221</c:v>
                </c:pt>
                <c:pt idx="192">
                  <c:v>505.87500000000216</c:v>
                </c:pt>
                <c:pt idx="193">
                  <c:v>506.42500000000223</c:v>
                </c:pt>
                <c:pt idx="194">
                  <c:v>506.97500000000218</c:v>
                </c:pt>
                <c:pt idx="195">
                  <c:v>507.52500000000225</c:v>
                </c:pt>
                <c:pt idx="196">
                  <c:v>508.07500000000221</c:v>
                </c:pt>
                <c:pt idx="197">
                  <c:v>508.62500000000227</c:v>
                </c:pt>
                <c:pt idx="198">
                  <c:v>509.17500000000223</c:v>
                </c:pt>
                <c:pt idx="199">
                  <c:v>509.7250000000023</c:v>
                </c:pt>
                <c:pt idx="200">
                  <c:v>510.27500000000225</c:v>
                </c:pt>
                <c:pt idx="201">
                  <c:v>510.82500000000232</c:v>
                </c:pt>
                <c:pt idx="202">
                  <c:v>511.37500000000227</c:v>
                </c:pt>
                <c:pt idx="203">
                  <c:v>511.92500000000234</c:v>
                </c:pt>
                <c:pt idx="204">
                  <c:v>512.4750000000023</c:v>
                </c:pt>
                <c:pt idx="205">
                  <c:v>513.02500000000225</c:v>
                </c:pt>
                <c:pt idx="206">
                  <c:v>513.57500000000221</c:v>
                </c:pt>
                <c:pt idx="207">
                  <c:v>514.12500000000216</c:v>
                </c:pt>
                <c:pt idx="208">
                  <c:v>514.67500000000211</c:v>
                </c:pt>
                <c:pt idx="209">
                  <c:v>515.22500000000207</c:v>
                </c:pt>
                <c:pt idx="210">
                  <c:v>515.77500000000202</c:v>
                </c:pt>
                <c:pt idx="211">
                  <c:v>516.32500000000198</c:v>
                </c:pt>
                <c:pt idx="212">
                  <c:v>516.87500000000193</c:v>
                </c:pt>
                <c:pt idx="213">
                  <c:v>517.42500000000189</c:v>
                </c:pt>
                <c:pt idx="214">
                  <c:v>517.97500000000184</c:v>
                </c:pt>
                <c:pt idx="215">
                  <c:v>518.5250000000018</c:v>
                </c:pt>
                <c:pt idx="216">
                  <c:v>519.07500000000175</c:v>
                </c:pt>
                <c:pt idx="217">
                  <c:v>519.62500000000171</c:v>
                </c:pt>
                <c:pt idx="218">
                  <c:v>520.17500000000166</c:v>
                </c:pt>
                <c:pt idx="219">
                  <c:v>520.72500000000161</c:v>
                </c:pt>
                <c:pt idx="220">
                  <c:v>521.27500000000157</c:v>
                </c:pt>
                <c:pt idx="221">
                  <c:v>521.82500000000152</c:v>
                </c:pt>
                <c:pt idx="222">
                  <c:v>522.37500000000148</c:v>
                </c:pt>
                <c:pt idx="223">
                  <c:v>522.92500000000143</c:v>
                </c:pt>
                <c:pt idx="224">
                  <c:v>523.47500000000139</c:v>
                </c:pt>
                <c:pt idx="225">
                  <c:v>524.02500000000134</c:v>
                </c:pt>
                <c:pt idx="226">
                  <c:v>524.5750000000013</c:v>
                </c:pt>
                <c:pt idx="227">
                  <c:v>525.12500000000125</c:v>
                </c:pt>
                <c:pt idx="228">
                  <c:v>525.67500000000121</c:v>
                </c:pt>
                <c:pt idx="229">
                  <c:v>526.22500000000116</c:v>
                </c:pt>
                <c:pt idx="230">
                  <c:v>526.77500000000111</c:v>
                </c:pt>
                <c:pt idx="231">
                  <c:v>527.32500000000107</c:v>
                </c:pt>
                <c:pt idx="232">
                  <c:v>527.87500000000102</c:v>
                </c:pt>
                <c:pt idx="233">
                  <c:v>528.42500000000098</c:v>
                </c:pt>
                <c:pt idx="234">
                  <c:v>528.97500000000093</c:v>
                </c:pt>
                <c:pt idx="235">
                  <c:v>529.52500000000089</c:v>
                </c:pt>
                <c:pt idx="236">
                  <c:v>530.07500000000084</c:v>
                </c:pt>
                <c:pt idx="237">
                  <c:v>530.6250000000008</c:v>
                </c:pt>
                <c:pt idx="238">
                  <c:v>531.17500000000075</c:v>
                </c:pt>
                <c:pt idx="239">
                  <c:v>531.7250000000007</c:v>
                </c:pt>
                <c:pt idx="240">
                  <c:v>532.27500000000066</c:v>
                </c:pt>
                <c:pt idx="241">
                  <c:v>532.82500000000061</c:v>
                </c:pt>
                <c:pt idx="242">
                  <c:v>533.37500000000057</c:v>
                </c:pt>
                <c:pt idx="243">
                  <c:v>533.92500000000052</c:v>
                </c:pt>
                <c:pt idx="244">
                  <c:v>534.47500000000048</c:v>
                </c:pt>
                <c:pt idx="245">
                  <c:v>535.02500000000043</c:v>
                </c:pt>
                <c:pt idx="246">
                  <c:v>535.57500000000039</c:v>
                </c:pt>
                <c:pt idx="247">
                  <c:v>536.12500000000034</c:v>
                </c:pt>
                <c:pt idx="248">
                  <c:v>536.6750000000003</c:v>
                </c:pt>
                <c:pt idx="249">
                  <c:v>537.22500000000025</c:v>
                </c:pt>
                <c:pt idx="250">
                  <c:v>537.7750000000002</c:v>
                </c:pt>
                <c:pt idx="251">
                  <c:v>538.32500000000016</c:v>
                </c:pt>
                <c:pt idx="252">
                  <c:v>538.87500000000011</c:v>
                </c:pt>
                <c:pt idx="253">
                  <c:v>539.42500000000007</c:v>
                </c:pt>
                <c:pt idx="254">
                  <c:v>539.97500000000002</c:v>
                </c:pt>
                <c:pt idx="255">
                  <c:v>540.52499999999998</c:v>
                </c:pt>
                <c:pt idx="256">
                  <c:v>541.07499999999993</c:v>
                </c:pt>
                <c:pt idx="257">
                  <c:v>541.62499999999989</c:v>
                </c:pt>
                <c:pt idx="258">
                  <c:v>542.17499999999984</c:v>
                </c:pt>
                <c:pt idx="259">
                  <c:v>542.7249999999998</c:v>
                </c:pt>
                <c:pt idx="260">
                  <c:v>543.27499999999975</c:v>
                </c:pt>
                <c:pt idx="261">
                  <c:v>543.8249999999997</c:v>
                </c:pt>
                <c:pt idx="262">
                  <c:v>544.37499999999966</c:v>
                </c:pt>
                <c:pt idx="263">
                  <c:v>544.92499999999961</c:v>
                </c:pt>
                <c:pt idx="264">
                  <c:v>545.47499999999957</c:v>
                </c:pt>
                <c:pt idx="265">
                  <c:v>546.02499999999952</c:v>
                </c:pt>
                <c:pt idx="266">
                  <c:v>546.57499999999948</c:v>
                </c:pt>
                <c:pt idx="267">
                  <c:v>547.12499999999943</c:v>
                </c:pt>
                <c:pt idx="268">
                  <c:v>547.67499999999939</c:v>
                </c:pt>
                <c:pt idx="269">
                  <c:v>548.22499999999934</c:v>
                </c:pt>
                <c:pt idx="270">
                  <c:v>548.7749999999993</c:v>
                </c:pt>
                <c:pt idx="271">
                  <c:v>549.32499999999925</c:v>
                </c:pt>
                <c:pt idx="272">
                  <c:v>549.8749999999992</c:v>
                </c:pt>
                <c:pt idx="273">
                  <c:v>550.42499999999916</c:v>
                </c:pt>
                <c:pt idx="274">
                  <c:v>550.97499999999911</c:v>
                </c:pt>
                <c:pt idx="275">
                  <c:v>551.52499999999907</c:v>
                </c:pt>
                <c:pt idx="276">
                  <c:v>552.07499999999902</c:v>
                </c:pt>
                <c:pt idx="277">
                  <c:v>552.62499999999898</c:v>
                </c:pt>
                <c:pt idx="278">
                  <c:v>553.17499999999893</c:v>
                </c:pt>
                <c:pt idx="279">
                  <c:v>553.72499999999889</c:v>
                </c:pt>
                <c:pt idx="280">
                  <c:v>554.27499999999884</c:v>
                </c:pt>
                <c:pt idx="281">
                  <c:v>554.82499999999879</c:v>
                </c:pt>
                <c:pt idx="282">
                  <c:v>555.37499999999875</c:v>
                </c:pt>
                <c:pt idx="283">
                  <c:v>555.9249999999987</c:v>
                </c:pt>
                <c:pt idx="284">
                  <c:v>556.47499999999866</c:v>
                </c:pt>
                <c:pt idx="285">
                  <c:v>557.02499999999861</c:v>
                </c:pt>
                <c:pt idx="286">
                  <c:v>557.57499999999857</c:v>
                </c:pt>
                <c:pt idx="287">
                  <c:v>558.12499999999852</c:v>
                </c:pt>
                <c:pt idx="288">
                  <c:v>558.67499999999848</c:v>
                </c:pt>
                <c:pt idx="289">
                  <c:v>559.22499999999843</c:v>
                </c:pt>
                <c:pt idx="290">
                  <c:v>559.77499999999839</c:v>
                </c:pt>
                <c:pt idx="291">
                  <c:v>560.32499999999834</c:v>
                </c:pt>
                <c:pt idx="292">
                  <c:v>560.87499999999829</c:v>
                </c:pt>
                <c:pt idx="293">
                  <c:v>561.42499999999825</c:v>
                </c:pt>
                <c:pt idx="294">
                  <c:v>561.9749999999982</c:v>
                </c:pt>
                <c:pt idx="295">
                  <c:v>562.52499999999816</c:v>
                </c:pt>
                <c:pt idx="296">
                  <c:v>563.07499999999811</c:v>
                </c:pt>
                <c:pt idx="297">
                  <c:v>563.62499999999807</c:v>
                </c:pt>
                <c:pt idx="298">
                  <c:v>564.17499999999802</c:v>
                </c:pt>
                <c:pt idx="299">
                  <c:v>564.72499999999798</c:v>
                </c:pt>
                <c:pt idx="300">
                  <c:v>565.27499999999793</c:v>
                </c:pt>
                <c:pt idx="301">
                  <c:v>565.82499999999789</c:v>
                </c:pt>
                <c:pt idx="302">
                  <c:v>566.37499999999784</c:v>
                </c:pt>
                <c:pt idx="303">
                  <c:v>566.92499999999779</c:v>
                </c:pt>
                <c:pt idx="304">
                  <c:v>567.47499999999775</c:v>
                </c:pt>
                <c:pt idx="305">
                  <c:v>568.0249999999977</c:v>
                </c:pt>
                <c:pt idx="306">
                  <c:v>568.57499999999766</c:v>
                </c:pt>
                <c:pt idx="307">
                  <c:v>569.12499999999761</c:v>
                </c:pt>
                <c:pt idx="308">
                  <c:v>569.67499999999757</c:v>
                </c:pt>
                <c:pt idx="309">
                  <c:v>570.22499999999752</c:v>
                </c:pt>
                <c:pt idx="310">
                  <c:v>570.77499999999748</c:v>
                </c:pt>
                <c:pt idx="311">
                  <c:v>571.32499999999743</c:v>
                </c:pt>
                <c:pt idx="312">
                  <c:v>571.87499999999739</c:v>
                </c:pt>
                <c:pt idx="313">
                  <c:v>572.42499999999734</c:v>
                </c:pt>
                <c:pt idx="314">
                  <c:v>572.97499999999729</c:v>
                </c:pt>
                <c:pt idx="315">
                  <c:v>573.52499999999725</c:v>
                </c:pt>
                <c:pt idx="316">
                  <c:v>574.0749999999972</c:v>
                </c:pt>
                <c:pt idx="317">
                  <c:v>574.62499999999716</c:v>
                </c:pt>
                <c:pt idx="318">
                  <c:v>575.17499999999711</c:v>
                </c:pt>
                <c:pt idx="319">
                  <c:v>575.72499999999707</c:v>
                </c:pt>
                <c:pt idx="320">
                  <c:v>576.27499999999702</c:v>
                </c:pt>
                <c:pt idx="321">
                  <c:v>576.82499999999698</c:v>
                </c:pt>
                <c:pt idx="322">
                  <c:v>577.37499999999693</c:v>
                </c:pt>
                <c:pt idx="323">
                  <c:v>577.92499999999688</c:v>
                </c:pt>
                <c:pt idx="324">
                  <c:v>578.47499999999684</c:v>
                </c:pt>
                <c:pt idx="325">
                  <c:v>579.02499999999679</c:v>
                </c:pt>
                <c:pt idx="326">
                  <c:v>579.57499999999675</c:v>
                </c:pt>
                <c:pt idx="327">
                  <c:v>580.1249999999967</c:v>
                </c:pt>
                <c:pt idx="328">
                  <c:v>580.67499999999666</c:v>
                </c:pt>
                <c:pt idx="329">
                  <c:v>581.22499999999661</c:v>
                </c:pt>
                <c:pt idx="330">
                  <c:v>581.77499999999657</c:v>
                </c:pt>
                <c:pt idx="331">
                  <c:v>582.32499999999652</c:v>
                </c:pt>
                <c:pt idx="332">
                  <c:v>582.87499999999648</c:v>
                </c:pt>
                <c:pt idx="333">
                  <c:v>583.42499999999643</c:v>
                </c:pt>
                <c:pt idx="334">
                  <c:v>583.97499999999638</c:v>
                </c:pt>
                <c:pt idx="335">
                  <c:v>584.52499999999634</c:v>
                </c:pt>
                <c:pt idx="336">
                  <c:v>585.07499999999629</c:v>
                </c:pt>
                <c:pt idx="337">
                  <c:v>585.62499999999625</c:v>
                </c:pt>
                <c:pt idx="338">
                  <c:v>586.1749999999962</c:v>
                </c:pt>
                <c:pt idx="339">
                  <c:v>586.72499999999616</c:v>
                </c:pt>
                <c:pt idx="340">
                  <c:v>587.27499999999611</c:v>
                </c:pt>
                <c:pt idx="341">
                  <c:v>587.82499999999607</c:v>
                </c:pt>
                <c:pt idx="342">
                  <c:v>588.37499999999602</c:v>
                </c:pt>
                <c:pt idx="343">
                  <c:v>588.92499999999598</c:v>
                </c:pt>
                <c:pt idx="344">
                  <c:v>589.47499999999593</c:v>
                </c:pt>
                <c:pt idx="345">
                  <c:v>590.02499999999588</c:v>
                </c:pt>
                <c:pt idx="346">
                  <c:v>590.57499999999584</c:v>
                </c:pt>
                <c:pt idx="347">
                  <c:v>591.12499999999579</c:v>
                </c:pt>
                <c:pt idx="348">
                  <c:v>591.67499999999575</c:v>
                </c:pt>
                <c:pt idx="349">
                  <c:v>592.2249999999957</c:v>
                </c:pt>
                <c:pt idx="350">
                  <c:v>592.77499999999566</c:v>
                </c:pt>
                <c:pt idx="351">
                  <c:v>593.32499999999561</c:v>
                </c:pt>
                <c:pt idx="352">
                  <c:v>593.87499999999557</c:v>
                </c:pt>
                <c:pt idx="353">
                  <c:v>594.42499999999552</c:v>
                </c:pt>
                <c:pt idx="354">
                  <c:v>594.97499999999548</c:v>
                </c:pt>
                <c:pt idx="355">
                  <c:v>595.52499999999543</c:v>
                </c:pt>
                <c:pt idx="356">
                  <c:v>596.07499999999538</c:v>
                </c:pt>
                <c:pt idx="357">
                  <c:v>596.62499999999534</c:v>
                </c:pt>
                <c:pt idx="358">
                  <c:v>597.17499999999529</c:v>
                </c:pt>
                <c:pt idx="359">
                  <c:v>597.72499999999525</c:v>
                </c:pt>
                <c:pt idx="360">
                  <c:v>598.2749999999952</c:v>
                </c:pt>
                <c:pt idx="361">
                  <c:v>598.82499999999516</c:v>
                </c:pt>
                <c:pt idx="362">
                  <c:v>599.37499999999511</c:v>
                </c:pt>
                <c:pt idx="363">
                  <c:v>599.92499999999507</c:v>
                </c:pt>
                <c:pt idx="364">
                  <c:v>600.47499999999502</c:v>
                </c:pt>
                <c:pt idx="365">
                  <c:v>601.02499999999498</c:v>
                </c:pt>
                <c:pt idx="366">
                  <c:v>601.57499999999493</c:v>
                </c:pt>
                <c:pt idx="367">
                  <c:v>602.12499999999488</c:v>
                </c:pt>
                <c:pt idx="368">
                  <c:v>602.67499999999484</c:v>
                </c:pt>
                <c:pt idx="369">
                  <c:v>603.22499999999479</c:v>
                </c:pt>
                <c:pt idx="370">
                  <c:v>603.77499999999475</c:v>
                </c:pt>
                <c:pt idx="371">
                  <c:v>604.3249999999947</c:v>
                </c:pt>
                <c:pt idx="372">
                  <c:v>604.87499999999466</c:v>
                </c:pt>
                <c:pt idx="373">
                  <c:v>605.42499999999461</c:v>
                </c:pt>
                <c:pt idx="374">
                  <c:v>605.97499999999457</c:v>
                </c:pt>
                <c:pt idx="375">
                  <c:v>606.52499999999452</c:v>
                </c:pt>
                <c:pt idx="376">
                  <c:v>607.07499999999447</c:v>
                </c:pt>
                <c:pt idx="377">
                  <c:v>607.62499999999443</c:v>
                </c:pt>
                <c:pt idx="378">
                  <c:v>608.17499999999438</c:v>
                </c:pt>
                <c:pt idx="379">
                  <c:v>608.72499999999434</c:v>
                </c:pt>
                <c:pt idx="380">
                  <c:v>609.27499999999429</c:v>
                </c:pt>
                <c:pt idx="381">
                  <c:v>609.82499999999425</c:v>
                </c:pt>
                <c:pt idx="382">
                  <c:v>610.3749999999942</c:v>
                </c:pt>
                <c:pt idx="383">
                  <c:v>610.92499999999416</c:v>
                </c:pt>
                <c:pt idx="384">
                  <c:v>611.47499999999411</c:v>
                </c:pt>
                <c:pt idx="385">
                  <c:v>612.02499999999407</c:v>
                </c:pt>
                <c:pt idx="386">
                  <c:v>612.57499999999402</c:v>
                </c:pt>
                <c:pt idx="387">
                  <c:v>613.12499999999397</c:v>
                </c:pt>
                <c:pt idx="388">
                  <c:v>613.67499999999393</c:v>
                </c:pt>
                <c:pt idx="389">
                  <c:v>614.22499999999388</c:v>
                </c:pt>
                <c:pt idx="390">
                  <c:v>614.77499999999384</c:v>
                </c:pt>
                <c:pt idx="391">
                  <c:v>615.32499999999379</c:v>
                </c:pt>
                <c:pt idx="392">
                  <c:v>615.87499999999375</c:v>
                </c:pt>
                <c:pt idx="393">
                  <c:v>616.4249999999937</c:v>
                </c:pt>
                <c:pt idx="394">
                  <c:v>616.97499999999366</c:v>
                </c:pt>
                <c:pt idx="395">
                  <c:v>617.52499999999361</c:v>
                </c:pt>
                <c:pt idx="396">
                  <c:v>618.07499999999357</c:v>
                </c:pt>
                <c:pt idx="397">
                  <c:v>618.62499999999352</c:v>
                </c:pt>
                <c:pt idx="398">
                  <c:v>619.17499999999347</c:v>
                </c:pt>
                <c:pt idx="399">
                  <c:v>619.72499999999343</c:v>
                </c:pt>
                <c:pt idx="400">
                  <c:v>620.27499999999338</c:v>
                </c:pt>
                <c:pt idx="401">
                  <c:v>620.82499999999334</c:v>
                </c:pt>
                <c:pt idx="402">
                  <c:v>621.37499999999329</c:v>
                </c:pt>
                <c:pt idx="403">
                  <c:v>621.92499999999325</c:v>
                </c:pt>
                <c:pt idx="404">
                  <c:v>622.4749999999932</c:v>
                </c:pt>
                <c:pt idx="405">
                  <c:v>623.02499999999316</c:v>
                </c:pt>
                <c:pt idx="406">
                  <c:v>623.57499999999311</c:v>
                </c:pt>
                <c:pt idx="407">
                  <c:v>624.12499999999307</c:v>
                </c:pt>
                <c:pt idx="408">
                  <c:v>624.67499999999302</c:v>
                </c:pt>
                <c:pt idx="409">
                  <c:v>625.22499999999297</c:v>
                </c:pt>
                <c:pt idx="410">
                  <c:v>625.77499999999293</c:v>
                </c:pt>
                <c:pt idx="411">
                  <c:v>626.32499999999288</c:v>
                </c:pt>
                <c:pt idx="412">
                  <c:v>626.87499999999284</c:v>
                </c:pt>
                <c:pt idx="413">
                  <c:v>627.42499999999279</c:v>
                </c:pt>
                <c:pt idx="414">
                  <c:v>627.97499999999275</c:v>
                </c:pt>
                <c:pt idx="415">
                  <c:v>628.5249999999927</c:v>
                </c:pt>
                <c:pt idx="416">
                  <c:v>629.07499999999266</c:v>
                </c:pt>
                <c:pt idx="417">
                  <c:v>629.62499999999261</c:v>
                </c:pt>
                <c:pt idx="418">
                  <c:v>630.17499999999256</c:v>
                </c:pt>
                <c:pt idx="419">
                  <c:v>630.72499999999252</c:v>
                </c:pt>
                <c:pt idx="420">
                  <c:v>631.27499999999247</c:v>
                </c:pt>
                <c:pt idx="421">
                  <c:v>631.82499999999243</c:v>
                </c:pt>
                <c:pt idx="422">
                  <c:v>632.37499999999238</c:v>
                </c:pt>
                <c:pt idx="423">
                  <c:v>632.92499999999234</c:v>
                </c:pt>
                <c:pt idx="424">
                  <c:v>633.47499999999229</c:v>
                </c:pt>
                <c:pt idx="425">
                  <c:v>634.02499999999225</c:v>
                </c:pt>
                <c:pt idx="426">
                  <c:v>634.5749999999922</c:v>
                </c:pt>
                <c:pt idx="427">
                  <c:v>635.12499999999216</c:v>
                </c:pt>
                <c:pt idx="428">
                  <c:v>635.67499999999211</c:v>
                </c:pt>
                <c:pt idx="429">
                  <c:v>636.22499999999206</c:v>
                </c:pt>
                <c:pt idx="430">
                  <c:v>636.77499999999202</c:v>
                </c:pt>
                <c:pt idx="431">
                  <c:v>637.32499999999197</c:v>
                </c:pt>
                <c:pt idx="432">
                  <c:v>637.87499999999193</c:v>
                </c:pt>
                <c:pt idx="433">
                  <c:v>638.42499999999188</c:v>
                </c:pt>
                <c:pt idx="434">
                  <c:v>638.97499999999184</c:v>
                </c:pt>
                <c:pt idx="435">
                  <c:v>639.52499999999179</c:v>
                </c:pt>
                <c:pt idx="436">
                  <c:v>640.07499999999175</c:v>
                </c:pt>
                <c:pt idx="437">
                  <c:v>640.6249999999917</c:v>
                </c:pt>
                <c:pt idx="438">
                  <c:v>641.17499999999166</c:v>
                </c:pt>
                <c:pt idx="439">
                  <c:v>641.72499999999161</c:v>
                </c:pt>
                <c:pt idx="440">
                  <c:v>642.27499999999156</c:v>
                </c:pt>
                <c:pt idx="441">
                  <c:v>642.82499999999152</c:v>
                </c:pt>
                <c:pt idx="442">
                  <c:v>643.37499999999147</c:v>
                </c:pt>
                <c:pt idx="443">
                  <c:v>643.92499999999143</c:v>
                </c:pt>
                <c:pt idx="444">
                  <c:v>644.47499999999138</c:v>
                </c:pt>
                <c:pt idx="445">
                  <c:v>645.02499999999134</c:v>
                </c:pt>
                <c:pt idx="446">
                  <c:v>645.57499999999129</c:v>
                </c:pt>
                <c:pt idx="447">
                  <c:v>646.12499999999125</c:v>
                </c:pt>
                <c:pt idx="448">
                  <c:v>646.6749999999912</c:v>
                </c:pt>
                <c:pt idx="449">
                  <c:v>647.22499999999116</c:v>
                </c:pt>
                <c:pt idx="450">
                  <c:v>647.77499999999111</c:v>
                </c:pt>
                <c:pt idx="451">
                  <c:v>648.32499999999106</c:v>
                </c:pt>
                <c:pt idx="452">
                  <c:v>648.87499999999102</c:v>
                </c:pt>
                <c:pt idx="453">
                  <c:v>649.42499999999097</c:v>
                </c:pt>
                <c:pt idx="454">
                  <c:v>649.97499999999093</c:v>
                </c:pt>
                <c:pt idx="455">
                  <c:v>650.52499999999088</c:v>
                </c:pt>
                <c:pt idx="456">
                  <c:v>651.07499999999084</c:v>
                </c:pt>
                <c:pt idx="457">
                  <c:v>651.62499999999079</c:v>
                </c:pt>
                <c:pt idx="458">
                  <c:v>652.17499999999075</c:v>
                </c:pt>
                <c:pt idx="459">
                  <c:v>652.7249999999907</c:v>
                </c:pt>
                <c:pt idx="460">
                  <c:v>653.27499999999065</c:v>
                </c:pt>
                <c:pt idx="461">
                  <c:v>653.82499999999061</c:v>
                </c:pt>
                <c:pt idx="462">
                  <c:v>654.37499999999056</c:v>
                </c:pt>
                <c:pt idx="463">
                  <c:v>654.92499999999052</c:v>
                </c:pt>
                <c:pt idx="464">
                  <c:v>655.47499999999047</c:v>
                </c:pt>
                <c:pt idx="465">
                  <c:v>656.02499999999043</c:v>
                </c:pt>
                <c:pt idx="466">
                  <c:v>656.57499999999038</c:v>
                </c:pt>
                <c:pt idx="467">
                  <c:v>657.12499999999034</c:v>
                </c:pt>
                <c:pt idx="468">
                  <c:v>657.67499999999029</c:v>
                </c:pt>
                <c:pt idx="469">
                  <c:v>658.22499999999025</c:v>
                </c:pt>
                <c:pt idx="470">
                  <c:v>658.7749999999902</c:v>
                </c:pt>
                <c:pt idx="471">
                  <c:v>659.32499999999015</c:v>
                </c:pt>
                <c:pt idx="472">
                  <c:v>659.87499999999011</c:v>
                </c:pt>
                <c:pt idx="473">
                  <c:v>660.42499999999006</c:v>
                </c:pt>
                <c:pt idx="474">
                  <c:v>660.97499999999002</c:v>
                </c:pt>
                <c:pt idx="475">
                  <c:v>661.52499999998997</c:v>
                </c:pt>
                <c:pt idx="476">
                  <c:v>662.07499999998993</c:v>
                </c:pt>
                <c:pt idx="477">
                  <c:v>662.62499999998988</c:v>
                </c:pt>
                <c:pt idx="478">
                  <c:v>663.17499999998984</c:v>
                </c:pt>
                <c:pt idx="479">
                  <c:v>663.72499999998979</c:v>
                </c:pt>
                <c:pt idx="480">
                  <c:v>664.27499999998975</c:v>
                </c:pt>
                <c:pt idx="481">
                  <c:v>664.8249999999897</c:v>
                </c:pt>
                <c:pt idx="482">
                  <c:v>665.37499999998965</c:v>
                </c:pt>
                <c:pt idx="483">
                  <c:v>665.92499999998961</c:v>
                </c:pt>
                <c:pt idx="484">
                  <c:v>666.47499999998956</c:v>
                </c:pt>
                <c:pt idx="485">
                  <c:v>667.02499999998952</c:v>
                </c:pt>
                <c:pt idx="486">
                  <c:v>667.57499999998947</c:v>
                </c:pt>
                <c:pt idx="487">
                  <c:v>668.12499999998943</c:v>
                </c:pt>
                <c:pt idx="488">
                  <c:v>668.67499999998938</c:v>
                </c:pt>
                <c:pt idx="489">
                  <c:v>669.22499999998934</c:v>
                </c:pt>
                <c:pt idx="490">
                  <c:v>669.77499999998929</c:v>
                </c:pt>
                <c:pt idx="491">
                  <c:v>670.32499999998925</c:v>
                </c:pt>
                <c:pt idx="492">
                  <c:v>670.8749999999892</c:v>
                </c:pt>
                <c:pt idx="493">
                  <c:v>671.42499999998915</c:v>
                </c:pt>
                <c:pt idx="494">
                  <c:v>671.97499999998911</c:v>
                </c:pt>
                <c:pt idx="495">
                  <c:v>672.52499999998906</c:v>
                </c:pt>
                <c:pt idx="496">
                  <c:v>673.07499999998902</c:v>
                </c:pt>
                <c:pt idx="497">
                  <c:v>673.62499999998897</c:v>
                </c:pt>
                <c:pt idx="498">
                  <c:v>674.17499999998893</c:v>
                </c:pt>
                <c:pt idx="499">
                  <c:v>674.72499999998888</c:v>
                </c:pt>
                <c:pt idx="500">
                  <c:v>675.27499999998884</c:v>
                </c:pt>
                <c:pt idx="501">
                  <c:v>675.82499999998879</c:v>
                </c:pt>
                <c:pt idx="502">
                  <c:v>676.37499999998875</c:v>
                </c:pt>
                <c:pt idx="503">
                  <c:v>676.9249999999887</c:v>
                </c:pt>
                <c:pt idx="504">
                  <c:v>677.47499999998865</c:v>
                </c:pt>
                <c:pt idx="505">
                  <c:v>678.02499999998861</c:v>
                </c:pt>
                <c:pt idx="506">
                  <c:v>678.57499999998856</c:v>
                </c:pt>
                <c:pt idx="507">
                  <c:v>679.12499999998852</c:v>
                </c:pt>
                <c:pt idx="508">
                  <c:v>679.67499999998847</c:v>
                </c:pt>
                <c:pt idx="509">
                  <c:v>680.22499999998843</c:v>
                </c:pt>
                <c:pt idx="510">
                  <c:v>680.77499999998838</c:v>
                </c:pt>
                <c:pt idx="511">
                  <c:v>681.32499999998834</c:v>
                </c:pt>
                <c:pt idx="512">
                  <c:v>681.87499999998829</c:v>
                </c:pt>
                <c:pt idx="513">
                  <c:v>682.42499999998824</c:v>
                </c:pt>
                <c:pt idx="514">
                  <c:v>682.9749999999882</c:v>
                </c:pt>
                <c:pt idx="515">
                  <c:v>683.52499999998815</c:v>
                </c:pt>
                <c:pt idx="516">
                  <c:v>684.07499999998811</c:v>
                </c:pt>
                <c:pt idx="517">
                  <c:v>684.62499999998806</c:v>
                </c:pt>
                <c:pt idx="518">
                  <c:v>685.17499999998802</c:v>
                </c:pt>
                <c:pt idx="519">
                  <c:v>685.72499999998797</c:v>
                </c:pt>
                <c:pt idx="520">
                  <c:v>686.27499999998793</c:v>
                </c:pt>
                <c:pt idx="521">
                  <c:v>686.82499999998788</c:v>
                </c:pt>
                <c:pt idx="522">
                  <c:v>687.37499999998784</c:v>
                </c:pt>
                <c:pt idx="523">
                  <c:v>687.92499999998779</c:v>
                </c:pt>
                <c:pt idx="524">
                  <c:v>688.47499999998774</c:v>
                </c:pt>
                <c:pt idx="525">
                  <c:v>689.0249999999877</c:v>
                </c:pt>
                <c:pt idx="526">
                  <c:v>689.57499999998765</c:v>
                </c:pt>
                <c:pt idx="527">
                  <c:v>690.12499999998761</c:v>
                </c:pt>
                <c:pt idx="528">
                  <c:v>690.67499999998756</c:v>
                </c:pt>
                <c:pt idx="529">
                  <c:v>691.22499999998752</c:v>
                </c:pt>
                <c:pt idx="530">
                  <c:v>691.77499999998747</c:v>
                </c:pt>
                <c:pt idx="531">
                  <c:v>692.32499999998743</c:v>
                </c:pt>
                <c:pt idx="532">
                  <c:v>692.87499999998738</c:v>
                </c:pt>
                <c:pt idx="533">
                  <c:v>693.42499999998734</c:v>
                </c:pt>
                <c:pt idx="534">
                  <c:v>693.97499999998729</c:v>
                </c:pt>
                <c:pt idx="535">
                  <c:v>694.52499999998724</c:v>
                </c:pt>
                <c:pt idx="536">
                  <c:v>695.0749999999872</c:v>
                </c:pt>
                <c:pt idx="537">
                  <c:v>695.62499999998715</c:v>
                </c:pt>
                <c:pt idx="538">
                  <c:v>696.17499999998711</c:v>
                </c:pt>
                <c:pt idx="539">
                  <c:v>696.72499999998706</c:v>
                </c:pt>
                <c:pt idx="540">
                  <c:v>697.27499999998702</c:v>
                </c:pt>
                <c:pt idx="541">
                  <c:v>697.82499999998697</c:v>
                </c:pt>
                <c:pt idx="542">
                  <c:v>698.37499999998693</c:v>
                </c:pt>
                <c:pt idx="543">
                  <c:v>698.92499999998688</c:v>
                </c:pt>
                <c:pt idx="544">
                  <c:v>699.47499999998684</c:v>
                </c:pt>
                <c:pt idx="545">
                  <c:v>700.02499999998679</c:v>
                </c:pt>
                <c:pt idx="546">
                  <c:v>700.57499999998674</c:v>
                </c:pt>
                <c:pt idx="547">
                  <c:v>701.1249999999867</c:v>
                </c:pt>
                <c:pt idx="548">
                  <c:v>701.67499999998665</c:v>
                </c:pt>
                <c:pt idx="549">
                  <c:v>702.22499999998661</c:v>
                </c:pt>
                <c:pt idx="550">
                  <c:v>702.77499999998656</c:v>
                </c:pt>
                <c:pt idx="551">
                  <c:v>703.32499999998652</c:v>
                </c:pt>
                <c:pt idx="552">
                  <c:v>703.87499999998647</c:v>
                </c:pt>
                <c:pt idx="553">
                  <c:v>704.42499999998643</c:v>
                </c:pt>
                <c:pt idx="554">
                  <c:v>704.97499999998638</c:v>
                </c:pt>
                <c:pt idx="555">
                  <c:v>705.52499999998633</c:v>
                </c:pt>
                <c:pt idx="556">
                  <c:v>706.07499999998629</c:v>
                </c:pt>
                <c:pt idx="557">
                  <c:v>706.62499999998624</c:v>
                </c:pt>
                <c:pt idx="558">
                  <c:v>707.1749999999862</c:v>
                </c:pt>
                <c:pt idx="559">
                  <c:v>707.72499999998615</c:v>
                </c:pt>
                <c:pt idx="560">
                  <c:v>708.27499999998611</c:v>
                </c:pt>
                <c:pt idx="561">
                  <c:v>708.82499999998606</c:v>
                </c:pt>
                <c:pt idx="562">
                  <c:v>709.37499999998602</c:v>
                </c:pt>
                <c:pt idx="563">
                  <c:v>709.92499999998597</c:v>
                </c:pt>
                <c:pt idx="564">
                  <c:v>710.47499999998593</c:v>
                </c:pt>
                <c:pt idx="565">
                  <c:v>711.02499999998588</c:v>
                </c:pt>
                <c:pt idx="566">
                  <c:v>711.57499999998583</c:v>
                </c:pt>
                <c:pt idx="567">
                  <c:v>712.12499999998579</c:v>
                </c:pt>
                <c:pt idx="568">
                  <c:v>712.67499999998574</c:v>
                </c:pt>
                <c:pt idx="569">
                  <c:v>713.2249999999857</c:v>
                </c:pt>
                <c:pt idx="570">
                  <c:v>713.77499999998565</c:v>
                </c:pt>
                <c:pt idx="571">
                  <c:v>714.32499999998561</c:v>
                </c:pt>
                <c:pt idx="572">
                  <c:v>714.87499999998556</c:v>
                </c:pt>
                <c:pt idx="573">
                  <c:v>715.42499999998552</c:v>
                </c:pt>
                <c:pt idx="574">
                  <c:v>715.97499999998547</c:v>
                </c:pt>
                <c:pt idx="575">
                  <c:v>716.52499999998543</c:v>
                </c:pt>
                <c:pt idx="576">
                  <c:v>717.07499999998538</c:v>
                </c:pt>
                <c:pt idx="577">
                  <c:v>717.62499999998533</c:v>
                </c:pt>
                <c:pt idx="578">
                  <c:v>718.17499999998529</c:v>
                </c:pt>
                <c:pt idx="579">
                  <c:v>718.72499999998524</c:v>
                </c:pt>
                <c:pt idx="580">
                  <c:v>719.2749999999852</c:v>
                </c:pt>
                <c:pt idx="581">
                  <c:v>719.82499999998515</c:v>
                </c:pt>
                <c:pt idx="582">
                  <c:v>720.37499999998511</c:v>
                </c:pt>
                <c:pt idx="583">
                  <c:v>720.92499999998506</c:v>
                </c:pt>
                <c:pt idx="584">
                  <c:v>721.47499999998502</c:v>
                </c:pt>
                <c:pt idx="585">
                  <c:v>722.02499999998497</c:v>
                </c:pt>
                <c:pt idx="586">
                  <c:v>722.57499999998493</c:v>
                </c:pt>
                <c:pt idx="587">
                  <c:v>723.12499999998488</c:v>
                </c:pt>
                <c:pt idx="588">
                  <c:v>723.67499999998483</c:v>
                </c:pt>
                <c:pt idx="589">
                  <c:v>724.22499999998479</c:v>
                </c:pt>
                <c:pt idx="590">
                  <c:v>724.77499999998474</c:v>
                </c:pt>
                <c:pt idx="591">
                  <c:v>725.3249999999847</c:v>
                </c:pt>
                <c:pt idx="592">
                  <c:v>725.87499999998465</c:v>
                </c:pt>
                <c:pt idx="593">
                  <c:v>726.42499999998461</c:v>
                </c:pt>
                <c:pt idx="594">
                  <c:v>726.97499999998456</c:v>
                </c:pt>
                <c:pt idx="595">
                  <c:v>727.52499999998452</c:v>
                </c:pt>
                <c:pt idx="596">
                  <c:v>728.07499999998447</c:v>
                </c:pt>
                <c:pt idx="597">
                  <c:v>728.62499999998442</c:v>
                </c:pt>
                <c:pt idx="598">
                  <c:v>729.17499999998438</c:v>
                </c:pt>
                <c:pt idx="599">
                  <c:v>729.72499999998433</c:v>
                </c:pt>
                <c:pt idx="600">
                  <c:v>730.27499999998429</c:v>
                </c:pt>
                <c:pt idx="601">
                  <c:v>730.82499999998424</c:v>
                </c:pt>
                <c:pt idx="602">
                  <c:v>731.3749999999842</c:v>
                </c:pt>
                <c:pt idx="603">
                  <c:v>731.92499999998415</c:v>
                </c:pt>
                <c:pt idx="604">
                  <c:v>732.47499999998411</c:v>
                </c:pt>
                <c:pt idx="605">
                  <c:v>733.02499999998406</c:v>
                </c:pt>
                <c:pt idx="606">
                  <c:v>733.57499999998402</c:v>
                </c:pt>
                <c:pt idx="607">
                  <c:v>734.12499999998397</c:v>
                </c:pt>
                <c:pt idx="608">
                  <c:v>734.67499999998392</c:v>
                </c:pt>
                <c:pt idx="609">
                  <c:v>735.22499999998388</c:v>
                </c:pt>
                <c:pt idx="610">
                  <c:v>735.77499999998383</c:v>
                </c:pt>
                <c:pt idx="611">
                  <c:v>736.32499999998379</c:v>
                </c:pt>
                <c:pt idx="612">
                  <c:v>736.87499999998374</c:v>
                </c:pt>
                <c:pt idx="613">
                  <c:v>737.4249999999837</c:v>
                </c:pt>
                <c:pt idx="614">
                  <c:v>737.97499999998365</c:v>
                </c:pt>
                <c:pt idx="615">
                  <c:v>738.52499999998361</c:v>
                </c:pt>
                <c:pt idx="616">
                  <c:v>739.07499999998356</c:v>
                </c:pt>
                <c:pt idx="617">
                  <c:v>739.62499999998352</c:v>
                </c:pt>
                <c:pt idx="618">
                  <c:v>740.17499999998347</c:v>
                </c:pt>
                <c:pt idx="619">
                  <c:v>740.72499999998342</c:v>
                </c:pt>
                <c:pt idx="620">
                  <c:v>741.27499999998338</c:v>
                </c:pt>
                <c:pt idx="621">
                  <c:v>741.82499999998333</c:v>
                </c:pt>
                <c:pt idx="622">
                  <c:v>742.37499999998329</c:v>
                </c:pt>
                <c:pt idx="623">
                  <c:v>742.92499999998324</c:v>
                </c:pt>
                <c:pt idx="624">
                  <c:v>743.4749999999832</c:v>
                </c:pt>
                <c:pt idx="625">
                  <c:v>744.02499999998315</c:v>
                </c:pt>
                <c:pt idx="626">
                  <c:v>744.57499999998311</c:v>
                </c:pt>
                <c:pt idx="627">
                  <c:v>745.12499999998306</c:v>
                </c:pt>
                <c:pt idx="628">
                  <c:v>745.67499999998302</c:v>
                </c:pt>
                <c:pt idx="629">
                  <c:v>746.22499999998297</c:v>
                </c:pt>
                <c:pt idx="630">
                  <c:v>746.77499999998292</c:v>
                </c:pt>
                <c:pt idx="631">
                  <c:v>747.32499999998288</c:v>
                </c:pt>
                <c:pt idx="632">
                  <c:v>747.87499999998283</c:v>
                </c:pt>
                <c:pt idx="633">
                  <c:v>748.42499999998279</c:v>
                </c:pt>
                <c:pt idx="634">
                  <c:v>748.97499999998274</c:v>
                </c:pt>
                <c:pt idx="635">
                  <c:v>749.5249999999827</c:v>
                </c:pt>
                <c:pt idx="636">
                  <c:v>750.07499999998265</c:v>
                </c:pt>
                <c:pt idx="637">
                  <c:v>750.62499999998261</c:v>
                </c:pt>
                <c:pt idx="638">
                  <c:v>751.17499999998256</c:v>
                </c:pt>
                <c:pt idx="639">
                  <c:v>751.72499999998251</c:v>
                </c:pt>
                <c:pt idx="640">
                  <c:v>752.27499999998247</c:v>
                </c:pt>
                <c:pt idx="641">
                  <c:v>752.82499999998242</c:v>
                </c:pt>
                <c:pt idx="642">
                  <c:v>753.37499999998238</c:v>
                </c:pt>
                <c:pt idx="643">
                  <c:v>753.92499999998233</c:v>
                </c:pt>
                <c:pt idx="644">
                  <c:v>754.47499999998229</c:v>
                </c:pt>
                <c:pt idx="645">
                  <c:v>755.02499999998224</c:v>
                </c:pt>
                <c:pt idx="646">
                  <c:v>755.5749999999822</c:v>
                </c:pt>
                <c:pt idx="647">
                  <c:v>756.12499999998215</c:v>
                </c:pt>
                <c:pt idx="648">
                  <c:v>756.67499999998211</c:v>
                </c:pt>
                <c:pt idx="649">
                  <c:v>757.22499999998206</c:v>
                </c:pt>
                <c:pt idx="650">
                  <c:v>757.77499999998201</c:v>
                </c:pt>
                <c:pt idx="651">
                  <c:v>758.32499999998197</c:v>
                </c:pt>
                <c:pt idx="652">
                  <c:v>758.87499999998192</c:v>
                </c:pt>
                <c:pt idx="653">
                  <c:v>759.42499999998188</c:v>
                </c:pt>
                <c:pt idx="654">
                  <c:v>759.97499999998183</c:v>
                </c:pt>
                <c:pt idx="655">
                  <c:v>760.52499999998179</c:v>
                </c:pt>
                <c:pt idx="656">
                  <c:v>761.07499999998174</c:v>
                </c:pt>
                <c:pt idx="657">
                  <c:v>761.6249999999817</c:v>
                </c:pt>
                <c:pt idx="658">
                  <c:v>762.17499999998165</c:v>
                </c:pt>
                <c:pt idx="659">
                  <c:v>762.72499999998161</c:v>
                </c:pt>
                <c:pt idx="660">
                  <c:v>763.27499999998156</c:v>
                </c:pt>
                <c:pt idx="661">
                  <c:v>763.82499999998151</c:v>
                </c:pt>
                <c:pt idx="662">
                  <c:v>764.37499999998147</c:v>
                </c:pt>
                <c:pt idx="663">
                  <c:v>764.92499999998142</c:v>
                </c:pt>
                <c:pt idx="664">
                  <c:v>765.47499999998138</c:v>
                </c:pt>
                <c:pt idx="665">
                  <c:v>766.02499999998133</c:v>
                </c:pt>
                <c:pt idx="666">
                  <c:v>766.57499999998129</c:v>
                </c:pt>
                <c:pt idx="667">
                  <c:v>767.12499999998124</c:v>
                </c:pt>
                <c:pt idx="668">
                  <c:v>767.6749999999812</c:v>
                </c:pt>
                <c:pt idx="669">
                  <c:v>768.22499999998115</c:v>
                </c:pt>
                <c:pt idx="670">
                  <c:v>768.77499999998111</c:v>
                </c:pt>
                <c:pt idx="671">
                  <c:v>769.32499999998106</c:v>
                </c:pt>
                <c:pt idx="672">
                  <c:v>769.87499999998101</c:v>
                </c:pt>
                <c:pt idx="673">
                  <c:v>770.42499999998097</c:v>
                </c:pt>
                <c:pt idx="674">
                  <c:v>770.97499999998092</c:v>
                </c:pt>
                <c:pt idx="675">
                  <c:v>771.52499999998088</c:v>
                </c:pt>
                <c:pt idx="676">
                  <c:v>772.07499999998083</c:v>
                </c:pt>
                <c:pt idx="677">
                  <c:v>772.62499999998079</c:v>
                </c:pt>
                <c:pt idx="678">
                  <c:v>773.17499999998074</c:v>
                </c:pt>
                <c:pt idx="679">
                  <c:v>773.7249999999807</c:v>
                </c:pt>
                <c:pt idx="680">
                  <c:v>774.27499999998065</c:v>
                </c:pt>
                <c:pt idx="681">
                  <c:v>774.82499999998061</c:v>
                </c:pt>
                <c:pt idx="682">
                  <c:v>775.37499999998056</c:v>
                </c:pt>
                <c:pt idx="683">
                  <c:v>775.92499999998051</c:v>
                </c:pt>
                <c:pt idx="684">
                  <c:v>776.47499999998047</c:v>
                </c:pt>
                <c:pt idx="685">
                  <c:v>777.02499999998042</c:v>
                </c:pt>
                <c:pt idx="686">
                  <c:v>777.57499999998038</c:v>
                </c:pt>
                <c:pt idx="687">
                  <c:v>778.12499999998033</c:v>
                </c:pt>
                <c:pt idx="688">
                  <c:v>778.67499999998029</c:v>
                </c:pt>
                <c:pt idx="689">
                  <c:v>779.22499999998024</c:v>
                </c:pt>
                <c:pt idx="690">
                  <c:v>779.7749999999802</c:v>
                </c:pt>
                <c:pt idx="691">
                  <c:v>780.32499999998015</c:v>
                </c:pt>
                <c:pt idx="692">
                  <c:v>780.8749999999801</c:v>
                </c:pt>
                <c:pt idx="693">
                  <c:v>781.42499999998006</c:v>
                </c:pt>
                <c:pt idx="694">
                  <c:v>781.97499999998001</c:v>
                </c:pt>
                <c:pt idx="695">
                  <c:v>782.52499999997997</c:v>
                </c:pt>
                <c:pt idx="696">
                  <c:v>783.07499999997992</c:v>
                </c:pt>
                <c:pt idx="697">
                  <c:v>783.62499999997988</c:v>
                </c:pt>
                <c:pt idx="698">
                  <c:v>784.17499999997983</c:v>
                </c:pt>
                <c:pt idx="699">
                  <c:v>784.72499999997979</c:v>
                </c:pt>
                <c:pt idx="700">
                  <c:v>785.27499999997974</c:v>
                </c:pt>
                <c:pt idx="701">
                  <c:v>785.8249999999797</c:v>
                </c:pt>
                <c:pt idx="702">
                  <c:v>786.37499999997965</c:v>
                </c:pt>
                <c:pt idx="703">
                  <c:v>786.9249999999796</c:v>
                </c:pt>
                <c:pt idx="704">
                  <c:v>787.47499999997956</c:v>
                </c:pt>
                <c:pt idx="705">
                  <c:v>788.02499999997951</c:v>
                </c:pt>
                <c:pt idx="706">
                  <c:v>788.57499999997947</c:v>
                </c:pt>
                <c:pt idx="707">
                  <c:v>789.12499999997942</c:v>
                </c:pt>
                <c:pt idx="708">
                  <c:v>789.67499999997938</c:v>
                </c:pt>
                <c:pt idx="709">
                  <c:v>790.22499999997933</c:v>
                </c:pt>
                <c:pt idx="710">
                  <c:v>790.77499999997929</c:v>
                </c:pt>
                <c:pt idx="711">
                  <c:v>791.32499999997924</c:v>
                </c:pt>
                <c:pt idx="712">
                  <c:v>791.8749999999792</c:v>
                </c:pt>
                <c:pt idx="713">
                  <c:v>792.42499999997915</c:v>
                </c:pt>
                <c:pt idx="714">
                  <c:v>792.9749999999791</c:v>
                </c:pt>
                <c:pt idx="715">
                  <c:v>793.52499999997906</c:v>
                </c:pt>
                <c:pt idx="716">
                  <c:v>794.07499999997901</c:v>
                </c:pt>
                <c:pt idx="717">
                  <c:v>794.62499999997897</c:v>
                </c:pt>
                <c:pt idx="718">
                  <c:v>795.17499999997892</c:v>
                </c:pt>
                <c:pt idx="719">
                  <c:v>795.72499999997888</c:v>
                </c:pt>
                <c:pt idx="720">
                  <c:v>796.27499999997883</c:v>
                </c:pt>
                <c:pt idx="721">
                  <c:v>796.82499999997879</c:v>
                </c:pt>
                <c:pt idx="722">
                  <c:v>797.37499999997874</c:v>
                </c:pt>
                <c:pt idx="723">
                  <c:v>797.9249999999787</c:v>
                </c:pt>
                <c:pt idx="724">
                  <c:v>798.47499999997865</c:v>
                </c:pt>
                <c:pt idx="725">
                  <c:v>799.0249999999786</c:v>
                </c:pt>
                <c:pt idx="726">
                  <c:v>799.57499999997856</c:v>
                </c:pt>
                <c:pt idx="727">
                  <c:v>800.12499999997851</c:v>
                </c:pt>
                <c:pt idx="728">
                  <c:v>800.67499999997847</c:v>
                </c:pt>
                <c:pt idx="729">
                  <c:v>801.22499999997842</c:v>
                </c:pt>
                <c:pt idx="730">
                  <c:v>801.77499999997838</c:v>
                </c:pt>
                <c:pt idx="731">
                  <c:v>802.32499999997833</c:v>
                </c:pt>
                <c:pt idx="732">
                  <c:v>802.87499999997829</c:v>
                </c:pt>
                <c:pt idx="733">
                  <c:v>803.42499999997824</c:v>
                </c:pt>
                <c:pt idx="734">
                  <c:v>803.97499999997819</c:v>
                </c:pt>
                <c:pt idx="735">
                  <c:v>804.52499999997815</c:v>
                </c:pt>
                <c:pt idx="736">
                  <c:v>805.0749999999781</c:v>
                </c:pt>
                <c:pt idx="737">
                  <c:v>805.62499999997806</c:v>
                </c:pt>
                <c:pt idx="738">
                  <c:v>806.17499999997801</c:v>
                </c:pt>
                <c:pt idx="739">
                  <c:v>806.72499999997797</c:v>
                </c:pt>
                <c:pt idx="740">
                  <c:v>807.27499999997792</c:v>
                </c:pt>
                <c:pt idx="741">
                  <c:v>807.82499999997788</c:v>
                </c:pt>
                <c:pt idx="742">
                  <c:v>808.37499999997783</c:v>
                </c:pt>
                <c:pt idx="743">
                  <c:v>808.92499999997779</c:v>
                </c:pt>
                <c:pt idx="744">
                  <c:v>809.47499999997774</c:v>
                </c:pt>
                <c:pt idx="745">
                  <c:v>810.02499999997769</c:v>
                </c:pt>
                <c:pt idx="746">
                  <c:v>810.57499999997765</c:v>
                </c:pt>
                <c:pt idx="747">
                  <c:v>811.1249999999776</c:v>
                </c:pt>
                <c:pt idx="748">
                  <c:v>811.67499999997756</c:v>
                </c:pt>
                <c:pt idx="749">
                  <c:v>812.22499999997751</c:v>
                </c:pt>
                <c:pt idx="750">
                  <c:v>812.77499999997747</c:v>
                </c:pt>
                <c:pt idx="751">
                  <c:v>813.32499999997742</c:v>
                </c:pt>
                <c:pt idx="752">
                  <c:v>813.87499999997738</c:v>
                </c:pt>
                <c:pt idx="753">
                  <c:v>814.42499999997733</c:v>
                </c:pt>
                <c:pt idx="754">
                  <c:v>814.97499999997729</c:v>
                </c:pt>
                <c:pt idx="755">
                  <c:v>815.52499999997724</c:v>
                </c:pt>
                <c:pt idx="756">
                  <c:v>816.07499999997719</c:v>
                </c:pt>
                <c:pt idx="757">
                  <c:v>816.62499999997715</c:v>
                </c:pt>
                <c:pt idx="758">
                  <c:v>817.1749999999771</c:v>
                </c:pt>
                <c:pt idx="759">
                  <c:v>817.72499999997706</c:v>
                </c:pt>
                <c:pt idx="760">
                  <c:v>818.27499999997701</c:v>
                </c:pt>
                <c:pt idx="761">
                  <c:v>818.82499999997697</c:v>
                </c:pt>
                <c:pt idx="762">
                  <c:v>819.37499999997692</c:v>
                </c:pt>
                <c:pt idx="763">
                  <c:v>819.92499999997688</c:v>
                </c:pt>
                <c:pt idx="764">
                  <c:v>820.47499999997683</c:v>
                </c:pt>
                <c:pt idx="765">
                  <c:v>821.02499999997679</c:v>
                </c:pt>
                <c:pt idx="766">
                  <c:v>821.57499999997674</c:v>
                </c:pt>
                <c:pt idx="767">
                  <c:v>822.12499999997669</c:v>
                </c:pt>
                <c:pt idx="768">
                  <c:v>822.67499999997665</c:v>
                </c:pt>
                <c:pt idx="769">
                  <c:v>823.2249999999766</c:v>
                </c:pt>
                <c:pt idx="770">
                  <c:v>823.77499999997656</c:v>
                </c:pt>
                <c:pt idx="771">
                  <c:v>824.32499999997651</c:v>
                </c:pt>
                <c:pt idx="772">
                  <c:v>824.87499999997647</c:v>
                </c:pt>
                <c:pt idx="773">
                  <c:v>825.42499999997642</c:v>
                </c:pt>
                <c:pt idx="774">
                  <c:v>825.97499999997638</c:v>
                </c:pt>
                <c:pt idx="775">
                  <c:v>826.52499999997633</c:v>
                </c:pt>
                <c:pt idx="776">
                  <c:v>827.07499999997628</c:v>
                </c:pt>
                <c:pt idx="777">
                  <c:v>827.62499999997624</c:v>
                </c:pt>
                <c:pt idx="778">
                  <c:v>828.17499999997619</c:v>
                </c:pt>
                <c:pt idx="779">
                  <c:v>828.72499999997615</c:v>
                </c:pt>
                <c:pt idx="780">
                  <c:v>829.2749999999761</c:v>
                </c:pt>
                <c:pt idx="781">
                  <c:v>829.82499999997606</c:v>
                </c:pt>
                <c:pt idx="782">
                  <c:v>830.37499999997601</c:v>
                </c:pt>
                <c:pt idx="783">
                  <c:v>830.92499999997597</c:v>
                </c:pt>
                <c:pt idx="784">
                  <c:v>831.47499999997592</c:v>
                </c:pt>
                <c:pt idx="785">
                  <c:v>832.02499999997588</c:v>
                </c:pt>
                <c:pt idx="786">
                  <c:v>832.57499999997583</c:v>
                </c:pt>
                <c:pt idx="787">
                  <c:v>833.12499999997578</c:v>
                </c:pt>
                <c:pt idx="788">
                  <c:v>833.67499999997574</c:v>
                </c:pt>
                <c:pt idx="789">
                  <c:v>834.22499999997569</c:v>
                </c:pt>
                <c:pt idx="790">
                  <c:v>834.77499999997565</c:v>
                </c:pt>
                <c:pt idx="791">
                  <c:v>835.3249999999756</c:v>
                </c:pt>
                <c:pt idx="792">
                  <c:v>835.87499999997556</c:v>
                </c:pt>
                <c:pt idx="793">
                  <c:v>836.42499999997551</c:v>
                </c:pt>
                <c:pt idx="794">
                  <c:v>836.97499999997547</c:v>
                </c:pt>
                <c:pt idx="795">
                  <c:v>837.52499999997542</c:v>
                </c:pt>
                <c:pt idx="796">
                  <c:v>838.07499999997538</c:v>
                </c:pt>
                <c:pt idx="797">
                  <c:v>838.62499999997533</c:v>
                </c:pt>
                <c:pt idx="798">
                  <c:v>839.17499999997528</c:v>
                </c:pt>
                <c:pt idx="799">
                  <c:v>839.72499999997524</c:v>
                </c:pt>
                <c:pt idx="800">
                  <c:v>840.27499999997519</c:v>
                </c:pt>
                <c:pt idx="801">
                  <c:v>840.82499999997515</c:v>
                </c:pt>
                <c:pt idx="802">
                  <c:v>841.3749999999751</c:v>
                </c:pt>
                <c:pt idx="803">
                  <c:v>841.92499999997506</c:v>
                </c:pt>
                <c:pt idx="804">
                  <c:v>842.47499999997501</c:v>
                </c:pt>
                <c:pt idx="805">
                  <c:v>843.02499999997497</c:v>
                </c:pt>
                <c:pt idx="806">
                  <c:v>843.57499999997492</c:v>
                </c:pt>
                <c:pt idx="807">
                  <c:v>844.12499999997488</c:v>
                </c:pt>
                <c:pt idx="808">
                  <c:v>844.67499999997483</c:v>
                </c:pt>
                <c:pt idx="809">
                  <c:v>845.22499999997478</c:v>
                </c:pt>
                <c:pt idx="810">
                  <c:v>845.77499999997474</c:v>
                </c:pt>
                <c:pt idx="811">
                  <c:v>846.32499999997469</c:v>
                </c:pt>
                <c:pt idx="812">
                  <c:v>846.87499999997465</c:v>
                </c:pt>
                <c:pt idx="813">
                  <c:v>847.4249999999746</c:v>
                </c:pt>
                <c:pt idx="814">
                  <c:v>847.97499999997456</c:v>
                </c:pt>
                <c:pt idx="815">
                  <c:v>848.52499999997451</c:v>
                </c:pt>
                <c:pt idx="816">
                  <c:v>849.07499999997447</c:v>
                </c:pt>
                <c:pt idx="817">
                  <c:v>849.62499999997442</c:v>
                </c:pt>
                <c:pt idx="818">
                  <c:v>850.17499999997437</c:v>
                </c:pt>
                <c:pt idx="819">
                  <c:v>850.72499999997433</c:v>
                </c:pt>
                <c:pt idx="820">
                  <c:v>851.27499999997428</c:v>
                </c:pt>
                <c:pt idx="821">
                  <c:v>851.82499999997424</c:v>
                </c:pt>
                <c:pt idx="822">
                  <c:v>852.37499999997419</c:v>
                </c:pt>
                <c:pt idx="823">
                  <c:v>852.92499999997415</c:v>
                </c:pt>
                <c:pt idx="824">
                  <c:v>853.4749999999741</c:v>
                </c:pt>
                <c:pt idx="825">
                  <c:v>854.02499999997406</c:v>
                </c:pt>
                <c:pt idx="826">
                  <c:v>854.57499999997401</c:v>
                </c:pt>
                <c:pt idx="827">
                  <c:v>855.12499999997397</c:v>
                </c:pt>
                <c:pt idx="828">
                  <c:v>855.67499999997392</c:v>
                </c:pt>
                <c:pt idx="829">
                  <c:v>856.22499999997387</c:v>
                </c:pt>
                <c:pt idx="830">
                  <c:v>856.77499999997383</c:v>
                </c:pt>
                <c:pt idx="831">
                  <c:v>857.32499999997378</c:v>
                </c:pt>
                <c:pt idx="832">
                  <c:v>857.87499999997374</c:v>
                </c:pt>
                <c:pt idx="833">
                  <c:v>858.42499999997369</c:v>
                </c:pt>
                <c:pt idx="834">
                  <c:v>858.97499999997365</c:v>
                </c:pt>
                <c:pt idx="835">
                  <c:v>859.5249999999736</c:v>
                </c:pt>
                <c:pt idx="836">
                  <c:v>860.07499999997356</c:v>
                </c:pt>
                <c:pt idx="837">
                  <c:v>860.62499999997351</c:v>
                </c:pt>
                <c:pt idx="838">
                  <c:v>861.17499999997347</c:v>
                </c:pt>
                <c:pt idx="839">
                  <c:v>861.72499999997342</c:v>
                </c:pt>
                <c:pt idx="840">
                  <c:v>862.27499999997337</c:v>
                </c:pt>
                <c:pt idx="841">
                  <c:v>862.82499999997333</c:v>
                </c:pt>
                <c:pt idx="842">
                  <c:v>863.37499999997328</c:v>
                </c:pt>
                <c:pt idx="843">
                  <c:v>863.92499999997324</c:v>
                </c:pt>
                <c:pt idx="844">
                  <c:v>864.47499999997319</c:v>
                </c:pt>
                <c:pt idx="845">
                  <c:v>865.02499999997315</c:v>
                </c:pt>
                <c:pt idx="846">
                  <c:v>865.5749999999731</c:v>
                </c:pt>
                <c:pt idx="847">
                  <c:v>866.12499999997306</c:v>
                </c:pt>
                <c:pt idx="848">
                  <c:v>866.67499999997301</c:v>
                </c:pt>
                <c:pt idx="849">
                  <c:v>867.22499999997297</c:v>
                </c:pt>
                <c:pt idx="850">
                  <c:v>867.77499999997292</c:v>
                </c:pt>
                <c:pt idx="851">
                  <c:v>868.32499999997287</c:v>
                </c:pt>
                <c:pt idx="852">
                  <c:v>868.87499999997283</c:v>
                </c:pt>
                <c:pt idx="853">
                  <c:v>869.42499999997278</c:v>
                </c:pt>
                <c:pt idx="854">
                  <c:v>869.97499999997274</c:v>
                </c:pt>
                <c:pt idx="855">
                  <c:v>870.52499999997269</c:v>
                </c:pt>
                <c:pt idx="856">
                  <c:v>871.07499999997265</c:v>
                </c:pt>
                <c:pt idx="857">
                  <c:v>871.6249999999726</c:v>
                </c:pt>
                <c:pt idx="858">
                  <c:v>872.17499999997256</c:v>
                </c:pt>
                <c:pt idx="859">
                  <c:v>872.72499999997251</c:v>
                </c:pt>
                <c:pt idx="860">
                  <c:v>873.27499999997247</c:v>
                </c:pt>
                <c:pt idx="861">
                  <c:v>873.82499999997242</c:v>
                </c:pt>
                <c:pt idx="862">
                  <c:v>874.37499999997237</c:v>
                </c:pt>
                <c:pt idx="863">
                  <c:v>874.92499999997233</c:v>
                </c:pt>
                <c:pt idx="864">
                  <c:v>875.47499999997228</c:v>
                </c:pt>
                <c:pt idx="865">
                  <c:v>876.02499999997224</c:v>
                </c:pt>
                <c:pt idx="866">
                  <c:v>876.57499999997219</c:v>
                </c:pt>
                <c:pt idx="867">
                  <c:v>877.12499999997215</c:v>
                </c:pt>
                <c:pt idx="868">
                  <c:v>877.6749999999721</c:v>
                </c:pt>
                <c:pt idx="869">
                  <c:v>878.22499999997206</c:v>
                </c:pt>
                <c:pt idx="870">
                  <c:v>878.77499999997201</c:v>
                </c:pt>
                <c:pt idx="871">
                  <c:v>879.32499999997196</c:v>
                </c:pt>
                <c:pt idx="872">
                  <c:v>879.87499999997192</c:v>
                </c:pt>
                <c:pt idx="873">
                  <c:v>880.42499999997187</c:v>
                </c:pt>
                <c:pt idx="874">
                  <c:v>880.97499999997183</c:v>
                </c:pt>
                <c:pt idx="875">
                  <c:v>881.52499999997178</c:v>
                </c:pt>
                <c:pt idx="876">
                  <c:v>882.07499999997174</c:v>
                </c:pt>
                <c:pt idx="877">
                  <c:v>882.62499999997169</c:v>
                </c:pt>
                <c:pt idx="878">
                  <c:v>883.17499999997165</c:v>
                </c:pt>
                <c:pt idx="879">
                  <c:v>883.7249999999716</c:v>
                </c:pt>
                <c:pt idx="880">
                  <c:v>884.27499999997156</c:v>
                </c:pt>
                <c:pt idx="881">
                  <c:v>884.82499999997151</c:v>
                </c:pt>
                <c:pt idx="882">
                  <c:v>885.37499999997146</c:v>
                </c:pt>
                <c:pt idx="883">
                  <c:v>885.92499999997142</c:v>
                </c:pt>
                <c:pt idx="884">
                  <c:v>886.47499999997137</c:v>
                </c:pt>
                <c:pt idx="885">
                  <c:v>887.02499999997133</c:v>
                </c:pt>
                <c:pt idx="886">
                  <c:v>887.57499999997128</c:v>
                </c:pt>
                <c:pt idx="887">
                  <c:v>888.12499999997124</c:v>
                </c:pt>
                <c:pt idx="888">
                  <c:v>888.67499999997119</c:v>
                </c:pt>
                <c:pt idx="889">
                  <c:v>889.22499999997115</c:v>
                </c:pt>
                <c:pt idx="890">
                  <c:v>889.7749999999711</c:v>
                </c:pt>
                <c:pt idx="891">
                  <c:v>890.32499999997106</c:v>
                </c:pt>
                <c:pt idx="892">
                  <c:v>890.87499999997101</c:v>
                </c:pt>
                <c:pt idx="893">
                  <c:v>891.42499999997096</c:v>
                </c:pt>
                <c:pt idx="894">
                  <c:v>891.97499999997092</c:v>
                </c:pt>
                <c:pt idx="895">
                  <c:v>892.52499999997087</c:v>
                </c:pt>
                <c:pt idx="896">
                  <c:v>893.07499999997083</c:v>
                </c:pt>
                <c:pt idx="897">
                  <c:v>893.62499999997078</c:v>
                </c:pt>
                <c:pt idx="898">
                  <c:v>894.17499999997074</c:v>
                </c:pt>
                <c:pt idx="899">
                  <c:v>894.72499999997069</c:v>
                </c:pt>
                <c:pt idx="900">
                  <c:v>895.27499999997065</c:v>
                </c:pt>
                <c:pt idx="901">
                  <c:v>895.8249999999706</c:v>
                </c:pt>
                <c:pt idx="902">
                  <c:v>896.37499999997056</c:v>
                </c:pt>
                <c:pt idx="903">
                  <c:v>896.92499999997051</c:v>
                </c:pt>
                <c:pt idx="904">
                  <c:v>897.47499999997046</c:v>
                </c:pt>
                <c:pt idx="905">
                  <c:v>898.02499999997042</c:v>
                </c:pt>
                <c:pt idx="906">
                  <c:v>898.57499999997037</c:v>
                </c:pt>
                <c:pt idx="907">
                  <c:v>899.12499999997033</c:v>
                </c:pt>
                <c:pt idx="908">
                  <c:v>899.67499999997028</c:v>
                </c:pt>
                <c:pt idx="909">
                  <c:v>900.22499999997024</c:v>
                </c:pt>
                <c:pt idx="910">
                  <c:v>900.77499999997019</c:v>
                </c:pt>
                <c:pt idx="911">
                  <c:v>901.32499999997015</c:v>
                </c:pt>
                <c:pt idx="912">
                  <c:v>901.8749999999701</c:v>
                </c:pt>
                <c:pt idx="913">
                  <c:v>902.42499999997005</c:v>
                </c:pt>
                <c:pt idx="914">
                  <c:v>902.97499999997001</c:v>
                </c:pt>
                <c:pt idx="915">
                  <c:v>903.52499999996996</c:v>
                </c:pt>
                <c:pt idx="916">
                  <c:v>904.07499999996992</c:v>
                </c:pt>
                <c:pt idx="917">
                  <c:v>904.62499999996987</c:v>
                </c:pt>
                <c:pt idx="918">
                  <c:v>905.17499999996983</c:v>
                </c:pt>
                <c:pt idx="919">
                  <c:v>905.72499999996978</c:v>
                </c:pt>
                <c:pt idx="920">
                  <c:v>906.27499999996974</c:v>
                </c:pt>
                <c:pt idx="921">
                  <c:v>906.82499999996969</c:v>
                </c:pt>
                <c:pt idx="922">
                  <c:v>907.37499999996965</c:v>
                </c:pt>
                <c:pt idx="923">
                  <c:v>907.9249999999696</c:v>
                </c:pt>
                <c:pt idx="924">
                  <c:v>908.47499999996955</c:v>
                </c:pt>
                <c:pt idx="925">
                  <c:v>909.02499999996951</c:v>
                </c:pt>
                <c:pt idx="926">
                  <c:v>909.57499999996946</c:v>
                </c:pt>
                <c:pt idx="927">
                  <c:v>910.12499999996942</c:v>
                </c:pt>
                <c:pt idx="928">
                  <c:v>910.67499999996937</c:v>
                </c:pt>
                <c:pt idx="929">
                  <c:v>911.22499999996933</c:v>
                </c:pt>
                <c:pt idx="930">
                  <c:v>911.77499999996928</c:v>
                </c:pt>
                <c:pt idx="931">
                  <c:v>912.32499999996924</c:v>
                </c:pt>
                <c:pt idx="932">
                  <c:v>912.87499999996919</c:v>
                </c:pt>
                <c:pt idx="933">
                  <c:v>913.42499999996915</c:v>
                </c:pt>
                <c:pt idx="934">
                  <c:v>913.9749999999691</c:v>
                </c:pt>
                <c:pt idx="935">
                  <c:v>914.52499999996905</c:v>
                </c:pt>
                <c:pt idx="936">
                  <c:v>915.07499999996901</c:v>
                </c:pt>
                <c:pt idx="937">
                  <c:v>915.62499999996896</c:v>
                </c:pt>
                <c:pt idx="938">
                  <c:v>916.17499999996892</c:v>
                </c:pt>
                <c:pt idx="939">
                  <c:v>916.72499999996887</c:v>
                </c:pt>
                <c:pt idx="940">
                  <c:v>917.27499999996883</c:v>
                </c:pt>
                <c:pt idx="941">
                  <c:v>917.82499999996878</c:v>
                </c:pt>
                <c:pt idx="942">
                  <c:v>918.37499999996874</c:v>
                </c:pt>
                <c:pt idx="943">
                  <c:v>918.92499999996869</c:v>
                </c:pt>
                <c:pt idx="944">
                  <c:v>919.47499999996865</c:v>
                </c:pt>
                <c:pt idx="945">
                  <c:v>920.0249999999686</c:v>
                </c:pt>
                <c:pt idx="946">
                  <c:v>920.57499999996855</c:v>
                </c:pt>
                <c:pt idx="947">
                  <c:v>921.12499999996851</c:v>
                </c:pt>
                <c:pt idx="948">
                  <c:v>921.67499999996846</c:v>
                </c:pt>
                <c:pt idx="949">
                  <c:v>922.22499999996842</c:v>
                </c:pt>
                <c:pt idx="950">
                  <c:v>922.77499999996837</c:v>
                </c:pt>
                <c:pt idx="951">
                  <c:v>923.32499999996833</c:v>
                </c:pt>
                <c:pt idx="952">
                  <c:v>923.87499999996828</c:v>
                </c:pt>
                <c:pt idx="953">
                  <c:v>924.42499999996824</c:v>
                </c:pt>
                <c:pt idx="954">
                  <c:v>924.97499999996819</c:v>
                </c:pt>
                <c:pt idx="955">
                  <c:v>925.52499999996814</c:v>
                </c:pt>
                <c:pt idx="956">
                  <c:v>926.0749999999681</c:v>
                </c:pt>
                <c:pt idx="957">
                  <c:v>926.62499999996805</c:v>
                </c:pt>
                <c:pt idx="958">
                  <c:v>927.17499999996801</c:v>
                </c:pt>
                <c:pt idx="959">
                  <c:v>927.72499999996796</c:v>
                </c:pt>
                <c:pt idx="960">
                  <c:v>928.27499999996792</c:v>
                </c:pt>
                <c:pt idx="961">
                  <c:v>928.82499999996787</c:v>
                </c:pt>
                <c:pt idx="962">
                  <c:v>929.37499999996783</c:v>
                </c:pt>
                <c:pt idx="963">
                  <c:v>929.92499999996778</c:v>
                </c:pt>
                <c:pt idx="964">
                  <c:v>930.47499999996774</c:v>
                </c:pt>
                <c:pt idx="965">
                  <c:v>931.02499999996769</c:v>
                </c:pt>
                <c:pt idx="966">
                  <c:v>931.57499999996764</c:v>
                </c:pt>
                <c:pt idx="967">
                  <c:v>932.1249999999676</c:v>
                </c:pt>
                <c:pt idx="968">
                  <c:v>932.67499999996755</c:v>
                </c:pt>
                <c:pt idx="969">
                  <c:v>933.22499999996751</c:v>
                </c:pt>
                <c:pt idx="970">
                  <c:v>933.77499999996746</c:v>
                </c:pt>
                <c:pt idx="971">
                  <c:v>934.32499999996742</c:v>
                </c:pt>
                <c:pt idx="972">
                  <c:v>934.87499999996737</c:v>
                </c:pt>
                <c:pt idx="973">
                  <c:v>935.42499999996733</c:v>
                </c:pt>
                <c:pt idx="974">
                  <c:v>935.97499999996728</c:v>
                </c:pt>
                <c:pt idx="975">
                  <c:v>936.52499999996724</c:v>
                </c:pt>
                <c:pt idx="976">
                  <c:v>937.07499999996719</c:v>
                </c:pt>
                <c:pt idx="977">
                  <c:v>937.62499999996714</c:v>
                </c:pt>
                <c:pt idx="978">
                  <c:v>938.1749999999671</c:v>
                </c:pt>
                <c:pt idx="979">
                  <c:v>938.72499999996705</c:v>
                </c:pt>
                <c:pt idx="980">
                  <c:v>939.27499999996701</c:v>
                </c:pt>
                <c:pt idx="981">
                  <c:v>939.82499999996696</c:v>
                </c:pt>
                <c:pt idx="982">
                  <c:v>940.37499999996692</c:v>
                </c:pt>
                <c:pt idx="983">
                  <c:v>940.92499999996687</c:v>
                </c:pt>
                <c:pt idx="984">
                  <c:v>941.47499999996683</c:v>
                </c:pt>
                <c:pt idx="985">
                  <c:v>942.02499999996678</c:v>
                </c:pt>
                <c:pt idx="986">
                  <c:v>942.57499999996674</c:v>
                </c:pt>
                <c:pt idx="987">
                  <c:v>943.12499999996669</c:v>
                </c:pt>
                <c:pt idx="988">
                  <c:v>943.67499999996664</c:v>
                </c:pt>
                <c:pt idx="989">
                  <c:v>944.2249999999666</c:v>
                </c:pt>
                <c:pt idx="990">
                  <c:v>944.77499999996655</c:v>
                </c:pt>
                <c:pt idx="991">
                  <c:v>945.32499999996651</c:v>
                </c:pt>
                <c:pt idx="992">
                  <c:v>945.87499999996646</c:v>
                </c:pt>
                <c:pt idx="993">
                  <c:v>946.42499999996642</c:v>
                </c:pt>
                <c:pt idx="994">
                  <c:v>946.97499999996637</c:v>
                </c:pt>
                <c:pt idx="995">
                  <c:v>947.52499999996633</c:v>
                </c:pt>
                <c:pt idx="996">
                  <c:v>948.07499999996628</c:v>
                </c:pt>
                <c:pt idx="997">
                  <c:v>948.62499999996624</c:v>
                </c:pt>
                <c:pt idx="998">
                  <c:v>949.17499999996619</c:v>
                </c:pt>
                <c:pt idx="999">
                  <c:v>949.72499999996614</c:v>
                </c:pt>
                <c:pt idx="1000">
                  <c:v>950.2749999999661</c:v>
                </c:pt>
                <c:pt idx="1001">
                  <c:v>950.82499999996605</c:v>
                </c:pt>
                <c:pt idx="1002">
                  <c:v>951.37499999996601</c:v>
                </c:pt>
                <c:pt idx="1003">
                  <c:v>951.92499999996596</c:v>
                </c:pt>
                <c:pt idx="1004">
                  <c:v>952.47499999996592</c:v>
                </c:pt>
                <c:pt idx="1005">
                  <c:v>953.02499999996587</c:v>
                </c:pt>
                <c:pt idx="1006">
                  <c:v>953.57499999996583</c:v>
                </c:pt>
                <c:pt idx="1007">
                  <c:v>954.12499999996578</c:v>
                </c:pt>
                <c:pt idx="1008">
                  <c:v>954.67499999996573</c:v>
                </c:pt>
                <c:pt idx="1009">
                  <c:v>955.22499999996569</c:v>
                </c:pt>
                <c:pt idx="1010">
                  <c:v>955.77499999996564</c:v>
                </c:pt>
                <c:pt idx="1011">
                  <c:v>956.3249999999656</c:v>
                </c:pt>
                <c:pt idx="1012">
                  <c:v>956.87499999996555</c:v>
                </c:pt>
                <c:pt idx="1013">
                  <c:v>957.42499999996551</c:v>
                </c:pt>
                <c:pt idx="1014">
                  <c:v>957.97499999996546</c:v>
                </c:pt>
                <c:pt idx="1015">
                  <c:v>958.52499999996542</c:v>
                </c:pt>
                <c:pt idx="1016">
                  <c:v>959.07499999996537</c:v>
                </c:pt>
                <c:pt idx="1017">
                  <c:v>959.62499999996533</c:v>
                </c:pt>
                <c:pt idx="1018">
                  <c:v>960.17499999996528</c:v>
                </c:pt>
                <c:pt idx="1019">
                  <c:v>960.72499999996523</c:v>
                </c:pt>
                <c:pt idx="1020">
                  <c:v>961.27499999996519</c:v>
                </c:pt>
                <c:pt idx="1021">
                  <c:v>961.82499999996514</c:v>
                </c:pt>
                <c:pt idx="1022">
                  <c:v>962.3749999999651</c:v>
                </c:pt>
                <c:pt idx="1023">
                  <c:v>962.92499999996505</c:v>
                </c:pt>
                <c:pt idx="1024">
                  <c:v>963.47499999996501</c:v>
                </c:pt>
                <c:pt idx="1025">
                  <c:v>964.02499999996496</c:v>
                </c:pt>
                <c:pt idx="1026">
                  <c:v>964.57499999996492</c:v>
                </c:pt>
                <c:pt idx="1027">
                  <c:v>965.12499999996487</c:v>
                </c:pt>
                <c:pt idx="1028">
                  <c:v>965.67499999996483</c:v>
                </c:pt>
                <c:pt idx="1029">
                  <c:v>966.22499999996478</c:v>
                </c:pt>
                <c:pt idx="1030">
                  <c:v>966.77499999996473</c:v>
                </c:pt>
                <c:pt idx="1031">
                  <c:v>967.32499999996469</c:v>
                </c:pt>
                <c:pt idx="1032">
                  <c:v>967.87499999996464</c:v>
                </c:pt>
                <c:pt idx="1033">
                  <c:v>968.4249999999646</c:v>
                </c:pt>
                <c:pt idx="1034">
                  <c:v>968.97499999996455</c:v>
                </c:pt>
                <c:pt idx="1035">
                  <c:v>969.52499999996451</c:v>
                </c:pt>
                <c:pt idx="1036">
                  <c:v>970.07499999996446</c:v>
                </c:pt>
                <c:pt idx="1037">
                  <c:v>970.62499999996442</c:v>
                </c:pt>
                <c:pt idx="1038">
                  <c:v>971.17499999996437</c:v>
                </c:pt>
                <c:pt idx="1039">
                  <c:v>971.72499999996433</c:v>
                </c:pt>
                <c:pt idx="1040">
                  <c:v>972.27499999996428</c:v>
                </c:pt>
                <c:pt idx="1041">
                  <c:v>972.82499999996423</c:v>
                </c:pt>
                <c:pt idx="1042">
                  <c:v>973.37499999996419</c:v>
                </c:pt>
                <c:pt idx="1043">
                  <c:v>973.92499999996414</c:v>
                </c:pt>
                <c:pt idx="1044">
                  <c:v>974.4749999999641</c:v>
                </c:pt>
                <c:pt idx="1045">
                  <c:v>975.02499999996405</c:v>
                </c:pt>
                <c:pt idx="1046">
                  <c:v>975.57499999996401</c:v>
                </c:pt>
                <c:pt idx="1047">
                  <c:v>976.12499999996396</c:v>
                </c:pt>
                <c:pt idx="1048">
                  <c:v>976.67499999996392</c:v>
                </c:pt>
                <c:pt idx="1049">
                  <c:v>977.22499999996387</c:v>
                </c:pt>
                <c:pt idx="1050">
                  <c:v>977.77499999996382</c:v>
                </c:pt>
                <c:pt idx="1051">
                  <c:v>978.32499999996378</c:v>
                </c:pt>
                <c:pt idx="1052">
                  <c:v>978.87499999996373</c:v>
                </c:pt>
                <c:pt idx="1053">
                  <c:v>979.42499999996369</c:v>
                </c:pt>
                <c:pt idx="1054">
                  <c:v>979.97499999996364</c:v>
                </c:pt>
                <c:pt idx="1055">
                  <c:v>980.5249999999636</c:v>
                </c:pt>
                <c:pt idx="1056">
                  <c:v>981.07499999996355</c:v>
                </c:pt>
                <c:pt idx="1057">
                  <c:v>981.62499999996351</c:v>
                </c:pt>
                <c:pt idx="1058">
                  <c:v>982.17499999996346</c:v>
                </c:pt>
                <c:pt idx="1059">
                  <c:v>982.72499999996342</c:v>
                </c:pt>
                <c:pt idx="1060">
                  <c:v>983.27499999996337</c:v>
                </c:pt>
                <c:pt idx="1061">
                  <c:v>983.82499999996332</c:v>
                </c:pt>
                <c:pt idx="1062">
                  <c:v>984.37499999996328</c:v>
                </c:pt>
                <c:pt idx="1063">
                  <c:v>984.92499999996323</c:v>
                </c:pt>
                <c:pt idx="1064">
                  <c:v>985.47499999996319</c:v>
                </c:pt>
                <c:pt idx="1065">
                  <c:v>986.02499999996314</c:v>
                </c:pt>
                <c:pt idx="1066">
                  <c:v>986.5749999999631</c:v>
                </c:pt>
                <c:pt idx="1067">
                  <c:v>987.12499999996305</c:v>
                </c:pt>
                <c:pt idx="1068">
                  <c:v>987.67499999996301</c:v>
                </c:pt>
                <c:pt idx="1069">
                  <c:v>988.22499999996296</c:v>
                </c:pt>
                <c:pt idx="1070">
                  <c:v>988.77499999996292</c:v>
                </c:pt>
                <c:pt idx="1071">
                  <c:v>989.32499999996287</c:v>
                </c:pt>
                <c:pt idx="1072">
                  <c:v>989.87499999996282</c:v>
                </c:pt>
                <c:pt idx="1073">
                  <c:v>990.42499999996278</c:v>
                </c:pt>
                <c:pt idx="1074">
                  <c:v>990.97499999996273</c:v>
                </c:pt>
                <c:pt idx="1075">
                  <c:v>991.52499999996269</c:v>
                </c:pt>
                <c:pt idx="1076">
                  <c:v>992.07499999996264</c:v>
                </c:pt>
                <c:pt idx="1077">
                  <c:v>992.6249999999626</c:v>
                </c:pt>
                <c:pt idx="1078">
                  <c:v>993.17499999996255</c:v>
                </c:pt>
                <c:pt idx="1079">
                  <c:v>993.72499999996251</c:v>
                </c:pt>
                <c:pt idx="1080">
                  <c:v>994.27499999996246</c:v>
                </c:pt>
                <c:pt idx="1081">
                  <c:v>994.82499999996242</c:v>
                </c:pt>
                <c:pt idx="1082">
                  <c:v>995.37499999996237</c:v>
                </c:pt>
                <c:pt idx="1083">
                  <c:v>995.92499999996232</c:v>
                </c:pt>
                <c:pt idx="1084">
                  <c:v>996.47499999996228</c:v>
                </c:pt>
                <c:pt idx="1085">
                  <c:v>997.02499999996223</c:v>
                </c:pt>
                <c:pt idx="1086">
                  <c:v>997.57499999996219</c:v>
                </c:pt>
                <c:pt idx="1087">
                  <c:v>998.12499999996214</c:v>
                </c:pt>
                <c:pt idx="1088">
                  <c:v>998.6749999999621</c:v>
                </c:pt>
                <c:pt idx="1089">
                  <c:v>999.22499999996205</c:v>
                </c:pt>
                <c:pt idx="1090">
                  <c:v>999.77499999996201</c:v>
                </c:pt>
                <c:pt idx="1091">
                  <c:v>1000.324999999962</c:v>
                </c:pt>
                <c:pt idx="1092">
                  <c:v>1000.8749999999619</c:v>
                </c:pt>
                <c:pt idx="1093">
                  <c:v>1001.4249999999619</c:v>
                </c:pt>
                <c:pt idx="1094">
                  <c:v>1001.9749999999618</c:v>
                </c:pt>
                <c:pt idx="1095">
                  <c:v>1002.5249999999618</c:v>
                </c:pt>
                <c:pt idx="1096">
                  <c:v>1003.0749999999617</c:v>
                </c:pt>
                <c:pt idx="1097">
                  <c:v>1003.6249999999617</c:v>
                </c:pt>
                <c:pt idx="1098">
                  <c:v>1004.1749999999616</c:v>
                </c:pt>
                <c:pt idx="1099">
                  <c:v>1004.7249999999616</c:v>
                </c:pt>
                <c:pt idx="1100">
                  <c:v>1005.2749999999616</c:v>
                </c:pt>
                <c:pt idx="1101">
                  <c:v>1005.8249999999615</c:v>
                </c:pt>
                <c:pt idx="1102">
                  <c:v>1006.3749999999615</c:v>
                </c:pt>
                <c:pt idx="1103">
                  <c:v>1006.9249999999614</c:v>
                </c:pt>
                <c:pt idx="1104">
                  <c:v>1007.4749999999614</c:v>
                </c:pt>
                <c:pt idx="1105">
                  <c:v>1008.0249999999613</c:v>
                </c:pt>
                <c:pt idx="1106">
                  <c:v>1008.5749999999613</c:v>
                </c:pt>
                <c:pt idx="1107">
                  <c:v>1009.1249999999612</c:v>
                </c:pt>
                <c:pt idx="1108">
                  <c:v>1009.6749999999612</c:v>
                </c:pt>
                <c:pt idx="1109">
                  <c:v>1010.2249999999611</c:v>
                </c:pt>
                <c:pt idx="1110">
                  <c:v>1010.7749999999611</c:v>
                </c:pt>
                <c:pt idx="1111">
                  <c:v>1011.3249999999611</c:v>
                </c:pt>
                <c:pt idx="1112">
                  <c:v>1011.874999999961</c:v>
                </c:pt>
                <c:pt idx="1113">
                  <c:v>1012.424999999961</c:v>
                </c:pt>
                <c:pt idx="1114">
                  <c:v>1012.9749999999609</c:v>
                </c:pt>
                <c:pt idx="1115">
                  <c:v>1013.5249999999609</c:v>
                </c:pt>
                <c:pt idx="1116">
                  <c:v>1014.0749999999608</c:v>
                </c:pt>
                <c:pt idx="1117">
                  <c:v>1014.6249999999608</c:v>
                </c:pt>
                <c:pt idx="1118">
                  <c:v>1015.1749999999607</c:v>
                </c:pt>
                <c:pt idx="1119">
                  <c:v>1015.7249999999607</c:v>
                </c:pt>
                <c:pt idx="1120">
                  <c:v>1016.2749999999606</c:v>
                </c:pt>
                <c:pt idx="1121">
                  <c:v>1016.8249999999606</c:v>
                </c:pt>
                <c:pt idx="1122">
                  <c:v>1017.3749999999606</c:v>
                </c:pt>
                <c:pt idx="1123">
                  <c:v>1017.9249999999605</c:v>
                </c:pt>
                <c:pt idx="1124">
                  <c:v>1018.4749999999605</c:v>
                </c:pt>
                <c:pt idx="1125">
                  <c:v>1019.0249999999604</c:v>
                </c:pt>
                <c:pt idx="1126">
                  <c:v>1019.5749999999604</c:v>
                </c:pt>
                <c:pt idx="1127">
                  <c:v>1020.1249999999603</c:v>
                </c:pt>
                <c:pt idx="1128">
                  <c:v>1020.6749999999603</c:v>
                </c:pt>
                <c:pt idx="1129">
                  <c:v>1021.2249999999602</c:v>
                </c:pt>
                <c:pt idx="1130">
                  <c:v>1021.7749999999602</c:v>
                </c:pt>
                <c:pt idx="1131">
                  <c:v>1022.3249999999601</c:v>
                </c:pt>
                <c:pt idx="1132">
                  <c:v>1022.8749999999601</c:v>
                </c:pt>
                <c:pt idx="1133">
                  <c:v>1023.4249999999601</c:v>
                </c:pt>
                <c:pt idx="1134">
                  <c:v>1023.97499999996</c:v>
                </c:pt>
                <c:pt idx="1135">
                  <c:v>1024.5249999999601</c:v>
                </c:pt>
                <c:pt idx="1136">
                  <c:v>1025.0749999999598</c:v>
                </c:pt>
                <c:pt idx="1137">
                  <c:v>1025.62499999996</c:v>
                </c:pt>
                <c:pt idx="1138">
                  <c:v>1026.1749999999597</c:v>
                </c:pt>
                <c:pt idx="1139">
                  <c:v>1026.7249999999599</c:v>
                </c:pt>
                <c:pt idx="1140">
                  <c:v>1027.2749999999596</c:v>
                </c:pt>
                <c:pt idx="1141">
                  <c:v>1027.8249999999598</c:v>
                </c:pt>
                <c:pt idx="1142">
                  <c:v>1028.3749999999595</c:v>
                </c:pt>
                <c:pt idx="1143">
                  <c:v>1028.9249999999597</c:v>
                </c:pt>
                <c:pt idx="1144">
                  <c:v>1029.4749999999594</c:v>
                </c:pt>
                <c:pt idx="1145">
                  <c:v>1030.0249999999596</c:v>
                </c:pt>
                <c:pt idx="1146">
                  <c:v>1030.5749999999593</c:v>
                </c:pt>
                <c:pt idx="1147">
                  <c:v>1031.1249999999595</c:v>
                </c:pt>
                <c:pt idx="1148">
                  <c:v>1031.6749999999593</c:v>
                </c:pt>
                <c:pt idx="1149">
                  <c:v>1032.2249999999594</c:v>
                </c:pt>
                <c:pt idx="1150">
                  <c:v>1032.7749999999592</c:v>
                </c:pt>
                <c:pt idx="1151">
                  <c:v>1033.3249999999593</c:v>
                </c:pt>
                <c:pt idx="1152">
                  <c:v>1033.8749999999591</c:v>
                </c:pt>
                <c:pt idx="1153">
                  <c:v>1034.4249999999593</c:v>
                </c:pt>
                <c:pt idx="1154">
                  <c:v>1034.974999999959</c:v>
                </c:pt>
                <c:pt idx="1155">
                  <c:v>1035.5249999999592</c:v>
                </c:pt>
                <c:pt idx="1156">
                  <c:v>1036.0749999999589</c:v>
                </c:pt>
                <c:pt idx="1157">
                  <c:v>1036.6249999999591</c:v>
                </c:pt>
                <c:pt idx="1158">
                  <c:v>1037.1749999999588</c:v>
                </c:pt>
                <c:pt idx="1159">
                  <c:v>1037.724999999959</c:v>
                </c:pt>
                <c:pt idx="1160">
                  <c:v>1038.2749999999587</c:v>
                </c:pt>
                <c:pt idx="1161">
                  <c:v>1038.8249999999589</c:v>
                </c:pt>
                <c:pt idx="1162">
                  <c:v>1039.3749999999586</c:v>
                </c:pt>
                <c:pt idx="1163">
                  <c:v>1039.9249999999588</c:v>
                </c:pt>
                <c:pt idx="1164">
                  <c:v>1040.4749999999585</c:v>
                </c:pt>
                <c:pt idx="1165">
                  <c:v>1041.0249999999587</c:v>
                </c:pt>
                <c:pt idx="1166">
                  <c:v>1041.5749999999584</c:v>
                </c:pt>
                <c:pt idx="1167">
                  <c:v>1042.1249999999586</c:v>
                </c:pt>
                <c:pt idx="1168">
                  <c:v>1042.6749999999583</c:v>
                </c:pt>
                <c:pt idx="1169">
                  <c:v>1043.2249999999585</c:v>
                </c:pt>
                <c:pt idx="1170">
                  <c:v>1043.7749999999583</c:v>
                </c:pt>
                <c:pt idx="1171">
                  <c:v>1044.3249999999584</c:v>
                </c:pt>
                <c:pt idx="1172">
                  <c:v>1044.8749999999582</c:v>
                </c:pt>
                <c:pt idx="1173">
                  <c:v>1045.4249999999583</c:v>
                </c:pt>
                <c:pt idx="1174">
                  <c:v>1045.9749999999581</c:v>
                </c:pt>
                <c:pt idx="1175">
                  <c:v>1046.5249999999583</c:v>
                </c:pt>
                <c:pt idx="1176">
                  <c:v>1047.074999999958</c:v>
                </c:pt>
                <c:pt idx="1177">
                  <c:v>1047.6249999999582</c:v>
                </c:pt>
                <c:pt idx="1178">
                  <c:v>1048.1749999999579</c:v>
                </c:pt>
                <c:pt idx="1179">
                  <c:v>1048.7249999999581</c:v>
                </c:pt>
                <c:pt idx="1180">
                  <c:v>1049.2749999999578</c:v>
                </c:pt>
                <c:pt idx="1181">
                  <c:v>1049.824999999958</c:v>
                </c:pt>
                <c:pt idx="1182">
                  <c:v>1050.3749999999577</c:v>
                </c:pt>
                <c:pt idx="1183">
                  <c:v>1050.9249999999579</c:v>
                </c:pt>
                <c:pt idx="1184">
                  <c:v>1051.4749999999576</c:v>
                </c:pt>
                <c:pt idx="1185">
                  <c:v>1052.0249999999578</c:v>
                </c:pt>
                <c:pt idx="1186">
                  <c:v>1052.5749999999575</c:v>
                </c:pt>
                <c:pt idx="1187">
                  <c:v>1053.1249999999577</c:v>
                </c:pt>
                <c:pt idx="1188">
                  <c:v>1053.6749999999574</c:v>
                </c:pt>
                <c:pt idx="1189">
                  <c:v>1054.2249999999576</c:v>
                </c:pt>
                <c:pt idx="1190">
                  <c:v>1054.7749999999573</c:v>
                </c:pt>
                <c:pt idx="1191">
                  <c:v>1055.3249999999575</c:v>
                </c:pt>
                <c:pt idx="1192">
                  <c:v>1055.8749999999573</c:v>
                </c:pt>
                <c:pt idx="1193">
                  <c:v>1056.4249999999574</c:v>
                </c:pt>
                <c:pt idx="1194">
                  <c:v>1056.9749999999572</c:v>
                </c:pt>
                <c:pt idx="1195">
                  <c:v>1057.5249999999573</c:v>
                </c:pt>
                <c:pt idx="1196">
                  <c:v>1058.0749999999571</c:v>
                </c:pt>
                <c:pt idx="1197">
                  <c:v>1058.6249999999573</c:v>
                </c:pt>
                <c:pt idx="1198">
                  <c:v>1059.174999999957</c:v>
                </c:pt>
                <c:pt idx="1199">
                  <c:v>1059.7249999999572</c:v>
                </c:pt>
                <c:pt idx="1200">
                  <c:v>1060.2749999999569</c:v>
                </c:pt>
                <c:pt idx="1201">
                  <c:v>1060.8249999999571</c:v>
                </c:pt>
                <c:pt idx="1202">
                  <c:v>1061.3749999999568</c:v>
                </c:pt>
                <c:pt idx="1203">
                  <c:v>1061.924999999957</c:v>
                </c:pt>
                <c:pt idx="1204">
                  <c:v>1062.4749999999567</c:v>
                </c:pt>
                <c:pt idx="1205">
                  <c:v>1063.0249999999569</c:v>
                </c:pt>
                <c:pt idx="1206">
                  <c:v>1063.5749999999566</c:v>
                </c:pt>
                <c:pt idx="1207">
                  <c:v>1064.1249999999568</c:v>
                </c:pt>
                <c:pt idx="1208">
                  <c:v>1064.6749999999565</c:v>
                </c:pt>
                <c:pt idx="1209">
                  <c:v>1065.2249999999567</c:v>
                </c:pt>
                <c:pt idx="1210">
                  <c:v>1065.7749999999564</c:v>
                </c:pt>
                <c:pt idx="1211">
                  <c:v>1066.3249999999566</c:v>
                </c:pt>
                <c:pt idx="1212">
                  <c:v>1066.8749999999563</c:v>
                </c:pt>
                <c:pt idx="1213">
                  <c:v>1067.4249999999565</c:v>
                </c:pt>
                <c:pt idx="1214">
                  <c:v>1067.9749999999563</c:v>
                </c:pt>
                <c:pt idx="1215">
                  <c:v>1068.5249999999564</c:v>
                </c:pt>
                <c:pt idx="1216">
                  <c:v>1069.0749999999562</c:v>
                </c:pt>
                <c:pt idx="1217">
                  <c:v>1069.6249999999563</c:v>
                </c:pt>
                <c:pt idx="1218">
                  <c:v>1070.1749999999561</c:v>
                </c:pt>
                <c:pt idx="1219">
                  <c:v>1070.7249999999563</c:v>
                </c:pt>
                <c:pt idx="1220">
                  <c:v>1071.274999999956</c:v>
                </c:pt>
                <c:pt idx="1221">
                  <c:v>1071.8249999999562</c:v>
                </c:pt>
                <c:pt idx="1222">
                  <c:v>1072.3749999999559</c:v>
                </c:pt>
                <c:pt idx="1223">
                  <c:v>1072.9249999999561</c:v>
                </c:pt>
                <c:pt idx="1224">
                  <c:v>1073.4749999999558</c:v>
                </c:pt>
                <c:pt idx="1225">
                  <c:v>1074.024999999956</c:v>
                </c:pt>
                <c:pt idx="1226">
                  <c:v>1074.5749999999557</c:v>
                </c:pt>
                <c:pt idx="1227">
                  <c:v>1075.1249999999559</c:v>
                </c:pt>
                <c:pt idx="1228">
                  <c:v>1075.6749999999556</c:v>
                </c:pt>
                <c:pt idx="1229">
                  <c:v>1076.2249999999558</c:v>
                </c:pt>
                <c:pt idx="1230">
                  <c:v>1076.7749999999555</c:v>
                </c:pt>
                <c:pt idx="1231">
                  <c:v>1077.3249999999557</c:v>
                </c:pt>
                <c:pt idx="1232">
                  <c:v>1077.8749999999554</c:v>
                </c:pt>
                <c:pt idx="1233">
                  <c:v>1078.4249999999556</c:v>
                </c:pt>
                <c:pt idx="1234">
                  <c:v>1078.9749999999553</c:v>
                </c:pt>
                <c:pt idx="1235">
                  <c:v>1079.5249999999555</c:v>
                </c:pt>
                <c:pt idx="1236">
                  <c:v>1080.0749999999553</c:v>
                </c:pt>
                <c:pt idx="1237">
                  <c:v>1080.6249999999554</c:v>
                </c:pt>
                <c:pt idx="1238">
                  <c:v>1081.1749999999552</c:v>
                </c:pt>
                <c:pt idx="1239">
                  <c:v>1081.7249999999553</c:v>
                </c:pt>
                <c:pt idx="1240">
                  <c:v>1082.2749999999551</c:v>
                </c:pt>
                <c:pt idx="1241">
                  <c:v>1082.8249999999553</c:v>
                </c:pt>
                <c:pt idx="1242">
                  <c:v>1083.374999999955</c:v>
                </c:pt>
                <c:pt idx="1243">
                  <c:v>1083.9249999999552</c:v>
                </c:pt>
                <c:pt idx="1244">
                  <c:v>1084.4749999999549</c:v>
                </c:pt>
                <c:pt idx="1245">
                  <c:v>1085.0249999999551</c:v>
                </c:pt>
                <c:pt idx="1246">
                  <c:v>1085.5749999999548</c:v>
                </c:pt>
                <c:pt idx="1247">
                  <c:v>1086.124999999955</c:v>
                </c:pt>
                <c:pt idx="1248">
                  <c:v>1086.6749999999547</c:v>
                </c:pt>
                <c:pt idx="1249">
                  <c:v>1087.2249999999549</c:v>
                </c:pt>
                <c:pt idx="1250">
                  <c:v>1087.7749999999546</c:v>
                </c:pt>
                <c:pt idx="1251">
                  <c:v>1088.3249999999548</c:v>
                </c:pt>
                <c:pt idx="1252">
                  <c:v>1088.8749999999545</c:v>
                </c:pt>
                <c:pt idx="1253">
                  <c:v>1089.4249999999547</c:v>
                </c:pt>
                <c:pt idx="1254">
                  <c:v>1089.9749999999544</c:v>
                </c:pt>
                <c:pt idx="1255">
                  <c:v>1090.5249999999546</c:v>
                </c:pt>
                <c:pt idx="1256">
                  <c:v>1091.0749999999543</c:v>
                </c:pt>
                <c:pt idx="1257">
                  <c:v>1091.6249999999545</c:v>
                </c:pt>
                <c:pt idx="1258">
                  <c:v>1092.1749999999543</c:v>
                </c:pt>
                <c:pt idx="1259">
                  <c:v>1092.7249999999544</c:v>
                </c:pt>
                <c:pt idx="1260">
                  <c:v>1093.2749999999542</c:v>
                </c:pt>
                <c:pt idx="1261">
                  <c:v>1093.8249999999543</c:v>
                </c:pt>
                <c:pt idx="1262">
                  <c:v>1094.3749999999541</c:v>
                </c:pt>
                <c:pt idx="1263">
                  <c:v>1094.9249999999543</c:v>
                </c:pt>
                <c:pt idx="1264">
                  <c:v>1095.474999999954</c:v>
                </c:pt>
                <c:pt idx="1265">
                  <c:v>1096.0249999999542</c:v>
                </c:pt>
                <c:pt idx="1266">
                  <c:v>1096.5749999999539</c:v>
                </c:pt>
                <c:pt idx="1267">
                  <c:v>1097.1249999999541</c:v>
                </c:pt>
                <c:pt idx="1268">
                  <c:v>1097.6749999999538</c:v>
                </c:pt>
                <c:pt idx="1269">
                  <c:v>1098.224999999954</c:v>
                </c:pt>
                <c:pt idx="1270">
                  <c:v>1098.7749999999537</c:v>
                </c:pt>
                <c:pt idx="1271">
                  <c:v>1099.3249999999539</c:v>
                </c:pt>
                <c:pt idx="1272">
                  <c:v>1099.8749999999536</c:v>
                </c:pt>
                <c:pt idx="1273">
                  <c:v>1100.4249999999538</c:v>
                </c:pt>
                <c:pt idx="1274">
                  <c:v>1100.9749999999535</c:v>
                </c:pt>
                <c:pt idx="1275">
                  <c:v>1101.5249999999537</c:v>
                </c:pt>
                <c:pt idx="1276">
                  <c:v>1102.0749999999534</c:v>
                </c:pt>
                <c:pt idx="1277">
                  <c:v>1102.6249999999536</c:v>
                </c:pt>
                <c:pt idx="1278">
                  <c:v>1103.1749999999533</c:v>
                </c:pt>
                <c:pt idx="1279">
                  <c:v>1103.7249999999535</c:v>
                </c:pt>
                <c:pt idx="1280">
                  <c:v>1104.2749999999533</c:v>
                </c:pt>
                <c:pt idx="1281">
                  <c:v>1104.8249999999534</c:v>
                </c:pt>
                <c:pt idx="1282">
                  <c:v>1105.3749999999532</c:v>
                </c:pt>
                <c:pt idx="1283">
                  <c:v>1105.9249999999533</c:v>
                </c:pt>
                <c:pt idx="1284">
                  <c:v>1106.4749999999531</c:v>
                </c:pt>
                <c:pt idx="1285">
                  <c:v>1107.0249999999533</c:v>
                </c:pt>
                <c:pt idx="1286">
                  <c:v>1107.574999999953</c:v>
                </c:pt>
                <c:pt idx="1287">
                  <c:v>1108.1249999999532</c:v>
                </c:pt>
                <c:pt idx="1288">
                  <c:v>1108.6749999999529</c:v>
                </c:pt>
                <c:pt idx="1289">
                  <c:v>1109.2249999999531</c:v>
                </c:pt>
                <c:pt idx="1290">
                  <c:v>1109.7749999999528</c:v>
                </c:pt>
                <c:pt idx="1291">
                  <c:v>1110.324999999953</c:v>
                </c:pt>
                <c:pt idx="1292">
                  <c:v>1110.8749999999527</c:v>
                </c:pt>
                <c:pt idx="1293">
                  <c:v>1111.4249999999529</c:v>
                </c:pt>
                <c:pt idx="1294">
                  <c:v>1111.9749999999526</c:v>
                </c:pt>
                <c:pt idx="1295">
                  <c:v>1112.5249999999528</c:v>
                </c:pt>
                <c:pt idx="1296">
                  <c:v>1113.0749999999525</c:v>
                </c:pt>
                <c:pt idx="1297">
                  <c:v>1113.6249999999527</c:v>
                </c:pt>
                <c:pt idx="1298">
                  <c:v>1114.1749999999524</c:v>
                </c:pt>
                <c:pt idx="1299">
                  <c:v>1114.7249999999526</c:v>
                </c:pt>
                <c:pt idx="1300">
                  <c:v>1115.2749999999523</c:v>
                </c:pt>
                <c:pt idx="1301">
                  <c:v>1115.8249999999525</c:v>
                </c:pt>
                <c:pt idx="1302">
                  <c:v>1116.3749999999523</c:v>
                </c:pt>
                <c:pt idx="1303">
                  <c:v>1116.9249999999524</c:v>
                </c:pt>
                <c:pt idx="1304">
                  <c:v>1117.4749999999522</c:v>
                </c:pt>
                <c:pt idx="1305">
                  <c:v>1118.0249999999523</c:v>
                </c:pt>
                <c:pt idx="1306">
                  <c:v>1118.5749999999521</c:v>
                </c:pt>
                <c:pt idx="1307">
                  <c:v>1119.1249999999523</c:v>
                </c:pt>
                <c:pt idx="1308">
                  <c:v>1119.674999999952</c:v>
                </c:pt>
                <c:pt idx="1309">
                  <c:v>1120.2249999999522</c:v>
                </c:pt>
                <c:pt idx="1310">
                  <c:v>1120.7749999999519</c:v>
                </c:pt>
                <c:pt idx="1311">
                  <c:v>1121.3249999999521</c:v>
                </c:pt>
                <c:pt idx="1312">
                  <c:v>1121.8749999999518</c:v>
                </c:pt>
                <c:pt idx="1313">
                  <c:v>1122.424999999952</c:v>
                </c:pt>
                <c:pt idx="1314">
                  <c:v>1122.9749999999517</c:v>
                </c:pt>
                <c:pt idx="1315">
                  <c:v>1123.5249999999519</c:v>
                </c:pt>
                <c:pt idx="1316">
                  <c:v>1124.0749999999516</c:v>
                </c:pt>
                <c:pt idx="1317">
                  <c:v>1124.6249999999518</c:v>
                </c:pt>
                <c:pt idx="1318">
                  <c:v>1125.1749999999515</c:v>
                </c:pt>
                <c:pt idx="1319">
                  <c:v>1125.7249999999517</c:v>
                </c:pt>
                <c:pt idx="1320">
                  <c:v>1126.2749999999514</c:v>
                </c:pt>
                <c:pt idx="1321">
                  <c:v>1126.8249999999516</c:v>
                </c:pt>
                <c:pt idx="1322">
                  <c:v>1127.3749999999513</c:v>
                </c:pt>
                <c:pt idx="1323">
                  <c:v>1127.9249999999515</c:v>
                </c:pt>
                <c:pt idx="1324">
                  <c:v>1128.4749999999513</c:v>
                </c:pt>
                <c:pt idx="1325">
                  <c:v>1129.0249999999514</c:v>
                </c:pt>
                <c:pt idx="1326">
                  <c:v>1129.5749999999512</c:v>
                </c:pt>
                <c:pt idx="1327">
                  <c:v>1130.1249999999513</c:v>
                </c:pt>
                <c:pt idx="1328">
                  <c:v>1130.6749999999511</c:v>
                </c:pt>
                <c:pt idx="1329">
                  <c:v>1131.2249999999513</c:v>
                </c:pt>
                <c:pt idx="1330">
                  <c:v>1131.774999999951</c:v>
                </c:pt>
                <c:pt idx="1331">
                  <c:v>1132.3249999999512</c:v>
                </c:pt>
                <c:pt idx="1332">
                  <c:v>1132.8749999999509</c:v>
                </c:pt>
                <c:pt idx="1333">
                  <c:v>1133.4249999999511</c:v>
                </c:pt>
                <c:pt idx="1334">
                  <c:v>1133.9749999999508</c:v>
                </c:pt>
                <c:pt idx="1335">
                  <c:v>1134.524999999951</c:v>
                </c:pt>
                <c:pt idx="1336">
                  <c:v>1135.0749999999507</c:v>
                </c:pt>
                <c:pt idx="1337">
                  <c:v>1135.6249999999509</c:v>
                </c:pt>
                <c:pt idx="1338">
                  <c:v>1136.1749999999506</c:v>
                </c:pt>
                <c:pt idx="1339">
                  <c:v>1136.7249999999508</c:v>
                </c:pt>
                <c:pt idx="1340">
                  <c:v>1137.2749999999505</c:v>
                </c:pt>
                <c:pt idx="1341">
                  <c:v>1137.8249999999507</c:v>
                </c:pt>
                <c:pt idx="1342">
                  <c:v>1138.3749999999504</c:v>
                </c:pt>
                <c:pt idx="1343">
                  <c:v>1138.9249999999506</c:v>
                </c:pt>
                <c:pt idx="1344">
                  <c:v>1139.4749999999503</c:v>
                </c:pt>
                <c:pt idx="1345">
                  <c:v>1140.0249999999505</c:v>
                </c:pt>
                <c:pt idx="1346">
                  <c:v>1140.5749999999503</c:v>
                </c:pt>
                <c:pt idx="1347">
                  <c:v>1141.1249999999504</c:v>
                </c:pt>
                <c:pt idx="1348">
                  <c:v>1141.6749999999502</c:v>
                </c:pt>
                <c:pt idx="1349">
                  <c:v>1142.2249999999503</c:v>
                </c:pt>
                <c:pt idx="1350">
                  <c:v>1142.7749999999501</c:v>
                </c:pt>
                <c:pt idx="1351">
                  <c:v>1143.3249999999503</c:v>
                </c:pt>
                <c:pt idx="1352">
                  <c:v>1143.87499999995</c:v>
                </c:pt>
                <c:pt idx="1353">
                  <c:v>1144.4249999999502</c:v>
                </c:pt>
                <c:pt idx="1354">
                  <c:v>1144.9749999999499</c:v>
                </c:pt>
                <c:pt idx="1355">
                  <c:v>1145.5249999999501</c:v>
                </c:pt>
                <c:pt idx="1356">
                  <c:v>1146.0749999999498</c:v>
                </c:pt>
                <c:pt idx="1357">
                  <c:v>1146.62499999995</c:v>
                </c:pt>
                <c:pt idx="1358">
                  <c:v>1147.1749999999497</c:v>
                </c:pt>
                <c:pt idx="1359">
                  <c:v>1147.7249999999499</c:v>
                </c:pt>
                <c:pt idx="1360">
                  <c:v>1148.2749999999496</c:v>
                </c:pt>
                <c:pt idx="1361">
                  <c:v>1148.8249999999498</c:v>
                </c:pt>
                <c:pt idx="1362">
                  <c:v>1149.3749999999495</c:v>
                </c:pt>
                <c:pt idx="1363">
                  <c:v>1149.9249999999497</c:v>
                </c:pt>
                <c:pt idx="1364">
                  <c:v>1150.4749999999494</c:v>
                </c:pt>
                <c:pt idx="1365">
                  <c:v>1151.0249999999496</c:v>
                </c:pt>
                <c:pt idx="1366">
                  <c:v>1151.5749999999493</c:v>
                </c:pt>
                <c:pt idx="1367">
                  <c:v>1152.1249999999495</c:v>
                </c:pt>
                <c:pt idx="1368">
                  <c:v>1152.6749999999493</c:v>
                </c:pt>
                <c:pt idx="1369">
                  <c:v>1153.2249999999494</c:v>
                </c:pt>
                <c:pt idx="1370">
                  <c:v>1153.7749999999492</c:v>
                </c:pt>
                <c:pt idx="1371">
                  <c:v>1154.3249999999493</c:v>
                </c:pt>
                <c:pt idx="1372">
                  <c:v>1154.8749999999491</c:v>
                </c:pt>
                <c:pt idx="1373">
                  <c:v>1155.4249999999493</c:v>
                </c:pt>
                <c:pt idx="1374">
                  <c:v>1155.974999999949</c:v>
                </c:pt>
                <c:pt idx="1375">
                  <c:v>1156.5249999999492</c:v>
                </c:pt>
                <c:pt idx="1376">
                  <c:v>1157.0749999999489</c:v>
                </c:pt>
                <c:pt idx="1377">
                  <c:v>1157.6249999999491</c:v>
                </c:pt>
                <c:pt idx="1378">
                  <c:v>1158.1749999999488</c:v>
                </c:pt>
                <c:pt idx="1379">
                  <c:v>1158.724999999949</c:v>
                </c:pt>
                <c:pt idx="1380">
                  <c:v>1159.2749999999487</c:v>
                </c:pt>
                <c:pt idx="1381">
                  <c:v>1159.8249999999489</c:v>
                </c:pt>
                <c:pt idx="1382">
                  <c:v>1160.3749999999486</c:v>
                </c:pt>
                <c:pt idx="1383">
                  <c:v>1160.9249999999488</c:v>
                </c:pt>
                <c:pt idx="1384">
                  <c:v>1161.4749999999485</c:v>
                </c:pt>
                <c:pt idx="1385">
                  <c:v>1162.0249999999487</c:v>
                </c:pt>
                <c:pt idx="1386">
                  <c:v>1162.5749999999484</c:v>
                </c:pt>
                <c:pt idx="1387">
                  <c:v>1163.1249999999486</c:v>
                </c:pt>
                <c:pt idx="1388">
                  <c:v>1163.6749999999483</c:v>
                </c:pt>
                <c:pt idx="1389">
                  <c:v>1164.2249999999485</c:v>
                </c:pt>
                <c:pt idx="1390">
                  <c:v>1164.7749999999482</c:v>
                </c:pt>
                <c:pt idx="1391">
                  <c:v>1165.3249999999484</c:v>
                </c:pt>
                <c:pt idx="1392">
                  <c:v>1165.8749999999482</c:v>
                </c:pt>
                <c:pt idx="1393">
                  <c:v>1166.4249999999483</c:v>
                </c:pt>
                <c:pt idx="1394">
                  <c:v>1166.9749999999481</c:v>
                </c:pt>
                <c:pt idx="1395">
                  <c:v>1167.5249999999482</c:v>
                </c:pt>
                <c:pt idx="1396">
                  <c:v>1168.074999999948</c:v>
                </c:pt>
                <c:pt idx="1397">
                  <c:v>1168.6249999999482</c:v>
                </c:pt>
                <c:pt idx="1398">
                  <c:v>1169.1749999999479</c:v>
                </c:pt>
                <c:pt idx="1399">
                  <c:v>1169.7249999999481</c:v>
                </c:pt>
                <c:pt idx="1400">
                  <c:v>1170.2749999999478</c:v>
                </c:pt>
                <c:pt idx="1401">
                  <c:v>1170.824999999948</c:v>
                </c:pt>
                <c:pt idx="1402">
                  <c:v>1171.3749999999477</c:v>
                </c:pt>
                <c:pt idx="1403">
                  <c:v>1171.9249999999479</c:v>
                </c:pt>
                <c:pt idx="1404">
                  <c:v>1172.4749999999476</c:v>
                </c:pt>
                <c:pt idx="1405">
                  <c:v>1173.0249999999478</c:v>
                </c:pt>
                <c:pt idx="1406">
                  <c:v>1173.5749999999475</c:v>
                </c:pt>
                <c:pt idx="1407">
                  <c:v>1174.1249999999477</c:v>
                </c:pt>
                <c:pt idx="1408">
                  <c:v>1174.6749999999474</c:v>
                </c:pt>
                <c:pt idx="1409">
                  <c:v>1175.2249999999476</c:v>
                </c:pt>
                <c:pt idx="1410">
                  <c:v>1175.7749999999473</c:v>
                </c:pt>
                <c:pt idx="1411">
                  <c:v>1176.3249999999475</c:v>
                </c:pt>
                <c:pt idx="1412">
                  <c:v>1176.8749999999472</c:v>
                </c:pt>
                <c:pt idx="1413">
                  <c:v>1177.4249999999474</c:v>
                </c:pt>
                <c:pt idx="1414">
                  <c:v>1177.9749999999472</c:v>
                </c:pt>
                <c:pt idx="1415">
                  <c:v>1178.5249999999473</c:v>
                </c:pt>
                <c:pt idx="1416">
                  <c:v>1179.0749999999471</c:v>
                </c:pt>
                <c:pt idx="1417">
                  <c:v>1179.6249999999472</c:v>
                </c:pt>
                <c:pt idx="1418">
                  <c:v>1180.174999999947</c:v>
                </c:pt>
                <c:pt idx="1419">
                  <c:v>1180.7249999999472</c:v>
                </c:pt>
                <c:pt idx="1420">
                  <c:v>1181.2749999999469</c:v>
                </c:pt>
                <c:pt idx="1421">
                  <c:v>1181.8249999999471</c:v>
                </c:pt>
                <c:pt idx="1422">
                  <c:v>1182.3749999999468</c:v>
                </c:pt>
                <c:pt idx="1423">
                  <c:v>1182.924999999947</c:v>
                </c:pt>
                <c:pt idx="1424">
                  <c:v>1183.4749999999467</c:v>
                </c:pt>
                <c:pt idx="1425">
                  <c:v>1184.0249999999469</c:v>
                </c:pt>
                <c:pt idx="1426">
                  <c:v>1184.5749999999466</c:v>
                </c:pt>
                <c:pt idx="1427">
                  <c:v>1185.1249999999468</c:v>
                </c:pt>
                <c:pt idx="1428">
                  <c:v>1185.6749999999465</c:v>
                </c:pt>
                <c:pt idx="1429">
                  <c:v>1186.2249999999467</c:v>
                </c:pt>
                <c:pt idx="1430">
                  <c:v>1186.7749999999464</c:v>
                </c:pt>
                <c:pt idx="1431">
                  <c:v>1187.3249999999466</c:v>
                </c:pt>
                <c:pt idx="1432">
                  <c:v>1187.8749999999463</c:v>
                </c:pt>
                <c:pt idx="1433">
                  <c:v>1188.4249999999465</c:v>
                </c:pt>
                <c:pt idx="1434">
                  <c:v>1188.9749999999462</c:v>
                </c:pt>
                <c:pt idx="1435">
                  <c:v>1189.5249999999464</c:v>
                </c:pt>
                <c:pt idx="1436">
                  <c:v>1190.0749999999462</c:v>
                </c:pt>
                <c:pt idx="1437">
                  <c:v>1190.6249999999463</c:v>
                </c:pt>
                <c:pt idx="1438">
                  <c:v>1191.1749999999461</c:v>
                </c:pt>
                <c:pt idx="1439">
                  <c:v>1191.7249999999462</c:v>
                </c:pt>
                <c:pt idx="1440">
                  <c:v>1192.274999999946</c:v>
                </c:pt>
                <c:pt idx="1441">
                  <c:v>1192.8249999999462</c:v>
                </c:pt>
                <c:pt idx="1442">
                  <c:v>1193.3749999999459</c:v>
                </c:pt>
                <c:pt idx="1443">
                  <c:v>1193.9249999999461</c:v>
                </c:pt>
                <c:pt idx="1444">
                  <c:v>1194.4749999999458</c:v>
                </c:pt>
                <c:pt idx="1445">
                  <c:v>1195.024999999946</c:v>
                </c:pt>
                <c:pt idx="1446">
                  <c:v>1195.5749999999457</c:v>
                </c:pt>
                <c:pt idx="1447">
                  <c:v>1196.1249999999459</c:v>
                </c:pt>
                <c:pt idx="1448">
                  <c:v>1196.6749999999456</c:v>
                </c:pt>
                <c:pt idx="1449">
                  <c:v>1197.2249999999458</c:v>
                </c:pt>
                <c:pt idx="1450">
                  <c:v>1197.7749999999455</c:v>
                </c:pt>
                <c:pt idx="1451">
                  <c:v>1198.3249999999457</c:v>
                </c:pt>
                <c:pt idx="1452">
                  <c:v>1198.8749999999454</c:v>
                </c:pt>
                <c:pt idx="1453">
                  <c:v>1199.4249999999456</c:v>
                </c:pt>
                <c:pt idx="1454">
                  <c:v>1199.9749999999453</c:v>
                </c:pt>
                <c:pt idx="1455">
                  <c:v>1200.5249999999455</c:v>
                </c:pt>
                <c:pt idx="1456">
                  <c:v>1201.0749999999452</c:v>
                </c:pt>
                <c:pt idx="1457">
                  <c:v>1201.6249999999454</c:v>
                </c:pt>
                <c:pt idx="1458">
                  <c:v>1202.1749999999452</c:v>
                </c:pt>
                <c:pt idx="1459">
                  <c:v>1202.7249999999453</c:v>
                </c:pt>
                <c:pt idx="1460">
                  <c:v>1203.2749999999451</c:v>
                </c:pt>
                <c:pt idx="1461">
                  <c:v>1203.8249999999452</c:v>
                </c:pt>
                <c:pt idx="1462">
                  <c:v>1204.374999999945</c:v>
                </c:pt>
                <c:pt idx="1463">
                  <c:v>1204.9249999999452</c:v>
                </c:pt>
                <c:pt idx="1464">
                  <c:v>1205.4749999999449</c:v>
                </c:pt>
                <c:pt idx="1465">
                  <c:v>1206.0249999999451</c:v>
                </c:pt>
                <c:pt idx="1466">
                  <c:v>1206.5749999999448</c:v>
                </c:pt>
                <c:pt idx="1467">
                  <c:v>1207.124999999945</c:v>
                </c:pt>
                <c:pt idx="1468">
                  <c:v>1207.6749999999447</c:v>
                </c:pt>
                <c:pt idx="1469">
                  <c:v>1208.2249999999449</c:v>
                </c:pt>
                <c:pt idx="1470">
                  <c:v>1208.7749999999446</c:v>
                </c:pt>
                <c:pt idx="1471">
                  <c:v>1209.3249999999448</c:v>
                </c:pt>
                <c:pt idx="1472">
                  <c:v>1209.8749999999445</c:v>
                </c:pt>
                <c:pt idx="1473">
                  <c:v>1210.4249999999447</c:v>
                </c:pt>
                <c:pt idx="1474">
                  <c:v>1210.9749999999444</c:v>
                </c:pt>
                <c:pt idx="1475">
                  <c:v>1211.5249999999446</c:v>
                </c:pt>
                <c:pt idx="1476">
                  <c:v>1212.0749999999443</c:v>
                </c:pt>
                <c:pt idx="1477">
                  <c:v>1212.6249999999445</c:v>
                </c:pt>
                <c:pt idx="1478">
                  <c:v>1213.1749999999442</c:v>
                </c:pt>
                <c:pt idx="1479">
                  <c:v>1213.7249999999444</c:v>
                </c:pt>
                <c:pt idx="1480">
                  <c:v>1214.2749999999442</c:v>
                </c:pt>
                <c:pt idx="1481">
                  <c:v>1214.8249999999443</c:v>
                </c:pt>
                <c:pt idx="1482">
                  <c:v>1215.3749999999441</c:v>
                </c:pt>
                <c:pt idx="1483">
                  <c:v>1215.9249999999442</c:v>
                </c:pt>
                <c:pt idx="1484">
                  <c:v>1216.474999999944</c:v>
                </c:pt>
                <c:pt idx="1485">
                  <c:v>1217.0249999999442</c:v>
                </c:pt>
                <c:pt idx="1486">
                  <c:v>1217.5749999999439</c:v>
                </c:pt>
                <c:pt idx="1487">
                  <c:v>1218.1249999999441</c:v>
                </c:pt>
                <c:pt idx="1488">
                  <c:v>1218.6749999999438</c:v>
                </c:pt>
                <c:pt idx="1489">
                  <c:v>1219.224999999944</c:v>
                </c:pt>
                <c:pt idx="1490">
                  <c:v>1219.7749999999437</c:v>
                </c:pt>
                <c:pt idx="1491">
                  <c:v>1220.3249999999439</c:v>
                </c:pt>
                <c:pt idx="1492">
                  <c:v>1220.8749999999436</c:v>
                </c:pt>
                <c:pt idx="1493">
                  <c:v>1221.4249999999438</c:v>
                </c:pt>
                <c:pt idx="1494">
                  <c:v>1221.9749999999435</c:v>
                </c:pt>
                <c:pt idx="1495">
                  <c:v>1222.5249999999437</c:v>
                </c:pt>
                <c:pt idx="1496">
                  <c:v>1223.0749999999434</c:v>
                </c:pt>
                <c:pt idx="1497">
                  <c:v>1223.6249999999436</c:v>
                </c:pt>
                <c:pt idx="1498">
                  <c:v>1224.1749999999433</c:v>
                </c:pt>
                <c:pt idx="1499">
                  <c:v>1224.7249999999435</c:v>
                </c:pt>
                <c:pt idx="1500">
                  <c:v>1225.2749999999432</c:v>
                </c:pt>
                <c:pt idx="1501">
                  <c:v>1225.8249999999434</c:v>
                </c:pt>
                <c:pt idx="1502">
                  <c:v>1226.3749999999432</c:v>
                </c:pt>
                <c:pt idx="1503">
                  <c:v>1226.9249999999433</c:v>
                </c:pt>
                <c:pt idx="1504">
                  <c:v>1227.4749999999431</c:v>
                </c:pt>
                <c:pt idx="1505">
                  <c:v>1228.0249999999432</c:v>
                </c:pt>
                <c:pt idx="1506">
                  <c:v>1228.574999999943</c:v>
                </c:pt>
                <c:pt idx="1507">
                  <c:v>1229.1249999999432</c:v>
                </c:pt>
                <c:pt idx="1508">
                  <c:v>1229.6749999999429</c:v>
                </c:pt>
                <c:pt idx="1509">
                  <c:v>1230.2249999999431</c:v>
                </c:pt>
                <c:pt idx="1510">
                  <c:v>1230.7749999999428</c:v>
                </c:pt>
                <c:pt idx="1511">
                  <c:v>1231.324999999943</c:v>
                </c:pt>
                <c:pt idx="1512">
                  <c:v>1231.8749999999427</c:v>
                </c:pt>
                <c:pt idx="1513">
                  <c:v>1232.4249999999429</c:v>
                </c:pt>
                <c:pt idx="1514">
                  <c:v>1232.9749999999426</c:v>
                </c:pt>
                <c:pt idx="1515">
                  <c:v>1233.5249999999428</c:v>
                </c:pt>
                <c:pt idx="1516">
                  <c:v>1234.0749999999425</c:v>
                </c:pt>
                <c:pt idx="1517">
                  <c:v>1234.6249999999427</c:v>
                </c:pt>
                <c:pt idx="1518">
                  <c:v>1235.1749999999424</c:v>
                </c:pt>
                <c:pt idx="1519">
                  <c:v>1235.7249999999426</c:v>
                </c:pt>
                <c:pt idx="1520">
                  <c:v>1236.2749999999423</c:v>
                </c:pt>
                <c:pt idx="1521">
                  <c:v>1236.8249999999425</c:v>
                </c:pt>
                <c:pt idx="1522">
                  <c:v>1237.3749999999422</c:v>
                </c:pt>
                <c:pt idx="1523">
                  <c:v>1237.9249999999424</c:v>
                </c:pt>
                <c:pt idx="1524">
                  <c:v>1238.4749999999422</c:v>
                </c:pt>
                <c:pt idx="1525">
                  <c:v>1239.0249999999423</c:v>
                </c:pt>
                <c:pt idx="1526">
                  <c:v>1239.5749999999421</c:v>
                </c:pt>
                <c:pt idx="1527">
                  <c:v>1240.1249999999422</c:v>
                </c:pt>
                <c:pt idx="1528">
                  <c:v>1240.674999999942</c:v>
                </c:pt>
                <c:pt idx="1529">
                  <c:v>1241.2249999999422</c:v>
                </c:pt>
                <c:pt idx="1530">
                  <c:v>1241.7749999999419</c:v>
                </c:pt>
                <c:pt idx="1531">
                  <c:v>1242.3249999999421</c:v>
                </c:pt>
                <c:pt idx="1532">
                  <c:v>1242.8749999999418</c:v>
                </c:pt>
                <c:pt idx="1533">
                  <c:v>1243.424999999942</c:v>
                </c:pt>
                <c:pt idx="1534">
                  <c:v>1243.9749999999417</c:v>
                </c:pt>
                <c:pt idx="1535">
                  <c:v>1244.5249999999419</c:v>
                </c:pt>
                <c:pt idx="1536">
                  <c:v>1245.0749999999416</c:v>
                </c:pt>
                <c:pt idx="1537">
                  <c:v>1245.6249999999418</c:v>
                </c:pt>
                <c:pt idx="1538">
                  <c:v>1246.1749999999415</c:v>
                </c:pt>
                <c:pt idx="1539">
                  <c:v>1246.7249999999417</c:v>
                </c:pt>
                <c:pt idx="1540">
                  <c:v>1247.2749999999414</c:v>
                </c:pt>
                <c:pt idx="1541">
                  <c:v>1247.8249999999416</c:v>
                </c:pt>
                <c:pt idx="1542">
                  <c:v>1248.3749999999413</c:v>
                </c:pt>
                <c:pt idx="1543">
                  <c:v>1248.9249999999415</c:v>
                </c:pt>
                <c:pt idx="1544">
                  <c:v>1249.4749999999412</c:v>
                </c:pt>
                <c:pt idx="1545">
                  <c:v>1250.0249999999414</c:v>
                </c:pt>
                <c:pt idx="1546">
                  <c:v>1250.5749999999412</c:v>
                </c:pt>
                <c:pt idx="1547">
                  <c:v>1251.1249999999413</c:v>
                </c:pt>
                <c:pt idx="1548">
                  <c:v>1251.6749999999411</c:v>
                </c:pt>
                <c:pt idx="1549">
                  <c:v>1252.2249999999412</c:v>
                </c:pt>
                <c:pt idx="1550">
                  <c:v>1252.774999999941</c:v>
                </c:pt>
                <c:pt idx="1551">
                  <c:v>1253.3249999999412</c:v>
                </c:pt>
                <c:pt idx="1552">
                  <c:v>1253.8749999999409</c:v>
                </c:pt>
                <c:pt idx="1553">
                  <c:v>1254.4249999999411</c:v>
                </c:pt>
                <c:pt idx="1554">
                  <c:v>1254.9749999999408</c:v>
                </c:pt>
                <c:pt idx="1555">
                  <c:v>1255.524999999941</c:v>
                </c:pt>
                <c:pt idx="1556">
                  <c:v>1256.0749999999407</c:v>
                </c:pt>
                <c:pt idx="1557">
                  <c:v>1256.6249999999409</c:v>
                </c:pt>
                <c:pt idx="1558">
                  <c:v>1257.1749999999406</c:v>
                </c:pt>
                <c:pt idx="1559">
                  <c:v>1257.7249999999408</c:v>
                </c:pt>
                <c:pt idx="1560">
                  <c:v>1258.2749999999405</c:v>
                </c:pt>
                <c:pt idx="1561">
                  <c:v>1258.8249999999407</c:v>
                </c:pt>
                <c:pt idx="1562">
                  <c:v>1259.3749999999404</c:v>
                </c:pt>
                <c:pt idx="1563">
                  <c:v>1259.9249999999406</c:v>
                </c:pt>
                <c:pt idx="1564">
                  <c:v>1260.4749999999403</c:v>
                </c:pt>
                <c:pt idx="1565">
                  <c:v>1261.0249999999405</c:v>
                </c:pt>
                <c:pt idx="1566">
                  <c:v>1261.5749999999402</c:v>
                </c:pt>
                <c:pt idx="1567">
                  <c:v>1262.1249999999404</c:v>
                </c:pt>
                <c:pt idx="1568">
                  <c:v>1262.6749999999402</c:v>
                </c:pt>
                <c:pt idx="1569">
                  <c:v>1263.2249999999403</c:v>
                </c:pt>
                <c:pt idx="1570">
                  <c:v>1263.7749999999401</c:v>
                </c:pt>
                <c:pt idx="1571">
                  <c:v>1264.3249999999402</c:v>
                </c:pt>
                <c:pt idx="1572">
                  <c:v>1264.87499999994</c:v>
                </c:pt>
                <c:pt idx="1573">
                  <c:v>1265.4249999999402</c:v>
                </c:pt>
                <c:pt idx="1574">
                  <c:v>1265.9749999999399</c:v>
                </c:pt>
                <c:pt idx="1575">
                  <c:v>1266.5249999999401</c:v>
                </c:pt>
                <c:pt idx="1576">
                  <c:v>1267.0749999999398</c:v>
                </c:pt>
                <c:pt idx="1577">
                  <c:v>1267.62499999994</c:v>
                </c:pt>
                <c:pt idx="1578">
                  <c:v>1268.1749999999397</c:v>
                </c:pt>
                <c:pt idx="1579">
                  <c:v>1268.7249999999399</c:v>
                </c:pt>
                <c:pt idx="1580">
                  <c:v>1269.2749999999396</c:v>
                </c:pt>
                <c:pt idx="1581">
                  <c:v>1269.8249999999398</c:v>
                </c:pt>
                <c:pt idx="1582">
                  <c:v>1270.3749999999395</c:v>
                </c:pt>
                <c:pt idx="1583">
                  <c:v>1270.9249999999397</c:v>
                </c:pt>
                <c:pt idx="1584">
                  <c:v>1271.4749999999394</c:v>
                </c:pt>
                <c:pt idx="1585">
                  <c:v>1272.0249999999396</c:v>
                </c:pt>
                <c:pt idx="1586">
                  <c:v>1272.5749999999393</c:v>
                </c:pt>
                <c:pt idx="1587">
                  <c:v>1273.1249999999395</c:v>
                </c:pt>
                <c:pt idx="1588">
                  <c:v>1273.6749999999392</c:v>
                </c:pt>
                <c:pt idx="1589">
                  <c:v>1274.2249999999394</c:v>
                </c:pt>
                <c:pt idx="1590">
                  <c:v>1274.7749999999392</c:v>
                </c:pt>
                <c:pt idx="1591">
                  <c:v>1275.3249999999393</c:v>
                </c:pt>
                <c:pt idx="1592">
                  <c:v>1275.8749999999391</c:v>
                </c:pt>
                <c:pt idx="1593">
                  <c:v>1276.4249999999392</c:v>
                </c:pt>
                <c:pt idx="1594">
                  <c:v>1276.974999999939</c:v>
                </c:pt>
                <c:pt idx="1595">
                  <c:v>1277.5249999999392</c:v>
                </c:pt>
                <c:pt idx="1596">
                  <c:v>1278.0749999999389</c:v>
                </c:pt>
                <c:pt idx="1597">
                  <c:v>1278.6249999999391</c:v>
                </c:pt>
                <c:pt idx="1598">
                  <c:v>1279.1749999999388</c:v>
                </c:pt>
                <c:pt idx="1599">
                  <c:v>1279.724999999939</c:v>
                </c:pt>
                <c:pt idx="1600">
                  <c:v>1280.2749999999387</c:v>
                </c:pt>
                <c:pt idx="1601">
                  <c:v>1280.8249999999389</c:v>
                </c:pt>
                <c:pt idx="1602">
                  <c:v>1281.3749999999386</c:v>
                </c:pt>
                <c:pt idx="1603">
                  <c:v>1281.9249999999388</c:v>
                </c:pt>
                <c:pt idx="1604">
                  <c:v>1282.4749999999385</c:v>
                </c:pt>
                <c:pt idx="1605">
                  <c:v>1283.0249999999387</c:v>
                </c:pt>
                <c:pt idx="1606">
                  <c:v>1283.5749999999384</c:v>
                </c:pt>
                <c:pt idx="1607">
                  <c:v>1284.1249999999386</c:v>
                </c:pt>
                <c:pt idx="1608">
                  <c:v>1284.6749999999383</c:v>
                </c:pt>
                <c:pt idx="1609">
                  <c:v>1285.2249999999385</c:v>
                </c:pt>
                <c:pt idx="1610">
                  <c:v>1285.7749999999382</c:v>
                </c:pt>
                <c:pt idx="1611">
                  <c:v>1286.3249999999384</c:v>
                </c:pt>
                <c:pt idx="1612">
                  <c:v>1286.8749999999382</c:v>
                </c:pt>
                <c:pt idx="1613">
                  <c:v>1287.4249999999383</c:v>
                </c:pt>
                <c:pt idx="1614">
                  <c:v>1287.9749999999381</c:v>
                </c:pt>
                <c:pt idx="1615">
                  <c:v>1288.5249999999382</c:v>
                </c:pt>
                <c:pt idx="1616">
                  <c:v>1289.074999999938</c:v>
                </c:pt>
                <c:pt idx="1617">
                  <c:v>1289.6249999999382</c:v>
                </c:pt>
                <c:pt idx="1618">
                  <c:v>1290.1749999999379</c:v>
                </c:pt>
                <c:pt idx="1619">
                  <c:v>1290.7249999999381</c:v>
                </c:pt>
                <c:pt idx="1620">
                  <c:v>1291.2749999999378</c:v>
                </c:pt>
                <c:pt idx="1621">
                  <c:v>1291.824999999938</c:v>
                </c:pt>
                <c:pt idx="1622">
                  <c:v>1292.3749999999377</c:v>
                </c:pt>
                <c:pt idx="1623">
                  <c:v>1292.9249999999379</c:v>
                </c:pt>
                <c:pt idx="1624">
                  <c:v>1293.4749999999376</c:v>
                </c:pt>
                <c:pt idx="1625">
                  <c:v>1294.0249999999378</c:v>
                </c:pt>
                <c:pt idx="1626">
                  <c:v>1294.5749999999375</c:v>
                </c:pt>
                <c:pt idx="1627">
                  <c:v>1295.1249999999377</c:v>
                </c:pt>
                <c:pt idx="1628">
                  <c:v>1295.6749999999374</c:v>
                </c:pt>
                <c:pt idx="1629">
                  <c:v>1296.2249999999376</c:v>
                </c:pt>
                <c:pt idx="1630">
                  <c:v>1296.7749999999373</c:v>
                </c:pt>
                <c:pt idx="1631">
                  <c:v>1297.3249999999375</c:v>
                </c:pt>
                <c:pt idx="1632">
                  <c:v>1297.8749999999372</c:v>
                </c:pt>
                <c:pt idx="1633">
                  <c:v>1298.4249999999374</c:v>
                </c:pt>
                <c:pt idx="1634">
                  <c:v>1298.9749999999372</c:v>
                </c:pt>
                <c:pt idx="1635">
                  <c:v>1299.5249999999373</c:v>
                </c:pt>
                <c:pt idx="1636">
                  <c:v>1300.0749999999371</c:v>
                </c:pt>
                <c:pt idx="1637">
                  <c:v>1300.6249999999372</c:v>
                </c:pt>
                <c:pt idx="1638">
                  <c:v>1301.174999999937</c:v>
                </c:pt>
                <c:pt idx="1639">
                  <c:v>1301.7249999999372</c:v>
                </c:pt>
                <c:pt idx="1640">
                  <c:v>1302.2749999999369</c:v>
                </c:pt>
                <c:pt idx="1641">
                  <c:v>1302.8249999999371</c:v>
                </c:pt>
                <c:pt idx="1642">
                  <c:v>1303.3749999999368</c:v>
                </c:pt>
                <c:pt idx="1643">
                  <c:v>1303.924999999937</c:v>
                </c:pt>
                <c:pt idx="1644">
                  <c:v>1304.4749999999367</c:v>
                </c:pt>
                <c:pt idx="1645">
                  <c:v>1305.0249999999369</c:v>
                </c:pt>
                <c:pt idx="1646">
                  <c:v>1305.5749999999366</c:v>
                </c:pt>
                <c:pt idx="1647">
                  <c:v>1306.1249999999368</c:v>
                </c:pt>
                <c:pt idx="1648">
                  <c:v>1306.6749999999365</c:v>
                </c:pt>
                <c:pt idx="1649">
                  <c:v>1307.2249999999367</c:v>
                </c:pt>
                <c:pt idx="1650">
                  <c:v>1307.7749999999364</c:v>
                </c:pt>
                <c:pt idx="1651">
                  <c:v>1308.3249999999366</c:v>
                </c:pt>
                <c:pt idx="1652">
                  <c:v>1308.8749999999363</c:v>
                </c:pt>
                <c:pt idx="1653">
                  <c:v>1309.4249999999365</c:v>
                </c:pt>
                <c:pt idx="1654">
                  <c:v>1309.9749999999362</c:v>
                </c:pt>
                <c:pt idx="1655">
                  <c:v>1310.5249999999364</c:v>
                </c:pt>
                <c:pt idx="1656">
                  <c:v>1311.0749999999362</c:v>
                </c:pt>
                <c:pt idx="1657">
                  <c:v>1311.6249999999363</c:v>
                </c:pt>
                <c:pt idx="1658">
                  <c:v>1312.1749999999361</c:v>
                </c:pt>
                <c:pt idx="1659">
                  <c:v>1312.7249999999362</c:v>
                </c:pt>
                <c:pt idx="1660">
                  <c:v>1313.274999999936</c:v>
                </c:pt>
                <c:pt idx="1661">
                  <c:v>1313.8249999999362</c:v>
                </c:pt>
                <c:pt idx="1662">
                  <c:v>1314.3749999999359</c:v>
                </c:pt>
                <c:pt idx="1663">
                  <c:v>1314.9249999999361</c:v>
                </c:pt>
                <c:pt idx="1664">
                  <c:v>1315.4749999999358</c:v>
                </c:pt>
                <c:pt idx="1665">
                  <c:v>1316.024999999936</c:v>
                </c:pt>
                <c:pt idx="1666">
                  <c:v>1316.5749999999357</c:v>
                </c:pt>
                <c:pt idx="1667">
                  <c:v>1317.1249999999359</c:v>
                </c:pt>
                <c:pt idx="1668">
                  <c:v>1317.6749999999356</c:v>
                </c:pt>
                <c:pt idx="1669">
                  <c:v>1318.2249999999358</c:v>
                </c:pt>
                <c:pt idx="1670">
                  <c:v>1318.7749999999355</c:v>
                </c:pt>
                <c:pt idx="1671">
                  <c:v>1319.3249999999357</c:v>
                </c:pt>
                <c:pt idx="1672">
                  <c:v>1319.8749999999354</c:v>
                </c:pt>
                <c:pt idx="1673">
                  <c:v>1320.4249999999356</c:v>
                </c:pt>
                <c:pt idx="1674">
                  <c:v>1320.9749999999353</c:v>
                </c:pt>
                <c:pt idx="1675">
                  <c:v>1321.5249999999355</c:v>
                </c:pt>
                <c:pt idx="1676">
                  <c:v>1322.0749999999352</c:v>
                </c:pt>
                <c:pt idx="1677">
                  <c:v>1322.6249999999354</c:v>
                </c:pt>
                <c:pt idx="1678">
                  <c:v>1323.1749999999352</c:v>
                </c:pt>
                <c:pt idx="1679">
                  <c:v>1323.7249999999353</c:v>
                </c:pt>
                <c:pt idx="1680">
                  <c:v>1324.2749999999351</c:v>
                </c:pt>
                <c:pt idx="1681">
                  <c:v>1324.8249999999352</c:v>
                </c:pt>
                <c:pt idx="1682">
                  <c:v>1325.374999999935</c:v>
                </c:pt>
                <c:pt idx="1683">
                  <c:v>1325.9249999999352</c:v>
                </c:pt>
                <c:pt idx="1684">
                  <c:v>1326.4749999999349</c:v>
                </c:pt>
                <c:pt idx="1685">
                  <c:v>1327.0249999999351</c:v>
                </c:pt>
                <c:pt idx="1686">
                  <c:v>1327.5749999999348</c:v>
                </c:pt>
                <c:pt idx="1687">
                  <c:v>1328.124999999935</c:v>
                </c:pt>
                <c:pt idx="1688">
                  <c:v>1328.6749999999347</c:v>
                </c:pt>
                <c:pt idx="1689">
                  <c:v>1329.2249999999349</c:v>
                </c:pt>
                <c:pt idx="1690">
                  <c:v>1329.7749999999346</c:v>
                </c:pt>
                <c:pt idx="1691">
                  <c:v>1330.3249999999348</c:v>
                </c:pt>
                <c:pt idx="1692">
                  <c:v>1330.8749999999345</c:v>
                </c:pt>
                <c:pt idx="1693">
                  <c:v>1331.4249999999347</c:v>
                </c:pt>
                <c:pt idx="1694">
                  <c:v>1331.9749999999344</c:v>
                </c:pt>
                <c:pt idx="1695">
                  <c:v>1332.5249999999346</c:v>
                </c:pt>
                <c:pt idx="1696">
                  <c:v>1333.0749999999343</c:v>
                </c:pt>
                <c:pt idx="1697">
                  <c:v>1333.6249999999345</c:v>
                </c:pt>
                <c:pt idx="1698">
                  <c:v>1334.1749999999342</c:v>
                </c:pt>
                <c:pt idx="1699">
                  <c:v>1334.7249999999344</c:v>
                </c:pt>
                <c:pt idx="1700">
                  <c:v>1335.2749999999342</c:v>
                </c:pt>
                <c:pt idx="1701">
                  <c:v>1335.8249999999343</c:v>
                </c:pt>
                <c:pt idx="1702">
                  <c:v>1336.3749999999341</c:v>
                </c:pt>
                <c:pt idx="1703">
                  <c:v>1336.9249999999342</c:v>
                </c:pt>
                <c:pt idx="1704">
                  <c:v>1337.474999999934</c:v>
                </c:pt>
                <c:pt idx="1705">
                  <c:v>1338.0249999999342</c:v>
                </c:pt>
                <c:pt idx="1706">
                  <c:v>1338.5749999999339</c:v>
                </c:pt>
                <c:pt idx="1707">
                  <c:v>1339.1249999999341</c:v>
                </c:pt>
                <c:pt idx="1708">
                  <c:v>1339.6749999999338</c:v>
                </c:pt>
                <c:pt idx="1709">
                  <c:v>1340.224999999934</c:v>
                </c:pt>
                <c:pt idx="1710">
                  <c:v>1340.7749999999337</c:v>
                </c:pt>
                <c:pt idx="1711">
                  <c:v>1341.3249999999339</c:v>
                </c:pt>
                <c:pt idx="1712">
                  <c:v>1341.8749999999336</c:v>
                </c:pt>
                <c:pt idx="1713">
                  <c:v>1342.4249999999338</c:v>
                </c:pt>
                <c:pt idx="1714">
                  <c:v>1342.9749999999335</c:v>
                </c:pt>
                <c:pt idx="1715">
                  <c:v>1343.5249999999337</c:v>
                </c:pt>
                <c:pt idx="1716">
                  <c:v>1344.0749999999334</c:v>
                </c:pt>
                <c:pt idx="1717">
                  <c:v>1344.6249999999336</c:v>
                </c:pt>
                <c:pt idx="1718">
                  <c:v>1345.1749999999333</c:v>
                </c:pt>
                <c:pt idx="1719">
                  <c:v>1345.7249999999335</c:v>
                </c:pt>
                <c:pt idx="1720">
                  <c:v>1346.2749999999332</c:v>
                </c:pt>
                <c:pt idx="1721">
                  <c:v>1346.8249999999334</c:v>
                </c:pt>
                <c:pt idx="1722">
                  <c:v>1347.3749999999332</c:v>
                </c:pt>
                <c:pt idx="1723">
                  <c:v>1347.9249999999333</c:v>
                </c:pt>
                <c:pt idx="1724">
                  <c:v>1348.4749999999331</c:v>
                </c:pt>
                <c:pt idx="1725">
                  <c:v>1349.0249999999332</c:v>
                </c:pt>
                <c:pt idx="1726">
                  <c:v>1349.574999999933</c:v>
                </c:pt>
                <c:pt idx="1727">
                  <c:v>1350.1249999999332</c:v>
                </c:pt>
                <c:pt idx="1728">
                  <c:v>1350.6749999999329</c:v>
                </c:pt>
                <c:pt idx="1729">
                  <c:v>1351.2249999999331</c:v>
                </c:pt>
                <c:pt idx="1730">
                  <c:v>1351.7749999999328</c:v>
                </c:pt>
                <c:pt idx="1731">
                  <c:v>1352.324999999933</c:v>
                </c:pt>
                <c:pt idx="1732">
                  <c:v>1352.8749999999327</c:v>
                </c:pt>
                <c:pt idx="1733">
                  <c:v>1353.4249999999329</c:v>
                </c:pt>
                <c:pt idx="1734">
                  <c:v>1353.9749999999326</c:v>
                </c:pt>
                <c:pt idx="1735">
                  <c:v>1354.5249999999328</c:v>
                </c:pt>
                <c:pt idx="1736">
                  <c:v>1355.0749999999325</c:v>
                </c:pt>
                <c:pt idx="1737">
                  <c:v>1355.6249999999327</c:v>
                </c:pt>
                <c:pt idx="1738">
                  <c:v>1356.1749999999324</c:v>
                </c:pt>
                <c:pt idx="1739">
                  <c:v>1356.7249999999326</c:v>
                </c:pt>
                <c:pt idx="1740">
                  <c:v>1357.2749999999323</c:v>
                </c:pt>
                <c:pt idx="1741">
                  <c:v>1357.8249999999325</c:v>
                </c:pt>
                <c:pt idx="1742">
                  <c:v>1358.3749999999322</c:v>
                </c:pt>
                <c:pt idx="1743">
                  <c:v>1358.9249999999324</c:v>
                </c:pt>
                <c:pt idx="1744">
                  <c:v>1359.4749999999322</c:v>
                </c:pt>
                <c:pt idx="1745">
                  <c:v>1360.0249999999323</c:v>
                </c:pt>
                <c:pt idx="1746">
                  <c:v>1360.5749999999321</c:v>
                </c:pt>
                <c:pt idx="1747">
                  <c:v>1361.1249999999322</c:v>
                </c:pt>
                <c:pt idx="1748">
                  <c:v>1361.674999999932</c:v>
                </c:pt>
                <c:pt idx="1749">
                  <c:v>1362.2249999999322</c:v>
                </c:pt>
                <c:pt idx="1750">
                  <c:v>1362.7749999999319</c:v>
                </c:pt>
                <c:pt idx="1751">
                  <c:v>1363.3249999999321</c:v>
                </c:pt>
                <c:pt idx="1752">
                  <c:v>1363.8749999999318</c:v>
                </c:pt>
                <c:pt idx="1753">
                  <c:v>1364.424999999932</c:v>
                </c:pt>
                <c:pt idx="1754">
                  <c:v>1364.9749999999317</c:v>
                </c:pt>
                <c:pt idx="1755">
                  <c:v>1365.5249999999319</c:v>
                </c:pt>
                <c:pt idx="1756">
                  <c:v>1366.0749999999316</c:v>
                </c:pt>
                <c:pt idx="1757">
                  <c:v>1366.6249999999318</c:v>
                </c:pt>
                <c:pt idx="1758">
                  <c:v>1367.1749999999315</c:v>
                </c:pt>
                <c:pt idx="1759">
                  <c:v>1367.7249999999317</c:v>
                </c:pt>
                <c:pt idx="1760">
                  <c:v>1368.2749999999314</c:v>
                </c:pt>
                <c:pt idx="1761">
                  <c:v>1368.8249999999316</c:v>
                </c:pt>
                <c:pt idx="1762">
                  <c:v>1369.3749999999313</c:v>
                </c:pt>
                <c:pt idx="1763">
                  <c:v>1369.9249999999315</c:v>
                </c:pt>
                <c:pt idx="1764">
                  <c:v>1370.4749999999312</c:v>
                </c:pt>
                <c:pt idx="1765">
                  <c:v>1371.0249999999314</c:v>
                </c:pt>
                <c:pt idx="1766">
                  <c:v>1371.5749999999312</c:v>
                </c:pt>
                <c:pt idx="1767">
                  <c:v>1372.1249999999313</c:v>
                </c:pt>
                <c:pt idx="1768">
                  <c:v>1372.6749999999311</c:v>
                </c:pt>
                <c:pt idx="1769">
                  <c:v>1373.2249999999312</c:v>
                </c:pt>
                <c:pt idx="1770">
                  <c:v>1373.774999999931</c:v>
                </c:pt>
                <c:pt idx="1771">
                  <c:v>1374.3249999999312</c:v>
                </c:pt>
                <c:pt idx="1772">
                  <c:v>1374.8749999999309</c:v>
                </c:pt>
                <c:pt idx="1773">
                  <c:v>1375.4249999999311</c:v>
                </c:pt>
                <c:pt idx="1774">
                  <c:v>1375.9749999999308</c:v>
                </c:pt>
                <c:pt idx="1775">
                  <c:v>1376.524999999931</c:v>
                </c:pt>
                <c:pt idx="1776">
                  <c:v>1377.0749999999307</c:v>
                </c:pt>
                <c:pt idx="1777">
                  <c:v>1377.6249999999309</c:v>
                </c:pt>
                <c:pt idx="1778">
                  <c:v>1378.1749999999306</c:v>
                </c:pt>
                <c:pt idx="1779">
                  <c:v>1378.7249999999308</c:v>
                </c:pt>
                <c:pt idx="1780">
                  <c:v>1379.2749999999305</c:v>
                </c:pt>
                <c:pt idx="1781">
                  <c:v>1379.8249999999307</c:v>
                </c:pt>
                <c:pt idx="1782">
                  <c:v>1380.3749999999304</c:v>
                </c:pt>
                <c:pt idx="1783">
                  <c:v>1380.9249999999306</c:v>
                </c:pt>
                <c:pt idx="1784">
                  <c:v>1381.4749999999303</c:v>
                </c:pt>
                <c:pt idx="1785">
                  <c:v>1382.0249999999305</c:v>
                </c:pt>
                <c:pt idx="1786">
                  <c:v>1382.5749999999302</c:v>
                </c:pt>
                <c:pt idx="1787">
                  <c:v>1383.1249999999304</c:v>
                </c:pt>
                <c:pt idx="1788">
                  <c:v>1383.6749999999302</c:v>
                </c:pt>
                <c:pt idx="1789">
                  <c:v>1384.2249999999303</c:v>
                </c:pt>
                <c:pt idx="1790">
                  <c:v>1384.7749999999301</c:v>
                </c:pt>
                <c:pt idx="1791">
                  <c:v>1385.3249999999302</c:v>
                </c:pt>
                <c:pt idx="1792">
                  <c:v>1385.87499999993</c:v>
                </c:pt>
                <c:pt idx="1793">
                  <c:v>1386.4249999999302</c:v>
                </c:pt>
                <c:pt idx="1794">
                  <c:v>1386.9749999999299</c:v>
                </c:pt>
                <c:pt idx="1795">
                  <c:v>1387.5249999999301</c:v>
                </c:pt>
                <c:pt idx="1796">
                  <c:v>1388.0749999999298</c:v>
                </c:pt>
                <c:pt idx="1797">
                  <c:v>1388.62499999993</c:v>
                </c:pt>
                <c:pt idx="1798">
                  <c:v>1389.1749999999297</c:v>
                </c:pt>
                <c:pt idx="1799">
                  <c:v>1389.7249999999299</c:v>
                </c:pt>
                <c:pt idx="1800">
                  <c:v>1390.2749999999296</c:v>
                </c:pt>
                <c:pt idx="1801">
                  <c:v>1390.8249999999298</c:v>
                </c:pt>
                <c:pt idx="1802">
                  <c:v>1391.3749999999295</c:v>
                </c:pt>
                <c:pt idx="1803">
                  <c:v>1391.9249999999297</c:v>
                </c:pt>
                <c:pt idx="1804">
                  <c:v>1392.4749999999294</c:v>
                </c:pt>
                <c:pt idx="1805">
                  <c:v>1393.0249999999296</c:v>
                </c:pt>
                <c:pt idx="1806">
                  <c:v>1393.5749999999293</c:v>
                </c:pt>
                <c:pt idx="1807">
                  <c:v>1394.1249999999295</c:v>
                </c:pt>
                <c:pt idx="1808">
                  <c:v>1394.6749999999292</c:v>
                </c:pt>
                <c:pt idx="1809">
                  <c:v>1395.2249999999294</c:v>
                </c:pt>
                <c:pt idx="1810">
                  <c:v>1395.7749999999292</c:v>
                </c:pt>
                <c:pt idx="1811">
                  <c:v>1396.3249999999293</c:v>
                </c:pt>
                <c:pt idx="1812">
                  <c:v>1396.8749999999291</c:v>
                </c:pt>
                <c:pt idx="1813">
                  <c:v>1397.4249999999292</c:v>
                </c:pt>
                <c:pt idx="1814">
                  <c:v>1397.974999999929</c:v>
                </c:pt>
                <c:pt idx="1815">
                  <c:v>1398.5249999999292</c:v>
                </c:pt>
                <c:pt idx="1816">
                  <c:v>1399.0749999999289</c:v>
                </c:pt>
                <c:pt idx="1817">
                  <c:v>1399.6249999999291</c:v>
                </c:pt>
                <c:pt idx="1818">
                  <c:v>1400.1749999999288</c:v>
                </c:pt>
                <c:pt idx="1819">
                  <c:v>1400.724999999929</c:v>
                </c:pt>
                <c:pt idx="1820">
                  <c:v>1401.2749999999287</c:v>
                </c:pt>
                <c:pt idx="1821">
                  <c:v>1401.8249999999289</c:v>
                </c:pt>
                <c:pt idx="1822">
                  <c:v>1402.3749999999286</c:v>
                </c:pt>
                <c:pt idx="1823">
                  <c:v>1402.9249999999288</c:v>
                </c:pt>
                <c:pt idx="1824">
                  <c:v>1403.4749999999285</c:v>
                </c:pt>
                <c:pt idx="1825">
                  <c:v>1404.0249999999287</c:v>
                </c:pt>
                <c:pt idx="1826">
                  <c:v>1404.5749999999284</c:v>
                </c:pt>
                <c:pt idx="1827">
                  <c:v>1405.1249999999286</c:v>
                </c:pt>
                <c:pt idx="1828">
                  <c:v>1405.6749999999283</c:v>
                </c:pt>
                <c:pt idx="1829">
                  <c:v>1406.2249999999285</c:v>
                </c:pt>
                <c:pt idx="1830">
                  <c:v>1406.7749999999282</c:v>
                </c:pt>
                <c:pt idx="1831">
                  <c:v>1407.3249999999284</c:v>
                </c:pt>
                <c:pt idx="1832">
                  <c:v>1407.8749999999281</c:v>
                </c:pt>
                <c:pt idx="1833">
                  <c:v>1408.4249999999283</c:v>
                </c:pt>
                <c:pt idx="1834">
                  <c:v>1408.9749999999281</c:v>
                </c:pt>
                <c:pt idx="1835">
                  <c:v>1409.5249999999282</c:v>
                </c:pt>
                <c:pt idx="1836">
                  <c:v>1410.074999999928</c:v>
                </c:pt>
                <c:pt idx="1837">
                  <c:v>1410.6249999999281</c:v>
                </c:pt>
                <c:pt idx="1838">
                  <c:v>1411.1749999999279</c:v>
                </c:pt>
                <c:pt idx="1839">
                  <c:v>1411.7249999999281</c:v>
                </c:pt>
                <c:pt idx="1840">
                  <c:v>1412.2749999999278</c:v>
                </c:pt>
                <c:pt idx="1841">
                  <c:v>1412.824999999928</c:v>
                </c:pt>
                <c:pt idx="1842">
                  <c:v>1413.3749999999277</c:v>
                </c:pt>
                <c:pt idx="1843">
                  <c:v>1413.9249999999279</c:v>
                </c:pt>
                <c:pt idx="1844">
                  <c:v>1414.4749999999276</c:v>
                </c:pt>
                <c:pt idx="1845">
                  <c:v>1415.0249999999278</c:v>
                </c:pt>
                <c:pt idx="1846">
                  <c:v>1415.5749999999275</c:v>
                </c:pt>
                <c:pt idx="1847">
                  <c:v>1416.1249999999277</c:v>
                </c:pt>
                <c:pt idx="1848">
                  <c:v>1416.6749999999274</c:v>
                </c:pt>
                <c:pt idx="1849">
                  <c:v>1417.2249999999276</c:v>
                </c:pt>
                <c:pt idx="1850">
                  <c:v>1417.7749999999273</c:v>
                </c:pt>
                <c:pt idx="1851">
                  <c:v>1418.3249999999275</c:v>
                </c:pt>
                <c:pt idx="1852">
                  <c:v>1418.8749999999272</c:v>
                </c:pt>
                <c:pt idx="1853">
                  <c:v>1419.4249999999274</c:v>
                </c:pt>
                <c:pt idx="1854">
                  <c:v>1419.9749999999271</c:v>
                </c:pt>
                <c:pt idx="1855">
                  <c:v>1420.5249999999273</c:v>
                </c:pt>
                <c:pt idx="1856">
                  <c:v>1421.0749999999271</c:v>
                </c:pt>
                <c:pt idx="1857">
                  <c:v>1421.6249999999272</c:v>
                </c:pt>
                <c:pt idx="1858">
                  <c:v>1422.174999999927</c:v>
                </c:pt>
                <c:pt idx="1859">
                  <c:v>1422.7249999999271</c:v>
                </c:pt>
                <c:pt idx="1860">
                  <c:v>1423.2749999999269</c:v>
                </c:pt>
                <c:pt idx="1861">
                  <c:v>1423.8249999999271</c:v>
                </c:pt>
                <c:pt idx="1862">
                  <c:v>1424.3749999999268</c:v>
                </c:pt>
                <c:pt idx="1863">
                  <c:v>1424.924999999927</c:v>
                </c:pt>
                <c:pt idx="1864">
                  <c:v>1425.4749999999267</c:v>
                </c:pt>
                <c:pt idx="1865">
                  <c:v>1426.0249999999269</c:v>
                </c:pt>
                <c:pt idx="1866">
                  <c:v>1426.5749999999266</c:v>
                </c:pt>
                <c:pt idx="1867">
                  <c:v>1427.1249999999268</c:v>
                </c:pt>
                <c:pt idx="1868">
                  <c:v>1427.6749999999265</c:v>
                </c:pt>
                <c:pt idx="1869">
                  <c:v>1428.2249999999267</c:v>
                </c:pt>
                <c:pt idx="1870">
                  <c:v>1428.7749999999264</c:v>
                </c:pt>
                <c:pt idx="1871">
                  <c:v>1429.3249999999266</c:v>
                </c:pt>
                <c:pt idx="1872">
                  <c:v>1429.8749999999263</c:v>
                </c:pt>
                <c:pt idx="1873">
                  <c:v>1430.4249999999265</c:v>
                </c:pt>
                <c:pt idx="1874">
                  <c:v>1430.9749999999262</c:v>
                </c:pt>
                <c:pt idx="1875">
                  <c:v>1431.5249999999264</c:v>
                </c:pt>
                <c:pt idx="1876">
                  <c:v>1432.0749999999261</c:v>
                </c:pt>
                <c:pt idx="1877">
                  <c:v>1432.6249999999263</c:v>
                </c:pt>
                <c:pt idx="1878">
                  <c:v>1433.1749999999261</c:v>
                </c:pt>
                <c:pt idx="1879">
                  <c:v>1433.7249999999262</c:v>
                </c:pt>
                <c:pt idx="1880">
                  <c:v>1434.274999999926</c:v>
                </c:pt>
                <c:pt idx="1881">
                  <c:v>1434.8249999999261</c:v>
                </c:pt>
                <c:pt idx="1882">
                  <c:v>1435.3749999999259</c:v>
                </c:pt>
                <c:pt idx="1883">
                  <c:v>1435.9249999999261</c:v>
                </c:pt>
                <c:pt idx="1884">
                  <c:v>1436.4749999999258</c:v>
                </c:pt>
                <c:pt idx="1885">
                  <c:v>1437.024999999926</c:v>
                </c:pt>
                <c:pt idx="1886">
                  <c:v>1437.5749999999257</c:v>
                </c:pt>
                <c:pt idx="1887">
                  <c:v>1438.1249999999259</c:v>
                </c:pt>
                <c:pt idx="1888">
                  <c:v>1438.6749999999256</c:v>
                </c:pt>
                <c:pt idx="1889">
                  <c:v>1439.2249999999258</c:v>
                </c:pt>
                <c:pt idx="1890">
                  <c:v>1439.7749999999255</c:v>
                </c:pt>
                <c:pt idx="1891">
                  <c:v>1440.3249999999257</c:v>
                </c:pt>
                <c:pt idx="1892">
                  <c:v>1440.8749999999254</c:v>
                </c:pt>
                <c:pt idx="1893">
                  <c:v>1441.4249999999256</c:v>
                </c:pt>
                <c:pt idx="1894">
                  <c:v>1441.9749999999253</c:v>
                </c:pt>
                <c:pt idx="1895">
                  <c:v>1442.5249999999255</c:v>
                </c:pt>
                <c:pt idx="1896">
                  <c:v>1443.0749999999252</c:v>
                </c:pt>
                <c:pt idx="1897">
                  <c:v>1443.6249999999254</c:v>
                </c:pt>
                <c:pt idx="1898">
                  <c:v>1444.1749999999251</c:v>
                </c:pt>
                <c:pt idx="1899">
                  <c:v>1444.7249999999253</c:v>
                </c:pt>
                <c:pt idx="1900">
                  <c:v>1445.2749999999251</c:v>
                </c:pt>
                <c:pt idx="1901">
                  <c:v>1445.8249999999252</c:v>
                </c:pt>
                <c:pt idx="1902">
                  <c:v>1446.374999999925</c:v>
                </c:pt>
                <c:pt idx="1903">
                  <c:v>1446.9249999999251</c:v>
                </c:pt>
                <c:pt idx="1904">
                  <c:v>1447.4749999999249</c:v>
                </c:pt>
                <c:pt idx="1905">
                  <c:v>1448.0249999999251</c:v>
                </c:pt>
                <c:pt idx="1906">
                  <c:v>1448.5749999999248</c:v>
                </c:pt>
                <c:pt idx="1907">
                  <c:v>1449.124999999925</c:v>
                </c:pt>
                <c:pt idx="1908">
                  <c:v>1449.6749999999247</c:v>
                </c:pt>
                <c:pt idx="1909">
                  <c:v>1450.2249999999249</c:v>
                </c:pt>
                <c:pt idx="1910">
                  <c:v>1450.7749999999246</c:v>
                </c:pt>
                <c:pt idx="1911">
                  <c:v>1451.3249999999248</c:v>
                </c:pt>
                <c:pt idx="1912">
                  <c:v>1451.8749999999245</c:v>
                </c:pt>
                <c:pt idx="1913">
                  <c:v>1452.4249999999247</c:v>
                </c:pt>
                <c:pt idx="1914">
                  <c:v>1452.9749999999244</c:v>
                </c:pt>
                <c:pt idx="1915">
                  <c:v>1453.5249999999246</c:v>
                </c:pt>
                <c:pt idx="1916">
                  <c:v>1454.0749999999243</c:v>
                </c:pt>
                <c:pt idx="1917">
                  <c:v>1454.6249999999245</c:v>
                </c:pt>
                <c:pt idx="1918">
                  <c:v>1455.1749999999242</c:v>
                </c:pt>
                <c:pt idx="1919">
                  <c:v>1455.7249999999244</c:v>
                </c:pt>
                <c:pt idx="1920">
                  <c:v>1456.2749999999241</c:v>
                </c:pt>
                <c:pt idx="1921">
                  <c:v>1456.8249999999243</c:v>
                </c:pt>
                <c:pt idx="1922">
                  <c:v>1457.3749999999241</c:v>
                </c:pt>
                <c:pt idx="1923">
                  <c:v>1457.9249999999242</c:v>
                </c:pt>
                <c:pt idx="1924">
                  <c:v>1458.474999999924</c:v>
                </c:pt>
                <c:pt idx="1925">
                  <c:v>1459.0249999999241</c:v>
                </c:pt>
                <c:pt idx="1926">
                  <c:v>1459.5749999999239</c:v>
                </c:pt>
                <c:pt idx="1927">
                  <c:v>1460.1249999999241</c:v>
                </c:pt>
                <c:pt idx="1928">
                  <c:v>1460.6749999999238</c:v>
                </c:pt>
                <c:pt idx="1929">
                  <c:v>1461.224999999924</c:v>
                </c:pt>
                <c:pt idx="1930">
                  <c:v>1461.7749999999237</c:v>
                </c:pt>
                <c:pt idx="1931">
                  <c:v>1462.3249999999239</c:v>
                </c:pt>
                <c:pt idx="1932">
                  <c:v>1462.8749999999236</c:v>
                </c:pt>
                <c:pt idx="1933">
                  <c:v>1463.4249999999238</c:v>
                </c:pt>
                <c:pt idx="1934">
                  <c:v>1463.9749999999235</c:v>
                </c:pt>
                <c:pt idx="1935">
                  <c:v>1464.5249999999237</c:v>
                </c:pt>
                <c:pt idx="1936">
                  <c:v>1465.0749999999234</c:v>
                </c:pt>
                <c:pt idx="1937">
                  <c:v>1465.6249999999236</c:v>
                </c:pt>
                <c:pt idx="1938">
                  <c:v>1466.1749999999233</c:v>
                </c:pt>
                <c:pt idx="1939">
                  <c:v>1466.7249999999235</c:v>
                </c:pt>
                <c:pt idx="1940">
                  <c:v>1467.2749999999232</c:v>
                </c:pt>
                <c:pt idx="1941">
                  <c:v>1467.8249999999234</c:v>
                </c:pt>
                <c:pt idx="1942">
                  <c:v>1468.3749999999231</c:v>
                </c:pt>
                <c:pt idx="1943">
                  <c:v>1468.9249999999233</c:v>
                </c:pt>
                <c:pt idx="1944">
                  <c:v>1469.4749999999231</c:v>
                </c:pt>
                <c:pt idx="1945">
                  <c:v>1470.0249999999232</c:v>
                </c:pt>
                <c:pt idx="1946">
                  <c:v>1470.574999999923</c:v>
                </c:pt>
                <c:pt idx="1947">
                  <c:v>1471.1249999999231</c:v>
                </c:pt>
                <c:pt idx="1948">
                  <c:v>1471.6749999999229</c:v>
                </c:pt>
                <c:pt idx="1949">
                  <c:v>1472.2249999999231</c:v>
                </c:pt>
                <c:pt idx="1950">
                  <c:v>1472.7749999999228</c:v>
                </c:pt>
                <c:pt idx="1951">
                  <c:v>1473.324999999923</c:v>
                </c:pt>
                <c:pt idx="1952">
                  <c:v>1473.8749999999227</c:v>
                </c:pt>
                <c:pt idx="1953">
                  <c:v>1474.4249999999229</c:v>
                </c:pt>
                <c:pt idx="1954">
                  <c:v>1474.9749999999226</c:v>
                </c:pt>
                <c:pt idx="1955">
                  <c:v>1475.5249999999228</c:v>
                </c:pt>
                <c:pt idx="1956">
                  <c:v>1476.0749999999225</c:v>
                </c:pt>
                <c:pt idx="1957">
                  <c:v>1476.6249999999227</c:v>
                </c:pt>
                <c:pt idx="1958">
                  <c:v>1477.1749999999224</c:v>
                </c:pt>
                <c:pt idx="1959">
                  <c:v>1477.7249999999226</c:v>
                </c:pt>
                <c:pt idx="1960">
                  <c:v>1478.2749999999223</c:v>
                </c:pt>
                <c:pt idx="1961">
                  <c:v>1478.8249999999225</c:v>
                </c:pt>
                <c:pt idx="1962">
                  <c:v>1479.3749999999222</c:v>
                </c:pt>
                <c:pt idx="1963">
                  <c:v>1479.9249999999224</c:v>
                </c:pt>
                <c:pt idx="1964">
                  <c:v>1480.4749999999221</c:v>
                </c:pt>
                <c:pt idx="1965">
                  <c:v>1481.0249999999223</c:v>
                </c:pt>
                <c:pt idx="1966">
                  <c:v>1481.5749999999221</c:v>
                </c:pt>
                <c:pt idx="1967">
                  <c:v>1482.1249999999222</c:v>
                </c:pt>
                <c:pt idx="1968">
                  <c:v>1482.674999999922</c:v>
                </c:pt>
                <c:pt idx="1969">
                  <c:v>1483.2249999999221</c:v>
                </c:pt>
                <c:pt idx="1970">
                  <c:v>1483.7749999999219</c:v>
                </c:pt>
                <c:pt idx="1971">
                  <c:v>1484.3249999999221</c:v>
                </c:pt>
                <c:pt idx="1972">
                  <c:v>1484.8749999999218</c:v>
                </c:pt>
                <c:pt idx="1973">
                  <c:v>1485.424999999922</c:v>
                </c:pt>
                <c:pt idx="1974">
                  <c:v>1485.9749999999217</c:v>
                </c:pt>
                <c:pt idx="1975">
                  <c:v>1486.5249999999219</c:v>
                </c:pt>
                <c:pt idx="1976">
                  <c:v>1487.0749999999216</c:v>
                </c:pt>
                <c:pt idx="1977">
                  <c:v>1487.6249999999218</c:v>
                </c:pt>
                <c:pt idx="1978">
                  <c:v>1488.1749999999215</c:v>
                </c:pt>
                <c:pt idx="1979">
                  <c:v>1488.7249999999217</c:v>
                </c:pt>
                <c:pt idx="1980">
                  <c:v>1489.2749999999214</c:v>
                </c:pt>
                <c:pt idx="1981">
                  <c:v>1489.8249999999216</c:v>
                </c:pt>
                <c:pt idx="1982">
                  <c:v>1490.3749999999213</c:v>
                </c:pt>
                <c:pt idx="1983">
                  <c:v>1490.9249999999215</c:v>
                </c:pt>
                <c:pt idx="1984">
                  <c:v>1491.4749999999212</c:v>
                </c:pt>
                <c:pt idx="1985">
                  <c:v>1492.0249999999214</c:v>
                </c:pt>
                <c:pt idx="1986">
                  <c:v>1492.5749999999211</c:v>
                </c:pt>
                <c:pt idx="1987">
                  <c:v>1493.1249999999213</c:v>
                </c:pt>
                <c:pt idx="1988">
                  <c:v>1493.6749999999211</c:v>
                </c:pt>
                <c:pt idx="1989">
                  <c:v>1494.2249999999212</c:v>
                </c:pt>
                <c:pt idx="1990">
                  <c:v>1494.774999999921</c:v>
                </c:pt>
                <c:pt idx="1991">
                  <c:v>1495.3249999999211</c:v>
                </c:pt>
                <c:pt idx="1992">
                  <c:v>1495.8749999999209</c:v>
                </c:pt>
                <c:pt idx="1993">
                  <c:v>1496.4249999999211</c:v>
                </c:pt>
                <c:pt idx="1994">
                  <c:v>1496.9749999999208</c:v>
                </c:pt>
                <c:pt idx="1995">
                  <c:v>1497.524999999921</c:v>
                </c:pt>
                <c:pt idx="1996">
                  <c:v>1498.0749999999207</c:v>
                </c:pt>
                <c:pt idx="1997">
                  <c:v>1498.6249999999209</c:v>
                </c:pt>
                <c:pt idx="1998">
                  <c:v>1499.1749999999206</c:v>
                </c:pt>
                <c:pt idx="1999">
                  <c:v>1499.7249999999208</c:v>
                </c:pt>
              </c:numCache>
            </c:numRef>
          </c:xVal>
          <c:yVal>
            <c:numRef>
              <c:f>'VW_40 Cell micro'!$N$3:$N$2002</c:f>
              <c:numCache>
                <c:formatCode>General</c:formatCode>
                <c:ptCount val="2000"/>
                <c:pt idx="0">
                  <c:v>0.40937181483273077</c:v>
                </c:pt>
                <c:pt idx="1">
                  <c:v>0.4148961495378663</c:v>
                </c:pt>
                <c:pt idx="2">
                  <c:v>0.41638816977274651</c:v>
                </c:pt>
                <c:pt idx="3">
                  <c:v>0.41901374596558011</c:v>
                </c:pt>
                <c:pt idx="4">
                  <c:v>0.42240556364283821</c:v>
                </c:pt>
                <c:pt idx="5">
                  <c:v>0.42463164097530548</c:v>
                </c:pt>
                <c:pt idx="6">
                  <c:v>0.42999083345114986</c:v>
                </c:pt>
                <c:pt idx="7">
                  <c:v>0.43415888156855853</c:v>
                </c:pt>
                <c:pt idx="8">
                  <c:v>0.43765700931230306</c:v>
                </c:pt>
                <c:pt idx="9">
                  <c:v>0.44066224195664427</c:v>
                </c:pt>
                <c:pt idx="10">
                  <c:v>0.44364226995798878</c:v>
                </c:pt>
                <c:pt idx="11">
                  <c:v>0.44708702904164482</c:v>
                </c:pt>
                <c:pt idx="12">
                  <c:v>0.45121417026978927</c:v>
                </c:pt>
                <c:pt idx="13">
                  <c:v>0.45563080213841795</c:v>
                </c:pt>
                <c:pt idx="14">
                  <c:v>0.45941397555714003</c:v>
                </c:pt>
                <c:pt idx="15">
                  <c:v>0.46329466733109254</c:v>
                </c:pt>
                <c:pt idx="16">
                  <c:v>0.4665891539183662</c:v>
                </c:pt>
                <c:pt idx="17">
                  <c:v>0.47001415507985705</c:v>
                </c:pt>
                <c:pt idx="18">
                  <c:v>0.47339047630259196</c:v>
                </c:pt>
                <c:pt idx="19">
                  <c:v>0.47703079154408623</c:v>
                </c:pt>
                <c:pt idx="20">
                  <c:v>0.48053569186654754</c:v>
                </c:pt>
                <c:pt idx="21">
                  <c:v>0.48387294331983532</c:v>
                </c:pt>
                <c:pt idx="22">
                  <c:v>0.48661093533785021</c:v>
                </c:pt>
                <c:pt idx="23">
                  <c:v>0.48936918938248469</c:v>
                </c:pt>
                <c:pt idx="24">
                  <c:v>0.49203749832908944</c:v>
                </c:pt>
                <c:pt idx="25">
                  <c:v>0.49415642759640943</c:v>
                </c:pt>
                <c:pt idx="26">
                  <c:v>0.49640388102785604</c:v>
                </c:pt>
                <c:pt idx="27">
                  <c:v>0.49776624826429405</c:v>
                </c:pt>
                <c:pt idx="28">
                  <c:v>0.49885917955223857</c:v>
                </c:pt>
                <c:pt idx="29">
                  <c:v>0.50009649131591816</c:v>
                </c:pt>
                <c:pt idx="30">
                  <c:v>0.50175688774020066</c:v>
                </c:pt>
                <c:pt idx="31">
                  <c:v>0.50333712513405016</c:v>
                </c:pt>
                <c:pt idx="32">
                  <c:v>0.50484819324685981</c:v>
                </c:pt>
                <c:pt idx="33">
                  <c:v>0.50635115449434354</c:v>
                </c:pt>
                <c:pt idx="34">
                  <c:v>0.50736057801225487</c:v>
                </c:pt>
                <c:pt idx="35">
                  <c:v>0.50839488714334591</c:v>
                </c:pt>
                <c:pt idx="36">
                  <c:v>0.5092580067168625</c:v>
                </c:pt>
                <c:pt idx="37">
                  <c:v>0.50988744775782935</c:v>
                </c:pt>
                <c:pt idx="38">
                  <c:v>0.51047188547785083</c:v>
                </c:pt>
                <c:pt idx="39">
                  <c:v>0.51098761875326681</c:v>
                </c:pt>
                <c:pt idx="40">
                  <c:v>0.51122987606581716</c:v>
                </c:pt>
                <c:pt idx="41">
                  <c:v>0.51153937842665909</c:v>
                </c:pt>
                <c:pt idx="42">
                  <c:v>0.5116685369690207</c:v>
                </c:pt>
                <c:pt idx="43">
                  <c:v>0.51204815703866235</c:v>
                </c:pt>
                <c:pt idx="44">
                  <c:v>0.51253346740801076</c:v>
                </c:pt>
                <c:pt idx="45">
                  <c:v>0.51275533576023091</c:v>
                </c:pt>
                <c:pt idx="46">
                  <c:v>0.5132760297281318</c:v>
                </c:pt>
                <c:pt idx="47">
                  <c:v>0.51384816597028549</c:v>
                </c:pt>
                <c:pt idx="48">
                  <c:v>0.51443275140382949</c:v>
                </c:pt>
                <c:pt idx="49">
                  <c:v>0.51525844939945775</c:v>
                </c:pt>
                <c:pt idx="50">
                  <c:v>0.51671426935079912</c:v>
                </c:pt>
                <c:pt idx="51">
                  <c:v>0.51802082178031328</c:v>
                </c:pt>
                <c:pt idx="52">
                  <c:v>0.51944720874847783</c:v>
                </c:pt>
                <c:pt idx="53">
                  <c:v>0.52094859862597143</c:v>
                </c:pt>
                <c:pt idx="54">
                  <c:v>0.52224619328774236</c:v>
                </c:pt>
                <c:pt idx="55">
                  <c:v>0.52363504617712431</c:v>
                </c:pt>
                <c:pt idx="56">
                  <c:v>0.52486862948877688</c:v>
                </c:pt>
                <c:pt idx="57">
                  <c:v>0.52626400274987706</c:v>
                </c:pt>
                <c:pt idx="58">
                  <c:v>0.52772678831575159</c:v>
                </c:pt>
                <c:pt idx="59">
                  <c:v>0.52911505532935788</c:v>
                </c:pt>
                <c:pt idx="60">
                  <c:v>0.53041834921897058</c:v>
                </c:pt>
                <c:pt idx="61">
                  <c:v>0.53189455281324527</c:v>
                </c:pt>
                <c:pt idx="62">
                  <c:v>0.5333829923950425</c:v>
                </c:pt>
                <c:pt idx="63">
                  <c:v>0.53503644038124165</c:v>
                </c:pt>
                <c:pt idx="64">
                  <c:v>0.53670928566351384</c:v>
                </c:pt>
                <c:pt idx="65">
                  <c:v>0.53835180016974493</c:v>
                </c:pt>
                <c:pt idx="66">
                  <c:v>0.54012578629956853</c:v>
                </c:pt>
                <c:pt idx="67">
                  <c:v>0.54173156135434164</c:v>
                </c:pt>
                <c:pt idx="68">
                  <c:v>0.54322933360015946</c:v>
                </c:pt>
                <c:pt idx="69">
                  <c:v>0.54490266692472622</c:v>
                </c:pt>
                <c:pt idx="70">
                  <c:v>0.54647253562842424</c:v>
                </c:pt>
                <c:pt idx="71">
                  <c:v>0.54755273851777986</c:v>
                </c:pt>
                <c:pt idx="72">
                  <c:v>0.54866777995147764</c:v>
                </c:pt>
                <c:pt idx="73">
                  <c:v>0.6270763308051448</c:v>
                </c:pt>
                <c:pt idx="74">
                  <c:v>0.62855940267314836</c:v>
                </c:pt>
                <c:pt idx="75">
                  <c:v>0.63001101663402892</c:v>
                </c:pt>
                <c:pt idx="76">
                  <c:v>0.63130645188539969</c:v>
                </c:pt>
                <c:pt idx="77">
                  <c:v>0.63254428314471822</c:v>
                </c:pt>
                <c:pt idx="78">
                  <c:v>0.63378638862089332</c:v>
                </c:pt>
                <c:pt idx="79">
                  <c:v>0.63502154664598609</c:v>
                </c:pt>
                <c:pt idx="80">
                  <c:v>0.63621877530050486</c:v>
                </c:pt>
                <c:pt idx="81">
                  <c:v>0.63745815972379094</c:v>
                </c:pt>
                <c:pt idx="82">
                  <c:v>0.63862601210041425</c:v>
                </c:pt>
                <c:pt idx="83">
                  <c:v>0.63959382198925308</c:v>
                </c:pt>
                <c:pt idx="84">
                  <c:v>0.64215587254175954</c:v>
                </c:pt>
                <c:pt idx="85">
                  <c:v>0.64456563163658931</c:v>
                </c:pt>
                <c:pt idx="86">
                  <c:v>0.64687900112184527</c:v>
                </c:pt>
                <c:pt idx="87">
                  <c:v>0.64926736992683798</c:v>
                </c:pt>
                <c:pt idx="88">
                  <c:v>0.65155366120566738</c:v>
                </c:pt>
                <c:pt idx="89">
                  <c:v>0.65367162247035793</c:v>
                </c:pt>
                <c:pt idx="90">
                  <c:v>0.65585531903278471</c:v>
                </c:pt>
                <c:pt idx="91">
                  <c:v>0.65792040374215743</c:v>
                </c:pt>
                <c:pt idx="92">
                  <c:v>0.66002902503839223</c:v>
                </c:pt>
                <c:pt idx="93">
                  <c:v>0.66199446937473938</c:v>
                </c:pt>
                <c:pt idx="94">
                  <c:v>0.66380901400308634</c:v>
                </c:pt>
                <c:pt idx="95">
                  <c:v>0.66556016021278563</c:v>
                </c:pt>
                <c:pt idx="96">
                  <c:v>0.66720934745581628</c:v>
                </c:pt>
                <c:pt idx="97">
                  <c:v>0.66874510487535632</c:v>
                </c:pt>
                <c:pt idx="98">
                  <c:v>0.67024759145522395</c:v>
                </c:pt>
                <c:pt idx="99">
                  <c:v>0.67183266504001349</c:v>
                </c:pt>
                <c:pt idx="100">
                  <c:v>0.67333784500535776</c:v>
                </c:pt>
                <c:pt idx="101">
                  <c:v>0.67504495218932459</c:v>
                </c:pt>
                <c:pt idx="102">
                  <c:v>0.67676687846444761</c:v>
                </c:pt>
                <c:pt idx="103">
                  <c:v>0.67840059382255569</c:v>
                </c:pt>
                <c:pt idx="104">
                  <c:v>0.6801728958195612</c:v>
                </c:pt>
                <c:pt idx="105">
                  <c:v>0.68201568473543051</c:v>
                </c:pt>
                <c:pt idx="106">
                  <c:v>0.68404666566119632</c:v>
                </c:pt>
                <c:pt idx="107">
                  <c:v>0.68624796581403513</c:v>
                </c:pt>
                <c:pt idx="108">
                  <c:v>0.6884394132224062</c:v>
                </c:pt>
                <c:pt idx="109">
                  <c:v>0.69055618712436673</c:v>
                </c:pt>
                <c:pt idx="110">
                  <c:v>0.69278043127524114</c:v>
                </c:pt>
                <c:pt idx="111">
                  <c:v>0.6949401939467541</c:v>
                </c:pt>
                <c:pt idx="112">
                  <c:v>0.69719884369268081</c:v>
                </c:pt>
                <c:pt idx="113">
                  <c:v>0.69951031471736813</c:v>
                </c:pt>
                <c:pt idx="114">
                  <c:v>0.70174407212684697</c:v>
                </c:pt>
                <c:pt idx="115">
                  <c:v>0.70397696752873484</c:v>
                </c:pt>
                <c:pt idx="116">
                  <c:v>0.70629972220524784</c:v>
                </c:pt>
                <c:pt idx="117">
                  <c:v>0.7086687442218863</c:v>
                </c:pt>
                <c:pt idx="118">
                  <c:v>0.71103045999528691</c:v>
                </c:pt>
                <c:pt idx="119">
                  <c:v>0.71349378243438211</c:v>
                </c:pt>
                <c:pt idx="120">
                  <c:v>0.71582153738632759</c:v>
                </c:pt>
                <c:pt idx="121">
                  <c:v>0.71822636615070312</c:v>
                </c:pt>
                <c:pt idx="122">
                  <c:v>0.72056901295710174</c:v>
                </c:pt>
                <c:pt idx="123">
                  <c:v>0.72271830121401492</c:v>
                </c:pt>
                <c:pt idx="124">
                  <c:v>0.72516469616894164</c:v>
                </c:pt>
                <c:pt idx="125">
                  <c:v>0.72769341649437236</c:v>
                </c:pt>
                <c:pt idx="126">
                  <c:v>0.73024109043693564</c:v>
                </c:pt>
                <c:pt idx="127">
                  <c:v>0.7327739787419959</c:v>
                </c:pt>
                <c:pt idx="128">
                  <c:v>0.73507256179617741</c:v>
                </c:pt>
                <c:pt idx="129">
                  <c:v>0.73723897359394108</c:v>
                </c:pt>
                <c:pt idx="130">
                  <c:v>0.73953869390759053</c:v>
                </c:pt>
                <c:pt idx="131">
                  <c:v>0.7417644417869087</c:v>
                </c:pt>
                <c:pt idx="132">
                  <c:v>0.74407446109905206</c:v>
                </c:pt>
                <c:pt idx="133">
                  <c:v>0.74641652837756067</c:v>
                </c:pt>
                <c:pt idx="134">
                  <c:v>0.74855114040031934</c:v>
                </c:pt>
                <c:pt idx="135">
                  <c:v>0.7504452433251374</c:v>
                </c:pt>
                <c:pt idx="136">
                  <c:v>0.7522873292065585</c:v>
                </c:pt>
                <c:pt idx="137">
                  <c:v>0.7539470303593877</c:v>
                </c:pt>
                <c:pt idx="138">
                  <c:v>0.75554456298414674</c:v>
                </c:pt>
                <c:pt idx="139">
                  <c:v>0.75722954273309062</c:v>
                </c:pt>
                <c:pt idx="140">
                  <c:v>0.75877854462956429</c:v>
                </c:pt>
                <c:pt idx="141">
                  <c:v>0.76058777454194404</c:v>
                </c:pt>
                <c:pt idx="142">
                  <c:v>0.76249407423860716</c:v>
                </c:pt>
                <c:pt idx="143">
                  <c:v>0.76434202702252141</c:v>
                </c:pt>
                <c:pt idx="144">
                  <c:v>0.76633993835163561</c:v>
                </c:pt>
                <c:pt idx="145">
                  <c:v>0.7680873017492843</c:v>
                </c:pt>
                <c:pt idx="146">
                  <c:v>0.76960466643719216</c:v>
                </c:pt>
                <c:pt idx="147">
                  <c:v>0.77101168200355741</c:v>
                </c:pt>
                <c:pt idx="148">
                  <c:v>0.77225393885644034</c:v>
                </c:pt>
                <c:pt idx="149">
                  <c:v>0.77362318312151945</c:v>
                </c:pt>
                <c:pt idx="150">
                  <c:v>0.77528157264344999</c:v>
                </c:pt>
                <c:pt idx="151">
                  <c:v>0.77681849659969182</c:v>
                </c:pt>
                <c:pt idx="152">
                  <c:v>0.77845774702727977</c:v>
                </c:pt>
                <c:pt idx="153">
                  <c:v>0.78015530583951409</c:v>
                </c:pt>
                <c:pt idx="154">
                  <c:v>0.78162776889413399</c:v>
                </c:pt>
                <c:pt idx="155">
                  <c:v>0.78323709319020374</c:v>
                </c:pt>
                <c:pt idx="156">
                  <c:v>0.78511779807928683</c:v>
                </c:pt>
                <c:pt idx="157">
                  <c:v>0.78698758551217884</c:v>
                </c:pt>
                <c:pt idx="158">
                  <c:v>0.78886019635320981</c:v>
                </c:pt>
                <c:pt idx="159">
                  <c:v>0.79080978656582201</c:v>
                </c:pt>
                <c:pt idx="160">
                  <c:v>0.79260301612344097</c:v>
                </c:pt>
                <c:pt idx="161">
                  <c:v>0.79453939756117853</c:v>
                </c:pt>
                <c:pt idx="162">
                  <c:v>0.79644417951115598</c:v>
                </c:pt>
                <c:pt idx="163">
                  <c:v>0.79822704197177174</c:v>
                </c:pt>
                <c:pt idx="164">
                  <c:v>0.8000319227033138</c:v>
                </c:pt>
                <c:pt idx="165">
                  <c:v>0.80176262284154809</c:v>
                </c:pt>
                <c:pt idx="166">
                  <c:v>0.80349654253056257</c:v>
                </c:pt>
                <c:pt idx="167">
                  <c:v>0.80539943964299099</c:v>
                </c:pt>
                <c:pt idx="168">
                  <c:v>0.80726149108871681</c:v>
                </c:pt>
                <c:pt idx="169">
                  <c:v>0.80890115249834427</c:v>
                </c:pt>
                <c:pt idx="170">
                  <c:v>0.81041702501725588</c:v>
                </c:pt>
                <c:pt idx="171">
                  <c:v>0.8115663914547151</c:v>
                </c:pt>
                <c:pt idx="172">
                  <c:v>0.81268665537352835</c:v>
                </c:pt>
                <c:pt idx="173">
                  <c:v>0.81375214243096283</c:v>
                </c:pt>
                <c:pt idx="174">
                  <c:v>0.81463786190164533</c:v>
                </c:pt>
                <c:pt idx="175">
                  <c:v>0.81567391894345631</c:v>
                </c:pt>
                <c:pt idx="176">
                  <c:v>0.81665775718665312</c:v>
                </c:pt>
                <c:pt idx="177">
                  <c:v>0.81751584965077007</c:v>
                </c:pt>
                <c:pt idx="178">
                  <c:v>0.81839850806866321</c:v>
                </c:pt>
                <c:pt idx="179">
                  <c:v>0.81938720064025117</c:v>
                </c:pt>
                <c:pt idx="180">
                  <c:v>0.82025892920519128</c:v>
                </c:pt>
                <c:pt idx="181">
                  <c:v>0.82120208657960747</c:v>
                </c:pt>
                <c:pt idx="182">
                  <c:v>0.82201539715712235</c:v>
                </c:pt>
                <c:pt idx="183">
                  <c:v>0.82255703837472061</c:v>
                </c:pt>
                <c:pt idx="184">
                  <c:v>0.8230586065146106</c:v>
                </c:pt>
                <c:pt idx="185">
                  <c:v>0.82344484867882894</c:v>
                </c:pt>
                <c:pt idx="186">
                  <c:v>0.82377096299743657</c:v>
                </c:pt>
                <c:pt idx="187">
                  <c:v>0.82420508615376986</c:v>
                </c:pt>
                <c:pt idx="188">
                  <c:v>0.8244839052011379</c:v>
                </c:pt>
                <c:pt idx="189">
                  <c:v>0.82471352440711021</c:v>
                </c:pt>
                <c:pt idx="190">
                  <c:v>0.8252724688980464</c:v>
                </c:pt>
                <c:pt idx="191">
                  <c:v>0.82583067723952541</c:v>
                </c:pt>
                <c:pt idx="192">
                  <c:v>0.82667570814009639</c:v>
                </c:pt>
                <c:pt idx="193">
                  <c:v>0.82776617456919444</c:v>
                </c:pt>
                <c:pt idx="194">
                  <c:v>0.82882266150878559</c:v>
                </c:pt>
                <c:pt idx="195">
                  <c:v>0.82990365181125347</c:v>
                </c:pt>
                <c:pt idx="196">
                  <c:v>0.83104522596585662</c:v>
                </c:pt>
                <c:pt idx="197">
                  <c:v>0.83208830816818724</c:v>
                </c:pt>
                <c:pt idx="198">
                  <c:v>0.83312524018303691</c:v>
                </c:pt>
                <c:pt idx="199">
                  <c:v>0.83416434271404361</c:v>
                </c:pt>
                <c:pt idx="200">
                  <c:v>0.83504802338297301</c:v>
                </c:pt>
                <c:pt idx="201">
                  <c:v>0.83602043319191144</c:v>
                </c:pt>
                <c:pt idx="202">
                  <c:v>0.83685352496450771</c:v>
                </c:pt>
                <c:pt idx="203">
                  <c:v>0.83766028601273512</c:v>
                </c:pt>
                <c:pt idx="204">
                  <c:v>0.83859191404545652</c:v>
                </c:pt>
                <c:pt idx="205">
                  <c:v>0.83947227756659004</c:v>
                </c:pt>
                <c:pt idx="206">
                  <c:v>0.84043639425325034</c:v>
                </c:pt>
                <c:pt idx="207">
                  <c:v>0.84154790590557405</c:v>
                </c:pt>
                <c:pt idx="208">
                  <c:v>0.84254820111649498</c:v>
                </c:pt>
                <c:pt idx="209">
                  <c:v>0.84363330863611408</c:v>
                </c:pt>
                <c:pt idx="210">
                  <c:v>0.84499193449916843</c:v>
                </c:pt>
                <c:pt idx="211">
                  <c:v>0.84618809944425188</c:v>
                </c:pt>
                <c:pt idx="212">
                  <c:v>0.84753362012688316</c:v>
                </c:pt>
                <c:pt idx="213">
                  <c:v>0.84879001574263646</c:v>
                </c:pt>
                <c:pt idx="214">
                  <c:v>0.84963853776213849</c:v>
                </c:pt>
                <c:pt idx="215">
                  <c:v>0.85037692243906027</c:v>
                </c:pt>
                <c:pt idx="216">
                  <c:v>0.85122183787900796</c:v>
                </c:pt>
                <c:pt idx="217">
                  <c:v>0.85207771959977263</c:v>
                </c:pt>
                <c:pt idx="218">
                  <c:v>0.85318854790215115</c:v>
                </c:pt>
                <c:pt idx="219">
                  <c:v>0.85430383069182292</c:v>
                </c:pt>
                <c:pt idx="220">
                  <c:v>0.85530179098116876</c:v>
                </c:pt>
                <c:pt idx="221">
                  <c:v>0.85649656056484158</c:v>
                </c:pt>
                <c:pt idx="222">
                  <c:v>0.85781993207874185</c:v>
                </c:pt>
                <c:pt idx="223">
                  <c:v>0.85937049964892998</c:v>
                </c:pt>
                <c:pt idx="224">
                  <c:v>0.8609857215225617</c:v>
                </c:pt>
                <c:pt idx="225">
                  <c:v>0.8624874710651006</c:v>
                </c:pt>
                <c:pt idx="226">
                  <c:v>0.86395229650352157</c:v>
                </c:pt>
                <c:pt idx="227">
                  <c:v>0.86546272570832328</c:v>
                </c:pt>
                <c:pt idx="228">
                  <c:v>0.86683984097726052</c:v>
                </c:pt>
                <c:pt idx="229">
                  <c:v>0.86821019498711904</c:v>
                </c:pt>
                <c:pt idx="230">
                  <c:v>0.86976874885394684</c:v>
                </c:pt>
                <c:pt idx="231">
                  <c:v>0.87125059834589014</c:v>
                </c:pt>
                <c:pt idx="232">
                  <c:v>0.87297764075000539</c:v>
                </c:pt>
                <c:pt idx="233">
                  <c:v>0.87460119004989623</c:v>
                </c:pt>
                <c:pt idx="234">
                  <c:v>0.8760678821410488</c:v>
                </c:pt>
                <c:pt idx="235">
                  <c:v>0.87783208518103495</c:v>
                </c:pt>
                <c:pt idx="236">
                  <c:v>0.87976966428971692</c:v>
                </c:pt>
                <c:pt idx="237">
                  <c:v>0.88157183818660523</c:v>
                </c:pt>
                <c:pt idx="238">
                  <c:v>0.88323103707452211</c:v>
                </c:pt>
                <c:pt idx="239">
                  <c:v>0.88473303187185948</c:v>
                </c:pt>
                <c:pt idx="240">
                  <c:v>0.88628287771682168</c:v>
                </c:pt>
                <c:pt idx="241">
                  <c:v>0.88812087579057752</c:v>
                </c:pt>
                <c:pt idx="242">
                  <c:v>0.88998389709448367</c:v>
                </c:pt>
                <c:pt idx="243">
                  <c:v>0.89185478360115322</c:v>
                </c:pt>
                <c:pt idx="244">
                  <c:v>0.89371292153017812</c:v>
                </c:pt>
                <c:pt idx="245">
                  <c:v>0.89555424047844823</c:v>
                </c:pt>
                <c:pt idx="246">
                  <c:v>0.89766074722022515</c:v>
                </c:pt>
                <c:pt idx="247">
                  <c:v>0.89997949605237804</c:v>
                </c:pt>
                <c:pt idx="248">
                  <c:v>0.90211340538933071</c:v>
                </c:pt>
                <c:pt idx="249">
                  <c:v>0.90414697962292767</c:v>
                </c:pt>
                <c:pt idx="250">
                  <c:v>0.90623909243027956</c:v>
                </c:pt>
                <c:pt idx="251">
                  <c:v>0.90791378952643165</c:v>
                </c:pt>
                <c:pt idx="252">
                  <c:v>0.90949757031437151</c:v>
                </c:pt>
                <c:pt idx="253">
                  <c:v>0.91081659767211653</c:v>
                </c:pt>
                <c:pt idx="254">
                  <c:v>0.91197392776862429</c:v>
                </c:pt>
                <c:pt idx="255">
                  <c:v>0.91351252859570187</c:v>
                </c:pt>
                <c:pt idx="256">
                  <c:v>0.91506566327284211</c:v>
                </c:pt>
                <c:pt idx="257">
                  <c:v>0.91655516445895424</c:v>
                </c:pt>
                <c:pt idx="258">
                  <c:v>0.91808353811635701</c:v>
                </c:pt>
                <c:pt idx="259">
                  <c:v>0.91964832634094973</c:v>
                </c:pt>
                <c:pt idx="260">
                  <c:v>0.92108371013302726</c:v>
                </c:pt>
                <c:pt idx="261">
                  <c:v>0.92256525332365169</c:v>
                </c:pt>
                <c:pt idx="262">
                  <c:v>0.92386447971547814</c:v>
                </c:pt>
                <c:pt idx="263">
                  <c:v>0.92507244720449677</c:v>
                </c:pt>
                <c:pt idx="264">
                  <c:v>0.92615783515832961</c:v>
                </c:pt>
                <c:pt idx="265">
                  <c:v>0.92709031108599971</c:v>
                </c:pt>
                <c:pt idx="266">
                  <c:v>0.9279554191733127</c:v>
                </c:pt>
                <c:pt idx="267">
                  <c:v>0.92866188024489582</c:v>
                </c:pt>
                <c:pt idx="268">
                  <c:v>0.92918261800732271</c:v>
                </c:pt>
                <c:pt idx="269">
                  <c:v>0.92981069119636406</c:v>
                </c:pt>
                <c:pt idx="270">
                  <c:v>0.93070625968336984</c:v>
                </c:pt>
                <c:pt idx="271">
                  <c:v>0.93127524381745652</c:v>
                </c:pt>
                <c:pt idx="272">
                  <c:v>0.93201404202057925</c:v>
                </c:pt>
                <c:pt idx="273">
                  <c:v>0.93273696778653314</c:v>
                </c:pt>
                <c:pt idx="274">
                  <c:v>0.93338798840979798</c:v>
                </c:pt>
                <c:pt idx="275">
                  <c:v>0.9342302765511703</c:v>
                </c:pt>
                <c:pt idx="276">
                  <c:v>0.93478326746136997</c:v>
                </c:pt>
                <c:pt idx="277">
                  <c:v>0.93517174956395921</c:v>
                </c:pt>
                <c:pt idx="278">
                  <c:v>0.93559239722335852</c:v>
                </c:pt>
                <c:pt idx="279">
                  <c:v>0.93597305544564258</c:v>
                </c:pt>
                <c:pt idx="280">
                  <c:v>0.93629511254746323</c:v>
                </c:pt>
                <c:pt idx="281">
                  <c:v>0.93687398652803144</c:v>
                </c:pt>
                <c:pt idx="282">
                  <c:v>0.93752439811878385</c:v>
                </c:pt>
                <c:pt idx="283">
                  <c:v>0.93847653660222818</c:v>
                </c:pt>
                <c:pt idx="284">
                  <c:v>0.9399728629355677</c:v>
                </c:pt>
                <c:pt idx="285">
                  <c:v>0.94149057957796789</c:v>
                </c:pt>
                <c:pt idx="286">
                  <c:v>0.94306831593675133</c:v>
                </c:pt>
                <c:pt idx="287">
                  <c:v>0.94470354024106762</c:v>
                </c:pt>
                <c:pt idx="288">
                  <c:v>0.94616222537143013</c:v>
                </c:pt>
                <c:pt idx="289">
                  <c:v>0.9474686012748057</c:v>
                </c:pt>
                <c:pt idx="290">
                  <c:v>0.9488046574515957</c:v>
                </c:pt>
                <c:pt idx="291">
                  <c:v>0.94984159814944202</c:v>
                </c:pt>
                <c:pt idx="292">
                  <c:v>0.95121097330531013</c:v>
                </c:pt>
                <c:pt idx="293">
                  <c:v>0.95269810000219879</c:v>
                </c:pt>
                <c:pt idx="294">
                  <c:v>0.95432105639059484</c:v>
                </c:pt>
                <c:pt idx="295">
                  <c:v>0.95621038322563023</c:v>
                </c:pt>
                <c:pt idx="296">
                  <c:v>0.95804128128905408</c:v>
                </c:pt>
                <c:pt idx="297">
                  <c:v>0.95959864551674134</c:v>
                </c:pt>
                <c:pt idx="298">
                  <c:v>0.96128090479499206</c:v>
                </c:pt>
                <c:pt idx="299">
                  <c:v>0.9628229072564275</c:v>
                </c:pt>
                <c:pt idx="300">
                  <c:v>0.96421227186344016</c:v>
                </c:pt>
                <c:pt idx="301">
                  <c:v>0.96572445474344182</c:v>
                </c:pt>
                <c:pt idx="302">
                  <c:v>0.96709209268081098</c:v>
                </c:pt>
                <c:pt idx="303">
                  <c:v>0.96846906910231623</c:v>
                </c:pt>
                <c:pt idx="304">
                  <c:v>0.96967332839769615</c:v>
                </c:pt>
                <c:pt idx="305">
                  <c:v>0.97029547028387464</c:v>
                </c:pt>
                <c:pt idx="306">
                  <c:v>0.97092171773740366</c:v>
                </c:pt>
                <c:pt idx="307">
                  <c:v>0.9716395608424867</c:v>
                </c:pt>
                <c:pt idx="308">
                  <c:v>0.97222436233408394</c:v>
                </c:pt>
                <c:pt idx="309">
                  <c:v>0.97277208074206656</c:v>
                </c:pt>
                <c:pt idx="310">
                  <c:v>0.97350591699090294</c:v>
                </c:pt>
                <c:pt idx="311">
                  <c:v>0.97408586992804591</c:v>
                </c:pt>
                <c:pt idx="312">
                  <c:v>0.97486663214702041</c:v>
                </c:pt>
                <c:pt idx="313">
                  <c:v>0.97569969607594831</c:v>
                </c:pt>
                <c:pt idx="314">
                  <c:v>0.97632625256455186</c:v>
                </c:pt>
                <c:pt idx="315">
                  <c:v>0.97685298405092802</c:v>
                </c:pt>
                <c:pt idx="316">
                  <c:v>0.97728788005104328</c:v>
                </c:pt>
                <c:pt idx="317">
                  <c:v>0.97768486646530028</c:v>
                </c:pt>
                <c:pt idx="318">
                  <c:v>0.97835515212959612</c:v>
                </c:pt>
                <c:pt idx="319">
                  <c:v>0.97892361582843457</c:v>
                </c:pt>
                <c:pt idx="320">
                  <c:v>0.97952212659969617</c:v>
                </c:pt>
                <c:pt idx="321">
                  <c:v>0.98035736992179856</c:v>
                </c:pt>
                <c:pt idx="322">
                  <c:v>0.98113924325426838</c:v>
                </c:pt>
                <c:pt idx="323">
                  <c:v>0.98198565125944703</c:v>
                </c:pt>
                <c:pt idx="324">
                  <c:v>0.98282524805830496</c:v>
                </c:pt>
                <c:pt idx="325">
                  <c:v>0.98353730231130021</c:v>
                </c:pt>
                <c:pt idx="326">
                  <c:v>0.98422649034504262</c:v>
                </c:pt>
                <c:pt idx="327">
                  <c:v>0.98488530060977519</c:v>
                </c:pt>
                <c:pt idx="328">
                  <c:v>0.98533106670027104</c:v>
                </c:pt>
                <c:pt idx="329">
                  <c:v>0.98591841243498357</c:v>
                </c:pt>
                <c:pt idx="330">
                  <c:v>0.98675445181131971</c:v>
                </c:pt>
                <c:pt idx="331">
                  <c:v>0.98751789137533619</c:v>
                </c:pt>
                <c:pt idx="332">
                  <c:v>0.98850681353953562</c:v>
                </c:pt>
                <c:pt idx="333">
                  <c:v>0.98957776207893167</c:v>
                </c:pt>
                <c:pt idx="334">
                  <c:v>0.99050813073942401</c:v>
                </c:pt>
                <c:pt idx="335">
                  <c:v>0.99159431150667954</c:v>
                </c:pt>
                <c:pt idx="336">
                  <c:v>0.9927229372571883</c:v>
                </c:pt>
                <c:pt idx="337">
                  <c:v>0.99379573365172558</c:v>
                </c:pt>
                <c:pt idx="338">
                  <c:v>0.99492233082760306</c:v>
                </c:pt>
                <c:pt idx="339">
                  <c:v>0.99583041841382725</c:v>
                </c:pt>
                <c:pt idx="340">
                  <c:v>0.99648858536664631</c:v>
                </c:pt>
                <c:pt idx="341">
                  <c:v>0.9971852442421496</c:v>
                </c:pt>
                <c:pt idx="342">
                  <c:v>0.99769992254737483</c:v>
                </c:pt>
                <c:pt idx="343">
                  <c:v>0.9981481566347804</c:v>
                </c:pt>
                <c:pt idx="344">
                  <c:v>0.99853648912696258</c:v>
                </c:pt>
                <c:pt idx="345">
                  <c:v>0.99874565889794398</c:v>
                </c:pt>
                <c:pt idx="346">
                  <c:v>0.99898145579257824</c:v>
                </c:pt>
                <c:pt idx="347">
                  <c:v>0.99929111563835271</c:v>
                </c:pt>
                <c:pt idx="348">
                  <c:v>0.99950184801083375</c:v>
                </c:pt>
                <c:pt idx="349">
                  <c:v>0.99973082715079442</c:v>
                </c:pt>
                <c:pt idx="350">
                  <c:v>0.99982791814199523</c:v>
                </c:pt>
                <c:pt idx="351">
                  <c:v>0.9997998621570211</c:v>
                </c:pt>
                <c:pt idx="352">
                  <c:v>0.99994629108338495</c:v>
                </c:pt>
                <c:pt idx="353">
                  <c:v>1</c:v>
                </c:pt>
                <c:pt idx="354">
                  <c:v>0.99965918384364238</c:v>
                </c:pt>
                <c:pt idx="355">
                  <c:v>0.99918548029105791</c:v>
                </c:pt>
                <c:pt idx="356">
                  <c:v>0.99843784062190233</c:v>
                </c:pt>
                <c:pt idx="357">
                  <c:v>0.99747867055976724</c:v>
                </c:pt>
                <c:pt idx="358">
                  <c:v>0.9966210132868889</c:v>
                </c:pt>
                <c:pt idx="359">
                  <c:v>0.99562276136622019</c:v>
                </c:pt>
                <c:pt idx="360">
                  <c:v>0.99478156909076054</c:v>
                </c:pt>
                <c:pt idx="361">
                  <c:v>0.99434127459291155</c:v>
                </c:pt>
                <c:pt idx="362">
                  <c:v>0.99387542677092067</c:v>
                </c:pt>
                <c:pt idx="363">
                  <c:v>0.993546550469254</c:v>
                </c:pt>
                <c:pt idx="364">
                  <c:v>0.99321554813888335</c:v>
                </c:pt>
                <c:pt idx="365">
                  <c:v>0.99262511937459252</c:v>
                </c:pt>
                <c:pt idx="366">
                  <c:v>0.99205280819691533</c:v>
                </c:pt>
                <c:pt idx="367">
                  <c:v>0.99147030196120012</c:v>
                </c:pt>
                <c:pt idx="368">
                  <c:v>0.99068094493134795</c:v>
                </c:pt>
                <c:pt idx="369">
                  <c:v>0.98981758059080183</c:v>
                </c:pt>
                <c:pt idx="370">
                  <c:v>0.98888903174082532</c:v>
                </c:pt>
                <c:pt idx="371">
                  <c:v>0.98793324795788817</c:v>
                </c:pt>
                <c:pt idx="372">
                  <c:v>0.98709751887140407</c:v>
                </c:pt>
                <c:pt idx="373">
                  <c:v>0.98625880470763694</c:v>
                </c:pt>
                <c:pt idx="374">
                  <c:v>0.9853571300424816</c:v>
                </c:pt>
                <c:pt idx="375">
                  <c:v>0.9847741761390818</c:v>
                </c:pt>
                <c:pt idx="376">
                  <c:v>0.98432706042737328</c:v>
                </c:pt>
                <c:pt idx="377">
                  <c:v>0.98401540791310482</c:v>
                </c:pt>
                <c:pt idx="378">
                  <c:v>0.98385715516986527</c:v>
                </c:pt>
                <c:pt idx="379">
                  <c:v>0.983481992080667</c:v>
                </c:pt>
                <c:pt idx="380">
                  <c:v>0.98313752062298532</c:v>
                </c:pt>
                <c:pt idx="381">
                  <c:v>0.98281360964859388</c:v>
                </c:pt>
                <c:pt idx="382">
                  <c:v>0.98206609055995064</c:v>
                </c:pt>
                <c:pt idx="383">
                  <c:v>0.98124016838717543</c:v>
                </c:pt>
                <c:pt idx="384">
                  <c:v>0.98038769588656549</c:v>
                </c:pt>
                <c:pt idx="385">
                  <c:v>0.97948691494445494</c:v>
                </c:pt>
                <c:pt idx="386">
                  <c:v>0.97882514358553052</c:v>
                </c:pt>
                <c:pt idx="387">
                  <c:v>0.97830731260754655</c:v>
                </c:pt>
                <c:pt idx="388">
                  <c:v>0.97775198022584142</c:v>
                </c:pt>
                <c:pt idx="389">
                  <c:v>0.97723324576130299</c:v>
                </c:pt>
                <c:pt idx="390">
                  <c:v>0.97669286419512202</c:v>
                </c:pt>
                <c:pt idx="391">
                  <c:v>0.97605501487507296</c:v>
                </c:pt>
                <c:pt idx="392">
                  <c:v>0.97537694352553506</c:v>
                </c:pt>
                <c:pt idx="393">
                  <c:v>0.97426400637161148</c:v>
                </c:pt>
                <c:pt idx="394">
                  <c:v>0.97276420164242328</c:v>
                </c:pt>
                <c:pt idx="395">
                  <c:v>0.97123185829376757</c:v>
                </c:pt>
                <c:pt idx="396">
                  <c:v>0.96953046227436535</c:v>
                </c:pt>
                <c:pt idx="397">
                  <c:v>0.96778282358297685</c:v>
                </c:pt>
                <c:pt idx="398">
                  <c:v>0.96621369721871453</c:v>
                </c:pt>
                <c:pt idx="399">
                  <c:v>0.96456938248285151</c:v>
                </c:pt>
                <c:pt idx="400">
                  <c:v>0.96296828670216639</c:v>
                </c:pt>
                <c:pt idx="401">
                  <c:v>0.96141372744392961</c:v>
                </c:pt>
                <c:pt idx="402">
                  <c:v>0.95941921864192292</c:v>
                </c:pt>
                <c:pt idx="403">
                  <c:v>0.95764862311667576</c:v>
                </c:pt>
                <c:pt idx="404">
                  <c:v>0.95597549338104215</c:v>
                </c:pt>
                <c:pt idx="405">
                  <c:v>0.9541741471525077</c:v>
                </c:pt>
                <c:pt idx="406">
                  <c:v>0.95243234601863169</c:v>
                </c:pt>
                <c:pt idx="407">
                  <c:v>0.95070168479589601</c:v>
                </c:pt>
                <c:pt idx="408">
                  <c:v>0.94885334190574511</c:v>
                </c:pt>
                <c:pt idx="409">
                  <c:v>0.94700116523440758</c:v>
                </c:pt>
                <c:pt idx="410">
                  <c:v>0.94516360441589997</c:v>
                </c:pt>
                <c:pt idx="411">
                  <c:v>0.94341009060571124</c:v>
                </c:pt>
                <c:pt idx="412">
                  <c:v>0.94209952283339415</c:v>
                </c:pt>
                <c:pt idx="413">
                  <c:v>0.94096009411706905</c:v>
                </c:pt>
                <c:pt idx="414">
                  <c:v>0.94010660342830776</c:v>
                </c:pt>
                <c:pt idx="415">
                  <c:v>0.93944241713166754</c:v>
                </c:pt>
                <c:pt idx="416">
                  <c:v>0.93871461950000912</c:v>
                </c:pt>
                <c:pt idx="417">
                  <c:v>0.93789263296044256</c:v>
                </c:pt>
                <c:pt idx="418">
                  <c:v>0.93711404781704288</c:v>
                </c:pt>
                <c:pt idx="419">
                  <c:v>0.93608894362382788</c:v>
                </c:pt>
                <c:pt idx="420">
                  <c:v>0.93504781632823297</c:v>
                </c:pt>
                <c:pt idx="421">
                  <c:v>0.934154984650019</c:v>
                </c:pt>
                <c:pt idx="422">
                  <c:v>0.93314497492585424</c:v>
                </c:pt>
                <c:pt idx="423">
                  <c:v>0.93252955005011284</c:v>
                </c:pt>
                <c:pt idx="424">
                  <c:v>0.931901675422253</c:v>
                </c:pt>
                <c:pt idx="425">
                  <c:v>0.93104369161775413</c:v>
                </c:pt>
                <c:pt idx="426">
                  <c:v>0.93013512050188674</c:v>
                </c:pt>
                <c:pt idx="427">
                  <c:v>0.92913246384454973</c:v>
                </c:pt>
                <c:pt idx="428">
                  <c:v>0.9279640978367808</c:v>
                </c:pt>
                <c:pt idx="429">
                  <c:v>0.92674368788015538</c:v>
                </c:pt>
                <c:pt idx="430">
                  <c:v>0.92538702350786284</c:v>
                </c:pt>
                <c:pt idx="431">
                  <c:v>0.92361477667678982</c:v>
                </c:pt>
                <c:pt idx="432">
                  <c:v>0.92194372135836733</c:v>
                </c:pt>
                <c:pt idx="433">
                  <c:v>0.91998730997101474</c:v>
                </c:pt>
                <c:pt idx="434">
                  <c:v>0.91797004465824672</c:v>
                </c:pt>
                <c:pt idx="435">
                  <c:v>0.91590337847526382</c:v>
                </c:pt>
                <c:pt idx="436">
                  <c:v>0.91374832873353251</c:v>
                </c:pt>
                <c:pt idx="437">
                  <c:v>0.91158314604953861</c:v>
                </c:pt>
                <c:pt idx="438">
                  <c:v>0.9096157674232942</c:v>
                </c:pt>
                <c:pt idx="439">
                  <c:v>0.90752953794774038</c:v>
                </c:pt>
                <c:pt idx="440">
                  <c:v>0.90545330135795321</c:v>
                </c:pt>
                <c:pt idx="441">
                  <c:v>0.90333028550558114</c:v>
                </c:pt>
                <c:pt idx="442">
                  <c:v>0.90100066254637146</c:v>
                </c:pt>
                <c:pt idx="443">
                  <c:v>0.89871343990573938</c:v>
                </c:pt>
                <c:pt idx="444">
                  <c:v>0.89640088285549391</c:v>
                </c:pt>
                <c:pt idx="445">
                  <c:v>0.89390076097476223</c:v>
                </c:pt>
                <c:pt idx="446">
                  <c:v>0.8915362895045178</c:v>
                </c:pt>
                <c:pt idx="447">
                  <c:v>0.8892673351465793</c:v>
                </c:pt>
                <c:pt idx="448">
                  <c:v>0.88699637702024992</c:v>
                </c:pt>
                <c:pt idx="449">
                  <c:v>0.8847666893805296</c:v>
                </c:pt>
                <c:pt idx="450">
                  <c:v>0.88257119998021771</c:v>
                </c:pt>
                <c:pt idx="451">
                  <c:v>0.88045292737806113</c:v>
                </c:pt>
                <c:pt idx="452">
                  <c:v>0.87886534542026651</c:v>
                </c:pt>
                <c:pt idx="453">
                  <c:v>0.87715367657959531</c:v>
                </c:pt>
                <c:pt idx="454">
                  <c:v>0.87542389704337953</c:v>
                </c:pt>
                <c:pt idx="455">
                  <c:v>0.87374821797695124</c:v>
                </c:pt>
                <c:pt idx="456">
                  <c:v>0.87208246470803741</c:v>
                </c:pt>
                <c:pt idx="457">
                  <c:v>0.87053746694913725</c:v>
                </c:pt>
                <c:pt idx="458">
                  <c:v>0.86928045703089341</c:v>
                </c:pt>
                <c:pt idx="459">
                  <c:v>0.86788390920129865</c:v>
                </c:pt>
                <c:pt idx="460">
                  <c:v>0.86644182352628185</c:v>
                </c:pt>
                <c:pt idx="461">
                  <c:v>0.86512136811198503</c:v>
                </c:pt>
                <c:pt idx="462">
                  <c:v>0.86374895853879841</c:v>
                </c:pt>
                <c:pt idx="463">
                  <c:v>0.86246958393818274</c:v>
                </c:pt>
                <c:pt idx="464">
                  <c:v>0.86134427559352167</c:v>
                </c:pt>
                <c:pt idx="465">
                  <c:v>0.86018352532579878</c:v>
                </c:pt>
                <c:pt idx="466">
                  <c:v>0.8591997562070377</c:v>
                </c:pt>
                <c:pt idx="467">
                  <c:v>0.85829115963724412</c:v>
                </c:pt>
                <c:pt idx="468">
                  <c:v>0.8573334166100125</c:v>
                </c:pt>
                <c:pt idx="469">
                  <c:v>0.85631553139159067</c:v>
                </c:pt>
                <c:pt idx="470">
                  <c:v>0.85517657002261505</c:v>
                </c:pt>
                <c:pt idx="471">
                  <c:v>0.85389746050516224</c:v>
                </c:pt>
                <c:pt idx="472">
                  <c:v>0.85265177370776868</c:v>
                </c:pt>
                <c:pt idx="473">
                  <c:v>0.85134252328924254</c:v>
                </c:pt>
                <c:pt idx="474">
                  <c:v>0.850219280082255</c:v>
                </c:pt>
                <c:pt idx="475">
                  <c:v>0.84925529767673269</c:v>
                </c:pt>
                <c:pt idx="476">
                  <c:v>0.84814930547851752</c:v>
                </c:pt>
                <c:pt idx="477">
                  <c:v>0.84700997916857335</c:v>
                </c:pt>
                <c:pt idx="478">
                  <c:v>0.84586491835824673</c:v>
                </c:pt>
                <c:pt idx="479">
                  <c:v>0.84439943183175659</c:v>
                </c:pt>
                <c:pt idx="480">
                  <c:v>0.84277783586886512</c:v>
                </c:pt>
                <c:pt idx="481">
                  <c:v>0.8411814127889532</c:v>
                </c:pt>
                <c:pt idx="482">
                  <c:v>0.83943840156551575</c:v>
                </c:pt>
                <c:pt idx="483">
                  <c:v>0.83779828276159862</c:v>
                </c:pt>
                <c:pt idx="484">
                  <c:v>0.83619271134212114</c:v>
                </c:pt>
                <c:pt idx="485">
                  <c:v>0.83446069823817248</c:v>
                </c:pt>
                <c:pt idx="486">
                  <c:v>0.83279053035904516</c:v>
                </c:pt>
                <c:pt idx="487">
                  <c:v>0.8311178343487543</c:v>
                </c:pt>
                <c:pt idx="488">
                  <c:v>0.82933212809457946</c:v>
                </c:pt>
                <c:pt idx="489">
                  <c:v>0.82764982385179275</c:v>
                </c:pt>
                <c:pt idx="490">
                  <c:v>0.82606119361530073</c:v>
                </c:pt>
                <c:pt idx="491">
                  <c:v>0.82463097125212159</c:v>
                </c:pt>
                <c:pt idx="492">
                  <c:v>0.82349016519215201</c:v>
                </c:pt>
                <c:pt idx="493">
                  <c:v>0.82235190881070386</c:v>
                </c:pt>
                <c:pt idx="494">
                  <c:v>0.82131649902135706</c:v>
                </c:pt>
                <c:pt idx="495">
                  <c:v>0.82022706637545584</c:v>
                </c:pt>
                <c:pt idx="496">
                  <c:v>0.81903430829551804</c:v>
                </c:pt>
                <c:pt idx="497">
                  <c:v>0.81797684757271716</c:v>
                </c:pt>
                <c:pt idx="498">
                  <c:v>0.81691660320037551</c:v>
                </c:pt>
                <c:pt idx="499">
                  <c:v>0.81567932694901635</c:v>
                </c:pt>
                <c:pt idx="500">
                  <c:v>0.8145243278025518</c:v>
                </c:pt>
                <c:pt idx="501">
                  <c:v>0.81365948540910138</c:v>
                </c:pt>
                <c:pt idx="502">
                  <c:v>0.81282987958124875</c:v>
                </c:pt>
                <c:pt idx="503">
                  <c:v>0.812189407991187</c:v>
                </c:pt>
                <c:pt idx="504">
                  <c:v>0.8116011713309822</c:v>
                </c:pt>
                <c:pt idx="505">
                  <c:v>0.81087934069237344</c:v>
                </c:pt>
                <c:pt idx="506">
                  <c:v>0.8101429760468577</c:v>
                </c:pt>
                <c:pt idx="507">
                  <c:v>0.80926782330328262</c:v>
                </c:pt>
                <c:pt idx="508">
                  <c:v>0.8082833169068665</c:v>
                </c:pt>
                <c:pt idx="509">
                  <c:v>0.80734499905482604</c:v>
                </c:pt>
                <c:pt idx="510">
                  <c:v>0.80615875793448832</c:v>
                </c:pt>
                <c:pt idx="511">
                  <c:v>0.80488534255592037</c:v>
                </c:pt>
                <c:pt idx="512">
                  <c:v>0.80371399987603742</c:v>
                </c:pt>
                <c:pt idx="513">
                  <c:v>0.8023756415093386</c:v>
                </c:pt>
                <c:pt idx="514">
                  <c:v>0.8011212484878395</c:v>
                </c:pt>
                <c:pt idx="515">
                  <c:v>0.79990303475118585</c:v>
                </c:pt>
                <c:pt idx="516">
                  <c:v>0.79858193448116799</c:v>
                </c:pt>
                <c:pt idx="517">
                  <c:v>0.79731498697446723</c:v>
                </c:pt>
                <c:pt idx="518">
                  <c:v>0.79601925522473982</c:v>
                </c:pt>
                <c:pt idx="519">
                  <c:v>0.79469619782160783</c:v>
                </c:pt>
                <c:pt idx="520">
                  <c:v>0.79344693134810695</c:v>
                </c:pt>
                <c:pt idx="521">
                  <c:v>0.79222925430567626</c:v>
                </c:pt>
                <c:pt idx="522">
                  <c:v>0.79071898689021813</c:v>
                </c:pt>
                <c:pt idx="523">
                  <c:v>0.78923205230670102</c:v>
                </c:pt>
                <c:pt idx="524">
                  <c:v>0.78762583774275152</c:v>
                </c:pt>
                <c:pt idx="525">
                  <c:v>0.78592418808834308</c:v>
                </c:pt>
                <c:pt idx="526">
                  <c:v>0.78433696648125506</c:v>
                </c:pt>
                <c:pt idx="527">
                  <c:v>0.78276325608538722</c:v>
                </c:pt>
                <c:pt idx="528">
                  <c:v>0.78132103853972668</c:v>
                </c:pt>
                <c:pt idx="529">
                  <c:v>0.78007567223647578</c:v>
                </c:pt>
                <c:pt idx="530">
                  <c:v>0.77884587597391586</c:v>
                </c:pt>
                <c:pt idx="531">
                  <c:v>0.77774004824294773</c:v>
                </c:pt>
                <c:pt idx="532">
                  <c:v>0.77682150180616882</c:v>
                </c:pt>
                <c:pt idx="533">
                  <c:v>0.77572451994374025</c:v>
                </c:pt>
                <c:pt idx="534">
                  <c:v>0.7745766396643744</c:v>
                </c:pt>
                <c:pt idx="535">
                  <c:v>0.77340439047673959</c:v>
                </c:pt>
                <c:pt idx="536">
                  <c:v>0.77214778048424693</c:v>
                </c:pt>
                <c:pt idx="537">
                  <c:v>0.77097496418055822</c:v>
                </c:pt>
                <c:pt idx="538">
                  <c:v>0.76981442613066364</c:v>
                </c:pt>
                <c:pt idx="539">
                  <c:v>0.76860166223273085</c:v>
                </c:pt>
                <c:pt idx="540">
                  <c:v>0.76746444386134272</c:v>
                </c:pt>
                <c:pt idx="541">
                  <c:v>0.76652121723542299</c:v>
                </c:pt>
                <c:pt idx="542">
                  <c:v>0.76554976450253476</c:v>
                </c:pt>
                <c:pt idx="543">
                  <c:v>0.7648043647553322</c:v>
                </c:pt>
                <c:pt idx="544">
                  <c:v>0.76405145807679953</c:v>
                </c:pt>
                <c:pt idx="545">
                  <c:v>0.7632771996476978</c:v>
                </c:pt>
                <c:pt idx="546">
                  <c:v>0.76267522877832128</c:v>
                </c:pt>
                <c:pt idx="547">
                  <c:v>0.76230023530296853</c:v>
                </c:pt>
                <c:pt idx="548">
                  <c:v>0.76207717126108476</c:v>
                </c:pt>
                <c:pt idx="549">
                  <c:v>0.76188548039126425</c:v>
                </c:pt>
                <c:pt idx="550">
                  <c:v>0.76158418918593929</c:v>
                </c:pt>
                <c:pt idx="551">
                  <c:v>0.76125273556108819</c:v>
                </c:pt>
                <c:pt idx="552">
                  <c:v>0.7610687228975519</c:v>
                </c:pt>
                <c:pt idx="553">
                  <c:v>0.7607407466267111</c:v>
                </c:pt>
                <c:pt idx="554">
                  <c:v>0.76054718328163839</c:v>
                </c:pt>
                <c:pt idx="555">
                  <c:v>0.76049706033805398</c:v>
                </c:pt>
                <c:pt idx="556">
                  <c:v>0.76037363772822353</c:v>
                </c:pt>
                <c:pt idx="557">
                  <c:v>0.76020046718106404</c:v>
                </c:pt>
                <c:pt idx="558">
                  <c:v>0.75995129773071168</c:v>
                </c:pt>
                <c:pt idx="559">
                  <c:v>0.75936397558620272</c:v>
                </c:pt>
                <c:pt idx="560">
                  <c:v>0.75869985285844288</c:v>
                </c:pt>
                <c:pt idx="561">
                  <c:v>0.75801006533891679</c:v>
                </c:pt>
                <c:pt idx="562">
                  <c:v>0.75714779605256799</c:v>
                </c:pt>
                <c:pt idx="563">
                  <c:v>0.75653334751870316</c:v>
                </c:pt>
                <c:pt idx="564">
                  <c:v>0.75611673311800376</c:v>
                </c:pt>
                <c:pt idx="565">
                  <c:v>0.75571668956471982</c:v>
                </c:pt>
                <c:pt idx="566">
                  <c:v>0.75545900538517785</c:v>
                </c:pt>
                <c:pt idx="567">
                  <c:v>0.75513089425599256</c:v>
                </c:pt>
                <c:pt idx="568">
                  <c:v>0.75455349255878912</c:v>
                </c:pt>
                <c:pt idx="569">
                  <c:v>0.75388169437866959</c:v>
                </c:pt>
                <c:pt idx="570">
                  <c:v>0.75315426079940051</c:v>
                </c:pt>
                <c:pt idx="571">
                  <c:v>0.7524437447867538</c:v>
                </c:pt>
                <c:pt idx="572">
                  <c:v>0.75185079231458785</c:v>
                </c:pt>
                <c:pt idx="573">
                  <c:v>0.75116675164474001</c:v>
                </c:pt>
                <c:pt idx="574">
                  <c:v>0.75067193236647356</c:v>
                </c:pt>
                <c:pt idx="575">
                  <c:v>0.75024159889652853</c:v>
                </c:pt>
                <c:pt idx="576">
                  <c:v>0.74969688166721782</c:v>
                </c:pt>
                <c:pt idx="577">
                  <c:v>0.74907367771843658</c:v>
                </c:pt>
                <c:pt idx="578">
                  <c:v>0.7483656945801952</c:v>
                </c:pt>
                <c:pt idx="579">
                  <c:v>0.74749625015646493</c:v>
                </c:pt>
                <c:pt idx="580">
                  <c:v>0.74684949715586257</c:v>
                </c:pt>
                <c:pt idx="581">
                  <c:v>0.74627252965294721</c:v>
                </c:pt>
                <c:pt idx="582">
                  <c:v>0.74566314224008012</c:v>
                </c:pt>
                <c:pt idx="583">
                  <c:v>0.74521864603342358</c:v>
                </c:pt>
                <c:pt idx="584">
                  <c:v>0.74468617008913507</c:v>
                </c:pt>
                <c:pt idx="585">
                  <c:v>0.74391030967444949</c:v>
                </c:pt>
                <c:pt idx="586">
                  <c:v>0.74315071684854539</c:v>
                </c:pt>
                <c:pt idx="587">
                  <c:v>0.74227531401487234</c:v>
                </c:pt>
                <c:pt idx="588">
                  <c:v>0.74134275307015485</c:v>
                </c:pt>
                <c:pt idx="589">
                  <c:v>0.74041473294083093</c:v>
                </c:pt>
                <c:pt idx="590">
                  <c:v>0.73935428524493807</c:v>
                </c:pt>
                <c:pt idx="591">
                  <c:v>0.73824990878726482</c:v>
                </c:pt>
                <c:pt idx="592">
                  <c:v>0.73718646485680184</c:v>
                </c:pt>
                <c:pt idx="593">
                  <c:v>0.73596149452455639</c:v>
                </c:pt>
                <c:pt idx="594">
                  <c:v>0.73476100518564869</c:v>
                </c:pt>
                <c:pt idx="595">
                  <c:v>0.73348831628533384</c:v>
                </c:pt>
                <c:pt idx="596">
                  <c:v>0.73207520794852587</c:v>
                </c:pt>
                <c:pt idx="597">
                  <c:v>0.73057058523200291</c:v>
                </c:pt>
                <c:pt idx="598">
                  <c:v>0.72908484071160817</c:v>
                </c:pt>
                <c:pt idx="599">
                  <c:v>0.72760803614765512</c:v>
                </c:pt>
                <c:pt idx="600">
                  <c:v>0.726272137996399</c:v>
                </c:pt>
                <c:pt idx="601">
                  <c:v>0.72500395374304361</c:v>
                </c:pt>
                <c:pt idx="602">
                  <c:v>0.7236708467131554</c:v>
                </c:pt>
                <c:pt idx="603">
                  <c:v>0.72247923240669532</c:v>
                </c:pt>
                <c:pt idx="604">
                  <c:v>0.72116783738496282</c:v>
                </c:pt>
                <c:pt idx="605">
                  <c:v>0.71968903397669859</c:v>
                </c:pt>
                <c:pt idx="606">
                  <c:v>0.7182648455690066</c:v>
                </c:pt>
                <c:pt idx="607">
                  <c:v>0.71677833011078129</c:v>
                </c:pt>
                <c:pt idx="608">
                  <c:v>0.71529498351616272</c:v>
                </c:pt>
                <c:pt idx="609">
                  <c:v>0.71387805852836039</c:v>
                </c:pt>
                <c:pt idx="610">
                  <c:v>0.7124463317141746</c:v>
                </c:pt>
                <c:pt idx="611">
                  <c:v>0.71100161064766554</c:v>
                </c:pt>
                <c:pt idx="612">
                  <c:v>0.70962283690209915</c:v>
                </c:pt>
                <c:pt idx="613">
                  <c:v>0.70812513752646389</c:v>
                </c:pt>
                <c:pt idx="614">
                  <c:v>0.70662572015663938</c:v>
                </c:pt>
                <c:pt idx="615">
                  <c:v>0.7050991156223112</c:v>
                </c:pt>
                <c:pt idx="616">
                  <c:v>0.70348801089015267</c:v>
                </c:pt>
                <c:pt idx="617">
                  <c:v>0.70198448380045797</c:v>
                </c:pt>
                <c:pt idx="618">
                  <c:v>0.70069816482474989</c:v>
                </c:pt>
                <c:pt idx="619">
                  <c:v>0.69952985182158811</c:v>
                </c:pt>
                <c:pt idx="620">
                  <c:v>0.69840132160571344</c:v>
                </c:pt>
                <c:pt idx="621">
                  <c:v>0.69710144302028265</c:v>
                </c:pt>
                <c:pt idx="622">
                  <c:v>0.69561991106982102</c:v>
                </c:pt>
                <c:pt idx="623">
                  <c:v>0.69419008190763487</c:v>
                </c:pt>
                <c:pt idx="624">
                  <c:v>0.6926659817725328</c:v>
                </c:pt>
                <c:pt idx="625">
                  <c:v>0.69117952413375972</c:v>
                </c:pt>
                <c:pt idx="626">
                  <c:v>0.68981495433482665</c:v>
                </c:pt>
                <c:pt idx="627">
                  <c:v>0.6884307136674539</c:v>
                </c:pt>
                <c:pt idx="628">
                  <c:v>0.68710518351548378</c:v>
                </c:pt>
                <c:pt idx="629">
                  <c:v>0.68584366064880076</c:v>
                </c:pt>
                <c:pt idx="630">
                  <c:v>0.6844769158006746</c:v>
                </c:pt>
                <c:pt idx="631">
                  <c:v>0.68305361489510041</c:v>
                </c:pt>
                <c:pt idx="632">
                  <c:v>0.68172375934535578</c:v>
                </c:pt>
                <c:pt idx="633">
                  <c:v>0.6802790314388053</c:v>
                </c:pt>
                <c:pt idx="634">
                  <c:v>0.67892477713735433</c:v>
                </c:pt>
                <c:pt idx="635">
                  <c:v>0.67767053474478933</c:v>
                </c:pt>
                <c:pt idx="636">
                  <c:v>0.67634887217439255</c:v>
                </c:pt>
                <c:pt idx="637">
                  <c:v>0.67505661304768005</c:v>
                </c:pt>
                <c:pt idx="638">
                  <c:v>0.6737145286063313</c:v>
                </c:pt>
                <c:pt idx="639">
                  <c:v>0.67219799567461358</c:v>
                </c:pt>
                <c:pt idx="640">
                  <c:v>0.67058297596842542</c:v>
                </c:pt>
                <c:pt idx="641">
                  <c:v>0.6688726035778394</c:v>
                </c:pt>
                <c:pt idx="642">
                  <c:v>0.66727680796516609</c:v>
                </c:pt>
                <c:pt idx="643">
                  <c:v>0.66590460957909337</c:v>
                </c:pt>
                <c:pt idx="644">
                  <c:v>0.664612450284085</c:v>
                </c:pt>
                <c:pt idx="645">
                  <c:v>0.66343833574289524</c:v>
                </c:pt>
                <c:pt idx="646">
                  <c:v>0.66230626046920371</c:v>
                </c:pt>
                <c:pt idx="647">
                  <c:v>0.66106298307794109</c:v>
                </c:pt>
                <c:pt idx="648">
                  <c:v>0.65980252994297728</c:v>
                </c:pt>
                <c:pt idx="649">
                  <c:v>0.65857526312376358</c:v>
                </c:pt>
                <c:pt idx="650">
                  <c:v>0.65728623484451998</c:v>
                </c:pt>
                <c:pt idx="651">
                  <c:v>0.65607239161444031</c:v>
                </c:pt>
                <c:pt idx="652">
                  <c:v>0.6550062528727203</c:v>
                </c:pt>
                <c:pt idx="653">
                  <c:v>0.65384648368789167</c:v>
                </c:pt>
                <c:pt idx="654">
                  <c:v>0.65284504911165975</c:v>
                </c:pt>
                <c:pt idx="655">
                  <c:v>0.65188282244106899</c:v>
                </c:pt>
                <c:pt idx="656">
                  <c:v>0.65087682289635229</c:v>
                </c:pt>
                <c:pt idx="657">
                  <c:v>0.65002316039010766</c:v>
                </c:pt>
                <c:pt idx="658">
                  <c:v>0.64918716881271321</c:v>
                </c:pt>
                <c:pt idx="659">
                  <c:v>0.64827958695403609</c:v>
                </c:pt>
                <c:pt idx="660">
                  <c:v>0.64742485827675145</c:v>
                </c:pt>
                <c:pt idx="661">
                  <c:v>0.6465462950509302</c:v>
                </c:pt>
                <c:pt idx="662">
                  <c:v>0.6456401077650028</c:v>
                </c:pt>
                <c:pt idx="663">
                  <c:v>0.64496059270969197</c:v>
                </c:pt>
                <c:pt idx="664">
                  <c:v>0.64436101922423028</c:v>
                </c:pt>
                <c:pt idx="665">
                  <c:v>0.64373092749412675</c:v>
                </c:pt>
                <c:pt idx="666">
                  <c:v>0.64301146491826688</c:v>
                </c:pt>
                <c:pt idx="667">
                  <c:v>0.64224194193736228</c:v>
                </c:pt>
                <c:pt idx="668">
                  <c:v>0.64153725303838205</c:v>
                </c:pt>
                <c:pt idx="669">
                  <c:v>0.64093359026400898</c:v>
                </c:pt>
                <c:pt idx="670">
                  <c:v>0.64027484642718624</c:v>
                </c:pt>
                <c:pt idx="671">
                  <c:v>0.63963307882755049</c:v>
                </c:pt>
                <c:pt idx="672">
                  <c:v>0.63906244786953381</c:v>
                </c:pt>
                <c:pt idx="673">
                  <c:v>0.63837944847674855</c:v>
                </c:pt>
                <c:pt idx="674">
                  <c:v>0.63782883615429564</c:v>
                </c:pt>
                <c:pt idx="675">
                  <c:v>0.63717107698351261</c:v>
                </c:pt>
                <c:pt idx="676">
                  <c:v>0.63637817770679583</c:v>
                </c:pt>
                <c:pt idx="677">
                  <c:v>0.63555061288524928</c:v>
                </c:pt>
                <c:pt idx="678">
                  <c:v>0.63464856297043171</c:v>
                </c:pt>
                <c:pt idx="679">
                  <c:v>0.63363431223604949</c:v>
                </c:pt>
                <c:pt idx="680">
                  <c:v>0.63265989278811485</c:v>
                </c:pt>
                <c:pt idx="681">
                  <c:v>0.63170541386744294</c:v>
                </c:pt>
                <c:pt idx="682">
                  <c:v>0.63064771180679358</c:v>
                </c:pt>
                <c:pt idx="683">
                  <c:v>0.62969744024893815</c:v>
                </c:pt>
                <c:pt idx="684">
                  <c:v>0.62853713306921744</c:v>
                </c:pt>
                <c:pt idx="685">
                  <c:v>0.62729594799381683</c:v>
                </c:pt>
                <c:pt idx="686">
                  <c:v>0.62612473573693472</c:v>
                </c:pt>
                <c:pt idx="687">
                  <c:v>0.62500661256651502</c:v>
                </c:pt>
                <c:pt idx="688">
                  <c:v>0.62385144300838147</c:v>
                </c:pt>
                <c:pt idx="689">
                  <c:v>0.62275501183327686</c:v>
                </c:pt>
                <c:pt idx="690">
                  <c:v>0.62158503617556693</c:v>
                </c:pt>
                <c:pt idx="691">
                  <c:v>0.62039249679518349</c:v>
                </c:pt>
                <c:pt idx="692">
                  <c:v>0.61915113892576301</c:v>
                </c:pt>
                <c:pt idx="693">
                  <c:v>0.61773830485624359</c:v>
                </c:pt>
                <c:pt idx="694">
                  <c:v>0.61627582471817655</c:v>
                </c:pt>
                <c:pt idx="695">
                  <c:v>0.6147791179611094</c:v>
                </c:pt>
                <c:pt idx="696">
                  <c:v>0.613301855271844</c:v>
                </c:pt>
                <c:pt idx="697">
                  <c:v>0.61181891552256651</c:v>
                </c:pt>
                <c:pt idx="698">
                  <c:v>0.61028406575724747</c:v>
                </c:pt>
                <c:pt idx="699">
                  <c:v>0.60866207752569002</c:v>
                </c:pt>
                <c:pt idx="700">
                  <c:v>0.6071302924488996</c:v>
                </c:pt>
                <c:pt idx="701">
                  <c:v>0.60557175908592087</c:v>
                </c:pt>
                <c:pt idx="702">
                  <c:v>0.60392066586918935</c:v>
                </c:pt>
                <c:pt idx="703">
                  <c:v>0.6024481636082043</c:v>
                </c:pt>
                <c:pt idx="704">
                  <c:v>0.60096059206988528</c:v>
                </c:pt>
                <c:pt idx="705">
                  <c:v>0.59952156677853607</c:v>
                </c:pt>
                <c:pt idx="706">
                  <c:v>0.59805684510343582</c:v>
                </c:pt>
                <c:pt idx="707">
                  <c:v>0.59648177659721235</c:v>
                </c:pt>
                <c:pt idx="708">
                  <c:v>0.59490046381611117</c:v>
                </c:pt>
                <c:pt idx="709">
                  <c:v>0.59343984102761782</c:v>
                </c:pt>
                <c:pt idx="710">
                  <c:v>0.59175452305854392</c:v>
                </c:pt>
                <c:pt idx="711">
                  <c:v>0.589861276622066</c:v>
                </c:pt>
                <c:pt idx="712">
                  <c:v>0.58797665313044289</c:v>
                </c:pt>
                <c:pt idx="713">
                  <c:v>0.58604054025592711</c:v>
                </c:pt>
                <c:pt idx="714">
                  <c:v>0.58414342301303224</c:v>
                </c:pt>
                <c:pt idx="715">
                  <c:v>0.58234280254555104</c:v>
                </c:pt>
                <c:pt idx="716">
                  <c:v>0.58052785665713524</c:v>
                </c:pt>
                <c:pt idx="717">
                  <c:v>0.57868715836981099</c:v>
                </c:pt>
                <c:pt idx="718">
                  <c:v>0.57688119961812323</c:v>
                </c:pt>
                <c:pt idx="719">
                  <c:v>0.57511748303233579</c:v>
                </c:pt>
                <c:pt idx="720">
                  <c:v>0.57346466183555433</c:v>
                </c:pt>
                <c:pt idx="721">
                  <c:v>0.5717910559741155</c:v>
                </c:pt>
                <c:pt idx="722">
                  <c:v>0.57009764259448703</c:v>
                </c:pt>
                <c:pt idx="723">
                  <c:v>0.56856741987232762</c:v>
                </c:pt>
                <c:pt idx="724">
                  <c:v>0.56701481097608242</c:v>
                </c:pt>
                <c:pt idx="725">
                  <c:v>0.56559268670351703</c:v>
                </c:pt>
                <c:pt idx="726">
                  <c:v>0.56430063245822404</c:v>
                </c:pt>
                <c:pt idx="727">
                  <c:v>0.562995121181325</c:v>
                </c:pt>
                <c:pt idx="728">
                  <c:v>0.56175627256625582</c:v>
                </c:pt>
                <c:pt idx="729">
                  <c:v>0.56052367831198835</c:v>
                </c:pt>
                <c:pt idx="730">
                  <c:v>0.55914051964640143</c:v>
                </c:pt>
                <c:pt idx="731">
                  <c:v>0.55779002042195536</c:v>
                </c:pt>
                <c:pt idx="732">
                  <c:v>0.55663259893199335</c:v>
                </c:pt>
                <c:pt idx="733">
                  <c:v>0.55546860435626044</c:v>
                </c:pt>
                <c:pt idx="734">
                  <c:v>0.55452232489000586</c:v>
                </c:pt>
                <c:pt idx="735">
                  <c:v>0.55366435198683528</c:v>
                </c:pt>
                <c:pt idx="736">
                  <c:v>0.55276169660763375</c:v>
                </c:pt>
                <c:pt idx="737">
                  <c:v>0.5519081992245225</c:v>
                </c:pt>
                <c:pt idx="738">
                  <c:v>0.55108951523633654</c:v>
                </c:pt>
                <c:pt idx="739">
                  <c:v>0.55035219909966482</c:v>
                </c:pt>
                <c:pt idx="740">
                  <c:v>0.54972246075248565</c:v>
                </c:pt>
                <c:pt idx="741">
                  <c:v>0.54904565150281293</c:v>
                </c:pt>
                <c:pt idx="742">
                  <c:v>0.54835087557951412</c:v>
                </c:pt>
                <c:pt idx="743">
                  <c:v>0.54774099217763661</c:v>
                </c:pt>
                <c:pt idx="744">
                  <c:v>0.54705735293745827</c:v>
                </c:pt>
                <c:pt idx="745">
                  <c:v>0.54646967806212698</c:v>
                </c:pt>
                <c:pt idx="746">
                  <c:v>0.5458448543582437</c:v>
                </c:pt>
                <c:pt idx="747">
                  <c:v>0.54506717277743955</c:v>
                </c:pt>
                <c:pt idx="748">
                  <c:v>0.54422025977296717</c:v>
                </c:pt>
                <c:pt idx="749">
                  <c:v>0.54332971509678318</c:v>
                </c:pt>
                <c:pt idx="750">
                  <c:v>0.54232730470186497</c:v>
                </c:pt>
                <c:pt idx="751">
                  <c:v>0.54140905184428001</c:v>
                </c:pt>
                <c:pt idx="752">
                  <c:v>0.54054543240374742</c:v>
                </c:pt>
                <c:pt idx="753">
                  <c:v>0.53963825432944701</c:v>
                </c:pt>
                <c:pt idx="754">
                  <c:v>0.53882807733060201</c:v>
                </c:pt>
                <c:pt idx="755">
                  <c:v>0.5379423660509971</c:v>
                </c:pt>
                <c:pt idx="756">
                  <c:v>0.53699944632487639</c:v>
                </c:pt>
                <c:pt idx="757">
                  <c:v>0.53609067958708978</c:v>
                </c:pt>
                <c:pt idx="758">
                  <c:v>0.53511678402571983</c:v>
                </c:pt>
                <c:pt idx="759">
                  <c:v>0.53412132583795902</c:v>
                </c:pt>
                <c:pt idx="760">
                  <c:v>0.53312439386070887</c:v>
                </c:pt>
                <c:pt idx="761">
                  <c:v>0.5320332924777128</c:v>
                </c:pt>
                <c:pt idx="762">
                  <c:v>0.5309211785093535</c:v>
                </c:pt>
                <c:pt idx="763">
                  <c:v>0.52992015639780032</c:v>
                </c:pt>
                <c:pt idx="764">
                  <c:v>0.52885846669270686</c:v>
                </c:pt>
                <c:pt idx="765">
                  <c:v>0.52778060263967486</c:v>
                </c:pt>
                <c:pt idx="766">
                  <c:v>0.52661387084831968</c:v>
                </c:pt>
                <c:pt idx="767">
                  <c:v>0.52537982202982103</c:v>
                </c:pt>
                <c:pt idx="768">
                  <c:v>0.52425047436811356</c:v>
                </c:pt>
                <c:pt idx="769">
                  <c:v>0.52326572421321538</c:v>
                </c:pt>
                <c:pt idx="770">
                  <c:v>0.52227738111507072</c:v>
                </c:pt>
                <c:pt idx="771">
                  <c:v>0.52131991681554291</c:v>
                </c:pt>
                <c:pt idx="772">
                  <c:v>0.52042542164403593</c:v>
                </c:pt>
                <c:pt idx="773">
                  <c:v>0.51963093107897196</c:v>
                </c:pt>
                <c:pt idx="774">
                  <c:v>0.51896299454394446</c:v>
                </c:pt>
                <c:pt idx="775">
                  <c:v>0.51820749342920946</c:v>
                </c:pt>
                <c:pt idx="776">
                  <c:v>0.51746987147106316</c:v>
                </c:pt>
                <c:pt idx="777">
                  <c:v>0.51681249736524026</c:v>
                </c:pt>
                <c:pt idx="778">
                  <c:v>0.51617531343115763</c:v>
                </c:pt>
                <c:pt idx="779">
                  <c:v>0.51558397858283056</c:v>
                </c:pt>
                <c:pt idx="780">
                  <c:v>0.51508796389172895</c:v>
                </c:pt>
                <c:pt idx="781">
                  <c:v>0.51455121245364022</c:v>
                </c:pt>
                <c:pt idx="782">
                  <c:v>0.51401440488399974</c:v>
                </c:pt>
                <c:pt idx="783">
                  <c:v>0.51354019427354025</c:v>
                </c:pt>
                <c:pt idx="784">
                  <c:v>0.51295893563886652</c:v>
                </c:pt>
                <c:pt idx="785">
                  <c:v>0.51243974392754499</c:v>
                </c:pt>
                <c:pt idx="786">
                  <c:v>0.51200835393728228</c:v>
                </c:pt>
                <c:pt idx="787">
                  <c:v>0.51167126519716855</c:v>
                </c:pt>
                <c:pt idx="788">
                  <c:v>0.51139774270778993</c:v>
                </c:pt>
                <c:pt idx="789">
                  <c:v>0.51106313897800337</c:v>
                </c:pt>
                <c:pt idx="790">
                  <c:v>0.51051813367746923</c:v>
                </c:pt>
                <c:pt idx="791">
                  <c:v>0.50985760137962099</c:v>
                </c:pt>
                <c:pt idx="792">
                  <c:v>0.50912680577822977</c:v>
                </c:pt>
                <c:pt idx="793">
                  <c:v>0.50823386320140573</c:v>
                </c:pt>
                <c:pt idx="794">
                  <c:v>0.50729645067306928</c:v>
                </c:pt>
                <c:pt idx="795">
                  <c:v>0.50626040990032573</c:v>
                </c:pt>
                <c:pt idx="796">
                  <c:v>0.50525273437229823</c:v>
                </c:pt>
                <c:pt idx="797">
                  <c:v>0.50418740406832596</c:v>
                </c:pt>
                <c:pt idx="798">
                  <c:v>0.50297445095954108</c:v>
                </c:pt>
                <c:pt idx="799">
                  <c:v>0.50167555660650354</c:v>
                </c:pt>
                <c:pt idx="800">
                  <c:v>0.50037410473385524</c:v>
                </c:pt>
                <c:pt idx="801">
                  <c:v>0.4988823931840376</c:v>
                </c:pt>
                <c:pt idx="802">
                  <c:v>0.49731580652126961</c:v>
                </c:pt>
                <c:pt idx="803">
                  <c:v>0.49579467657636639</c:v>
                </c:pt>
                <c:pt idx="804">
                  <c:v>0.49418254974680842</c:v>
                </c:pt>
                <c:pt idx="805">
                  <c:v>0.49262618224125548</c:v>
                </c:pt>
                <c:pt idx="806">
                  <c:v>0.49104937603597432</c:v>
                </c:pt>
                <c:pt idx="807">
                  <c:v>0.48940084055750843</c:v>
                </c:pt>
                <c:pt idx="808">
                  <c:v>0.48770214917264826</c:v>
                </c:pt>
                <c:pt idx="809">
                  <c:v>0.48601381901045215</c:v>
                </c:pt>
                <c:pt idx="810">
                  <c:v>0.48415263020817023</c:v>
                </c:pt>
                <c:pt idx="811">
                  <c:v>0.48215901254581556</c:v>
                </c:pt>
                <c:pt idx="812">
                  <c:v>0.48023938270186978</c:v>
                </c:pt>
                <c:pt idx="813">
                  <c:v>0.47837768348291615</c:v>
                </c:pt>
                <c:pt idx="814">
                  <c:v>0.47656320963163185</c:v>
                </c:pt>
                <c:pt idx="815">
                  <c:v>0.47469007411326553</c:v>
                </c:pt>
                <c:pt idx="816">
                  <c:v>0.47277444961768045</c:v>
                </c:pt>
                <c:pt idx="817">
                  <c:v>0.47080390003769346</c:v>
                </c:pt>
                <c:pt idx="818">
                  <c:v>0.46873622292305556</c:v>
                </c:pt>
                <c:pt idx="819">
                  <c:v>0.46662534468218425</c:v>
                </c:pt>
                <c:pt idx="820">
                  <c:v>0.46471613456182714</c:v>
                </c:pt>
                <c:pt idx="821">
                  <c:v>0.46295206107222048</c:v>
                </c:pt>
                <c:pt idx="822">
                  <c:v>0.46134272765262946</c:v>
                </c:pt>
                <c:pt idx="823">
                  <c:v>0.45986964250818213</c:v>
                </c:pt>
                <c:pt idx="824">
                  <c:v>0.45837495556580643</c:v>
                </c:pt>
                <c:pt idx="825">
                  <c:v>0.45694935895420463</c:v>
                </c:pt>
                <c:pt idx="826">
                  <c:v>0.45554261312478728</c:v>
                </c:pt>
                <c:pt idx="827">
                  <c:v>0.45411928133801527</c:v>
                </c:pt>
                <c:pt idx="828">
                  <c:v>0.45278005558920009</c:v>
                </c:pt>
                <c:pt idx="829">
                  <c:v>0.45152203758534598</c:v>
                </c:pt>
                <c:pt idx="830">
                  <c:v>0.45026301112768791</c:v>
                </c:pt>
                <c:pt idx="831">
                  <c:v>0.44923572215059066</c:v>
                </c:pt>
                <c:pt idx="832">
                  <c:v>0.44840102851187708</c:v>
                </c:pt>
                <c:pt idx="833">
                  <c:v>0.44752360837107108</c:v>
                </c:pt>
                <c:pt idx="834">
                  <c:v>0.44662696608680053</c:v>
                </c:pt>
                <c:pt idx="835">
                  <c:v>0.44575454371467238</c:v>
                </c:pt>
                <c:pt idx="836">
                  <c:v>0.44486689535098595</c:v>
                </c:pt>
                <c:pt idx="837">
                  <c:v>0.44401790832757954</c:v>
                </c:pt>
                <c:pt idx="838">
                  <c:v>0.44325544642361858</c:v>
                </c:pt>
                <c:pt idx="839">
                  <c:v>0.44263301302310909</c:v>
                </c:pt>
                <c:pt idx="840">
                  <c:v>0.44211454971575204</c:v>
                </c:pt>
                <c:pt idx="841">
                  <c:v>0.44130652218833544</c:v>
                </c:pt>
                <c:pt idx="842">
                  <c:v>0.44020604346441444</c:v>
                </c:pt>
                <c:pt idx="843">
                  <c:v>0.43904471098869396</c:v>
                </c:pt>
                <c:pt idx="844">
                  <c:v>0.43779350201832201</c:v>
                </c:pt>
                <c:pt idx="845">
                  <c:v>0.43665577290014945</c:v>
                </c:pt>
                <c:pt idx="846">
                  <c:v>0.43559904412558476</c:v>
                </c:pt>
                <c:pt idx="847">
                  <c:v>0.43450499977877033</c:v>
                </c:pt>
                <c:pt idx="848">
                  <c:v>0.43341740178336391</c:v>
                </c:pt>
                <c:pt idx="849">
                  <c:v>0.43227185563861414</c:v>
                </c:pt>
                <c:pt idx="850">
                  <c:v>0.43101717571280401</c:v>
                </c:pt>
                <c:pt idx="851">
                  <c:v>0.42972669869456337</c:v>
                </c:pt>
                <c:pt idx="852">
                  <c:v>0.42837581510797368</c:v>
                </c:pt>
                <c:pt idx="853">
                  <c:v>0.42702748423482756</c:v>
                </c:pt>
                <c:pt idx="854">
                  <c:v>0.42577066449532203</c:v>
                </c:pt>
                <c:pt idx="855">
                  <c:v>0.42451997365941113</c:v>
                </c:pt>
                <c:pt idx="856">
                  <c:v>0.42324261411646613</c:v>
                </c:pt>
                <c:pt idx="857">
                  <c:v>0.42202203470481298</c:v>
                </c:pt>
                <c:pt idx="858">
                  <c:v>0.42080913473926029</c:v>
                </c:pt>
                <c:pt idx="859">
                  <c:v>0.41954696702561572</c:v>
                </c:pt>
                <c:pt idx="860">
                  <c:v>0.4182346900102169</c:v>
                </c:pt>
                <c:pt idx="861">
                  <c:v>0.4169128393357649</c:v>
                </c:pt>
                <c:pt idx="862">
                  <c:v>0.41571314322169645</c:v>
                </c:pt>
                <c:pt idx="863">
                  <c:v>0.41469529025887275</c:v>
                </c:pt>
                <c:pt idx="864">
                  <c:v>0.4137071228380641</c:v>
                </c:pt>
                <c:pt idx="865">
                  <c:v>0.41279527668614596</c:v>
                </c:pt>
                <c:pt idx="866">
                  <c:v>0.41180154854006362</c:v>
                </c:pt>
                <c:pt idx="867">
                  <c:v>0.41070641818165715</c:v>
                </c:pt>
                <c:pt idx="868">
                  <c:v>0.40958580688986407</c:v>
                </c:pt>
                <c:pt idx="869">
                  <c:v>0.40844049965298901</c:v>
                </c:pt>
                <c:pt idx="870">
                  <c:v>0.40724372010125509</c:v>
                </c:pt>
                <c:pt idx="871">
                  <c:v>0.40607882500602527</c:v>
                </c:pt>
                <c:pt idx="872">
                  <c:v>0.40486168442337322</c:v>
                </c:pt>
                <c:pt idx="873">
                  <c:v>0.40354153511738244</c:v>
                </c:pt>
                <c:pt idx="874">
                  <c:v>0.40222552334359452</c:v>
                </c:pt>
                <c:pt idx="875">
                  <c:v>0.40084613715228395</c:v>
                </c:pt>
                <c:pt idx="876">
                  <c:v>0.39951333031290182</c:v>
                </c:pt>
                <c:pt idx="877">
                  <c:v>0.39824400607704935</c:v>
                </c:pt>
                <c:pt idx="878">
                  <c:v>0.39699403543050538</c:v>
                </c:pt>
                <c:pt idx="879">
                  <c:v>0.39578648618692319</c:v>
                </c:pt>
                <c:pt idx="880">
                  <c:v>0.39465336488418873</c:v>
                </c:pt>
                <c:pt idx="881">
                  <c:v>0.39342308380927493</c:v>
                </c:pt>
                <c:pt idx="882">
                  <c:v>0.39214211005337118</c:v>
                </c:pt>
                <c:pt idx="883">
                  <c:v>0.39090309241698423</c:v>
                </c:pt>
                <c:pt idx="884">
                  <c:v>0.38956810177299145</c:v>
                </c:pt>
                <c:pt idx="885">
                  <c:v>0.38824090400620975</c:v>
                </c:pt>
                <c:pt idx="886">
                  <c:v>0.38687497753133504</c:v>
                </c:pt>
                <c:pt idx="887">
                  <c:v>0.38549337285678897</c:v>
                </c:pt>
                <c:pt idx="888">
                  <c:v>0.38415963704024136</c:v>
                </c:pt>
                <c:pt idx="889">
                  <c:v>0.38286994218705461</c:v>
                </c:pt>
                <c:pt idx="890">
                  <c:v>0.38159768705939034</c:v>
                </c:pt>
                <c:pt idx="891">
                  <c:v>0.38037687857350189</c:v>
                </c:pt>
                <c:pt idx="892">
                  <c:v>0.37909037175735899</c:v>
                </c:pt>
                <c:pt idx="893">
                  <c:v>0.37781285319216057</c:v>
                </c:pt>
                <c:pt idx="894">
                  <c:v>0.3766540925956946</c:v>
                </c:pt>
                <c:pt idx="895">
                  <c:v>0.37550369700197284</c:v>
                </c:pt>
                <c:pt idx="896">
                  <c:v>0.37440152956406614</c:v>
                </c:pt>
                <c:pt idx="897">
                  <c:v>0.37328976743766773</c:v>
                </c:pt>
                <c:pt idx="898">
                  <c:v>0.37209170126131974</c:v>
                </c:pt>
                <c:pt idx="899">
                  <c:v>0.37086171487559977</c:v>
                </c:pt>
                <c:pt idx="900">
                  <c:v>0.36961757287585589</c:v>
                </c:pt>
                <c:pt idx="901">
                  <c:v>0.36827226520351819</c:v>
                </c:pt>
                <c:pt idx="902">
                  <c:v>0.36702012592002492</c:v>
                </c:pt>
                <c:pt idx="903">
                  <c:v>0.36586726767423733</c:v>
                </c:pt>
                <c:pt idx="904">
                  <c:v>0.36467714933872059</c:v>
                </c:pt>
                <c:pt idx="905">
                  <c:v>0.36357855533604461</c:v>
                </c:pt>
                <c:pt idx="906">
                  <c:v>0.36250419338675743</c:v>
                </c:pt>
                <c:pt idx="907">
                  <c:v>0.36143348674996761</c:v>
                </c:pt>
                <c:pt idx="908">
                  <c:v>0.36038870732502271</c:v>
                </c:pt>
                <c:pt idx="909">
                  <c:v>0.35933028803196243</c:v>
                </c:pt>
                <c:pt idx="910">
                  <c:v>0.35820711440356101</c:v>
                </c:pt>
                <c:pt idx="911">
                  <c:v>0.35706352222372745</c:v>
                </c:pt>
                <c:pt idx="912">
                  <c:v>0.3558944120136236</c:v>
                </c:pt>
                <c:pt idx="913">
                  <c:v>0.35473746833017611</c:v>
                </c:pt>
                <c:pt idx="914">
                  <c:v>0.35362444267487764</c:v>
                </c:pt>
                <c:pt idx="915">
                  <c:v>0.35242348698956405</c:v>
                </c:pt>
                <c:pt idx="916">
                  <c:v>0.35120951038448278</c:v>
                </c:pt>
                <c:pt idx="917">
                  <c:v>0.35003302866120833</c:v>
                </c:pt>
                <c:pt idx="918">
                  <c:v>0.3488701954656786</c:v>
                </c:pt>
                <c:pt idx="919">
                  <c:v>0.34768118369219436</c:v>
                </c:pt>
                <c:pt idx="920">
                  <c:v>0.34643926862167962</c:v>
                </c:pt>
                <c:pt idx="921">
                  <c:v>0.34513609821014135</c:v>
                </c:pt>
                <c:pt idx="922">
                  <c:v>0.34391708306517554</c:v>
                </c:pt>
                <c:pt idx="923">
                  <c:v>0.34268432308663327</c:v>
                </c:pt>
                <c:pt idx="924">
                  <c:v>0.34134775531970757</c:v>
                </c:pt>
                <c:pt idx="925">
                  <c:v>0.34003659914141376</c:v>
                </c:pt>
                <c:pt idx="926">
                  <c:v>0.33870249167254302</c:v>
                </c:pt>
                <c:pt idx="927">
                  <c:v>0.33733675550699493</c:v>
                </c:pt>
                <c:pt idx="928">
                  <c:v>0.33598887149253387</c:v>
                </c:pt>
                <c:pt idx="929">
                  <c:v>0.33464094913379638</c:v>
                </c:pt>
                <c:pt idx="930">
                  <c:v>0.33331883573192461</c:v>
                </c:pt>
                <c:pt idx="931">
                  <c:v>0.3320806030800908</c:v>
                </c:pt>
                <c:pt idx="932">
                  <c:v>0.33082466813014605</c:v>
                </c:pt>
                <c:pt idx="933">
                  <c:v>0.32952057157853365</c:v>
                </c:pt>
                <c:pt idx="934">
                  <c:v>0.32820039023664505</c:v>
                </c:pt>
                <c:pt idx="935">
                  <c:v>0.32686334769101028</c:v>
                </c:pt>
                <c:pt idx="936">
                  <c:v>0.32563463213741678</c:v>
                </c:pt>
                <c:pt idx="937">
                  <c:v>0.32447880662028783</c:v>
                </c:pt>
                <c:pt idx="938">
                  <c:v>0.32327698222827145</c:v>
                </c:pt>
                <c:pt idx="939">
                  <c:v>0.32204035560284977</c:v>
                </c:pt>
                <c:pt idx="940">
                  <c:v>0.32087688161014788</c:v>
                </c:pt>
                <c:pt idx="941">
                  <c:v>0.31977336544626944</c:v>
                </c:pt>
                <c:pt idx="942">
                  <c:v>0.31871815445588059</c:v>
                </c:pt>
                <c:pt idx="943">
                  <c:v>0.31767049178941242</c:v>
                </c:pt>
                <c:pt idx="944">
                  <c:v>0.31664452803322152</c:v>
                </c:pt>
                <c:pt idx="945">
                  <c:v>0.31576998389309863</c:v>
                </c:pt>
                <c:pt idx="946">
                  <c:v>0.3149399400181484</c:v>
                </c:pt>
                <c:pt idx="947">
                  <c:v>0.31412879899383661</c:v>
                </c:pt>
                <c:pt idx="948">
                  <c:v>0.31335989477020376</c:v>
                </c:pt>
                <c:pt idx="949">
                  <c:v>0.3125776547502272</c:v>
                </c:pt>
                <c:pt idx="950">
                  <c:v>0.31174736880328441</c:v>
                </c:pt>
                <c:pt idx="951">
                  <c:v>0.31088749688749484</c:v>
                </c:pt>
                <c:pt idx="952">
                  <c:v>0.30997253903600874</c:v>
                </c:pt>
                <c:pt idx="953">
                  <c:v>0.30908014552466134</c:v>
                </c:pt>
                <c:pt idx="954">
                  <c:v>0.30828049598715873</c:v>
                </c:pt>
                <c:pt idx="955">
                  <c:v>0.30750672058542194</c:v>
                </c:pt>
                <c:pt idx="956">
                  <c:v>0.30674095276139335</c:v>
                </c:pt>
                <c:pt idx="957">
                  <c:v>0.30594757450746024</c:v>
                </c:pt>
                <c:pt idx="958">
                  <c:v>0.30508235050286919</c:v>
                </c:pt>
                <c:pt idx="959">
                  <c:v>0.30421206180609195</c:v>
                </c:pt>
                <c:pt idx="960">
                  <c:v>0.30337589076740851</c:v>
                </c:pt>
                <c:pt idx="961">
                  <c:v>0.30252323761833927</c:v>
                </c:pt>
                <c:pt idx="962">
                  <c:v>0.30169130313113424</c:v>
                </c:pt>
                <c:pt idx="963">
                  <c:v>0.30088405749829872</c:v>
                </c:pt>
                <c:pt idx="964">
                  <c:v>0.30004215457421707</c:v>
                </c:pt>
                <c:pt idx="965">
                  <c:v>0.29925576668106413</c:v>
                </c:pt>
                <c:pt idx="966">
                  <c:v>0.29842207640181678</c:v>
                </c:pt>
                <c:pt idx="967">
                  <c:v>0.29745000251019671</c:v>
                </c:pt>
                <c:pt idx="968">
                  <c:v>0.29628837426999338</c:v>
                </c:pt>
                <c:pt idx="969">
                  <c:v>0.29503103898434624</c:v>
                </c:pt>
                <c:pt idx="970">
                  <c:v>0.29376633826398191</c:v>
                </c:pt>
                <c:pt idx="971">
                  <c:v>0.29256384091398757</c:v>
                </c:pt>
                <c:pt idx="972">
                  <c:v>0.29136472271749597</c:v>
                </c:pt>
                <c:pt idx="973">
                  <c:v>0.2901714333198479</c:v>
                </c:pt>
                <c:pt idx="974">
                  <c:v>0.28901679401596897</c:v>
                </c:pt>
                <c:pt idx="975">
                  <c:v>0.28772954789136695</c:v>
                </c:pt>
                <c:pt idx="976">
                  <c:v>0.28642426470725318</c:v>
                </c:pt>
                <c:pt idx="977">
                  <c:v>0.2850960925178968</c:v>
                </c:pt>
                <c:pt idx="978">
                  <c:v>0.28368768403532685</c:v>
                </c:pt>
                <c:pt idx="979">
                  <c:v>0.28228128172510886</c:v>
                </c:pt>
                <c:pt idx="980">
                  <c:v>0.28090128927949748</c:v>
                </c:pt>
                <c:pt idx="981">
                  <c:v>0.27950407923573933</c:v>
                </c:pt>
                <c:pt idx="982">
                  <c:v>0.27809847020350303</c:v>
                </c:pt>
                <c:pt idx="983">
                  <c:v>0.27669231685934659</c:v>
                </c:pt>
                <c:pt idx="984">
                  <c:v>0.27523882541772782</c:v>
                </c:pt>
                <c:pt idx="985">
                  <c:v>0.27375927163239494</c:v>
                </c:pt>
                <c:pt idx="986">
                  <c:v>0.27222190989508083</c:v>
                </c:pt>
                <c:pt idx="987">
                  <c:v>0.27063814760380062</c:v>
                </c:pt>
                <c:pt idx="988">
                  <c:v>0.26915748853031995</c:v>
                </c:pt>
                <c:pt idx="989">
                  <c:v>0.26783473722000561</c:v>
                </c:pt>
                <c:pt idx="990">
                  <c:v>0.26653960466917537</c:v>
                </c:pt>
                <c:pt idx="991">
                  <c:v>0.26523526268787495</c:v>
                </c:pt>
                <c:pt idx="992">
                  <c:v>0.26379672436110019</c:v>
                </c:pt>
                <c:pt idx="993">
                  <c:v>0.26229555818812328</c:v>
                </c:pt>
                <c:pt idx="994">
                  <c:v>0.26083781556694574</c:v>
                </c:pt>
                <c:pt idx="995">
                  <c:v>0.25933582529939225</c:v>
                </c:pt>
                <c:pt idx="996">
                  <c:v>0.25794175696917793</c:v>
                </c:pt>
                <c:pt idx="997">
                  <c:v>0.25659195491090575</c:v>
                </c:pt>
                <c:pt idx="998">
                  <c:v>0.25537076683329424</c:v>
                </c:pt>
                <c:pt idx="999">
                  <c:v>0.25444741787100911</c:v>
                </c:pt>
                <c:pt idx="1000">
                  <c:v>0.25366432395548832</c:v>
                </c:pt>
                <c:pt idx="1001">
                  <c:v>0.25289117550555396</c:v>
                </c:pt>
                <c:pt idx="1002">
                  <c:v>0.25214561324516915</c:v>
                </c:pt>
                <c:pt idx="1003">
                  <c:v>0.25144765317031792</c:v>
                </c:pt>
                <c:pt idx="1004">
                  <c:v>0.25072851704320026</c:v>
                </c:pt>
                <c:pt idx="1005">
                  <c:v>0.25004994197148389</c:v>
                </c:pt>
                <c:pt idx="1006">
                  <c:v>0.24938922489400567</c:v>
                </c:pt>
                <c:pt idx="1007">
                  <c:v>0.2487372200224143</c:v>
                </c:pt>
                <c:pt idx="1008">
                  <c:v>0.2481022271866119</c:v>
                </c:pt>
                <c:pt idx="1009">
                  <c:v>0.24744874598612659</c:v>
                </c:pt>
                <c:pt idx="1010">
                  <c:v>0.24680071645712071</c:v>
                </c:pt>
                <c:pt idx="1011">
                  <c:v>0.24619183454651872</c:v>
                </c:pt>
                <c:pt idx="1012">
                  <c:v>0.24559165744476238</c:v>
                </c:pt>
                <c:pt idx="1013">
                  <c:v>0.24510371055958186</c:v>
                </c:pt>
                <c:pt idx="1014">
                  <c:v>0.24469658726063637</c:v>
                </c:pt>
                <c:pt idx="1015">
                  <c:v>0.24424210953170591</c:v>
                </c:pt>
                <c:pt idx="1016">
                  <c:v>0.24381705732904504</c:v>
                </c:pt>
                <c:pt idx="1017">
                  <c:v>0.24337847468202975</c:v>
                </c:pt>
                <c:pt idx="1018">
                  <c:v>0.24290118338070182</c:v>
                </c:pt>
                <c:pt idx="1019">
                  <c:v>0.24231591935720562</c:v>
                </c:pt>
                <c:pt idx="1020">
                  <c:v>0.24151160137562366</c:v>
                </c:pt>
                <c:pt idx="1021">
                  <c:v>0.24059581302493541</c:v>
                </c:pt>
                <c:pt idx="1022">
                  <c:v>0.23969423411544247</c:v>
                </c:pt>
                <c:pt idx="1023">
                  <c:v>0.23880060492056759</c:v>
                </c:pt>
                <c:pt idx="1024">
                  <c:v>0.23793519000838045</c:v>
                </c:pt>
                <c:pt idx="1025">
                  <c:v>0.23724734470147241</c:v>
                </c:pt>
                <c:pt idx="1026">
                  <c:v>0.2365620415468358</c:v>
                </c:pt>
                <c:pt idx="1027">
                  <c:v>0.23586059092891912</c:v>
                </c:pt>
                <c:pt idx="1028">
                  <c:v>0.23516968227431867</c:v>
                </c:pt>
                <c:pt idx="1029">
                  <c:v>0.23449819875363764</c:v>
                </c:pt>
                <c:pt idx="1030">
                  <c:v>0.23386986088118233</c:v>
                </c:pt>
                <c:pt idx="1031">
                  <c:v>0.23327774343204286</c:v>
                </c:pt>
                <c:pt idx="1032">
                  <c:v>0.23269123198893968</c:v>
                </c:pt>
                <c:pt idx="1033">
                  <c:v>0.23211087725897483</c:v>
                </c:pt>
                <c:pt idx="1034">
                  <c:v>0.23154468543392967</c:v>
                </c:pt>
                <c:pt idx="1035">
                  <c:v>0.23095263047304468</c:v>
                </c:pt>
                <c:pt idx="1036">
                  <c:v>0.230430044679241</c:v>
                </c:pt>
                <c:pt idx="1037">
                  <c:v>0.22994241357318107</c:v>
                </c:pt>
                <c:pt idx="1038">
                  <c:v>0.22946629946886138</c:v>
                </c:pt>
                <c:pt idx="1039">
                  <c:v>0.22903867672833197</c:v>
                </c:pt>
                <c:pt idx="1040">
                  <c:v>0.22865821219489457</c:v>
                </c:pt>
                <c:pt idx="1041">
                  <c:v>0.22829434658597331</c:v>
                </c:pt>
                <c:pt idx="1042">
                  <c:v>0.22796014180851959</c:v>
                </c:pt>
                <c:pt idx="1043">
                  <c:v>0.2276000332862082</c:v>
                </c:pt>
                <c:pt idx="1044">
                  <c:v>0.22719884142311214</c:v>
                </c:pt>
                <c:pt idx="1045">
                  <c:v>0.22674440131144089</c:v>
                </c:pt>
                <c:pt idx="1046">
                  <c:v>0.22610297474239768</c:v>
                </c:pt>
                <c:pt idx="1047">
                  <c:v>0.22544573464944057</c:v>
                </c:pt>
                <c:pt idx="1048">
                  <c:v>0.22483688407641989</c:v>
                </c:pt>
                <c:pt idx="1049">
                  <c:v>0.22421908536012594</c:v>
                </c:pt>
                <c:pt idx="1050">
                  <c:v>0.22359378755779769</c:v>
                </c:pt>
                <c:pt idx="1051">
                  <c:v>0.22297630049161454</c:v>
                </c:pt>
                <c:pt idx="1052">
                  <c:v>0.2223217814347099</c:v>
                </c:pt>
                <c:pt idx="1053">
                  <c:v>0.22165365175546725</c:v>
                </c:pt>
                <c:pt idx="1054">
                  <c:v>0.22101839329158912</c:v>
                </c:pt>
                <c:pt idx="1055">
                  <c:v>0.22036153215653742</c:v>
                </c:pt>
                <c:pt idx="1056">
                  <c:v>0.21973331800946816</c:v>
                </c:pt>
                <c:pt idx="1057">
                  <c:v>0.21908327412313419</c:v>
                </c:pt>
                <c:pt idx="1058">
                  <c:v>0.21840802602099377</c:v>
                </c:pt>
                <c:pt idx="1059">
                  <c:v>0.21774507857669648</c:v>
                </c:pt>
                <c:pt idx="1060">
                  <c:v>0.21709110685904309</c:v>
                </c:pt>
                <c:pt idx="1061">
                  <c:v>0.21642609032124221</c:v>
                </c:pt>
                <c:pt idx="1062">
                  <c:v>0.21578483964817935</c:v>
                </c:pt>
                <c:pt idx="1063">
                  <c:v>0.21513211320142983</c:v>
                </c:pt>
                <c:pt idx="1064">
                  <c:v>0.21445715940315915</c:v>
                </c:pt>
                <c:pt idx="1065">
                  <c:v>0.21382013770464611</c:v>
                </c:pt>
                <c:pt idx="1066">
                  <c:v>0.21316914892159713</c:v>
                </c:pt>
                <c:pt idx="1067">
                  <c:v>0.21255615719984478</c:v>
                </c:pt>
                <c:pt idx="1068">
                  <c:v>0.21195629311894001</c:v>
                </c:pt>
                <c:pt idx="1069">
                  <c:v>0.21127999071045592</c:v>
                </c:pt>
                <c:pt idx="1070">
                  <c:v>0.21057626251993034</c:v>
                </c:pt>
                <c:pt idx="1071">
                  <c:v>0.20987829468367561</c:v>
                </c:pt>
                <c:pt idx="1072">
                  <c:v>0.20914964361939575</c:v>
                </c:pt>
                <c:pt idx="1073">
                  <c:v>0.20840733454904573</c:v>
                </c:pt>
                <c:pt idx="1074">
                  <c:v>0.2076678725201872</c:v>
                </c:pt>
                <c:pt idx="1075">
                  <c:v>0.20688713498193334</c:v>
                </c:pt>
                <c:pt idx="1076">
                  <c:v>0.20612763198994721</c:v>
                </c:pt>
                <c:pt idx="1077">
                  <c:v>0.20536683957323776</c:v>
                </c:pt>
                <c:pt idx="1078">
                  <c:v>0.20459003553455918</c:v>
                </c:pt>
                <c:pt idx="1079">
                  <c:v>0.20381444154969275</c:v>
                </c:pt>
                <c:pt idx="1080">
                  <c:v>0.20304115128642322</c:v>
                </c:pt>
                <c:pt idx="1081">
                  <c:v>0.20224575274561721</c:v>
                </c:pt>
                <c:pt idx="1082">
                  <c:v>0.20142367407204378</c:v>
                </c:pt>
                <c:pt idx="1083">
                  <c:v>0.20052657730121989</c:v>
                </c:pt>
                <c:pt idx="1084">
                  <c:v>0.1996086838012183</c:v>
                </c:pt>
                <c:pt idx="1085">
                  <c:v>0.19874540839014965</c:v>
                </c:pt>
                <c:pt idx="1086">
                  <c:v>0.19788503872907418</c:v>
                </c:pt>
                <c:pt idx="1087">
                  <c:v>0.19708460678944362</c:v>
                </c:pt>
                <c:pt idx="1088">
                  <c:v>0.19630221461064917</c:v>
                </c:pt>
                <c:pt idx="1089">
                  <c:v>0.19553046723529663</c:v>
                </c:pt>
                <c:pt idx="1090">
                  <c:v>0.19477887802357979</c:v>
                </c:pt>
                <c:pt idx="1091">
                  <c:v>0.19405205023738603</c:v>
                </c:pt>
                <c:pt idx="1092">
                  <c:v>0.19328352227674933</c:v>
                </c:pt>
                <c:pt idx="1093">
                  <c:v>0.19250126396730852</c:v>
                </c:pt>
                <c:pt idx="1094">
                  <c:v>0.19175084043937252</c:v>
                </c:pt>
                <c:pt idx="1095">
                  <c:v>0.19099218177573607</c:v>
                </c:pt>
                <c:pt idx="1096">
                  <c:v>0.19026285633641252</c:v>
                </c:pt>
                <c:pt idx="1097">
                  <c:v>0.18953148442953721</c:v>
                </c:pt>
                <c:pt idx="1098">
                  <c:v>0.18879891061423168</c:v>
                </c:pt>
                <c:pt idx="1099">
                  <c:v>0.18810175519214201</c:v>
                </c:pt>
                <c:pt idx="1100">
                  <c:v>0.18744952168251722</c:v>
                </c:pt>
                <c:pt idx="1101">
                  <c:v>0.18680248801028293</c:v>
                </c:pt>
                <c:pt idx="1102">
                  <c:v>0.18618148386347616</c:v>
                </c:pt>
                <c:pt idx="1103">
                  <c:v>0.1855634563343935</c:v>
                </c:pt>
                <c:pt idx="1104">
                  <c:v>0.18497398667658357</c:v>
                </c:pt>
                <c:pt idx="1105">
                  <c:v>0.18442314627920914</c:v>
                </c:pt>
                <c:pt idx="1106">
                  <c:v>0.18385563750645911</c:v>
                </c:pt>
                <c:pt idx="1107">
                  <c:v>0.18329611436321494</c:v>
                </c:pt>
                <c:pt idx="1108">
                  <c:v>0.18271472175819439</c:v>
                </c:pt>
                <c:pt idx="1109">
                  <c:v>0.18209627038174953</c:v>
                </c:pt>
                <c:pt idx="1110">
                  <c:v>0.18143816496164711</c:v>
                </c:pt>
                <c:pt idx="1111">
                  <c:v>0.18083370232772117</c:v>
                </c:pt>
                <c:pt idx="1112">
                  <c:v>0.18024452062789389</c:v>
                </c:pt>
                <c:pt idx="1113">
                  <c:v>0.17968094193813117</c:v>
                </c:pt>
                <c:pt idx="1114">
                  <c:v>0.17912182809274482</c:v>
                </c:pt>
                <c:pt idx="1115">
                  <c:v>0.1785480177913385</c:v>
                </c:pt>
                <c:pt idx="1116">
                  <c:v>0.17800893797262268</c:v>
                </c:pt>
                <c:pt idx="1117">
                  <c:v>0.17745994534620507</c:v>
                </c:pt>
                <c:pt idx="1118">
                  <c:v>0.17688909377455139</c:v>
                </c:pt>
                <c:pt idx="1119">
                  <c:v>0.1762980599304797</c:v>
                </c:pt>
                <c:pt idx="1120">
                  <c:v>0.17568124504667837</c:v>
                </c:pt>
                <c:pt idx="1121">
                  <c:v>0.17501119227724349</c:v>
                </c:pt>
                <c:pt idx="1122">
                  <c:v>0.17432823789299293</c:v>
                </c:pt>
                <c:pt idx="1123">
                  <c:v>0.1735824805014082</c:v>
                </c:pt>
                <c:pt idx="1124">
                  <c:v>0.17278810705453473</c:v>
                </c:pt>
                <c:pt idx="1125">
                  <c:v>0.17200720267737371</c:v>
                </c:pt>
                <c:pt idx="1126">
                  <c:v>0.17121405032776688</c:v>
                </c:pt>
                <c:pt idx="1127">
                  <c:v>0.17042987205967322</c:v>
                </c:pt>
                <c:pt idx="1128">
                  <c:v>0.16964185361102374</c:v>
                </c:pt>
                <c:pt idx="1129">
                  <c:v>0.16885288384805167</c:v>
                </c:pt>
                <c:pt idx="1130">
                  <c:v>0.16808973853031706</c:v>
                </c:pt>
                <c:pt idx="1131">
                  <c:v>0.16737541744646628</c:v>
                </c:pt>
                <c:pt idx="1132">
                  <c:v>0.1666506943799036</c:v>
                </c:pt>
                <c:pt idx="1133">
                  <c:v>0.16591116035661652</c:v>
                </c:pt>
                <c:pt idx="1134">
                  <c:v>0.16518407949539587</c:v>
                </c:pt>
                <c:pt idx="1135">
                  <c:v>0.16446003243037641</c:v>
                </c:pt>
                <c:pt idx="1136">
                  <c:v>0.16375208332143679</c:v>
                </c:pt>
                <c:pt idx="1137">
                  <c:v>0.16303463561153717</c:v>
                </c:pt>
                <c:pt idx="1138">
                  <c:v>0.16232619402352438</c:v>
                </c:pt>
                <c:pt idx="1139">
                  <c:v>0.16164031325504946</c:v>
                </c:pt>
                <c:pt idx="1140">
                  <c:v>0.16096687412832539</c:v>
                </c:pt>
                <c:pt idx="1141">
                  <c:v>0.16028535471743541</c:v>
                </c:pt>
                <c:pt idx="1142">
                  <c:v>0.15963281907039784</c:v>
                </c:pt>
                <c:pt idx="1143">
                  <c:v>0.15898914012727844</c:v>
                </c:pt>
                <c:pt idx="1144">
                  <c:v>0.15838592730523623</c:v>
                </c:pt>
                <c:pt idx="1145">
                  <c:v>0.15774457631242458</c:v>
                </c:pt>
                <c:pt idx="1146">
                  <c:v>0.15687297001061026</c:v>
                </c:pt>
                <c:pt idx="1147">
                  <c:v>0.15591899199087075</c:v>
                </c:pt>
                <c:pt idx="1148">
                  <c:v>0.15494183335626838</c:v>
                </c:pt>
                <c:pt idx="1149">
                  <c:v>0.15394205259357505</c:v>
                </c:pt>
                <c:pt idx="1150">
                  <c:v>0.15293267227211982</c:v>
                </c:pt>
                <c:pt idx="1151">
                  <c:v>0.15193597881445961</c:v>
                </c:pt>
                <c:pt idx="1152">
                  <c:v>0.15092740197743526</c:v>
                </c:pt>
                <c:pt idx="1153">
                  <c:v>0.14991682934707276</c:v>
                </c:pt>
                <c:pt idx="1154">
                  <c:v>0.14893178869659571</c:v>
                </c:pt>
                <c:pt idx="1155">
                  <c:v>0.14795565769569854</c:v>
                </c:pt>
                <c:pt idx="1156">
                  <c:v>0.14702300644943669</c:v>
                </c:pt>
                <c:pt idx="1157">
                  <c:v>0.14608377643018339</c:v>
                </c:pt>
                <c:pt idx="1158">
                  <c:v>0.14514305273838485</c:v>
                </c:pt>
                <c:pt idx="1159">
                  <c:v>0.14418884493618331</c:v>
                </c:pt>
                <c:pt idx="1160">
                  <c:v>0.14320956406569327</c:v>
                </c:pt>
                <c:pt idx="1161">
                  <c:v>0.14221433506651038</c:v>
                </c:pt>
                <c:pt idx="1162">
                  <c:v>0.14122634142769119</c:v>
                </c:pt>
                <c:pt idx="1163">
                  <c:v>0.1402079732269515</c:v>
                </c:pt>
                <c:pt idx="1164">
                  <c:v>0.13918299052825403</c:v>
                </c:pt>
                <c:pt idx="1165">
                  <c:v>0.13818610006249801</c:v>
                </c:pt>
                <c:pt idx="1166">
                  <c:v>0.13728751438947845</c:v>
                </c:pt>
                <c:pt idx="1167">
                  <c:v>0.13663071416338973</c:v>
                </c:pt>
                <c:pt idx="1168">
                  <c:v>0.13606074505191068</c:v>
                </c:pt>
                <c:pt idx="1169">
                  <c:v>0.13547826235196928</c:v>
                </c:pt>
                <c:pt idx="1170">
                  <c:v>0.13487892175951086</c:v>
                </c:pt>
                <c:pt idx="1171">
                  <c:v>0.1342321169301593</c:v>
                </c:pt>
                <c:pt idx="1172">
                  <c:v>0.13343085073835745</c:v>
                </c:pt>
                <c:pt idx="1173">
                  <c:v>0.13258289503848159</c:v>
                </c:pt>
                <c:pt idx="1174">
                  <c:v>0.13171382414768937</c:v>
                </c:pt>
                <c:pt idx="1175">
                  <c:v>0.1308218810580378</c:v>
                </c:pt>
                <c:pt idx="1176">
                  <c:v>0.12992355264056493</c:v>
                </c:pt>
                <c:pt idx="1177">
                  <c:v>0.12898709769945854</c:v>
                </c:pt>
                <c:pt idx="1178">
                  <c:v>0.12805568441946269</c:v>
                </c:pt>
                <c:pt idx="1179">
                  <c:v>0.12712735704208594</c:v>
                </c:pt>
                <c:pt idx="1180">
                  <c:v>0.12620980038199858</c:v>
                </c:pt>
                <c:pt idx="1181">
                  <c:v>0.12531537145319208</c:v>
                </c:pt>
                <c:pt idx="1182">
                  <c:v>0.124460749005169</c:v>
                </c:pt>
                <c:pt idx="1183">
                  <c:v>0.12359382919454533</c:v>
                </c:pt>
                <c:pt idx="1184">
                  <c:v>0.12272935230929066</c:v>
                </c:pt>
                <c:pt idx="1185">
                  <c:v>0.12188353555646762</c:v>
                </c:pt>
                <c:pt idx="1186">
                  <c:v>0.12101205176924762</c:v>
                </c:pt>
                <c:pt idx="1187">
                  <c:v>0.12013449171939249</c:v>
                </c:pt>
                <c:pt idx="1188">
                  <c:v>0.11924428381512717</c:v>
                </c:pt>
                <c:pt idx="1189">
                  <c:v>0.11834930599105568</c:v>
                </c:pt>
                <c:pt idx="1190">
                  <c:v>0.11749261653927538</c:v>
                </c:pt>
                <c:pt idx="1191">
                  <c:v>0.11668289647110752</c:v>
                </c:pt>
                <c:pt idx="1192">
                  <c:v>0.11595063383463108</c:v>
                </c:pt>
                <c:pt idx="1193">
                  <c:v>0.11537693018803458</c:v>
                </c:pt>
                <c:pt idx="1194">
                  <c:v>0.11485270383780619</c:v>
                </c:pt>
                <c:pt idx="1195">
                  <c:v>0.11433129083483387</c:v>
                </c:pt>
                <c:pt idx="1196">
                  <c:v>0.11385401502880034</c:v>
                </c:pt>
                <c:pt idx="1197">
                  <c:v>0.11341266647265606</c:v>
                </c:pt>
                <c:pt idx="1198">
                  <c:v>0.11302725010276506</c:v>
                </c:pt>
                <c:pt idx="1199">
                  <c:v>0.11265938281316967</c:v>
                </c:pt>
                <c:pt idx="1200">
                  <c:v>0.11228650224869809</c:v>
                </c:pt>
                <c:pt idx="1201">
                  <c:v>0.11191163937530708</c:v>
                </c:pt>
                <c:pt idx="1202">
                  <c:v>0.11153830528691937</c:v>
                </c:pt>
                <c:pt idx="1203">
                  <c:v>0.11114519188387806</c:v>
                </c:pt>
                <c:pt idx="1204">
                  <c:v>0.11076591283486847</c:v>
                </c:pt>
                <c:pt idx="1205">
                  <c:v>0.11041521679581941</c:v>
                </c:pt>
                <c:pt idx="1206">
                  <c:v>0.11005414259417025</c:v>
                </c:pt>
                <c:pt idx="1207">
                  <c:v>0.10971748803105787</c:v>
                </c:pt>
                <c:pt idx="1208">
                  <c:v>0.1093836768238792</c:v>
                </c:pt>
                <c:pt idx="1209">
                  <c:v>0.10902750763135104</c:v>
                </c:pt>
                <c:pt idx="1210">
                  <c:v>0.10866056472478683</c:v>
                </c:pt>
                <c:pt idx="1211">
                  <c:v>0.10828260716140471</c:v>
                </c:pt>
                <c:pt idx="1212">
                  <c:v>0.10789226283208854</c:v>
                </c:pt>
                <c:pt idx="1213">
                  <c:v>0.10752681600788551</c:v>
                </c:pt>
                <c:pt idx="1214">
                  <c:v>0.10717722819290942</c:v>
                </c:pt>
                <c:pt idx="1215">
                  <c:v>0.10683469147121032</c:v>
                </c:pt>
                <c:pt idx="1216">
                  <c:v>0.10653836401877034</c:v>
                </c:pt>
                <c:pt idx="1217">
                  <c:v>0.10623153878333218</c:v>
                </c:pt>
                <c:pt idx="1218">
                  <c:v>0.10592603956645989</c:v>
                </c:pt>
                <c:pt idx="1219">
                  <c:v>0.10559386406124706</c:v>
                </c:pt>
                <c:pt idx="1220">
                  <c:v>0.10524917163376782</c:v>
                </c:pt>
                <c:pt idx="1221">
                  <c:v>0.10491503168571668</c:v>
                </c:pt>
                <c:pt idx="1222">
                  <c:v>0.10460593763414176</c:v>
                </c:pt>
                <c:pt idx="1223">
                  <c:v>0.10430160408666793</c:v>
                </c:pt>
                <c:pt idx="1224">
                  <c:v>0.10399398010956021</c:v>
                </c:pt>
                <c:pt idx="1225">
                  <c:v>0.10369442754003982</c:v>
                </c:pt>
                <c:pt idx="1226">
                  <c:v>0.10338264977730507</c:v>
                </c:pt>
                <c:pt idx="1227">
                  <c:v>0.10308625913520038</c:v>
                </c:pt>
                <c:pt idx="1228">
                  <c:v>0.10278812787165613</c:v>
                </c:pt>
                <c:pt idx="1229">
                  <c:v>0.10250839930494406</c:v>
                </c:pt>
                <c:pt idx="1230">
                  <c:v>0.10227316002798041</c:v>
                </c:pt>
                <c:pt idx="1231">
                  <c:v>0.10206921761493742</c:v>
                </c:pt>
                <c:pt idx="1232">
                  <c:v>0.10187824298870754</c:v>
                </c:pt>
                <c:pt idx="1233">
                  <c:v>0.10170145675483733</c:v>
                </c:pt>
                <c:pt idx="1234">
                  <c:v>0.10149264997917605</c:v>
                </c:pt>
                <c:pt idx="1235">
                  <c:v>0.10125409033492432</c:v>
                </c:pt>
                <c:pt idx="1236">
                  <c:v>0.10101311054778232</c:v>
                </c:pt>
                <c:pt idx="1237">
                  <c:v>0.10075706655766531</c:v>
                </c:pt>
                <c:pt idx="1238">
                  <c:v>0.10051140360381201</c:v>
                </c:pt>
                <c:pt idx="1239">
                  <c:v>0.10025837874079738</c:v>
                </c:pt>
                <c:pt idx="1240">
                  <c:v>0.10000509356690142</c:v>
                </c:pt>
                <c:pt idx="1241">
                  <c:v>9.9760898766366735E-2</c:v>
                </c:pt>
                <c:pt idx="1242">
                  <c:v>9.9524966696917128E-2</c:v>
                </c:pt>
                <c:pt idx="1243">
                  <c:v>9.9280508689069125E-2</c:v>
                </c:pt>
                <c:pt idx="1244">
                  <c:v>9.9034155157997197E-2</c:v>
                </c:pt>
                <c:pt idx="1245">
                  <c:v>9.8805800625994311E-2</c:v>
                </c:pt>
                <c:pt idx="1246">
                  <c:v>9.854587521704132E-2</c:v>
                </c:pt>
                <c:pt idx="1247">
                  <c:v>9.8260153607659023E-2</c:v>
                </c:pt>
                <c:pt idx="1248">
                  <c:v>9.7955235239918462E-2</c:v>
                </c:pt>
                <c:pt idx="1249">
                  <c:v>9.7641763700330717E-2</c:v>
                </c:pt>
                <c:pt idx="1250">
                  <c:v>9.7324669742438627E-2</c:v>
                </c:pt>
                <c:pt idx="1251">
                  <c:v>9.6995397193410729E-2</c:v>
                </c:pt>
                <c:pt idx="1252">
                  <c:v>9.6657508985998064E-2</c:v>
                </c:pt>
                <c:pt idx="1253">
                  <c:v>9.6321154725669281E-2</c:v>
                </c:pt>
                <c:pt idx="1254">
                  <c:v>9.5975585575839517E-2</c:v>
                </c:pt>
                <c:pt idx="1255">
                  <c:v>9.5627148324305966E-2</c:v>
                </c:pt>
                <c:pt idx="1256">
                  <c:v>9.530462223079364E-2</c:v>
                </c:pt>
                <c:pt idx="1257">
                  <c:v>9.497859874317853E-2</c:v>
                </c:pt>
                <c:pt idx="1258">
                  <c:v>9.4629130667206379E-2</c:v>
                </c:pt>
                <c:pt idx="1259">
                  <c:v>9.4247220234309051E-2</c:v>
                </c:pt>
                <c:pt idx="1260">
                  <c:v>9.3852913501277835E-2</c:v>
                </c:pt>
                <c:pt idx="1261">
                  <c:v>9.3442771235525149E-2</c:v>
                </c:pt>
                <c:pt idx="1262">
                  <c:v>9.303709889305728E-2</c:v>
                </c:pt>
                <c:pt idx="1263">
                  <c:v>9.2619027366096798E-2</c:v>
                </c:pt>
                <c:pt idx="1264">
                  <c:v>9.2192410537504391E-2</c:v>
                </c:pt>
                <c:pt idx="1265">
                  <c:v>9.1779727672108014E-2</c:v>
                </c:pt>
                <c:pt idx="1266">
                  <c:v>9.1364272096256777E-2</c:v>
                </c:pt>
                <c:pt idx="1267">
                  <c:v>9.0991476417366671E-2</c:v>
                </c:pt>
                <c:pt idx="1268">
                  <c:v>9.0663052135504948E-2</c:v>
                </c:pt>
                <c:pt idx="1269">
                  <c:v>9.035277784203917E-2</c:v>
                </c:pt>
                <c:pt idx="1270">
                  <c:v>9.0054214229357693E-2</c:v>
                </c:pt>
                <c:pt idx="1271">
                  <c:v>8.9757516051604258E-2</c:v>
                </c:pt>
                <c:pt idx="1272">
                  <c:v>8.9456512735949067E-2</c:v>
                </c:pt>
                <c:pt idx="1273">
                  <c:v>8.9151655676065172E-2</c:v>
                </c:pt>
                <c:pt idx="1274">
                  <c:v>8.8846912620827861E-2</c:v>
                </c:pt>
                <c:pt idx="1275">
                  <c:v>8.8551513468830209E-2</c:v>
                </c:pt>
                <c:pt idx="1276">
                  <c:v>8.8277101095230279E-2</c:v>
                </c:pt>
                <c:pt idx="1277">
                  <c:v>8.7990003239350467E-2</c:v>
                </c:pt>
                <c:pt idx="1278">
                  <c:v>8.7710976923914219E-2</c:v>
                </c:pt>
                <c:pt idx="1279">
                  <c:v>8.7455342704874053E-2</c:v>
                </c:pt>
                <c:pt idx="1280">
                  <c:v>8.7217206961320473E-2</c:v>
                </c:pt>
                <c:pt idx="1281">
                  <c:v>8.6978461052604664E-2</c:v>
                </c:pt>
                <c:pt idx="1282">
                  <c:v>8.6754357337283497E-2</c:v>
                </c:pt>
                <c:pt idx="1283">
                  <c:v>8.6518005962060981E-2</c:v>
                </c:pt>
                <c:pt idx="1284">
                  <c:v>8.6288201203926898E-2</c:v>
                </c:pt>
                <c:pt idx="1285">
                  <c:v>8.6076788881145214E-2</c:v>
                </c:pt>
                <c:pt idx="1286">
                  <c:v>8.58704613846588E-2</c:v>
                </c:pt>
                <c:pt idx="1287">
                  <c:v>8.5694259294691016E-2</c:v>
                </c:pt>
                <c:pt idx="1288">
                  <c:v>8.5526710979746373E-2</c:v>
                </c:pt>
                <c:pt idx="1289">
                  <c:v>8.5350844326982311E-2</c:v>
                </c:pt>
                <c:pt idx="1290">
                  <c:v>8.5167615540775621E-2</c:v>
                </c:pt>
                <c:pt idx="1291">
                  <c:v>8.4975702759026051E-2</c:v>
                </c:pt>
                <c:pt idx="1292">
                  <c:v>8.4777598534635859E-2</c:v>
                </c:pt>
                <c:pt idx="1293">
                  <c:v>8.4581376388723276E-2</c:v>
                </c:pt>
                <c:pt idx="1294">
                  <c:v>8.4387231080792699E-2</c:v>
                </c:pt>
                <c:pt idx="1295">
                  <c:v>8.4186705777730977E-2</c:v>
                </c:pt>
                <c:pt idx="1296">
                  <c:v>8.3989691383071149E-2</c:v>
                </c:pt>
                <c:pt idx="1297">
                  <c:v>8.3774431793907519E-2</c:v>
                </c:pt>
                <c:pt idx="1298">
                  <c:v>8.3552486937085557E-2</c:v>
                </c:pt>
                <c:pt idx="1299">
                  <c:v>8.3319816468696323E-2</c:v>
                </c:pt>
                <c:pt idx="1300">
                  <c:v>8.3081442581034615E-2</c:v>
                </c:pt>
                <c:pt idx="1301">
                  <c:v>8.2837181021865436E-2</c:v>
                </c:pt>
                <c:pt idx="1302">
                  <c:v>8.2594282048594564E-2</c:v>
                </c:pt>
                <c:pt idx="1303">
                  <c:v>8.2346801857096141E-2</c:v>
                </c:pt>
                <c:pt idx="1304">
                  <c:v>8.2103433676782522E-2</c:v>
                </c:pt>
                <c:pt idx="1305">
                  <c:v>8.1866770652860715E-2</c:v>
                </c:pt>
                <c:pt idx="1306">
                  <c:v>8.1623500121378811E-2</c:v>
                </c:pt>
                <c:pt idx="1307">
                  <c:v>8.1383613791329662E-2</c:v>
                </c:pt>
                <c:pt idx="1308">
                  <c:v>8.1123730355364687E-2</c:v>
                </c:pt>
                <c:pt idx="1309">
                  <c:v>8.0856338068963432E-2</c:v>
                </c:pt>
                <c:pt idx="1310">
                  <c:v>8.0594649564759965E-2</c:v>
                </c:pt>
                <c:pt idx="1311">
                  <c:v>8.0339521019580529E-2</c:v>
                </c:pt>
                <c:pt idx="1312">
                  <c:v>8.008653345889552E-2</c:v>
                </c:pt>
                <c:pt idx="1313">
                  <c:v>7.9839052132621616E-2</c:v>
                </c:pt>
                <c:pt idx="1314">
                  <c:v>7.959859922829618E-2</c:v>
                </c:pt>
                <c:pt idx="1315">
                  <c:v>7.936083790609276E-2</c:v>
                </c:pt>
                <c:pt idx="1316">
                  <c:v>7.913849584437592E-2</c:v>
                </c:pt>
                <c:pt idx="1317">
                  <c:v>7.8907465917631994E-2</c:v>
                </c:pt>
                <c:pt idx="1318">
                  <c:v>7.8679400735161609E-2</c:v>
                </c:pt>
                <c:pt idx="1319">
                  <c:v>7.8455033055907133E-2</c:v>
                </c:pt>
                <c:pt idx="1320">
                  <c:v>7.8239205103986645E-2</c:v>
                </c:pt>
                <c:pt idx="1321">
                  <c:v>7.8033417421573395E-2</c:v>
                </c:pt>
                <c:pt idx="1322">
                  <c:v>7.7839442189664571E-2</c:v>
                </c:pt>
                <c:pt idx="1323">
                  <c:v>7.7649996962044415E-2</c:v>
                </c:pt>
                <c:pt idx="1324">
                  <c:v>7.7463075258875677E-2</c:v>
                </c:pt>
                <c:pt idx="1325">
                  <c:v>7.727543243663744E-2</c:v>
                </c:pt>
                <c:pt idx="1326">
                  <c:v>7.7074111937352335E-2</c:v>
                </c:pt>
                <c:pt idx="1327">
                  <c:v>7.6871599057955334E-2</c:v>
                </c:pt>
                <c:pt idx="1328">
                  <c:v>7.6650495557648954E-2</c:v>
                </c:pt>
                <c:pt idx="1329">
                  <c:v>7.6417216846693836E-2</c:v>
                </c:pt>
                <c:pt idx="1330">
                  <c:v>7.6180764760086728E-2</c:v>
                </c:pt>
                <c:pt idx="1331">
                  <c:v>7.5944155323975027E-2</c:v>
                </c:pt>
                <c:pt idx="1332">
                  <c:v>7.5705638688791821E-2</c:v>
                </c:pt>
                <c:pt idx="1333">
                  <c:v>7.5474270634259669E-2</c:v>
                </c:pt>
                <c:pt idx="1334">
                  <c:v>7.5240414715353282E-2</c:v>
                </c:pt>
                <c:pt idx="1335">
                  <c:v>7.5002242176715694E-2</c:v>
                </c:pt>
                <c:pt idx="1336">
                  <c:v>7.4776089766622131E-2</c:v>
                </c:pt>
                <c:pt idx="1337">
                  <c:v>7.4537507585414775E-2</c:v>
                </c:pt>
                <c:pt idx="1338">
                  <c:v>7.4306952275176738E-2</c:v>
                </c:pt>
                <c:pt idx="1339">
                  <c:v>7.407353504286722E-2</c:v>
                </c:pt>
                <c:pt idx="1340">
                  <c:v>7.3840196782952838E-2</c:v>
                </c:pt>
                <c:pt idx="1341">
                  <c:v>7.3601078790008392E-2</c:v>
                </c:pt>
                <c:pt idx="1342">
                  <c:v>7.3365701764627422E-2</c:v>
                </c:pt>
                <c:pt idx="1343">
                  <c:v>7.3108937744871219E-2</c:v>
                </c:pt>
                <c:pt idx="1344">
                  <c:v>7.2826183288998717E-2</c:v>
                </c:pt>
                <c:pt idx="1345">
                  <c:v>7.2513502403470945E-2</c:v>
                </c:pt>
                <c:pt idx="1346">
                  <c:v>7.2193968116537402E-2</c:v>
                </c:pt>
                <c:pt idx="1347">
                  <c:v>7.1892639673088968E-2</c:v>
                </c:pt>
                <c:pt idx="1348">
                  <c:v>7.1592966123481108E-2</c:v>
                </c:pt>
                <c:pt idx="1349">
                  <c:v>7.1301058499084052E-2</c:v>
                </c:pt>
                <c:pt idx="1350">
                  <c:v>7.101503901435928E-2</c:v>
                </c:pt>
                <c:pt idx="1351">
                  <c:v>7.0725321686409021E-2</c:v>
                </c:pt>
                <c:pt idx="1352">
                  <c:v>7.0428354114929898E-2</c:v>
                </c:pt>
                <c:pt idx="1353">
                  <c:v>7.013022370999844E-2</c:v>
                </c:pt>
                <c:pt idx="1354">
                  <c:v>6.9821669550178933E-2</c:v>
                </c:pt>
                <c:pt idx="1355">
                  <c:v>6.9517587827025024E-2</c:v>
                </c:pt>
                <c:pt idx="1356">
                  <c:v>6.92292142999235E-2</c:v>
                </c:pt>
                <c:pt idx="1357">
                  <c:v>6.8929962245732043E-2</c:v>
                </c:pt>
                <c:pt idx="1358">
                  <c:v>6.8640386189573188E-2</c:v>
                </c:pt>
                <c:pt idx="1359">
                  <c:v>6.8351741658491491E-2</c:v>
                </c:pt>
                <c:pt idx="1360">
                  <c:v>6.8049799357061916E-2</c:v>
                </c:pt>
                <c:pt idx="1361">
                  <c:v>6.7732157313594027E-2</c:v>
                </c:pt>
                <c:pt idx="1362">
                  <c:v>6.7405760103468285E-2</c:v>
                </c:pt>
                <c:pt idx="1363">
                  <c:v>6.7097995538408464E-2</c:v>
                </c:pt>
                <c:pt idx="1364">
                  <c:v>6.6951062161448097E-2</c:v>
                </c:pt>
                <c:pt idx="1365">
                  <c:v>6.6905045753989173E-2</c:v>
                </c:pt>
                <c:pt idx="1366">
                  <c:v>6.6904443123064192E-2</c:v>
                </c:pt>
                <c:pt idx="1367">
                  <c:v>6.6931399260355406E-2</c:v>
                </c:pt>
                <c:pt idx="1368">
                  <c:v>6.6951180038200622E-2</c:v>
                </c:pt>
                <c:pt idx="1369">
                  <c:v>6.6971632564604242E-2</c:v>
                </c:pt>
                <c:pt idx="1370">
                  <c:v>6.6987778274067891E-2</c:v>
                </c:pt>
                <c:pt idx="1371">
                  <c:v>6.6997083090752807E-2</c:v>
                </c:pt>
                <c:pt idx="1372">
                  <c:v>6.7007800006157206E-2</c:v>
                </c:pt>
                <c:pt idx="1373">
                  <c:v>6.7030241931473028E-2</c:v>
                </c:pt>
                <c:pt idx="1374">
                  <c:v>6.7058159417721461E-2</c:v>
                </c:pt>
                <c:pt idx="1375">
                  <c:v>6.7094164425449673E-2</c:v>
                </c:pt>
                <c:pt idx="1376">
                  <c:v>6.7132940599731267E-2</c:v>
                </c:pt>
                <c:pt idx="1377">
                  <c:v>6.7155595167719823E-2</c:v>
                </c:pt>
                <c:pt idx="1378">
                  <c:v>6.71875414918401E-2</c:v>
                </c:pt>
                <c:pt idx="1379">
                  <c:v>6.7221780893149827E-2</c:v>
                </c:pt>
                <c:pt idx="1380">
                  <c:v>6.725657520101852E-2</c:v>
                </c:pt>
                <c:pt idx="1381">
                  <c:v>6.7324512941287953E-2</c:v>
                </c:pt>
                <c:pt idx="1382">
                  <c:v>6.7426404014449659E-2</c:v>
                </c:pt>
                <c:pt idx="1383">
                  <c:v>6.7549735853548051E-2</c:v>
                </c:pt>
                <c:pt idx="1384">
                  <c:v>6.765185525699334E-2</c:v>
                </c:pt>
                <c:pt idx="1385">
                  <c:v>6.7602009042229474E-2</c:v>
                </c:pt>
                <c:pt idx="1386">
                  <c:v>6.7462116522812948E-2</c:v>
                </c:pt>
                <c:pt idx="1387">
                  <c:v>6.7313352311939745E-2</c:v>
                </c:pt>
                <c:pt idx="1388">
                  <c:v>6.714671382178182E-2</c:v>
                </c:pt>
                <c:pt idx="1389">
                  <c:v>6.6990830155335523E-2</c:v>
                </c:pt>
                <c:pt idx="1390">
                  <c:v>6.6864546009356374E-2</c:v>
                </c:pt>
                <c:pt idx="1391">
                  <c:v>6.6759368597923849E-2</c:v>
                </c:pt>
                <c:pt idx="1392">
                  <c:v>6.66690034956854E-2</c:v>
                </c:pt>
                <c:pt idx="1393">
                  <c:v>6.6595365862973266E-2</c:v>
                </c:pt>
                <c:pt idx="1394">
                  <c:v>6.6516520457150577E-2</c:v>
                </c:pt>
                <c:pt idx="1395">
                  <c:v>6.6426799235737952E-2</c:v>
                </c:pt>
                <c:pt idx="1396">
                  <c:v>6.633843250766211E-2</c:v>
                </c:pt>
                <c:pt idx="1397">
                  <c:v>6.6242279538207618E-2</c:v>
                </c:pt>
                <c:pt idx="1398">
                  <c:v>6.6164497474497125E-2</c:v>
                </c:pt>
                <c:pt idx="1399">
                  <c:v>6.6119459418715373E-2</c:v>
                </c:pt>
                <c:pt idx="1400">
                  <c:v>6.6106797895699912E-2</c:v>
                </c:pt>
                <c:pt idx="1401">
                  <c:v>6.6114724996869698E-2</c:v>
                </c:pt>
                <c:pt idx="1402">
                  <c:v>6.6118452659863783E-2</c:v>
                </c:pt>
                <c:pt idx="1403">
                  <c:v>6.6105757174362179E-2</c:v>
                </c:pt>
                <c:pt idx="1404">
                  <c:v>6.6092595693456727E-2</c:v>
                </c:pt>
                <c:pt idx="1405">
                  <c:v>6.6082340756249247E-2</c:v>
                </c:pt>
                <c:pt idx="1406">
                  <c:v>6.6087239554611626E-2</c:v>
                </c:pt>
                <c:pt idx="1407">
                  <c:v>6.6123275745814586E-2</c:v>
                </c:pt>
                <c:pt idx="1408">
                  <c:v>6.6165264249105946E-2</c:v>
                </c:pt>
                <c:pt idx="1409">
                  <c:v>6.6206927219356976E-2</c:v>
                </c:pt>
                <c:pt idx="1410">
                  <c:v>6.6240224151463106E-2</c:v>
                </c:pt>
                <c:pt idx="1411">
                  <c:v>6.6242804483778672E-2</c:v>
                </c:pt>
                <c:pt idx="1412">
                  <c:v>6.6232438480931341E-2</c:v>
                </c:pt>
                <c:pt idx="1413">
                  <c:v>6.6225903873042988E-2</c:v>
                </c:pt>
                <c:pt idx="1414">
                  <c:v>6.620708050012139E-2</c:v>
                </c:pt>
                <c:pt idx="1415">
                  <c:v>6.6181100246842942E-2</c:v>
                </c:pt>
                <c:pt idx="1416">
                  <c:v>6.6168545490673442E-2</c:v>
                </c:pt>
                <c:pt idx="1417">
                  <c:v>6.6155598127082577E-2</c:v>
                </c:pt>
                <c:pt idx="1418">
                  <c:v>6.6155343205760705E-2</c:v>
                </c:pt>
                <c:pt idx="1419">
                  <c:v>6.6151391384903363E-2</c:v>
                </c:pt>
                <c:pt idx="1420">
                  <c:v>6.6115180376190838E-2</c:v>
                </c:pt>
                <c:pt idx="1421">
                  <c:v>6.6041691039429945E-2</c:v>
                </c:pt>
                <c:pt idx="1422">
                  <c:v>6.5947573368235396E-2</c:v>
                </c:pt>
                <c:pt idx="1423">
                  <c:v>6.5845861790281984E-2</c:v>
                </c:pt>
                <c:pt idx="1424">
                  <c:v>6.574853013176607E-2</c:v>
                </c:pt>
                <c:pt idx="1425">
                  <c:v>6.5647871623890006E-2</c:v>
                </c:pt>
                <c:pt idx="1426">
                  <c:v>6.5542838247562754E-2</c:v>
                </c:pt>
                <c:pt idx="1427">
                  <c:v>6.5441197386551297E-2</c:v>
                </c:pt>
                <c:pt idx="1428">
                  <c:v>6.5327041627771906E-2</c:v>
                </c:pt>
                <c:pt idx="1429">
                  <c:v>6.5209291080098625E-2</c:v>
                </c:pt>
                <c:pt idx="1430">
                  <c:v>6.5097005787050244E-2</c:v>
                </c:pt>
                <c:pt idx="1431">
                  <c:v>6.4987544084609175E-2</c:v>
                </c:pt>
                <c:pt idx="1432">
                  <c:v>6.4877712670641741E-2</c:v>
                </c:pt>
                <c:pt idx="1433">
                  <c:v>6.4757273631741857E-2</c:v>
                </c:pt>
                <c:pt idx="1434">
                  <c:v>6.4611261673031106E-2</c:v>
                </c:pt>
                <c:pt idx="1435">
                  <c:v>6.4458255426816283E-2</c:v>
                </c:pt>
                <c:pt idx="1436">
                  <c:v>6.4318501806738246E-2</c:v>
                </c:pt>
                <c:pt idx="1437">
                  <c:v>6.4182174532992381E-2</c:v>
                </c:pt>
                <c:pt idx="1438">
                  <c:v>6.4057779303576826E-2</c:v>
                </c:pt>
                <c:pt idx="1439">
                  <c:v>6.3933611561884221E-2</c:v>
                </c:pt>
                <c:pt idx="1440">
                  <c:v>6.3810219818314168E-2</c:v>
                </c:pt>
                <c:pt idx="1441">
                  <c:v>6.3684732634665744E-2</c:v>
                </c:pt>
                <c:pt idx="1442">
                  <c:v>6.356305956773653E-2</c:v>
                </c:pt>
                <c:pt idx="1443">
                  <c:v>6.3441216577981741E-2</c:v>
                </c:pt>
                <c:pt idx="1444">
                  <c:v>6.3323491230704548E-2</c:v>
                </c:pt>
                <c:pt idx="1445">
                  <c:v>6.3209666301222447E-2</c:v>
                </c:pt>
                <c:pt idx="1446">
                  <c:v>6.3094421534173592E-2</c:v>
                </c:pt>
                <c:pt idx="1447">
                  <c:v>6.2984845326053474E-2</c:v>
                </c:pt>
                <c:pt idx="1448">
                  <c:v>6.2868003207414716E-2</c:v>
                </c:pt>
                <c:pt idx="1449">
                  <c:v>6.2753943840756152E-2</c:v>
                </c:pt>
                <c:pt idx="1450">
                  <c:v>6.2639262893214254E-2</c:v>
                </c:pt>
                <c:pt idx="1451">
                  <c:v>6.2526901824353456E-2</c:v>
                </c:pt>
                <c:pt idx="1452">
                  <c:v>6.2410769885057671E-2</c:v>
                </c:pt>
                <c:pt idx="1453">
                  <c:v>6.2295354822040065E-2</c:v>
                </c:pt>
                <c:pt idx="1454">
                  <c:v>6.2181671292909316E-2</c:v>
                </c:pt>
                <c:pt idx="1455">
                  <c:v>6.2082204891706669E-2</c:v>
                </c:pt>
                <c:pt idx="1456">
                  <c:v>6.1994323379152755E-2</c:v>
                </c:pt>
                <c:pt idx="1457">
                  <c:v>6.1902146376759878E-2</c:v>
                </c:pt>
                <c:pt idx="1458">
                  <c:v>6.180809886695264E-2</c:v>
                </c:pt>
                <c:pt idx="1459">
                  <c:v>6.1705542687982423E-2</c:v>
                </c:pt>
                <c:pt idx="1460">
                  <c:v>6.1599557659229004E-2</c:v>
                </c:pt>
                <c:pt idx="1461">
                  <c:v>6.1489984380981022E-2</c:v>
                </c:pt>
                <c:pt idx="1462">
                  <c:v>6.1381680550607082E-2</c:v>
                </c:pt>
                <c:pt idx="1463">
                  <c:v>6.1269963381720638E-2</c:v>
                </c:pt>
                <c:pt idx="1464">
                  <c:v>6.116022337520674E-2</c:v>
                </c:pt>
                <c:pt idx="1465">
                  <c:v>6.1049828100419437E-2</c:v>
                </c:pt>
                <c:pt idx="1466">
                  <c:v>6.0936031898160568E-2</c:v>
                </c:pt>
                <c:pt idx="1467">
                  <c:v>6.0831721207051721E-2</c:v>
                </c:pt>
                <c:pt idx="1468">
                  <c:v>6.0722756346978463E-2</c:v>
                </c:pt>
                <c:pt idx="1469">
                  <c:v>6.0620989717883177E-2</c:v>
                </c:pt>
                <c:pt idx="1470">
                  <c:v>6.0518316230891059E-2</c:v>
                </c:pt>
                <c:pt idx="1471">
                  <c:v>6.0414838568062269E-2</c:v>
                </c:pt>
                <c:pt idx="1472">
                  <c:v>6.0308251839855581E-2</c:v>
                </c:pt>
                <c:pt idx="1473">
                  <c:v>6.0206653760994211E-2</c:v>
                </c:pt>
                <c:pt idx="1474">
                  <c:v>6.0108706945121118E-2</c:v>
                </c:pt>
                <c:pt idx="1475">
                  <c:v>6.0017453349973049E-2</c:v>
                </c:pt>
                <c:pt idx="1476">
                  <c:v>5.9928897800766281E-2</c:v>
                </c:pt>
                <c:pt idx="1477">
                  <c:v>5.9826994806432846E-2</c:v>
                </c:pt>
                <c:pt idx="1478">
                  <c:v>5.9721863149699045E-2</c:v>
                </c:pt>
                <c:pt idx="1479">
                  <c:v>5.9608923544796549E-2</c:v>
                </c:pt>
                <c:pt idx="1480">
                  <c:v>5.9488297750485114E-2</c:v>
                </c:pt>
                <c:pt idx="1481">
                  <c:v>5.9360097031887278E-2</c:v>
                </c:pt>
                <c:pt idx="1482">
                  <c:v>5.9229542622797622E-2</c:v>
                </c:pt>
                <c:pt idx="1483">
                  <c:v>5.9093940755498182E-2</c:v>
                </c:pt>
                <c:pt idx="1484">
                  <c:v>5.8961059608429324E-2</c:v>
                </c:pt>
                <c:pt idx="1485">
                  <c:v>5.8827161159762373E-2</c:v>
                </c:pt>
                <c:pt idx="1486">
                  <c:v>5.869140812101805E-2</c:v>
                </c:pt>
                <c:pt idx="1487">
                  <c:v>5.8560302998890409E-2</c:v>
                </c:pt>
                <c:pt idx="1488">
                  <c:v>5.8423381054579296E-2</c:v>
                </c:pt>
                <c:pt idx="1489">
                  <c:v>5.8282825560107943E-2</c:v>
                </c:pt>
                <c:pt idx="1490">
                  <c:v>5.8130915455702967E-2</c:v>
                </c:pt>
                <c:pt idx="1491">
                  <c:v>5.7971974600159189E-2</c:v>
                </c:pt>
                <c:pt idx="1492">
                  <c:v>5.7810989334317518E-2</c:v>
                </c:pt>
                <c:pt idx="1493">
                  <c:v>5.7655181865313265E-2</c:v>
                </c:pt>
                <c:pt idx="1494">
                  <c:v>5.7496274869785403E-2</c:v>
                </c:pt>
                <c:pt idx="1495">
                  <c:v>5.7337194215425158E-2</c:v>
                </c:pt>
                <c:pt idx="1496">
                  <c:v>5.7180479508924908E-2</c:v>
                </c:pt>
                <c:pt idx="1497">
                  <c:v>5.7020268750856744E-2</c:v>
                </c:pt>
                <c:pt idx="1498">
                  <c:v>5.6867484912143093E-2</c:v>
                </c:pt>
                <c:pt idx="1499">
                  <c:v>5.6717100549748267E-2</c:v>
                </c:pt>
                <c:pt idx="1500">
                  <c:v>5.6571095186188566E-2</c:v>
                </c:pt>
                <c:pt idx="1501">
                  <c:v>5.6427491248823444E-2</c:v>
                </c:pt>
                <c:pt idx="1502">
                  <c:v>5.6281649284164188E-2</c:v>
                </c:pt>
                <c:pt idx="1503">
                  <c:v>5.6131431376548385E-2</c:v>
                </c:pt>
                <c:pt idx="1504">
                  <c:v>5.5985910948469657E-2</c:v>
                </c:pt>
                <c:pt idx="1505">
                  <c:v>5.5840305119350078E-2</c:v>
                </c:pt>
                <c:pt idx="1506">
                  <c:v>5.5690087640634878E-2</c:v>
                </c:pt>
                <c:pt idx="1507">
                  <c:v>5.5538700900588926E-2</c:v>
                </c:pt>
                <c:pt idx="1508">
                  <c:v>5.5377201262117946E-2</c:v>
                </c:pt>
                <c:pt idx="1509">
                  <c:v>5.5215811590456257E-2</c:v>
                </c:pt>
                <c:pt idx="1510">
                  <c:v>5.502144292942289E-2</c:v>
                </c:pt>
                <c:pt idx="1511">
                  <c:v>5.4677276363940042E-2</c:v>
                </c:pt>
                <c:pt idx="1512">
                  <c:v>5.4247510848996039E-2</c:v>
                </c:pt>
                <c:pt idx="1513">
                  <c:v>5.3802072983764833E-2</c:v>
                </c:pt>
                <c:pt idx="1514">
                  <c:v>5.3343128015458902E-2</c:v>
                </c:pt>
                <c:pt idx="1515">
                  <c:v>5.2882308114051868E-2</c:v>
                </c:pt>
                <c:pt idx="1516">
                  <c:v>5.2416845049171205E-2</c:v>
                </c:pt>
                <c:pt idx="1517">
                  <c:v>5.1944056035986168E-2</c:v>
                </c:pt>
                <c:pt idx="1518">
                  <c:v>5.1474577394215217E-2</c:v>
                </c:pt>
                <c:pt idx="1519">
                  <c:v>5.1003394712358097E-2</c:v>
                </c:pt>
                <c:pt idx="1520">
                  <c:v>5.0527416130501601E-2</c:v>
                </c:pt>
                <c:pt idx="1521">
                  <c:v>5.0043939191522745E-2</c:v>
                </c:pt>
                <c:pt idx="1522">
                  <c:v>4.9555325867022701E-2</c:v>
                </c:pt>
                <c:pt idx="1523">
                  <c:v>4.9066620747529398E-2</c:v>
                </c:pt>
                <c:pt idx="1524">
                  <c:v>4.8579740454342005E-2</c:v>
                </c:pt>
                <c:pt idx="1525">
                  <c:v>4.8083126331068926E-2</c:v>
                </c:pt>
                <c:pt idx="1526">
                  <c:v>4.7576690935790547E-2</c:v>
                </c:pt>
                <c:pt idx="1527">
                  <c:v>4.7072440297822274E-2</c:v>
                </c:pt>
                <c:pt idx="1528">
                  <c:v>4.6558342761021436E-2</c:v>
                </c:pt>
                <c:pt idx="1529">
                  <c:v>4.6043942058191553E-2</c:v>
                </c:pt>
                <c:pt idx="1530">
                  <c:v>4.5519875948459597E-2</c:v>
                </c:pt>
                <c:pt idx="1531">
                  <c:v>4.5020352543877186E-2</c:v>
                </c:pt>
                <c:pt idx="1532">
                  <c:v>4.467471205831141E-2</c:v>
                </c:pt>
                <c:pt idx="1533">
                  <c:v>4.4421939112977413E-2</c:v>
                </c:pt>
                <c:pt idx="1534">
                  <c:v>4.4183568202373111E-2</c:v>
                </c:pt>
                <c:pt idx="1535">
                  <c:v>4.3952737872735577E-2</c:v>
                </c:pt>
                <c:pt idx="1536">
                  <c:v>4.3717527160851963E-2</c:v>
                </c:pt>
                <c:pt idx="1537">
                  <c:v>4.345753268689604E-2</c:v>
                </c:pt>
                <c:pt idx="1538">
                  <c:v>4.3191452704935428E-2</c:v>
                </c:pt>
                <c:pt idx="1539">
                  <c:v>4.2917726475195858E-2</c:v>
                </c:pt>
                <c:pt idx="1540">
                  <c:v>4.2637838568199381E-2</c:v>
                </c:pt>
                <c:pt idx="1541">
                  <c:v>4.2358114919872153E-2</c:v>
                </c:pt>
                <c:pt idx="1542">
                  <c:v>4.2083707424434978E-2</c:v>
                </c:pt>
                <c:pt idx="1543">
                  <c:v>4.1813577678658939E-2</c:v>
                </c:pt>
                <c:pt idx="1544">
                  <c:v>4.1551809994057283E-2</c:v>
                </c:pt>
                <c:pt idx="1545">
                  <c:v>4.128832889248242E-2</c:v>
                </c:pt>
                <c:pt idx="1546">
                  <c:v>4.0998112596235647E-2</c:v>
                </c:pt>
                <c:pt idx="1547">
                  <c:v>4.0682978511964139E-2</c:v>
                </c:pt>
                <c:pt idx="1548">
                  <c:v>4.0344193250701106E-2</c:v>
                </c:pt>
                <c:pt idx="1549">
                  <c:v>4.0010873848350066E-2</c:v>
                </c:pt>
                <c:pt idx="1550">
                  <c:v>3.9682975892516882E-2</c:v>
                </c:pt>
                <c:pt idx="1551">
                  <c:v>3.9361264182324114E-2</c:v>
                </c:pt>
                <c:pt idx="1552">
                  <c:v>3.9050873674249337E-2</c:v>
                </c:pt>
                <c:pt idx="1553">
                  <c:v>3.8743435062186013E-2</c:v>
                </c:pt>
                <c:pt idx="1554">
                  <c:v>3.8431231848252811E-2</c:v>
                </c:pt>
                <c:pt idx="1555">
                  <c:v>3.8117390348482279E-2</c:v>
                </c:pt>
                <c:pt idx="1556">
                  <c:v>3.7803522185649412E-2</c:v>
                </c:pt>
                <c:pt idx="1557">
                  <c:v>3.7487237403163683E-2</c:v>
                </c:pt>
                <c:pt idx="1558">
                  <c:v>3.7201937273431129E-2</c:v>
                </c:pt>
                <c:pt idx="1559">
                  <c:v>3.6921704904080525E-2</c:v>
                </c:pt>
                <c:pt idx="1560">
                  <c:v>3.6645321582200276E-2</c:v>
                </c:pt>
                <c:pt idx="1561">
                  <c:v>3.637364221877868E-2</c:v>
                </c:pt>
                <c:pt idx="1562">
                  <c:v>3.6108853187818951E-2</c:v>
                </c:pt>
                <c:pt idx="1563">
                  <c:v>3.584635695906311E-2</c:v>
                </c:pt>
                <c:pt idx="1564">
                  <c:v>3.5589907339847571E-2</c:v>
                </c:pt>
                <c:pt idx="1565">
                  <c:v>3.5333804574881167E-2</c:v>
                </c:pt>
                <c:pt idx="1566">
                  <c:v>3.5080307583421566E-2</c:v>
                </c:pt>
                <c:pt idx="1567">
                  <c:v>3.4861544259217371E-2</c:v>
                </c:pt>
                <c:pt idx="1568">
                  <c:v>3.4672098613593175E-2</c:v>
                </c:pt>
                <c:pt idx="1569">
                  <c:v>3.4501229415600833E-2</c:v>
                </c:pt>
                <c:pt idx="1570">
                  <c:v>3.4336470979878034E-2</c:v>
                </c:pt>
                <c:pt idx="1571">
                  <c:v>3.4171369365697778E-2</c:v>
                </c:pt>
                <c:pt idx="1572">
                  <c:v>3.4002470527693694E-2</c:v>
                </c:pt>
                <c:pt idx="1573">
                  <c:v>3.3829020894166319E-2</c:v>
                </c:pt>
                <c:pt idx="1574">
                  <c:v>3.3651950216756515E-2</c:v>
                </c:pt>
                <c:pt idx="1575">
                  <c:v>3.3477068083387351E-2</c:v>
                </c:pt>
                <c:pt idx="1576">
                  <c:v>3.3307752557718409E-2</c:v>
                </c:pt>
                <c:pt idx="1577">
                  <c:v>3.3139282325886532E-2</c:v>
                </c:pt>
                <c:pt idx="1578">
                  <c:v>3.2980784726251273E-2</c:v>
                </c:pt>
                <c:pt idx="1579">
                  <c:v>3.2819971306861657E-2</c:v>
                </c:pt>
                <c:pt idx="1580">
                  <c:v>3.2666308953683047E-2</c:v>
                </c:pt>
                <c:pt idx="1581">
                  <c:v>3.2516307888146787E-2</c:v>
                </c:pt>
                <c:pt idx="1582">
                  <c:v>3.2368429209025357E-2</c:v>
                </c:pt>
                <c:pt idx="1583">
                  <c:v>3.2217320570820399E-2</c:v>
                </c:pt>
                <c:pt idx="1584">
                  <c:v>3.2061961137023649E-2</c:v>
                </c:pt>
                <c:pt idx="1585">
                  <c:v>3.1899083170592361E-2</c:v>
                </c:pt>
                <c:pt idx="1586">
                  <c:v>3.1731010013285384E-2</c:v>
                </c:pt>
                <c:pt idx="1587">
                  <c:v>3.1566828038800038E-2</c:v>
                </c:pt>
                <c:pt idx="1588">
                  <c:v>3.140453999214473E-2</c:v>
                </c:pt>
                <c:pt idx="1589">
                  <c:v>3.1250371699487495E-2</c:v>
                </c:pt>
                <c:pt idx="1590">
                  <c:v>3.1102379619168216E-2</c:v>
                </c:pt>
                <c:pt idx="1591">
                  <c:v>3.0955872358989996E-2</c:v>
                </c:pt>
                <c:pt idx="1592">
                  <c:v>3.0809660195499494E-2</c:v>
                </c:pt>
                <c:pt idx="1593">
                  <c:v>3.0671467541631994E-2</c:v>
                </c:pt>
                <c:pt idx="1594">
                  <c:v>3.05382315318086E-2</c:v>
                </c:pt>
                <c:pt idx="1595">
                  <c:v>3.040706479029933E-2</c:v>
                </c:pt>
                <c:pt idx="1596">
                  <c:v>3.0276710180426214E-2</c:v>
                </c:pt>
                <c:pt idx="1597">
                  <c:v>3.0144624120703491E-2</c:v>
                </c:pt>
                <c:pt idx="1598">
                  <c:v>3.0016620542635528E-2</c:v>
                </c:pt>
                <c:pt idx="1599">
                  <c:v>2.9887778627128814E-2</c:v>
                </c:pt>
                <c:pt idx="1600">
                  <c:v>2.9762397106702126E-2</c:v>
                </c:pt>
                <c:pt idx="1601">
                  <c:v>2.9637241319379285E-2</c:v>
                </c:pt>
                <c:pt idx="1602">
                  <c:v>2.9513899851300592E-2</c:v>
                </c:pt>
                <c:pt idx="1603">
                  <c:v>2.9392896933351023E-2</c:v>
                </c:pt>
                <c:pt idx="1604">
                  <c:v>2.9275578669151932E-2</c:v>
                </c:pt>
                <c:pt idx="1605">
                  <c:v>2.9163753360278086E-2</c:v>
                </c:pt>
                <c:pt idx="1606">
                  <c:v>2.9057222413402813E-2</c:v>
                </c:pt>
                <c:pt idx="1607">
                  <c:v>2.8957493639282524E-2</c:v>
                </c:pt>
                <c:pt idx="1608">
                  <c:v>2.8856782458718665E-2</c:v>
                </c:pt>
                <c:pt idx="1609">
                  <c:v>2.8757779004089733E-2</c:v>
                </c:pt>
                <c:pt idx="1610">
                  <c:v>2.8655985850414335E-2</c:v>
                </c:pt>
                <c:pt idx="1611">
                  <c:v>2.8555407766600049E-2</c:v>
                </c:pt>
                <c:pt idx="1612">
                  <c:v>2.8457309320897666E-2</c:v>
                </c:pt>
                <c:pt idx="1613">
                  <c:v>2.8363325018618164E-2</c:v>
                </c:pt>
                <c:pt idx="1614">
                  <c:v>2.8266701028108687E-2</c:v>
                </c:pt>
                <c:pt idx="1615">
                  <c:v>2.8171085528766605E-2</c:v>
                </c:pt>
                <c:pt idx="1616">
                  <c:v>2.8075646754801033E-2</c:v>
                </c:pt>
                <c:pt idx="1617">
                  <c:v>2.7978516331030052E-2</c:v>
                </c:pt>
                <c:pt idx="1618">
                  <c:v>2.7885859310279391E-2</c:v>
                </c:pt>
                <c:pt idx="1619">
                  <c:v>2.7793632047587957E-2</c:v>
                </c:pt>
                <c:pt idx="1620">
                  <c:v>2.770667922988836E-2</c:v>
                </c:pt>
                <c:pt idx="1621">
                  <c:v>2.7623339335310068E-2</c:v>
                </c:pt>
                <c:pt idx="1622">
                  <c:v>2.7541918022955306E-2</c:v>
                </c:pt>
                <c:pt idx="1623">
                  <c:v>2.7460676787110807E-2</c:v>
                </c:pt>
                <c:pt idx="1624">
                  <c:v>2.7383524772710752E-2</c:v>
                </c:pt>
                <c:pt idx="1625">
                  <c:v>2.7306051354798189E-2</c:v>
                </c:pt>
                <c:pt idx="1626">
                  <c:v>2.7228202650192754E-2</c:v>
                </c:pt>
                <c:pt idx="1627">
                  <c:v>2.7154170850255413E-2</c:v>
                </c:pt>
                <c:pt idx="1628">
                  <c:v>2.7079674945445543E-2</c:v>
                </c:pt>
                <c:pt idx="1629">
                  <c:v>2.700951712949853E-2</c:v>
                </c:pt>
                <c:pt idx="1630">
                  <c:v>2.6938069278880129E-2</c:v>
                </c:pt>
                <c:pt idx="1631">
                  <c:v>2.6869361769827134E-2</c:v>
                </c:pt>
                <c:pt idx="1632">
                  <c:v>2.6801510398061414E-2</c:v>
                </c:pt>
                <c:pt idx="1633">
                  <c:v>2.6733798777334297E-2</c:v>
                </c:pt>
                <c:pt idx="1634">
                  <c:v>2.6665606165720245E-2</c:v>
                </c:pt>
                <c:pt idx="1635">
                  <c:v>2.6600821482958587E-2</c:v>
                </c:pt>
                <c:pt idx="1636">
                  <c:v>2.6538208200036266E-2</c:v>
                </c:pt>
                <c:pt idx="1637">
                  <c:v>2.6477147016519383E-2</c:v>
                </c:pt>
                <c:pt idx="1638">
                  <c:v>2.6421886684951608E-2</c:v>
                </c:pt>
                <c:pt idx="1639">
                  <c:v>2.6363515743175893E-2</c:v>
                </c:pt>
                <c:pt idx="1640">
                  <c:v>2.6302000598006556E-2</c:v>
                </c:pt>
                <c:pt idx="1641">
                  <c:v>2.623863732446928E-2</c:v>
                </c:pt>
                <c:pt idx="1642">
                  <c:v>2.6170816611492075E-2</c:v>
                </c:pt>
                <c:pt idx="1643">
                  <c:v>2.6102915345576305E-2</c:v>
                </c:pt>
                <c:pt idx="1644">
                  <c:v>2.6037724685007646E-2</c:v>
                </c:pt>
                <c:pt idx="1645">
                  <c:v>2.5971932169130341E-2</c:v>
                </c:pt>
                <c:pt idx="1646">
                  <c:v>2.5907869460428942E-2</c:v>
                </c:pt>
                <c:pt idx="1647">
                  <c:v>2.5847607335373265E-2</c:v>
                </c:pt>
                <c:pt idx="1648">
                  <c:v>2.5786892926352962E-2</c:v>
                </c:pt>
                <c:pt idx="1649">
                  <c:v>2.5728825792016283E-2</c:v>
                </c:pt>
                <c:pt idx="1650">
                  <c:v>2.5669635887260144E-2</c:v>
                </c:pt>
                <c:pt idx="1651">
                  <c:v>2.5612789416177239E-2</c:v>
                </c:pt>
                <c:pt idx="1652">
                  <c:v>2.5551224746729648E-2</c:v>
                </c:pt>
                <c:pt idx="1653">
                  <c:v>2.5484841617601912E-2</c:v>
                </c:pt>
                <c:pt idx="1654">
                  <c:v>2.5412124798339899E-2</c:v>
                </c:pt>
                <c:pt idx="1655">
                  <c:v>2.5337215942106573E-2</c:v>
                </c:pt>
                <c:pt idx="1656">
                  <c:v>2.5263133393800267E-2</c:v>
                </c:pt>
                <c:pt idx="1657">
                  <c:v>2.5188418560627753E-2</c:v>
                </c:pt>
                <c:pt idx="1658">
                  <c:v>2.5117600045962869E-2</c:v>
                </c:pt>
                <c:pt idx="1659">
                  <c:v>2.5043541363949259E-2</c:v>
                </c:pt>
                <c:pt idx="1660">
                  <c:v>2.4972919831527971E-2</c:v>
                </c:pt>
                <c:pt idx="1661">
                  <c:v>2.4906044034464433E-2</c:v>
                </c:pt>
                <c:pt idx="1662">
                  <c:v>2.4840197414824173E-2</c:v>
                </c:pt>
                <c:pt idx="1663">
                  <c:v>2.4775450197559782E-2</c:v>
                </c:pt>
                <c:pt idx="1664">
                  <c:v>2.4711907356463239E-2</c:v>
                </c:pt>
                <c:pt idx="1665">
                  <c:v>2.4647675199490727E-2</c:v>
                </c:pt>
                <c:pt idx="1666">
                  <c:v>2.4583390642523996E-2</c:v>
                </c:pt>
                <c:pt idx="1667">
                  <c:v>2.4519121159419042E-2</c:v>
                </c:pt>
                <c:pt idx="1668">
                  <c:v>2.4452191615610561E-2</c:v>
                </c:pt>
                <c:pt idx="1669">
                  <c:v>2.4387293220569199E-2</c:v>
                </c:pt>
                <c:pt idx="1670">
                  <c:v>2.4321707111010418E-2</c:v>
                </c:pt>
                <c:pt idx="1671">
                  <c:v>2.425715382503163E-2</c:v>
                </c:pt>
                <c:pt idx="1672">
                  <c:v>2.4192649297771218E-2</c:v>
                </c:pt>
                <c:pt idx="1673">
                  <c:v>2.413327213919509E-2</c:v>
                </c:pt>
                <c:pt idx="1674">
                  <c:v>2.4079765083477048E-2</c:v>
                </c:pt>
                <c:pt idx="1675">
                  <c:v>2.4032222331720636E-2</c:v>
                </c:pt>
                <c:pt idx="1676">
                  <c:v>2.3985925489188403E-2</c:v>
                </c:pt>
                <c:pt idx="1677">
                  <c:v>2.3937470919394532E-2</c:v>
                </c:pt>
                <c:pt idx="1678">
                  <c:v>2.3888651886620108E-2</c:v>
                </c:pt>
                <c:pt idx="1679">
                  <c:v>2.3832759196755038E-2</c:v>
                </c:pt>
                <c:pt idx="1680">
                  <c:v>2.3777464569516005E-2</c:v>
                </c:pt>
                <c:pt idx="1681">
                  <c:v>2.3721064073840014E-2</c:v>
                </c:pt>
                <c:pt idx="1682">
                  <c:v>2.3664357722808282E-2</c:v>
                </c:pt>
                <c:pt idx="1683">
                  <c:v>2.3607138333608862E-2</c:v>
                </c:pt>
                <c:pt idx="1684">
                  <c:v>2.3549661599233926E-2</c:v>
                </c:pt>
                <c:pt idx="1685">
                  <c:v>2.3488551894283779E-2</c:v>
                </c:pt>
                <c:pt idx="1686">
                  <c:v>2.3426752471931152E-2</c:v>
                </c:pt>
                <c:pt idx="1687">
                  <c:v>2.3366318055880519E-2</c:v>
                </c:pt>
                <c:pt idx="1688">
                  <c:v>2.3305166531953563E-2</c:v>
                </c:pt>
                <c:pt idx="1689">
                  <c:v>2.324710743860673E-2</c:v>
                </c:pt>
                <c:pt idx="1690">
                  <c:v>2.3188153303153283E-2</c:v>
                </c:pt>
                <c:pt idx="1691">
                  <c:v>2.3130393571287596E-2</c:v>
                </c:pt>
                <c:pt idx="1692">
                  <c:v>2.3073232224484447E-2</c:v>
                </c:pt>
                <c:pt idx="1693">
                  <c:v>2.3017348430358683E-2</c:v>
                </c:pt>
                <c:pt idx="1694">
                  <c:v>2.2960951204976626E-2</c:v>
                </c:pt>
                <c:pt idx="1695">
                  <c:v>2.2905618127374225E-2</c:v>
                </c:pt>
                <c:pt idx="1696">
                  <c:v>2.2849464710530551E-2</c:v>
                </c:pt>
                <c:pt idx="1697">
                  <c:v>2.2793933242071324E-2</c:v>
                </c:pt>
                <c:pt idx="1698">
                  <c:v>2.2741460422440522E-2</c:v>
                </c:pt>
                <c:pt idx="1699">
                  <c:v>2.2690601706962445E-2</c:v>
                </c:pt>
                <c:pt idx="1700">
                  <c:v>2.2644420487380412E-2</c:v>
                </c:pt>
                <c:pt idx="1701">
                  <c:v>2.2594679950483705E-2</c:v>
                </c:pt>
                <c:pt idx="1702">
                  <c:v>2.254490398870496E-2</c:v>
                </c:pt>
                <c:pt idx="1703">
                  <c:v>2.2492652312399931E-2</c:v>
                </c:pt>
                <c:pt idx="1704">
                  <c:v>2.243965211044046E-2</c:v>
                </c:pt>
                <c:pt idx="1705">
                  <c:v>2.2383238106987689E-2</c:v>
                </c:pt>
                <c:pt idx="1706">
                  <c:v>2.2326657962742563E-2</c:v>
                </c:pt>
                <c:pt idx="1707">
                  <c:v>2.2268427478254079E-2</c:v>
                </c:pt>
                <c:pt idx="1708">
                  <c:v>2.2207928540276835E-2</c:v>
                </c:pt>
                <c:pt idx="1709">
                  <c:v>2.2148627780135835E-2</c:v>
                </c:pt>
                <c:pt idx="1710">
                  <c:v>2.2086715322505088E-2</c:v>
                </c:pt>
                <c:pt idx="1711">
                  <c:v>2.2023829299426104E-2</c:v>
                </c:pt>
                <c:pt idx="1712">
                  <c:v>2.1958420817087706E-2</c:v>
                </c:pt>
                <c:pt idx="1713">
                  <c:v>2.1891485646861299E-2</c:v>
                </c:pt>
                <c:pt idx="1714">
                  <c:v>2.1823335126994265E-2</c:v>
                </c:pt>
                <c:pt idx="1715">
                  <c:v>2.1757001254498032E-2</c:v>
                </c:pt>
                <c:pt idx="1716">
                  <c:v>2.1691301539583058E-2</c:v>
                </c:pt>
                <c:pt idx="1717">
                  <c:v>2.1625690005862834E-2</c:v>
                </c:pt>
                <c:pt idx="1718">
                  <c:v>2.1564084800434043E-2</c:v>
                </c:pt>
                <c:pt idx="1719">
                  <c:v>2.1502930992130777E-2</c:v>
                </c:pt>
                <c:pt idx="1720">
                  <c:v>2.1443402431521267E-2</c:v>
                </c:pt>
                <c:pt idx="1721">
                  <c:v>2.1384970296091405E-2</c:v>
                </c:pt>
                <c:pt idx="1722">
                  <c:v>2.1332000454284111E-2</c:v>
                </c:pt>
                <c:pt idx="1723">
                  <c:v>2.1281301962141747E-2</c:v>
                </c:pt>
                <c:pt idx="1724">
                  <c:v>2.1234275048468934E-2</c:v>
                </c:pt>
                <c:pt idx="1725">
                  <c:v>2.1187924767776097E-2</c:v>
                </c:pt>
                <c:pt idx="1726">
                  <c:v>2.1145155361884306E-2</c:v>
                </c:pt>
                <c:pt idx="1727">
                  <c:v>2.1104713746418997E-2</c:v>
                </c:pt>
                <c:pt idx="1728">
                  <c:v>2.1065045954465376E-2</c:v>
                </c:pt>
                <c:pt idx="1729">
                  <c:v>2.1027566819288298E-2</c:v>
                </c:pt>
                <c:pt idx="1730">
                  <c:v>2.0990626761905468E-2</c:v>
                </c:pt>
                <c:pt idx="1731">
                  <c:v>2.0955480456161493E-2</c:v>
                </c:pt>
                <c:pt idx="1732">
                  <c:v>2.0920699175788128E-2</c:v>
                </c:pt>
                <c:pt idx="1733">
                  <c:v>2.08877973689989E-2</c:v>
                </c:pt>
                <c:pt idx="1734">
                  <c:v>2.0855251202866257E-2</c:v>
                </c:pt>
                <c:pt idx="1735">
                  <c:v>2.0823198464059219E-2</c:v>
                </c:pt>
                <c:pt idx="1736">
                  <c:v>2.0789383457044813E-2</c:v>
                </c:pt>
                <c:pt idx="1737">
                  <c:v>2.0754724358867119E-2</c:v>
                </c:pt>
                <c:pt idx="1738">
                  <c:v>2.0722990938796048E-2</c:v>
                </c:pt>
                <c:pt idx="1739">
                  <c:v>2.0689102430289874E-2</c:v>
                </c:pt>
                <c:pt idx="1740">
                  <c:v>2.0655609301031361E-2</c:v>
                </c:pt>
                <c:pt idx="1741">
                  <c:v>2.062169701925352E-2</c:v>
                </c:pt>
                <c:pt idx="1742">
                  <c:v>2.0587963034206774E-2</c:v>
                </c:pt>
                <c:pt idx="1743">
                  <c:v>2.0554846669888091E-2</c:v>
                </c:pt>
                <c:pt idx="1744">
                  <c:v>2.0521196620390016E-2</c:v>
                </c:pt>
                <c:pt idx="1745">
                  <c:v>2.0487374715886408E-2</c:v>
                </c:pt>
                <c:pt idx="1746">
                  <c:v>2.0453588292517321E-2</c:v>
                </c:pt>
                <c:pt idx="1747">
                  <c:v>2.0420958447095044E-2</c:v>
                </c:pt>
                <c:pt idx="1748">
                  <c:v>2.0388220978899842E-2</c:v>
                </c:pt>
                <c:pt idx="1749">
                  <c:v>2.0358143089106846E-2</c:v>
                </c:pt>
                <c:pt idx="1750">
                  <c:v>2.032662592161379E-2</c:v>
                </c:pt>
                <c:pt idx="1751">
                  <c:v>2.0295767403515658E-2</c:v>
                </c:pt>
                <c:pt idx="1752">
                  <c:v>2.0264684346408521E-2</c:v>
                </c:pt>
                <c:pt idx="1753">
                  <c:v>2.0234195340999538E-2</c:v>
                </c:pt>
                <c:pt idx="1754">
                  <c:v>2.0203399501944438E-2</c:v>
                </c:pt>
                <c:pt idx="1755">
                  <c:v>2.0173093918991452E-2</c:v>
                </c:pt>
                <c:pt idx="1756">
                  <c:v>2.014239865588166E-2</c:v>
                </c:pt>
                <c:pt idx="1757">
                  <c:v>2.0112188100781934E-2</c:v>
                </c:pt>
                <c:pt idx="1758">
                  <c:v>2.0083289426805411E-2</c:v>
                </c:pt>
                <c:pt idx="1759">
                  <c:v>2.0051937597612243E-2</c:v>
                </c:pt>
                <c:pt idx="1760">
                  <c:v>2.0021557297044319E-2</c:v>
                </c:pt>
                <c:pt idx="1761">
                  <c:v>1.9989615693086778E-2</c:v>
                </c:pt>
                <c:pt idx="1762">
                  <c:v>1.9957998145919555E-2</c:v>
                </c:pt>
                <c:pt idx="1763">
                  <c:v>1.9925590323841391E-2</c:v>
                </c:pt>
                <c:pt idx="1764">
                  <c:v>1.9892478911987678E-2</c:v>
                </c:pt>
                <c:pt idx="1765">
                  <c:v>1.9858307193770606E-2</c:v>
                </c:pt>
                <c:pt idx="1766">
                  <c:v>1.982223942063379E-2</c:v>
                </c:pt>
                <c:pt idx="1767">
                  <c:v>1.9782802888760481E-2</c:v>
                </c:pt>
                <c:pt idx="1768">
                  <c:v>1.9736744059367775E-2</c:v>
                </c:pt>
                <c:pt idx="1769">
                  <c:v>1.9690506142124774E-2</c:v>
                </c:pt>
                <c:pt idx="1770">
                  <c:v>1.9642952269562353E-2</c:v>
                </c:pt>
                <c:pt idx="1771">
                  <c:v>1.9595458715198657E-2</c:v>
                </c:pt>
                <c:pt idx="1772">
                  <c:v>1.9546256510108214E-2</c:v>
                </c:pt>
                <c:pt idx="1773">
                  <c:v>1.9496777072469464E-2</c:v>
                </c:pt>
                <c:pt idx="1774">
                  <c:v>1.9446745274250089E-2</c:v>
                </c:pt>
                <c:pt idx="1775">
                  <c:v>1.9397206337854064E-2</c:v>
                </c:pt>
                <c:pt idx="1776">
                  <c:v>1.934719078055654E-2</c:v>
                </c:pt>
                <c:pt idx="1777">
                  <c:v>1.9296975191517608E-2</c:v>
                </c:pt>
                <c:pt idx="1778">
                  <c:v>1.9247086576534369E-2</c:v>
                </c:pt>
                <c:pt idx="1779">
                  <c:v>1.9195938530782976E-2</c:v>
                </c:pt>
                <c:pt idx="1780">
                  <c:v>1.9146935100910287E-2</c:v>
                </c:pt>
                <c:pt idx="1781">
                  <c:v>1.9097526646168123E-2</c:v>
                </c:pt>
                <c:pt idx="1782">
                  <c:v>1.9049859765541161E-2</c:v>
                </c:pt>
                <c:pt idx="1783">
                  <c:v>1.9003087301850574E-2</c:v>
                </c:pt>
                <c:pt idx="1784">
                  <c:v>1.8958524128306668E-2</c:v>
                </c:pt>
                <c:pt idx="1785">
                  <c:v>1.8914127336281675E-2</c:v>
                </c:pt>
                <c:pt idx="1786">
                  <c:v>1.8871489033517094E-2</c:v>
                </c:pt>
                <c:pt idx="1787">
                  <c:v>1.8831302588204809E-2</c:v>
                </c:pt>
                <c:pt idx="1788">
                  <c:v>1.8791080003196781E-2</c:v>
                </c:pt>
                <c:pt idx="1789">
                  <c:v>1.8757177446158214E-2</c:v>
                </c:pt>
                <c:pt idx="1790">
                  <c:v>1.8723602682742865E-2</c:v>
                </c:pt>
                <c:pt idx="1791">
                  <c:v>1.8691771785545905E-2</c:v>
                </c:pt>
                <c:pt idx="1792">
                  <c:v>1.8660697600871964E-2</c:v>
                </c:pt>
                <c:pt idx="1793">
                  <c:v>1.8630264875260639E-2</c:v>
                </c:pt>
                <c:pt idx="1794">
                  <c:v>1.8599260365997353E-2</c:v>
                </c:pt>
                <c:pt idx="1795">
                  <c:v>1.8569302491730819E-2</c:v>
                </c:pt>
                <c:pt idx="1796">
                  <c:v>1.853887936158263E-2</c:v>
                </c:pt>
                <c:pt idx="1797">
                  <c:v>1.8507450761654866E-2</c:v>
                </c:pt>
                <c:pt idx="1798">
                  <c:v>1.8476510865297335E-2</c:v>
                </c:pt>
                <c:pt idx="1799">
                  <c:v>1.8447391403868214E-2</c:v>
                </c:pt>
                <c:pt idx="1800">
                  <c:v>1.8422352597018177E-2</c:v>
                </c:pt>
                <c:pt idx="1801">
                  <c:v>1.8397851631290447E-2</c:v>
                </c:pt>
                <c:pt idx="1802">
                  <c:v>1.8373071179627429E-2</c:v>
                </c:pt>
                <c:pt idx="1803">
                  <c:v>1.8345970330130901E-2</c:v>
                </c:pt>
                <c:pt idx="1804">
                  <c:v>1.8316683366006534E-2</c:v>
                </c:pt>
                <c:pt idx="1805">
                  <c:v>1.8285089983558645E-2</c:v>
                </c:pt>
                <c:pt idx="1806">
                  <c:v>1.8254106219101399E-2</c:v>
                </c:pt>
                <c:pt idx="1807">
                  <c:v>1.822270489561599E-2</c:v>
                </c:pt>
                <c:pt idx="1808">
                  <c:v>1.8190339372426801E-2</c:v>
                </c:pt>
                <c:pt idx="1809">
                  <c:v>1.8162260676621651E-2</c:v>
                </c:pt>
                <c:pt idx="1810">
                  <c:v>1.8134076503090936E-2</c:v>
                </c:pt>
                <c:pt idx="1811">
                  <c:v>1.8106890140243491E-2</c:v>
                </c:pt>
                <c:pt idx="1812">
                  <c:v>1.8079000685164624E-2</c:v>
                </c:pt>
                <c:pt idx="1813">
                  <c:v>1.805128635701863E-2</c:v>
                </c:pt>
                <c:pt idx="1814">
                  <c:v>1.8023592670527215E-2</c:v>
                </c:pt>
                <c:pt idx="1815">
                  <c:v>1.7996939263755885E-2</c:v>
                </c:pt>
                <c:pt idx="1816">
                  <c:v>1.7968459893380834E-2</c:v>
                </c:pt>
                <c:pt idx="1817">
                  <c:v>1.7939103044732636E-2</c:v>
                </c:pt>
                <c:pt idx="1818">
                  <c:v>1.7911448969216717E-2</c:v>
                </c:pt>
                <c:pt idx="1819">
                  <c:v>1.7882743189406868E-2</c:v>
                </c:pt>
                <c:pt idx="1820">
                  <c:v>1.7852785381558767E-2</c:v>
                </c:pt>
                <c:pt idx="1821">
                  <c:v>1.7819006445286379E-2</c:v>
                </c:pt>
                <c:pt idx="1822">
                  <c:v>1.7784140430413709E-2</c:v>
                </c:pt>
                <c:pt idx="1823">
                  <c:v>1.7749715571565221E-2</c:v>
                </c:pt>
                <c:pt idx="1824">
                  <c:v>1.7716501877095316E-2</c:v>
                </c:pt>
                <c:pt idx="1825">
                  <c:v>1.7683839267460078E-2</c:v>
                </c:pt>
                <c:pt idx="1826">
                  <c:v>1.7652407657059145E-2</c:v>
                </c:pt>
                <c:pt idx="1827">
                  <c:v>1.7620729729405236E-2</c:v>
                </c:pt>
                <c:pt idx="1828">
                  <c:v>1.7588406830381108E-2</c:v>
                </c:pt>
                <c:pt idx="1829">
                  <c:v>1.7557134723103798E-2</c:v>
                </c:pt>
                <c:pt idx="1830">
                  <c:v>1.7524935016752938E-2</c:v>
                </c:pt>
                <c:pt idx="1831">
                  <c:v>1.7493383215824571E-2</c:v>
                </c:pt>
                <c:pt idx="1832">
                  <c:v>1.7462055311786785E-2</c:v>
                </c:pt>
                <c:pt idx="1833">
                  <c:v>1.7430379148121091E-2</c:v>
                </c:pt>
                <c:pt idx="1834">
                  <c:v>1.7397377782772398E-2</c:v>
                </c:pt>
                <c:pt idx="1835">
                  <c:v>1.7364830781914371E-2</c:v>
                </c:pt>
                <c:pt idx="1836">
                  <c:v>1.7330521007589611E-2</c:v>
                </c:pt>
                <c:pt idx="1837">
                  <c:v>1.7296318561818867E-2</c:v>
                </c:pt>
                <c:pt idx="1838">
                  <c:v>1.7262599152441997E-2</c:v>
                </c:pt>
                <c:pt idx="1839">
                  <c:v>1.7226453755147777E-2</c:v>
                </c:pt>
                <c:pt idx="1840">
                  <c:v>1.7191056476331783E-2</c:v>
                </c:pt>
                <c:pt idx="1841">
                  <c:v>1.7154109766171044E-2</c:v>
                </c:pt>
                <c:pt idx="1842">
                  <c:v>1.7116973444952697E-2</c:v>
                </c:pt>
                <c:pt idx="1843">
                  <c:v>1.707947922867821E-2</c:v>
                </c:pt>
                <c:pt idx="1844">
                  <c:v>1.7041915482311033E-2</c:v>
                </c:pt>
                <c:pt idx="1845">
                  <c:v>1.7005074548927232E-2</c:v>
                </c:pt>
                <c:pt idx="1846">
                  <c:v>1.6968090867861201E-2</c:v>
                </c:pt>
                <c:pt idx="1847">
                  <c:v>1.6929818342250786E-2</c:v>
                </c:pt>
                <c:pt idx="1848">
                  <c:v>1.6891005600314247E-2</c:v>
                </c:pt>
                <c:pt idx="1849">
                  <c:v>1.6854074030326741E-2</c:v>
                </c:pt>
                <c:pt idx="1850">
                  <c:v>1.681775141929312E-2</c:v>
                </c:pt>
                <c:pt idx="1851">
                  <c:v>1.678274664403329E-2</c:v>
                </c:pt>
                <c:pt idx="1852">
                  <c:v>1.674758705422754E-2</c:v>
                </c:pt>
                <c:pt idx="1853">
                  <c:v>1.6712564302067828E-2</c:v>
                </c:pt>
                <c:pt idx="1854">
                  <c:v>1.6678288475726478E-2</c:v>
                </c:pt>
                <c:pt idx="1855">
                  <c:v>1.6645770873794978E-2</c:v>
                </c:pt>
                <c:pt idx="1856">
                  <c:v>1.6612267195164551E-2</c:v>
                </c:pt>
                <c:pt idx="1857">
                  <c:v>1.657965112180047E-2</c:v>
                </c:pt>
                <c:pt idx="1858">
                  <c:v>1.6547524601162641E-2</c:v>
                </c:pt>
                <c:pt idx="1859">
                  <c:v>1.6515060732321864E-2</c:v>
                </c:pt>
                <c:pt idx="1860">
                  <c:v>1.6485147151276122E-2</c:v>
                </c:pt>
                <c:pt idx="1861">
                  <c:v>1.6454740820035545E-2</c:v>
                </c:pt>
                <c:pt idx="1862">
                  <c:v>1.6424179683396472E-2</c:v>
                </c:pt>
                <c:pt idx="1863">
                  <c:v>1.6393195354465952E-2</c:v>
                </c:pt>
                <c:pt idx="1864">
                  <c:v>1.6361997152144796E-2</c:v>
                </c:pt>
                <c:pt idx="1865">
                  <c:v>1.632922101619973E-2</c:v>
                </c:pt>
                <c:pt idx="1866">
                  <c:v>1.6294581253175074E-2</c:v>
                </c:pt>
                <c:pt idx="1867">
                  <c:v>1.6260176919803908E-2</c:v>
                </c:pt>
                <c:pt idx="1868">
                  <c:v>1.6226166140181169E-2</c:v>
                </c:pt>
                <c:pt idx="1869">
                  <c:v>1.619326328485195E-2</c:v>
                </c:pt>
                <c:pt idx="1870">
                  <c:v>1.6158115051490295E-2</c:v>
                </c:pt>
                <c:pt idx="1871">
                  <c:v>1.6122180828970711E-2</c:v>
                </c:pt>
                <c:pt idx="1872">
                  <c:v>1.6085088647862778E-2</c:v>
                </c:pt>
                <c:pt idx="1873">
                  <c:v>1.6048138954391274E-2</c:v>
                </c:pt>
                <c:pt idx="1874">
                  <c:v>1.6010842943118372E-2</c:v>
                </c:pt>
                <c:pt idx="1875">
                  <c:v>1.5973609331190953E-2</c:v>
                </c:pt>
                <c:pt idx="1876">
                  <c:v>1.5935427016709039E-2</c:v>
                </c:pt>
                <c:pt idx="1877">
                  <c:v>1.5897875698049829E-2</c:v>
                </c:pt>
                <c:pt idx="1878">
                  <c:v>1.5861173910745357E-2</c:v>
                </c:pt>
                <c:pt idx="1879">
                  <c:v>1.5825015682654365E-2</c:v>
                </c:pt>
                <c:pt idx="1880">
                  <c:v>1.5791049401971742E-2</c:v>
                </c:pt>
                <c:pt idx="1881">
                  <c:v>1.5757237913569339E-2</c:v>
                </c:pt>
                <c:pt idx="1882">
                  <c:v>1.5722800843879527E-2</c:v>
                </c:pt>
                <c:pt idx="1883">
                  <c:v>1.5688804631164548E-2</c:v>
                </c:pt>
                <c:pt idx="1884">
                  <c:v>1.5654766923424594E-2</c:v>
                </c:pt>
                <c:pt idx="1885">
                  <c:v>1.5620356649510423E-2</c:v>
                </c:pt>
                <c:pt idx="1886">
                  <c:v>1.5587929060321887E-2</c:v>
                </c:pt>
                <c:pt idx="1887">
                  <c:v>1.5557544614256383E-2</c:v>
                </c:pt>
                <c:pt idx="1888">
                  <c:v>1.5528335187921544E-2</c:v>
                </c:pt>
                <c:pt idx="1889">
                  <c:v>1.5501611542739083E-2</c:v>
                </c:pt>
                <c:pt idx="1890">
                  <c:v>1.547439126062908E-2</c:v>
                </c:pt>
                <c:pt idx="1891">
                  <c:v>1.5448702161412026E-2</c:v>
                </c:pt>
                <c:pt idx="1892">
                  <c:v>1.5422320487607808E-2</c:v>
                </c:pt>
                <c:pt idx="1893">
                  <c:v>1.5396489018211452E-2</c:v>
                </c:pt>
                <c:pt idx="1894">
                  <c:v>1.5370201629442536E-2</c:v>
                </c:pt>
                <c:pt idx="1895">
                  <c:v>1.5344632111107735E-2</c:v>
                </c:pt>
                <c:pt idx="1896">
                  <c:v>1.5319232597390816E-2</c:v>
                </c:pt>
                <c:pt idx="1897">
                  <c:v>1.5294237480530392E-2</c:v>
                </c:pt>
                <c:pt idx="1898">
                  <c:v>1.5269451756255636E-2</c:v>
                </c:pt>
                <c:pt idx="1899">
                  <c:v>1.5244019250025364E-2</c:v>
                </c:pt>
                <c:pt idx="1900">
                  <c:v>1.5219586430139967E-2</c:v>
                </c:pt>
                <c:pt idx="1901">
                  <c:v>1.5194861278686682E-2</c:v>
                </c:pt>
                <c:pt idx="1902">
                  <c:v>1.517649010915135E-2</c:v>
                </c:pt>
                <c:pt idx="1903">
                  <c:v>1.5164754401379656E-2</c:v>
                </c:pt>
                <c:pt idx="1904">
                  <c:v>1.5156837427872594E-2</c:v>
                </c:pt>
                <c:pt idx="1905">
                  <c:v>1.5150819562776632E-2</c:v>
                </c:pt>
                <c:pt idx="1906">
                  <c:v>1.51458797059106E-2</c:v>
                </c:pt>
                <c:pt idx="1907">
                  <c:v>1.5140615167152805E-2</c:v>
                </c:pt>
                <c:pt idx="1908">
                  <c:v>1.5135389216093781E-2</c:v>
                </c:pt>
                <c:pt idx="1909">
                  <c:v>1.5130703114973254E-2</c:v>
                </c:pt>
                <c:pt idx="1910">
                  <c:v>1.5125238623185877E-2</c:v>
                </c:pt>
                <c:pt idx="1911">
                  <c:v>1.5120893134720287E-2</c:v>
                </c:pt>
                <c:pt idx="1912">
                  <c:v>1.5116375413503441E-2</c:v>
                </c:pt>
                <c:pt idx="1913">
                  <c:v>1.5113136025524309E-2</c:v>
                </c:pt>
                <c:pt idx="1914">
                  <c:v>1.5110298653936033E-2</c:v>
                </c:pt>
                <c:pt idx="1915">
                  <c:v>1.5108285139624002E-2</c:v>
                </c:pt>
                <c:pt idx="1916">
                  <c:v>1.5105899706122968E-2</c:v>
                </c:pt>
                <c:pt idx="1917">
                  <c:v>1.5104030275970435E-2</c:v>
                </c:pt>
                <c:pt idx="1918">
                  <c:v>1.5103866293931985E-2</c:v>
                </c:pt>
                <c:pt idx="1919">
                  <c:v>1.5105015269530436E-2</c:v>
                </c:pt>
                <c:pt idx="1920">
                  <c:v>1.5108578036847869E-2</c:v>
                </c:pt>
                <c:pt idx="1921">
                  <c:v>1.5112858148581401E-2</c:v>
                </c:pt>
                <c:pt idx="1922">
                  <c:v>1.5118147178016733E-2</c:v>
                </c:pt>
                <c:pt idx="1923">
                  <c:v>1.5115602745093593E-2</c:v>
                </c:pt>
                <c:pt idx="1924">
                  <c:v>1.510639107046079E-2</c:v>
                </c:pt>
                <c:pt idx="1925">
                  <c:v>1.5093465116073443E-2</c:v>
                </c:pt>
                <c:pt idx="1926">
                  <c:v>1.5079846604618174E-2</c:v>
                </c:pt>
                <c:pt idx="1927">
                  <c:v>1.5076744495306627E-2</c:v>
                </c:pt>
                <c:pt idx="1928">
                  <c:v>1.5073482710538388E-2</c:v>
                </c:pt>
                <c:pt idx="1929">
                  <c:v>1.506991610240002E-2</c:v>
                </c:pt>
                <c:pt idx="1930">
                  <c:v>1.5065424081381252E-2</c:v>
                </c:pt>
                <c:pt idx="1931">
                  <c:v>1.5060673524213345E-2</c:v>
                </c:pt>
                <c:pt idx="1932">
                  <c:v>1.5055256123658498E-2</c:v>
                </c:pt>
                <c:pt idx="1933">
                  <c:v>1.5049205119600046E-2</c:v>
                </c:pt>
                <c:pt idx="1934">
                  <c:v>1.5040944877189362E-2</c:v>
                </c:pt>
                <c:pt idx="1935">
                  <c:v>1.5031883776384253E-2</c:v>
                </c:pt>
                <c:pt idx="1936">
                  <c:v>1.5020756028517551E-2</c:v>
                </c:pt>
                <c:pt idx="1937">
                  <c:v>1.5009260320257022E-2</c:v>
                </c:pt>
                <c:pt idx="1938">
                  <c:v>1.4997286973367215E-2</c:v>
                </c:pt>
                <c:pt idx="1939">
                  <c:v>1.4984920036210308E-2</c:v>
                </c:pt>
                <c:pt idx="1940">
                  <c:v>1.4973082016028606E-2</c:v>
                </c:pt>
                <c:pt idx="1941">
                  <c:v>1.496069027146526E-2</c:v>
                </c:pt>
                <c:pt idx="1942">
                  <c:v>1.4948191054562037E-2</c:v>
                </c:pt>
                <c:pt idx="1943">
                  <c:v>1.4935204394744123E-2</c:v>
                </c:pt>
                <c:pt idx="1944">
                  <c:v>1.4922184380652183E-2</c:v>
                </c:pt>
                <c:pt idx="1945">
                  <c:v>1.4905669633627374E-2</c:v>
                </c:pt>
                <c:pt idx="1946">
                  <c:v>1.4884321473846378E-2</c:v>
                </c:pt>
                <c:pt idx="1947">
                  <c:v>1.4858333258515962E-2</c:v>
                </c:pt>
                <c:pt idx="1948">
                  <c:v>1.4831327142396152E-2</c:v>
                </c:pt>
                <c:pt idx="1949">
                  <c:v>1.4804701777327461E-2</c:v>
                </c:pt>
                <c:pt idx="1950">
                  <c:v>1.4778135819090229E-2</c:v>
                </c:pt>
                <c:pt idx="1951">
                  <c:v>1.4752745337706484E-2</c:v>
                </c:pt>
                <c:pt idx="1952">
                  <c:v>1.4727362076657173E-2</c:v>
                </c:pt>
                <c:pt idx="1953">
                  <c:v>1.4701857682241777E-2</c:v>
                </c:pt>
                <c:pt idx="1954">
                  <c:v>1.4676499742944419E-2</c:v>
                </c:pt>
                <c:pt idx="1955">
                  <c:v>1.4652570470578356E-2</c:v>
                </c:pt>
                <c:pt idx="1956">
                  <c:v>1.4628631522473647E-2</c:v>
                </c:pt>
                <c:pt idx="1957">
                  <c:v>1.4606190870011504E-2</c:v>
                </c:pt>
                <c:pt idx="1958">
                  <c:v>1.4584256696341108E-2</c:v>
                </c:pt>
                <c:pt idx="1959">
                  <c:v>1.4562685400336423E-2</c:v>
                </c:pt>
                <c:pt idx="1960">
                  <c:v>1.4541111812986302E-2</c:v>
                </c:pt>
                <c:pt idx="1961">
                  <c:v>1.4519146220481923E-2</c:v>
                </c:pt>
                <c:pt idx="1962">
                  <c:v>1.4497637664595289E-2</c:v>
                </c:pt>
                <c:pt idx="1963">
                  <c:v>1.4476160809376417E-2</c:v>
                </c:pt>
                <c:pt idx="1964">
                  <c:v>1.445486238804348E-2</c:v>
                </c:pt>
                <c:pt idx="1965">
                  <c:v>1.4433017375404035E-2</c:v>
                </c:pt>
                <c:pt idx="1966">
                  <c:v>1.4414915071413518E-2</c:v>
                </c:pt>
                <c:pt idx="1967">
                  <c:v>1.4401970570767964E-2</c:v>
                </c:pt>
                <c:pt idx="1968">
                  <c:v>1.4393479320200561E-2</c:v>
                </c:pt>
                <c:pt idx="1969">
                  <c:v>1.4386927397625955E-2</c:v>
                </c:pt>
                <c:pt idx="1970">
                  <c:v>1.4379758879357739E-2</c:v>
                </c:pt>
                <c:pt idx="1971">
                  <c:v>1.4373214339279254E-2</c:v>
                </c:pt>
                <c:pt idx="1972">
                  <c:v>1.4366325815236109E-2</c:v>
                </c:pt>
                <c:pt idx="1973">
                  <c:v>1.4359719091500335E-2</c:v>
                </c:pt>
                <c:pt idx="1974">
                  <c:v>1.4353331573356897E-2</c:v>
                </c:pt>
                <c:pt idx="1975">
                  <c:v>1.4347974704708189E-2</c:v>
                </c:pt>
                <c:pt idx="1976">
                  <c:v>1.4342554695141931E-2</c:v>
                </c:pt>
                <c:pt idx="1977">
                  <c:v>1.4336926130433081E-2</c:v>
                </c:pt>
                <c:pt idx="1978">
                  <c:v>1.4330904598681081E-2</c:v>
                </c:pt>
                <c:pt idx="1979">
                  <c:v>1.4324306694449056E-2</c:v>
                </c:pt>
                <c:pt idx="1980">
                  <c:v>1.4318535804128694E-2</c:v>
                </c:pt>
                <c:pt idx="1981">
                  <c:v>1.4312831080359988E-2</c:v>
                </c:pt>
                <c:pt idx="1982">
                  <c:v>1.4307384133057688E-2</c:v>
                </c:pt>
                <c:pt idx="1983">
                  <c:v>1.4301724815784832E-2</c:v>
                </c:pt>
                <c:pt idx="1984">
                  <c:v>1.4296696464481454E-2</c:v>
                </c:pt>
                <c:pt idx="1985">
                  <c:v>1.4291296296888535E-2</c:v>
                </c:pt>
                <c:pt idx="1986">
                  <c:v>1.4286528362976066E-2</c:v>
                </c:pt>
                <c:pt idx="1987">
                  <c:v>1.428013240866372E-2</c:v>
                </c:pt>
                <c:pt idx="1988">
                  <c:v>1.4274150400513589E-2</c:v>
                </c:pt>
                <c:pt idx="1989">
                  <c:v>1.4268923800816671E-2</c:v>
                </c:pt>
                <c:pt idx="1990">
                  <c:v>1.4263471701232341E-2</c:v>
                </c:pt>
                <c:pt idx="1991">
                  <c:v>1.4259362996626283E-2</c:v>
                </c:pt>
                <c:pt idx="1992">
                  <c:v>1.4254674139684575E-2</c:v>
                </c:pt>
                <c:pt idx="1993">
                  <c:v>1.425085927208888E-2</c:v>
                </c:pt>
                <c:pt idx="1994">
                  <c:v>1.4247084911915025E-2</c:v>
                </c:pt>
                <c:pt idx="1995">
                  <c:v>1.4243909811433008E-2</c:v>
                </c:pt>
                <c:pt idx="1996">
                  <c:v>1.4238769163131968E-2</c:v>
                </c:pt>
                <c:pt idx="1997">
                  <c:v>1.4233194415114591E-2</c:v>
                </c:pt>
                <c:pt idx="1998">
                  <c:v>1.4228181027095379E-2</c:v>
                </c:pt>
                <c:pt idx="1999">
                  <c:v>1.422399254267917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041-9648-AA99-C4B2DE2B42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913152"/>
        <c:axId val="167914304"/>
      </c:scatterChart>
      <c:scatterChart>
        <c:scatterStyle val="lineMarker"/>
        <c:varyColors val="0"/>
        <c:ser>
          <c:idx val="3"/>
          <c:order val="1"/>
          <c:tx>
            <c:v>60</c:v>
          </c:tx>
          <c:marker>
            <c:symbol val="none"/>
          </c:marker>
          <c:xVal>
            <c:numRef>
              <c:f>'VW_60 Cell micro'!$J$2:$J$61</c:f>
              <c:numCache>
                <c:formatCode>General</c:formatCode>
                <c:ptCount val="60"/>
                <c:pt idx="0">
                  <c:v>405.5</c:v>
                </c:pt>
                <c:pt idx="1">
                  <c:v>417.5</c:v>
                </c:pt>
                <c:pt idx="2">
                  <c:v>430</c:v>
                </c:pt>
                <c:pt idx="3">
                  <c:v>441.5</c:v>
                </c:pt>
                <c:pt idx="4">
                  <c:v>452</c:v>
                </c:pt>
                <c:pt idx="5">
                  <c:v>461.5</c:v>
                </c:pt>
                <c:pt idx="6">
                  <c:v>470.5</c:v>
                </c:pt>
                <c:pt idx="7">
                  <c:v>479.5</c:v>
                </c:pt>
                <c:pt idx="8">
                  <c:v>488.5</c:v>
                </c:pt>
                <c:pt idx="9">
                  <c:v>497</c:v>
                </c:pt>
                <c:pt idx="10">
                  <c:v>505</c:v>
                </c:pt>
                <c:pt idx="11">
                  <c:v>513</c:v>
                </c:pt>
                <c:pt idx="12">
                  <c:v>520.5</c:v>
                </c:pt>
                <c:pt idx="13">
                  <c:v>527.5</c:v>
                </c:pt>
                <c:pt idx="14">
                  <c:v>534.5</c:v>
                </c:pt>
                <c:pt idx="15">
                  <c:v>541.5</c:v>
                </c:pt>
                <c:pt idx="16">
                  <c:v>548.5</c:v>
                </c:pt>
                <c:pt idx="17">
                  <c:v>555.5</c:v>
                </c:pt>
                <c:pt idx="18">
                  <c:v>562.5</c:v>
                </c:pt>
                <c:pt idx="19">
                  <c:v>569.5</c:v>
                </c:pt>
                <c:pt idx="20">
                  <c:v>576.5</c:v>
                </c:pt>
                <c:pt idx="21">
                  <c:v>583.5</c:v>
                </c:pt>
                <c:pt idx="22">
                  <c:v>590.5</c:v>
                </c:pt>
                <c:pt idx="23">
                  <c:v>597.5</c:v>
                </c:pt>
                <c:pt idx="24">
                  <c:v>604.5</c:v>
                </c:pt>
                <c:pt idx="25">
                  <c:v>611.5</c:v>
                </c:pt>
                <c:pt idx="26">
                  <c:v>618.5</c:v>
                </c:pt>
                <c:pt idx="27">
                  <c:v>625.5</c:v>
                </c:pt>
                <c:pt idx="28">
                  <c:v>632.5</c:v>
                </c:pt>
                <c:pt idx="29">
                  <c:v>639.5</c:v>
                </c:pt>
                <c:pt idx="30">
                  <c:v>646.5</c:v>
                </c:pt>
                <c:pt idx="31">
                  <c:v>653.5</c:v>
                </c:pt>
                <c:pt idx="32">
                  <c:v>660.5</c:v>
                </c:pt>
                <c:pt idx="33">
                  <c:v>667.5</c:v>
                </c:pt>
                <c:pt idx="34">
                  <c:v>675</c:v>
                </c:pt>
                <c:pt idx="35">
                  <c:v>683</c:v>
                </c:pt>
                <c:pt idx="36">
                  <c:v>691</c:v>
                </c:pt>
                <c:pt idx="37">
                  <c:v>699</c:v>
                </c:pt>
                <c:pt idx="38">
                  <c:v>707</c:v>
                </c:pt>
                <c:pt idx="39">
                  <c:v>715</c:v>
                </c:pt>
                <c:pt idx="40">
                  <c:v>723</c:v>
                </c:pt>
                <c:pt idx="41">
                  <c:v>731.5</c:v>
                </c:pt>
                <c:pt idx="42">
                  <c:v>740.5</c:v>
                </c:pt>
                <c:pt idx="43">
                  <c:v>749.5</c:v>
                </c:pt>
                <c:pt idx="44">
                  <c:v>758.5</c:v>
                </c:pt>
                <c:pt idx="45">
                  <c:v>767.5</c:v>
                </c:pt>
                <c:pt idx="46">
                  <c:v>776.5</c:v>
                </c:pt>
                <c:pt idx="47">
                  <c:v>785.5</c:v>
                </c:pt>
                <c:pt idx="48">
                  <c:v>795.5</c:v>
                </c:pt>
                <c:pt idx="49">
                  <c:v>806.5</c:v>
                </c:pt>
                <c:pt idx="50">
                  <c:v>817.5</c:v>
                </c:pt>
                <c:pt idx="51">
                  <c:v>829</c:v>
                </c:pt>
                <c:pt idx="52">
                  <c:v>841</c:v>
                </c:pt>
                <c:pt idx="53">
                  <c:v>854</c:v>
                </c:pt>
                <c:pt idx="54">
                  <c:v>868</c:v>
                </c:pt>
                <c:pt idx="55">
                  <c:v>884.5</c:v>
                </c:pt>
                <c:pt idx="56">
                  <c:v>903.5</c:v>
                </c:pt>
                <c:pt idx="57">
                  <c:v>925</c:v>
                </c:pt>
                <c:pt idx="58">
                  <c:v>951.5</c:v>
                </c:pt>
                <c:pt idx="59">
                  <c:v>983</c:v>
                </c:pt>
              </c:numCache>
            </c:numRef>
          </c:xVal>
          <c:yVal>
            <c:numRef>
              <c:f>'VW_60 Cell micro'!$K$2:$K$61</c:f>
              <c:numCache>
                <c:formatCode>General</c:formatCode>
                <c:ptCount val="60"/>
                <c:pt idx="0">
                  <c:v>15</c:v>
                </c:pt>
                <c:pt idx="1">
                  <c:v>14</c:v>
                </c:pt>
                <c:pt idx="2">
                  <c:v>13</c:v>
                </c:pt>
                <c:pt idx="3">
                  <c:v>12</c:v>
                </c:pt>
                <c:pt idx="4">
                  <c:v>11</c:v>
                </c:pt>
                <c:pt idx="5">
                  <c:v>10</c:v>
                </c:pt>
                <c:pt idx="6">
                  <c:v>10</c:v>
                </c:pt>
                <c:pt idx="7">
                  <c:v>10</c:v>
                </c:pt>
                <c:pt idx="8">
                  <c:v>10</c:v>
                </c:pt>
                <c:pt idx="9">
                  <c:v>9</c:v>
                </c:pt>
                <c:pt idx="10">
                  <c:v>9</c:v>
                </c:pt>
                <c:pt idx="11">
                  <c:v>9</c:v>
                </c:pt>
                <c:pt idx="12">
                  <c:v>8</c:v>
                </c:pt>
                <c:pt idx="13">
                  <c:v>8</c:v>
                </c:pt>
                <c:pt idx="14">
                  <c:v>8</c:v>
                </c:pt>
                <c:pt idx="15">
                  <c:v>8</c:v>
                </c:pt>
                <c:pt idx="16">
                  <c:v>8</c:v>
                </c:pt>
                <c:pt idx="17">
                  <c:v>8</c:v>
                </c:pt>
                <c:pt idx="18">
                  <c:v>8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8</c:v>
                </c:pt>
                <c:pt idx="26">
                  <c:v>8</c:v>
                </c:pt>
                <c:pt idx="27">
                  <c:v>8</c:v>
                </c:pt>
                <c:pt idx="28">
                  <c:v>8</c:v>
                </c:pt>
                <c:pt idx="29">
                  <c:v>8</c:v>
                </c:pt>
                <c:pt idx="30">
                  <c:v>8</c:v>
                </c:pt>
                <c:pt idx="31">
                  <c:v>8</c:v>
                </c:pt>
                <c:pt idx="32">
                  <c:v>8</c:v>
                </c:pt>
                <c:pt idx="33">
                  <c:v>8</c:v>
                </c:pt>
                <c:pt idx="34">
                  <c:v>9</c:v>
                </c:pt>
                <c:pt idx="35">
                  <c:v>9</c:v>
                </c:pt>
                <c:pt idx="36">
                  <c:v>9</c:v>
                </c:pt>
                <c:pt idx="37">
                  <c:v>9</c:v>
                </c:pt>
                <c:pt idx="38">
                  <c:v>9</c:v>
                </c:pt>
                <c:pt idx="39">
                  <c:v>9</c:v>
                </c:pt>
                <c:pt idx="40">
                  <c:v>9</c:v>
                </c:pt>
                <c:pt idx="41">
                  <c:v>10</c:v>
                </c:pt>
                <c:pt idx="42">
                  <c:v>10</c:v>
                </c:pt>
                <c:pt idx="43">
                  <c:v>10</c:v>
                </c:pt>
                <c:pt idx="44">
                  <c:v>10</c:v>
                </c:pt>
                <c:pt idx="45">
                  <c:v>10</c:v>
                </c:pt>
                <c:pt idx="46">
                  <c:v>10</c:v>
                </c:pt>
                <c:pt idx="47">
                  <c:v>10</c:v>
                </c:pt>
                <c:pt idx="48">
                  <c:v>12</c:v>
                </c:pt>
                <c:pt idx="49">
                  <c:v>12</c:v>
                </c:pt>
                <c:pt idx="50">
                  <c:v>12</c:v>
                </c:pt>
                <c:pt idx="51">
                  <c:v>13</c:v>
                </c:pt>
                <c:pt idx="52">
                  <c:v>13</c:v>
                </c:pt>
                <c:pt idx="53">
                  <c:v>15</c:v>
                </c:pt>
                <c:pt idx="54">
                  <c:v>15</c:v>
                </c:pt>
                <c:pt idx="55">
                  <c:v>20</c:v>
                </c:pt>
                <c:pt idx="56">
                  <c:v>20</c:v>
                </c:pt>
                <c:pt idx="57">
                  <c:v>25</c:v>
                </c:pt>
                <c:pt idx="58">
                  <c:v>30</c:v>
                </c:pt>
                <c:pt idx="59">
                  <c:v>3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041-9648-AA99-C4B2DE2B42EF}"/>
            </c:ext>
          </c:extLst>
        </c:ser>
        <c:ser>
          <c:idx val="5"/>
          <c:order val="2"/>
          <c:tx>
            <c:v>80</c:v>
          </c:tx>
          <c:marker>
            <c:symbol val="none"/>
          </c:marker>
          <c:xVal>
            <c:numRef>
              <c:f>'VW_80 Cell micro'!$J$1:$J$80</c:f>
              <c:numCache>
                <c:formatCode>General</c:formatCode>
                <c:ptCount val="80"/>
                <c:pt idx="0">
                  <c:v>405.5</c:v>
                </c:pt>
                <c:pt idx="1">
                  <c:v>411.5</c:v>
                </c:pt>
                <c:pt idx="2">
                  <c:v>422</c:v>
                </c:pt>
                <c:pt idx="3">
                  <c:v>431.5</c:v>
                </c:pt>
                <c:pt idx="4">
                  <c:v>440.5</c:v>
                </c:pt>
                <c:pt idx="5">
                  <c:v>449</c:v>
                </c:pt>
                <c:pt idx="6">
                  <c:v>457</c:v>
                </c:pt>
                <c:pt idx="7">
                  <c:v>464.5</c:v>
                </c:pt>
                <c:pt idx="8">
                  <c:v>471.5</c:v>
                </c:pt>
                <c:pt idx="9">
                  <c:v>478</c:v>
                </c:pt>
                <c:pt idx="10">
                  <c:v>484</c:v>
                </c:pt>
                <c:pt idx="11">
                  <c:v>490</c:v>
                </c:pt>
                <c:pt idx="12">
                  <c:v>496</c:v>
                </c:pt>
                <c:pt idx="13">
                  <c:v>502</c:v>
                </c:pt>
                <c:pt idx="14">
                  <c:v>508</c:v>
                </c:pt>
                <c:pt idx="15">
                  <c:v>514</c:v>
                </c:pt>
                <c:pt idx="16">
                  <c:v>520</c:v>
                </c:pt>
                <c:pt idx="17">
                  <c:v>525.5</c:v>
                </c:pt>
                <c:pt idx="18">
                  <c:v>530.5</c:v>
                </c:pt>
                <c:pt idx="19">
                  <c:v>535.5</c:v>
                </c:pt>
                <c:pt idx="20">
                  <c:v>540.5</c:v>
                </c:pt>
                <c:pt idx="21">
                  <c:v>545.5</c:v>
                </c:pt>
                <c:pt idx="22">
                  <c:v>550.5</c:v>
                </c:pt>
                <c:pt idx="23">
                  <c:v>555.5</c:v>
                </c:pt>
                <c:pt idx="24">
                  <c:v>560.5</c:v>
                </c:pt>
                <c:pt idx="25">
                  <c:v>565.5</c:v>
                </c:pt>
                <c:pt idx="26">
                  <c:v>570.5</c:v>
                </c:pt>
                <c:pt idx="27">
                  <c:v>575.5</c:v>
                </c:pt>
                <c:pt idx="28">
                  <c:v>580.5</c:v>
                </c:pt>
                <c:pt idx="29">
                  <c:v>585.5</c:v>
                </c:pt>
                <c:pt idx="30">
                  <c:v>590.5</c:v>
                </c:pt>
                <c:pt idx="31">
                  <c:v>595.5</c:v>
                </c:pt>
                <c:pt idx="32">
                  <c:v>600</c:v>
                </c:pt>
                <c:pt idx="33">
                  <c:v>604</c:v>
                </c:pt>
                <c:pt idx="34">
                  <c:v>608</c:v>
                </c:pt>
                <c:pt idx="35">
                  <c:v>612.5</c:v>
                </c:pt>
                <c:pt idx="36">
                  <c:v>617.5</c:v>
                </c:pt>
                <c:pt idx="37">
                  <c:v>622.5</c:v>
                </c:pt>
                <c:pt idx="38">
                  <c:v>627.5</c:v>
                </c:pt>
                <c:pt idx="39">
                  <c:v>632.5</c:v>
                </c:pt>
                <c:pt idx="40">
                  <c:v>637.5</c:v>
                </c:pt>
                <c:pt idx="41">
                  <c:v>642.5</c:v>
                </c:pt>
                <c:pt idx="42">
                  <c:v>647.5</c:v>
                </c:pt>
                <c:pt idx="43">
                  <c:v>652.5</c:v>
                </c:pt>
                <c:pt idx="44">
                  <c:v>657.5</c:v>
                </c:pt>
                <c:pt idx="45">
                  <c:v>662.5</c:v>
                </c:pt>
                <c:pt idx="46">
                  <c:v>667.5</c:v>
                </c:pt>
                <c:pt idx="47">
                  <c:v>672.5</c:v>
                </c:pt>
                <c:pt idx="48">
                  <c:v>678</c:v>
                </c:pt>
                <c:pt idx="49">
                  <c:v>684</c:v>
                </c:pt>
                <c:pt idx="50">
                  <c:v>690</c:v>
                </c:pt>
                <c:pt idx="51">
                  <c:v>696</c:v>
                </c:pt>
                <c:pt idx="52">
                  <c:v>702</c:v>
                </c:pt>
                <c:pt idx="53">
                  <c:v>708</c:v>
                </c:pt>
                <c:pt idx="54">
                  <c:v>714</c:v>
                </c:pt>
                <c:pt idx="55">
                  <c:v>720.5</c:v>
                </c:pt>
                <c:pt idx="56">
                  <c:v>727.5</c:v>
                </c:pt>
                <c:pt idx="57">
                  <c:v>734.5</c:v>
                </c:pt>
                <c:pt idx="58">
                  <c:v>741.5</c:v>
                </c:pt>
                <c:pt idx="59">
                  <c:v>748.5</c:v>
                </c:pt>
                <c:pt idx="60">
                  <c:v>755.5</c:v>
                </c:pt>
                <c:pt idx="61">
                  <c:v>763</c:v>
                </c:pt>
                <c:pt idx="62">
                  <c:v>771</c:v>
                </c:pt>
                <c:pt idx="63">
                  <c:v>779</c:v>
                </c:pt>
                <c:pt idx="64">
                  <c:v>787</c:v>
                </c:pt>
                <c:pt idx="65">
                  <c:v>795.5</c:v>
                </c:pt>
                <c:pt idx="66">
                  <c:v>804.5</c:v>
                </c:pt>
                <c:pt idx="67">
                  <c:v>813.5</c:v>
                </c:pt>
                <c:pt idx="68">
                  <c:v>823</c:v>
                </c:pt>
                <c:pt idx="69">
                  <c:v>833.5</c:v>
                </c:pt>
                <c:pt idx="70">
                  <c:v>844.5</c:v>
                </c:pt>
                <c:pt idx="71">
                  <c:v>855.5</c:v>
                </c:pt>
                <c:pt idx="72">
                  <c:v>867</c:v>
                </c:pt>
                <c:pt idx="73">
                  <c:v>880</c:v>
                </c:pt>
                <c:pt idx="74">
                  <c:v>894</c:v>
                </c:pt>
                <c:pt idx="75">
                  <c:v>909</c:v>
                </c:pt>
                <c:pt idx="76">
                  <c:v>926.5</c:v>
                </c:pt>
                <c:pt idx="77">
                  <c:v>945.5</c:v>
                </c:pt>
                <c:pt idx="78">
                  <c:v>965.5</c:v>
                </c:pt>
                <c:pt idx="79">
                  <c:v>988</c:v>
                </c:pt>
              </c:numCache>
            </c:numRef>
          </c:xVal>
          <c:yVal>
            <c:numRef>
              <c:f>'VW_80 Cell micro'!$K$1:$K$80</c:f>
              <c:numCache>
                <c:formatCode>General</c:formatCode>
                <c:ptCount val="80"/>
                <c:pt idx="0">
                  <c:v>12</c:v>
                </c:pt>
                <c:pt idx="1">
                  <c:v>12</c:v>
                </c:pt>
                <c:pt idx="2">
                  <c:v>11</c:v>
                </c:pt>
                <c:pt idx="3">
                  <c:v>10</c:v>
                </c:pt>
                <c:pt idx="4">
                  <c:v>10</c:v>
                </c:pt>
                <c:pt idx="5">
                  <c:v>9</c:v>
                </c:pt>
                <c:pt idx="6">
                  <c:v>9</c:v>
                </c:pt>
                <c:pt idx="7">
                  <c:v>8</c:v>
                </c:pt>
                <c:pt idx="8">
                  <c:v>8</c:v>
                </c:pt>
                <c:pt idx="9">
                  <c:v>7</c:v>
                </c:pt>
                <c:pt idx="10">
                  <c:v>7</c:v>
                </c:pt>
                <c:pt idx="11">
                  <c:v>7</c:v>
                </c:pt>
                <c:pt idx="12">
                  <c:v>7</c:v>
                </c:pt>
                <c:pt idx="13">
                  <c:v>7</c:v>
                </c:pt>
                <c:pt idx="14">
                  <c:v>7</c:v>
                </c:pt>
                <c:pt idx="15">
                  <c:v>7</c:v>
                </c:pt>
                <c:pt idx="16">
                  <c:v>7</c:v>
                </c:pt>
                <c:pt idx="17">
                  <c:v>6</c:v>
                </c:pt>
                <c:pt idx="18">
                  <c:v>6</c:v>
                </c:pt>
                <c:pt idx="19">
                  <c:v>6</c:v>
                </c:pt>
                <c:pt idx="20">
                  <c:v>6</c:v>
                </c:pt>
                <c:pt idx="21">
                  <c:v>6</c:v>
                </c:pt>
                <c:pt idx="22">
                  <c:v>6</c:v>
                </c:pt>
                <c:pt idx="23">
                  <c:v>6</c:v>
                </c:pt>
                <c:pt idx="24">
                  <c:v>6</c:v>
                </c:pt>
                <c:pt idx="25">
                  <c:v>6</c:v>
                </c:pt>
                <c:pt idx="26">
                  <c:v>6</c:v>
                </c:pt>
                <c:pt idx="27">
                  <c:v>6</c:v>
                </c:pt>
                <c:pt idx="28">
                  <c:v>6</c:v>
                </c:pt>
                <c:pt idx="29">
                  <c:v>6</c:v>
                </c:pt>
                <c:pt idx="30">
                  <c:v>6</c:v>
                </c:pt>
                <c:pt idx="31">
                  <c:v>6</c:v>
                </c:pt>
                <c:pt idx="32">
                  <c:v>5</c:v>
                </c:pt>
                <c:pt idx="33">
                  <c:v>5</c:v>
                </c:pt>
                <c:pt idx="34">
                  <c:v>5</c:v>
                </c:pt>
                <c:pt idx="35">
                  <c:v>6</c:v>
                </c:pt>
                <c:pt idx="36">
                  <c:v>6</c:v>
                </c:pt>
                <c:pt idx="37">
                  <c:v>6</c:v>
                </c:pt>
                <c:pt idx="38">
                  <c:v>6</c:v>
                </c:pt>
                <c:pt idx="39">
                  <c:v>6</c:v>
                </c:pt>
                <c:pt idx="40">
                  <c:v>6</c:v>
                </c:pt>
                <c:pt idx="41">
                  <c:v>6</c:v>
                </c:pt>
                <c:pt idx="42">
                  <c:v>6</c:v>
                </c:pt>
                <c:pt idx="43">
                  <c:v>6</c:v>
                </c:pt>
                <c:pt idx="44">
                  <c:v>6</c:v>
                </c:pt>
                <c:pt idx="45">
                  <c:v>6</c:v>
                </c:pt>
                <c:pt idx="46">
                  <c:v>6</c:v>
                </c:pt>
                <c:pt idx="47">
                  <c:v>6</c:v>
                </c:pt>
                <c:pt idx="48">
                  <c:v>7</c:v>
                </c:pt>
                <c:pt idx="49">
                  <c:v>7</c:v>
                </c:pt>
                <c:pt idx="50">
                  <c:v>7</c:v>
                </c:pt>
                <c:pt idx="51">
                  <c:v>7</c:v>
                </c:pt>
                <c:pt idx="52">
                  <c:v>7</c:v>
                </c:pt>
                <c:pt idx="53">
                  <c:v>7</c:v>
                </c:pt>
                <c:pt idx="54">
                  <c:v>7</c:v>
                </c:pt>
                <c:pt idx="55">
                  <c:v>8</c:v>
                </c:pt>
                <c:pt idx="56">
                  <c:v>8</c:v>
                </c:pt>
                <c:pt idx="57">
                  <c:v>8</c:v>
                </c:pt>
                <c:pt idx="58">
                  <c:v>8</c:v>
                </c:pt>
                <c:pt idx="59">
                  <c:v>8</c:v>
                </c:pt>
                <c:pt idx="60">
                  <c:v>8</c:v>
                </c:pt>
                <c:pt idx="61">
                  <c:v>9</c:v>
                </c:pt>
                <c:pt idx="62">
                  <c:v>9</c:v>
                </c:pt>
                <c:pt idx="63">
                  <c:v>9</c:v>
                </c:pt>
                <c:pt idx="64">
                  <c:v>9</c:v>
                </c:pt>
                <c:pt idx="65">
                  <c:v>10</c:v>
                </c:pt>
                <c:pt idx="66">
                  <c:v>10</c:v>
                </c:pt>
                <c:pt idx="67">
                  <c:v>10</c:v>
                </c:pt>
                <c:pt idx="68">
                  <c:v>11</c:v>
                </c:pt>
                <c:pt idx="69">
                  <c:v>12</c:v>
                </c:pt>
                <c:pt idx="70">
                  <c:v>12</c:v>
                </c:pt>
                <c:pt idx="71">
                  <c:v>12</c:v>
                </c:pt>
                <c:pt idx="72">
                  <c:v>13</c:v>
                </c:pt>
                <c:pt idx="73">
                  <c:v>15</c:v>
                </c:pt>
                <c:pt idx="74">
                  <c:v>15</c:v>
                </c:pt>
                <c:pt idx="75">
                  <c:v>17</c:v>
                </c:pt>
                <c:pt idx="76">
                  <c:v>20</c:v>
                </c:pt>
                <c:pt idx="77">
                  <c:v>20</c:v>
                </c:pt>
                <c:pt idx="78">
                  <c:v>22</c:v>
                </c:pt>
                <c:pt idx="79">
                  <c:v>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041-9648-AA99-C4B2DE2B42E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7915456"/>
        <c:axId val="167914880"/>
      </c:scatterChart>
      <c:valAx>
        <c:axId val="167913152"/>
        <c:scaling>
          <c:orientation val="minMax"/>
          <c:max val="1000"/>
          <c:min val="400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m/z</a:t>
                </a:r>
              </a:p>
            </c:rich>
          </c:tx>
          <c:layout>
            <c:manualLayout>
              <c:xMode val="edge"/>
              <c:yMode val="edge"/>
              <c:x val="0.43736585726448229"/>
              <c:y val="0.8234870051849366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167914304"/>
        <c:crosses val="autoZero"/>
        <c:crossBetween val="midCat"/>
        <c:majorUnit val="200"/>
      </c:valAx>
      <c:valAx>
        <c:axId val="16791430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>
                    <a:solidFill>
                      <a:schemeClr val="accent1"/>
                    </a:solidFill>
                  </a:defRPr>
                </a:pPr>
                <a:r>
                  <a:rPr lang="en-US" sz="1600" dirty="0">
                    <a:solidFill>
                      <a:schemeClr val="accent1"/>
                    </a:solidFill>
                  </a:rPr>
                  <a:t> Normalized </a:t>
                </a:r>
                <a:r>
                  <a:rPr lang="en-US" sz="1600" baseline="0" dirty="0">
                    <a:solidFill>
                      <a:schemeClr val="accent1"/>
                    </a:solidFill>
                  </a:rPr>
                  <a:t> Density</a:t>
                </a:r>
                <a:endParaRPr lang="en-US" sz="1600" dirty="0">
                  <a:solidFill>
                    <a:schemeClr val="accent1"/>
                  </a:solidFill>
                </a:endParaRPr>
              </a:p>
            </c:rich>
          </c:tx>
          <c:layout>
            <c:manualLayout>
              <c:xMode val="edge"/>
              <c:yMode val="edge"/>
              <c:x val="9.4887664221296626E-4"/>
              <c:y val="0.1396300185098990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solidFill>
                  <a:schemeClr val="accent1"/>
                </a:solidFill>
              </a:defRPr>
            </a:pPr>
            <a:endParaRPr lang="en-US"/>
          </a:p>
        </c:txPr>
        <c:crossAx val="167913152"/>
        <c:crosses val="autoZero"/>
        <c:crossBetween val="midCat"/>
        <c:majorUnit val="0.2"/>
      </c:valAx>
      <c:valAx>
        <c:axId val="167914880"/>
        <c:scaling>
          <c:orientation val="minMax"/>
          <c:min val="0"/>
        </c:scaling>
        <c:delete val="0"/>
        <c:axPos val="r"/>
        <c:title>
          <c:tx>
            <c:rich>
              <a:bodyPr rot="-5400000" vert="horz"/>
              <a:lstStyle/>
              <a:p>
                <a:pPr>
                  <a:defRPr sz="1600">
                    <a:solidFill>
                      <a:schemeClr val="accent2"/>
                    </a:solidFill>
                  </a:defRPr>
                </a:pPr>
                <a:r>
                  <a:rPr lang="en-US" sz="1600">
                    <a:solidFill>
                      <a:schemeClr val="accent2"/>
                    </a:solidFill>
                  </a:rPr>
                  <a:t>Window Width</a:t>
                </a:r>
                <a:r>
                  <a:rPr lang="en-US" sz="1600" baseline="0">
                    <a:solidFill>
                      <a:schemeClr val="accent2"/>
                    </a:solidFill>
                  </a:rPr>
                  <a:t> (Da)</a:t>
                </a:r>
                <a:endParaRPr lang="en-US" sz="1600">
                  <a:solidFill>
                    <a:schemeClr val="accent2"/>
                  </a:solidFill>
                </a:endParaRPr>
              </a:p>
            </c:rich>
          </c:tx>
          <c:layout>
            <c:manualLayout>
              <c:xMode val="edge"/>
              <c:yMode val="edge"/>
              <c:x val="0.82033157790092426"/>
              <c:y val="0.1000339889373586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>
                <a:solidFill>
                  <a:schemeClr val="accent2"/>
                </a:solidFill>
              </a:defRPr>
            </a:pPr>
            <a:endParaRPr lang="en-US"/>
          </a:p>
        </c:txPr>
        <c:crossAx val="167915456"/>
        <c:crosses val="max"/>
        <c:crossBetween val="midCat"/>
      </c:valAx>
      <c:valAx>
        <c:axId val="16791545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6791488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547F076-C8C0-A741-9885-91F48CDCB025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40C79E-263A-6D45-9FCA-DF56B33AC5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907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595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0065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317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8892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4926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962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9758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1057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6568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26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4196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94E666-DEE2-7D4D-A9EC-3FDF350B239B}" type="datetimeFigureOut">
              <a:rPr lang="en-US" smtClean="0"/>
              <a:t>2/24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DF244-CE28-8143-8D72-0CCF0E775E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04873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Content Placeholder 1">
            <a:extLst>
              <a:ext uri="{FF2B5EF4-FFF2-40B4-BE49-F238E27FC236}">
                <a16:creationId xmlns:a16="http://schemas.microsoft.com/office/drawing/2014/main" id="{FF5B02CA-18D5-EE31-60F4-26952DE2B9C1}"/>
              </a:ext>
            </a:extLst>
          </p:cNvPr>
          <p:cNvSpPr txBox="1">
            <a:spLocks/>
          </p:cNvSpPr>
          <p:nvPr/>
        </p:nvSpPr>
        <p:spPr>
          <a:xfrm>
            <a:off x="89482" y="1326053"/>
            <a:ext cx="5259758" cy="623263"/>
          </a:xfrm>
          <a:prstGeom prst="rect">
            <a:avLst/>
          </a:prstGeom>
        </p:spPr>
        <p:txBody>
          <a:bodyPr>
            <a:noAutofit/>
          </a:bodyPr>
          <a:lstStyle>
            <a:lvl1pPr marL="194310" indent="-194310" algn="l" defTabSz="777240" rtl="0" eaLnBrk="1" latinLnBrk="0" hangingPunct="1">
              <a:lnSpc>
                <a:spcPct val="90000"/>
              </a:lnSpc>
              <a:spcBef>
                <a:spcPts val="850"/>
              </a:spcBef>
              <a:buFont typeface="Arial" panose="020B0604020202020204" pitchFamily="34" charset="0"/>
              <a:buChar char="•"/>
              <a:defRPr sz="238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8293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204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7155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7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6017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74879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13741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52603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91465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303270" indent="-194310" algn="l" defTabSz="777240" rtl="0" eaLnBrk="1" latinLnBrk="0" hangingPunct="1">
              <a:lnSpc>
                <a:spcPct val="90000"/>
              </a:lnSpc>
              <a:spcBef>
                <a:spcPts val="425"/>
              </a:spcBef>
              <a:buFont typeface="Arial" panose="020B0604020202020204" pitchFamily="34" charset="0"/>
              <a:buChar char="•"/>
              <a:defRPr sz="153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sz="1275" b="1" u="sng" dirty="0"/>
              <a:t>Chromatography (Waters M-Class)</a:t>
            </a:r>
          </a:p>
          <a:p>
            <a:pPr marL="0" indent="0">
              <a:lnSpc>
                <a:spcPct val="100000"/>
              </a:lnSpc>
              <a:buFont typeface="Arial" panose="020B0604020202020204" pitchFamily="34" charset="0"/>
              <a:buNone/>
            </a:pPr>
            <a:r>
              <a:rPr lang="en-US" sz="1275" dirty="0"/>
              <a:t>5 µL/min microflow trap-elute workflow </a:t>
            </a:r>
          </a:p>
          <a:p>
            <a:pPr marL="0" indent="0">
              <a:lnSpc>
                <a:spcPct val="100000"/>
              </a:lnSpc>
              <a:buFont typeface="Arial" panose="020B0604020202020204" pitchFamily="34" charset="0"/>
              <a:buNone/>
            </a:pPr>
            <a:r>
              <a:rPr lang="en-US" sz="1275" dirty="0"/>
              <a:t>with </a:t>
            </a:r>
            <a:r>
              <a:rPr lang="en-US" sz="1275" dirty="0" err="1"/>
              <a:t>Kinetex</a:t>
            </a:r>
            <a:r>
              <a:rPr lang="en-US" sz="1275" dirty="0"/>
              <a:t> XB-C18 150x0.3 mm column and C18 microtrap (10x0.3 mm)</a:t>
            </a:r>
          </a:p>
        </p:txBody>
      </p:sp>
      <p:sp>
        <p:nvSpPr>
          <p:cNvPr id="52" name="Title 2">
            <a:extLst>
              <a:ext uri="{FF2B5EF4-FFF2-40B4-BE49-F238E27FC236}">
                <a16:creationId xmlns:a16="http://schemas.microsoft.com/office/drawing/2014/main" id="{FA08B596-5285-BF5D-D5CF-1016A47427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58984" y="885422"/>
            <a:ext cx="6749975" cy="317547"/>
          </a:xfrm>
        </p:spPr>
        <p:txBody>
          <a:bodyPr>
            <a:normAutofit fontScale="90000"/>
          </a:bodyPr>
          <a:lstStyle/>
          <a:p>
            <a:pPr algn="ctr"/>
            <a:r>
              <a:rPr lang="en-US" sz="1785" b="1" dirty="0">
                <a:solidFill>
                  <a:schemeClr val="tx1"/>
                </a:solidFill>
                <a:latin typeface="+mn-lt"/>
              </a:rPr>
              <a:t>Zeno SWATH DIA Data Acquisition and Processing  with Spectronaut v16 </a:t>
            </a:r>
          </a:p>
        </p:txBody>
      </p:sp>
      <p:sp>
        <p:nvSpPr>
          <p:cNvPr id="54" name="Content Placeholder 1">
            <a:extLst>
              <a:ext uri="{FF2B5EF4-FFF2-40B4-BE49-F238E27FC236}">
                <a16:creationId xmlns:a16="http://schemas.microsoft.com/office/drawing/2014/main" id="{5E3E25E7-78CB-C5FA-3575-9BC51816C3A7}"/>
              </a:ext>
            </a:extLst>
          </p:cNvPr>
          <p:cNvSpPr txBox="1">
            <a:spLocks/>
          </p:cNvSpPr>
          <p:nvPr/>
        </p:nvSpPr>
        <p:spPr>
          <a:xfrm>
            <a:off x="4341702" y="2317186"/>
            <a:ext cx="3535493" cy="314566"/>
          </a:xfrm>
          <a:prstGeom prst="rect">
            <a:avLst/>
          </a:prstGeom>
        </p:spPr>
        <p:txBody>
          <a:bodyPr lIns="31090" tIns="0" rIns="0" bIns="0">
            <a:noAutofit/>
          </a:bodyPr>
          <a:lstStyle>
            <a:lvl1pPr marL="228600" indent="-228600" algn="l" rtl="0" eaLnBrk="1" fontAlgn="base" hangingPunct="1">
              <a:lnSpc>
                <a:spcPct val="110000"/>
              </a:lnSpc>
              <a:spcBef>
                <a:spcPts val="300"/>
              </a:spcBef>
              <a:spcAft>
                <a:spcPts val="800"/>
              </a:spcAft>
              <a:buClr>
                <a:schemeClr val="accent1"/>
              </a:buClr>
              <a:buSzPct val="120000"/>
              <a:buFont typeface="Arial" panose="020B0604020202020204" pitchFamily="34" charset="0"/>
              <a:buChar char="•"/>
              <a:defRPr sz="2000" baseline="0">
                <a:solidFill>
                  <a:schemeClr val="tx2"/>
                </a:solidFill>
                <a:latin typeface="+mn-lt"/>
                <a:ea typeface="ＭＳ Ｐゴシック" charset="-128"/>
                <a:cs typeface="ＭＳ Ｐゴシック" charset="-128"/>
              </a:defRPr>
            </a:lvl1pPr>
            <a:lvl2pPr marL="517525" indent="-288925" algn="l" rtl="0" eaLnBrk="1" fontAlgn="base" hangingPunct="1">
              <a:lnSpc>
                <a:spcPct val="110000"/>
              </a:lnSpc>
              <a:spcBef>
                <a:spcPts val="0"/>
              </a:spcBef>
              <a:spcAft>
                <a:spcPts val="700"/>
              </a:spcAft>
              <a:buClr>
                <a:schemeClr val="accent1"/>
              </a:buClr>
              <a:buFont typeface="Calibri"/>
              <a:buChar char="‒"/>
              <a:defRPr sz="1800">
                <a:solidFill>
                  <a:schemeClr val="tx2"/>
                </a:solidFill>
                <a:latin typeface="+mn-lt"/>
                <a:ea typeface="ＭＳ Ｐゴシック" charset="-128"/>
              </a:defRPr>
            </a:lvl2pPr>
            <a:lvl3pPr marL="746125" indent="-228600" algn="l" rtl="0" eaLnBrk="1" fontAlgn="base" hangingPunct="1">
              <a:lnSpc>
                <a:spcPct val="110000"/>
              </a:lnSpc>
              <a:spcBef>
                <a:spcPts val="0"/>
              </a:spcBef>
              <a:spcAft>
                <a:spcPts val="300"/>
              </a:spcAft>
              <a:buClr>
                <a:schemeClr val="accent4"/>
              </a:buClr>
              <a:buFont typeface="Arial" panose="020B0604020202020204" pitchFamily="34" charset="0"/>
              <a:buChar char="•"/>
              <a:defRPr sz="1600">
                <a:solidFill>
                  <a:schemeClr val="tx2"/>
                </a:solidFill>
                <a:latin typeface="+mn-lt"/>
                <a:ea typeface="ＭＳ Ｐゴシック" charset="-128"/>
              </a:defRPr>
            </a:lvl3pPr>
            <a:lvl4pPr marL="914400" indent="-168275" algn="l" rtl="0" eaLnBrk="1" fontAlgn="base" hangingPunct="1">
              <a:lnSpc>
                <a:spcPct val="100000"/>
              </a:lnSpc>
              <a:spcBef>
                <a:spcPts val="275"/>
              </a:spcBef>
              <a:spcAft>
                <a:spcPts val="200"/>
              </a:spcAft>
              <a:buClr>
                <a:schemeClr val="bg2"/>
              </a:buClr>
              <a:buFont typeface="Calibri" panose="020F0502020204030204" pitchFamily="34" charset="0"/>
              <a:buChar char="‒"/>
              <a:defRPr sz="1275">
                <a:solidFill>
                  <a:srgbClr val="595959"/>
                </a:solidFill>
                <a:latin typeface="+mn-lt"/>
                <a:ea typeface="ＭＳ Ｐゴシック" charset="-128"/>
              </a:defRPr>
            </a:lvl4pPr>
            <a:lvl5pPr marL="1082675" indent="-168275" algn="l" rtl="0" eaLnBrk="1" fontAlgn="base" hangingPunct="1">
              <a:lnSpc>
                <a:spcPct val="100000"/>
              </a:lnSpc>
              <a:spcBef>
                <a:spcPts val="275"/>
              </a:spcBef>
              <a:spcAft>
                <a:spcPct val="0"/>
              </a:spcAft>
              <a:buClr>
                <a:schemeClr val="bg2"/>
              </a:buClr>
              <a:buFont typeface="Calibri" panose="020F0502020204030204" pitchFamily="34" charset="0"/>
              <a:buChar char="‒"/>
              <a:defRPr sz="1125">
                <a:solidFill>
                  <a:srgbClr val="595959"/>
                </a:solidFill>
                <a:latin typeface="+mn-lt"/>
                <a:ea typeface="ＭＳ Ｐゴシック" charset="-128"/>
              </a:defRPr>
            </a:lvl5pPr>
            <a:lvl6pPr marL="2041746" indent="-208964" algn="l" rtl="0" eaLnBrk="1" fontAlgn="base" hangingPunct="1">
              <a:spcBef>
                <a:spcPct val="30000"/>
              </a:spcBef>
              <a:spcAft>
                <a:spcPct val="0"/>
              </a:spcAft>
              <a:buClr>
                <a:srgbClr val="EFA900"/>
              </a:buClr>
              <a:buChar char="»"/>
              <a:defRPr>
                <a:solidFill>
                  <a:schemeClr val="tx1"/>
                </a:solidFill>
                <a:latin typeface="+mn-lt"/>
              </a:defRPr>
            </a:lvl6pPr>
            <a:lvl7pPr marL="2459672" indent="-208964" algn="l" rtl="0" eaLnBrk="1" fontAlgn="base" hangingPunct="1">
              <a:spcBef>
                <a:spcPct val="30000"/>
              </a:spcBef>
              <a:spcAft>
                <a:spcPct val="0"/>
              </a:spcAft>
              <a:buClr>
                <a:srgbClr val="EFA900"/>
              </a:buClr>
              <a:buChar char="»"/>
              <a:defRPr>
                <a:solidFill>
                  <a:schemeClr val="tx1"/>
                </a:solidFill>
                <a:latin typeface="+mn-lt"/>
              </a:defRPr>
            </a:lvl7pPr>
            <a:lvl8pPr marL="2877599" indent="-208964" algn="l" rtl="0" eaLnBrk="1" fontAlgn="base" hangingPunct="1">
              <a:spcBef>
                <a:spcPct val="30000"/>
              </a:spcBef>
              <a:spcAft>
                <a:spcPct val="0"/>
              </a:spcAft>
              <a:buClr>
                <a:srgbClr val="EFA900"/>
              </a:buClr>
              <a:buChar char="»"/>
              <a:defRPr>
                <a:solidFill>
                  <a:schemeClr val="tx1"/>
                </a:solidFill>
                <a:latin typeface="+mn-lt"/>
              </a:defRPr>
            </a:lvl8pPr>
            <a:lvl9pPr marL="3295526" indent="-208964" algn="l" rtl="0" eaLnBrk="1" fontAlgn="base" hangingPunct="1">
              <a:spcBef>
                <a:spcPct val="30000"/>
              </a:spcBef>
              <a:spcAft>
                <a:spcPct val="0"/>
              </a:spcAft>
              <a:buClr>
                <a:srgbClr val="EFA900"/>
              </a:buClr>
              <a:buChar char="»"/>
              <a:defRPr>
                <a:solidFill>
                  <a:schemeClr val="tx1"/>
                </a:solidFill>
                <a:latin typeface="+mn-lt"/>
              </a:defRPr>
            </a:lvl9pPr>
          </a:lstStyle>
          <a:p>
            <a:pPr marL="0" indent="0" algn="ctr">
              <a:buNone/>
            </a:pPr>
            <a:r>
              <a:rPr lang="en-US" sz="1275" i="1" kern="0" dirty="0">
                <a:solidFill>
                  <a:schemeClr val="tx1"/>
                </a:solidFill>
              </a:rPr>
              <a:t>Variable window Zeno SWATH DIA acquisition</a:t>
            </a:r>
          </a:p>
          <a:p>
            <a:pPr marL="0" indent="0" algn="ctr">
              <a:buNone/>
            </a:pPr>
            <a:endParaRPr lang="en-US" sz="1275" kern="0" dirty="0">
              <a:solidFill>
                <a:schemeClr val="tx1"/>
              </a:solidFill>
            </a:endParaRPr>
          </a:p>
          <a:p>
            <a:pPr marL="194305" lvl="1" indent="0" algn="ctr">
              <a:buNone/>
            </a:pPr>
            <a:endParaRPr lang="en-US" sz="1275" kern="0" dirty="0">
              <a:solidFill>
                <a:schemeClr val="tx1"/>
              </a:solidFill>
            </a:endParaRP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21BBB95C-8D7A-80BF-DB74-543F02CD2BE3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34"/>
          <a:stretch/>
        </p:blipFill>
        <p:spPr bwMode="auto">
          <a:xfrm>
            <a:off x="4963701" y="1222915"/>
            <a:ext cx="1455166" cy="1106005"/>
          </a:xfrm>
          <a:prstGeom prst="rect">
            <a:avLst/>
          </a:prstGeom>
          <a:noFill/>
          <a:ln>
            <a:noFill/>
          </a:ln>
        </p:spPr>
      </p:pic>
      <p:sp>
        <p:nvSpPr>
          <p:cNvPr id="56" name="Rectangle 55">
            <a:extLst>
              <a:ext uri="{FF2B5EF4-FFF2-40B4-BE49-F238E27FC236}">
                <a16:creationId xmlns:a16="http://schemas.microsoft.com/office/drawing/2014/main" id="{CDFB8058-EE68-C909-924F-4396BAE88C3C}"/>
              </a:ext>
            </a:extLst>
          </p:cNvPr>
          <p:cNvSpPr/>
          <p:nvPr/>
        </p:nvSpPr>
        <p:spPr>
          <a:xfrm>
            <a:off x="5009552" y="1215427"/>
            <a:ext cx="881510" cy="44842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48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DEA05761-1FED-E861-BEEE-6A10ADF9D5A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823" y="1357733"/>
            <a:ext cx="1072108" cy="1071304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205ECC6C-AE34-96EC-EF93-AA3D9DF51BAF}"/>
              </a:ext>
            </a:extLst>
          </p:cNvPr>
          <p:cNvSpPr txBox="1"/>
          <p:nvPr/>
        </p:nvSpPr>
        <p:spPr>
          <a:xfrm>
            <a:off x="2419068" y="2247174"/>
            <a:ext cx="1556836" cy="33836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10000"/>
              </a:lnSpc>
              <a:spcBef>
                <a:spcPts val="255"/>
              </a:spcBef>
              <a:buClr>
                <a:srgbClr val="4472C4"/>
              </a:buClr>
            </a:pPr>
            <a:r>
              <a:rPr lang="en-US" sz="1530" b="1" u="sng" dirty="0">
                <a:solidFill>
                  <a:srgbClr val="009051"/>
                </a:solidFill>
              </a:rPr>
              <a:t>Zeno SWATH DIA</a:t>
            </a:r>
          </a:p>
        </p:txBody>
      </p:sp>
      <p:graphicFrame>
        <p:nvGraphicFramePr>
          <p:cNvPr id="59" name="Chart 58">
            <a:extLst>
              <a:ext uri="{FF2B5EF4-FFF2-40B4-BE49-F238E27FC236}">
                <a16:creationId xmlns:a16="http://schemas.microsoft.com/office/drawing/2014/main" id="{0055522A-6BB8-E62E-4E67-9361709EFF5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151641"/>
              </p:ext>
            </p:extLst>
          </p:nvPr>
        </p:nvGraphicFramePr>
        <p:xfrm>
          <a:off x="4611013" y="2474293"/>
          <a:ext cx="3138448" cy="23095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432C083C-6C4E-FD09-7E8C-67D365049746}"/>
              </a:ext>
            </a:extLst>
          </p:cNvPr>
          <p:cNvSpPr txBox="1"/>
          <p:nvPr/>
        </p:nvSpPr>
        <p:spPr>
          <a:xfrm>
            <a:off x="6314708" y="3692921"/>
            <a:ext cx="534121" cy="3671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solidFill>
                  <a:schemeClr val="accent1"/>
                </a:solidFill>
              </a:rPr>
              <a:t>Protein</a:t>
            </a:r>
          </a:p>
          <a:p>
            <a:r>
              <a:rPr lang="en-US" sz="893" dirty="0">
                <a:solidFill>
                  <a:schemeClr val="accent1"/>
                </a:solidFill>
              </a:rPr>
              <a:t>Density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0E73A21-16C7-2FA0-3309-DD904465423A}"/>
              </a:ext>
            </a:extLst>
          </p:cNvPr>
          <p:cNvSpPr txBox="1"/>
          <p:nvPr/>
        </p:nvSpPr>
        <p:spPr>
          <a:xfrm>
            <a:off x="5617360" y="3369959"/>
            <a:ext cx="74251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solidFill>
                  <a:srgbClr val="E2AA00"/>
                </a:solidFill>
              </a:rPr>
              <a:t>60 windows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C1E4BDB-CA37-C6C7-0ABD-230AD5BA2DC7}"/>
              </a:ext>
            </a:extLst>
          </p:cNvPr>
          <p:cNvSpPr txBox="1"/>
          <p:nvPr/>
        </p:nvSpPr>
        <p:spPr>
          <a:xfrm>
            <a:off x="5586880" y="3836600"/>
            <a:ext cx="742511" cy="2297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93" dirty="0">
                <a:solidFill>
                  <a:srgbClr val="629A3D"/>
                </a:solidFill>
              </a:rPr>
              <a:t>80 windows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25D2ED2-0EF5-9268-EFC3-5D7A318B2351}"/>
              </a:ext>
            </a:extLst>
          </p:cNvPr>
          <p:cNvSpPr txBox="1"/>
          <p:nvPr/>
        </p:nvSpPr>
        <p:spPr>
          <a:xfrm>
            <a:off x="453851" y="2254042"/>
            <a:ext cx="993029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b="1" u="sng" dirty="0">
                <a:solidFill>
                  <a:srgbClr val="0432FF"/>
                </a:solidFill>
              </a:rPr>
              <a:t>Zeno DDA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CF21B03D-259A-219E-C5EB-18E25AC3E71E}"/>
              </a:ext>
            </a:extLst>
          </p:cNvPr>
          <p:cNvSpPr txBox="1"/>
          <p:nvPr/>
        </p:nvSpPr>
        <p:spPr>
          <a:xfrm>
            <a:off x="84192" y="2522848"/>
            <a:ext cx="1747466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dirty="0">
                <a:solidFill>
                  <a:srgbClr val="0432FF"/>
                </a:solidFill>
              </a:rPr>
              <a:t>45 min (Top 45, 400 ng)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95274B6-84C5-3647-A99C-BA7289B74B85}"/>
              </a:ext>
            </a:extLst>
          </p:cNvPr>
          <p:cNvSpPr txBox="1"/>
          <p:nvPr/>
        </p:nvSpPr>
        <p:spPr>
          <a:xfrm>
            <a:off x="301524" y="4020157"/>
            <a:ext cx="1394934" cy="6222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0432FF"/>
                </a:solidFill>
              </a:rPr>
              <a:t>100 ms TOF MS</a:t>
            </a:r>
          </a:p>
          <a:p>
            <a:r>
              <a:rPr lang="en-US" sz="1148" dirty="0">
                <a:solidFill>
                  <a:srgbClr val="0432FF"/>
                </a:solidFill>
              </a:rPr>
              <a:t>  30 ms TOF MS/MS</a:t>
            </a:r>
          </a:p>
          <a:p>
            <a:r>
              <a:rPr lang="en-US" sz="1148" dirty="0">
                <a:solidFill>
                  <a:srgbClr val="0432FF"/>
                </a:solidFill>
              </a:rPr>
              <a:t>Cycle Time: 2.22 sec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69DCC10D-2BFA-CB8B-67A5-D7A3154515FB}"/>
              </a:ext>
            </a:extLst>
          </p:cNvPr>
          <p:cNvSpPr txBox="1"/>
          <p:nvPr/>
        </p:nvSpPr>
        <p:spPr>
          <a:xfrm>
            <a:off x="301524" y="2758297"/>
            <a:ext cx="1394934" cy="6222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48" dirty="0">
                <a:solidFill>
                  <a:srgbClr val="0432FF"/>
                </a:solidFill>
              </a:rPr>
              <a:t>100 ms TOF MS </a:t>
            </a:r>
          </a:p>
          <a:p>
            <a:r>
              <a:rPr lang="en-US" sz="1148" dirty="0">
                <a:solidFill>
                  <a:srgbClr val="0432FF"/>
                </a:solidFill>
              </a:rPr>
              <a:t>  20 ms TOF MS/MS</a:t>
            </a:r>
          </a:p>
          <a:p>
            <a:r>
              <a:rPr lang="en-US" sz="1148" dirty="0">
                <a:solidFill>
                  <a:srgbClr val="0432FF"/>
                </a:solidFill>
              </a:rPr>
              <a:t>Cycle Time: 1.24 sec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2CDA9C6-B0EC-9F68-0012-5C2A8CD25F3B}"/>
              </a:ext>
            </a:extLst>
          </p:cNvPr>
          <p:cNvSpPr txBox="1"/>
          <p:nvPr/>
        </p:nvSpPr>
        <p:spPr>
          <a:xfrm>
            <a:off x="84192" y="3721687"/>
            <a:ext cx="1687000" cy="2885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75" b="1" dirty="0">
                <a:solidFill>
                  <a:srgbClr val="0432FF"/>
                </a:solidFill>
              </a:rPr>
              <a:t>120 min (Top 60, 1 µg)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A45733B-FF12-1B03-5308-79F932F5F1D7}"/>
              </a:ext>
            </a:extLst>
          </p:cNvPr>
          <p:cNvSpPr txBox="1"/>
          <p:nvPr/>
        </p:nvSpPr>
        <p:spPr>
          <a:xfrm>
            <a:off x="2130891" y="2523765"/>
            <a:ext cx="2369816" cy="2973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indent="-97160">
              <a:lnSpc>
                <a:spcPct val="110000"/>
              </a:lnSpc>
              <a:buClr>
                <a:srgbClr val="4472C4"/>
              </a:buClr>
            </a:pPr>
            <a:r>
              <a:rPr lang="en-US" sz="1275" i="1" dirty="0">
                <a:solidFill>
                  <a:prstClr val="black"/>
                </a:solidFill>
              </a:rPr>
              <a:t>20 min (60 var. windows, 400 ng)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C656722D-BF7A-5EFA-7DE6-F112970FEAF6}"/>
              </a:ext>
            </a:extLst>
          </p:cNvPr>
          <p:cNvSpPr txBox="1"/>
          <p:nvPr/>
        </p:nvSpPr>
        <p:spPr>
          <a:xfrm>
            <a:off x="2130891" y="3712858"/>
            <a:ext cx="2333844" cy="2973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indent="-97160">
              <a:lnSpc>
                <a:spcPct val="110000"/>
              </a:lnSpc>
              <a:buClr>
                <a:srgbClr val="4472C4"/>
              </a:buClr>
            </a:pPr>
            <a:r>
              <a:rPr lang="en-US" sz="1275" b="1" dirty="0">
                <a:solidFill>
                  <a:srgbClr val="009051"/>
                </a:solidFill>
              </a:rPr>
              <a:t>120 min (80 var. windows, 1 µg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9FD90A1-161A-CD18-46E6-5F1EF0E07D98}"/>
              </a:ext>
            </a:extLst>
          </p:cNvPr>
          <p:cNvSpPr txBox="1"/>
          <p:nvPr/>
        </p:nvSpPr>
        <p:spPr>
          <a:xfrm>
            <a:off x="2284524" y="2755225"/>
            <a:ext cx="1359668" cy="6222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indent="-240204">
              <a:buClr>
                <a:srgbClr val="E7E6E6"/>
              </a:buClr>
            </a:pPr>
            <a:r>
              <a:rPr lang="en-US" sz="1148" i="1" dirty="0">
                <a:solidFill>
                  <a:prstClr val="black"/>
                </a:solidFill>
              </a:rPr>
              <a:t>100 ms TOF MS</a:t>
            </a:r>
          </a:p>
          <a:p>
            <a:pPr indent="-240204">
              <a:buClr>
                <a:srgbClr val="E7E6E6"/>
              </a:buClr>
            </a:pPr>
            <a:r>
              <a:rPr lang="en-US" sz="1148" i="1" dirty="0">
                <a:solidFill>
                  <a:prstClr val="black"/>
                </a:solidFill>
              </a:rPr>
              <a:t>  20 ms TOF MS/MS</a:t>
            </a:r>
          </a:p>
          <a:p>
            <a:pPr indent="-240204">
              <a:buClr>
                <a:srgbClr val="E7E6E6"/>
              </a:buClr>
            </a:pPr>
            <a:r>
              <a:rPr lang="en-US" sz="1148" i="1" dirty="0">
                <a:solidFill>
                  <a:prstClr val="black"/>
                </a:solidFill>
              </a:rPr>
              <a:t>Cycle time: 1.61 sec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8E8D807E-6398-7614-306F-FD26D151A94B}"/>
              </a:ext>
            </a:extLst>
          </p:cNvPr>
          <p:cNvSpPr txBox="1"/>
          <p:nvPr/>
        </p:nvSpPr>
        <p:spPr>
          <a:xfrm>
            <a:off x="2284523" y="4017233"/>
            <a:ext cx="1372492" cy="6222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indent="-240204">
              <a:buClr>
                <a:srgbClr val="E7E6E6"/>
              </a:buClr>
            </a:pPr>
            <a:r>
              <a:rPr lang="en-US" sz="1148" dirty="0">
                <a:solidFill>
                  <a:srgbClr val="009051"/>
                </a:solidFill>
              </a:rPr>
              <a:t>100 ms TOF MS</a:t>
            </a:r>
          </a:p>
          <a:p>
            <a:pPr indent="-240204">
              <a:buClr>
                <a:srgbClr val="E7E6E6"/>
              </a:buClr>
            </a:pPr>
            <a:r>
              <a:rPr lang="en-US" sz="1148" dirty="0">
                <a:solidFill>
                  <a:srgbClr val="009051"/>
                </a:solidFill>
              </a:rPr>
              <a:t>  25 ms TOF MS/MS</a:t>
            </a:r>
          </a:p>
          <a:p>
            <a:pPr indent="-240204">
              <a:buClr>
                <a:srgbClr val="E7E6E6"/>
              </a:buClr>
            </a:pPr>
            <a:r>
              <a:rPr lang="en-US" sz="1148" dirty="0">
                <a:solidFill>
                  <a:srgbClr val="009051"/>
                </a:solidFill>
              </a:rPr>
              <a:t>Cycle time: 2.50 sec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0BDCB97-32C6-350F-4F4A-8D8EEA6D640A}"/>
              </a:ext>
            </a:extLst>
          </p:cNvPr>
          <p:cNvSpPr txBox="1"/>
          <p:nvPr/>
        </p:nvSpPr>
        <p:spPr>
          <a:xfrm>
            <a:off x="2130891" y="3408483"/>
            <a:ext cx="2371162" cy="29738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indent="-97160">
              <a:lnSpc>
                <a:spcPct val="110000"/>
              </a:lnSpc>
              <a:buClr>
                <a:srgbClr val="4472C4"/>
              </a:buClr>
            </a:pPr>
            <a:r>
              <a:rPr lang="en-US" sz="1275" dirty="0">
                <a:solidFill>
                  <a:srgbClr val="009051"/>
                </a:solidFill>
              </a:rPr>
              <a:t>45 min (80 var. windows, 400 ng)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19904ED-493B-0DA3-A4EB-05CBFA76CF32}"/>
              </a:ext>
            </a:extLst>
          </p:cNvPr>
          <p:cNvSpPr txBox="1"/>
          <p:nvPr/>
        </p:nvSpPr>
        <p:spPr>
          <a:xfrm>
            <a:off x="301524" y="274320"/>
            <a:ext cx="12289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-0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CDB29D0-5FC0-F849-11B9-8AD55FC4EA58}"/>
              </a:ext>
            </a:extLst>
          </p:cNvPr>
          <p:cNvSpPr txBox="1"/>
          <p:nvPr/>
        </p:nvSpPr>
        <p:spPr>
          <a:xfrm>
            <a:off x="301524" y="7228347"/>
            <a:ext cx="7169352" cy="25351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8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3 Fig. Zeno SWATH DIA data acquisition and processing settings. 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aters M-Class microflow chromatography hardware and flow rates; </a:t>
            </a:r>
            <a:r>
              <a:rPr lang="en-US" sz="18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ZenoTOF</a:t>
            </a:r>
            <a:r>
              <a:rPr lang="en-US" sz="18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7600 system acquisition settings for DDA and DIA collected using a 120-, 45-, and 20-min microflow gradient; and plot of the overlap in peptide density and variable window coverage for 60 and 80 variable window methods. </a:t>
            </a: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30764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5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5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5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3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5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6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9" dur="5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0" dur="500" fill="hold"/>
                                        <p:tgtEl>
                                          <p:spTgt spid="6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3" dur="5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4" dur="500" fill="hold"/>
                                        <p:tgtEl>
                                          <p:spTgt spid="6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5" fill="hold">
                      <p:stCondLst>
                        <p:cond delay="indefinite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9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1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3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45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2000"/>
                                        <p:tgtEl>
                                          <p:spTgt spid="7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2000" fill="hold"/>
                                        <p:tgtEl>
                                          <p:spTgt spid="70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 fmla="#ppt_w*sin(2.5*pi*$)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2000" fill="hold"/>
                                        <p:tgtEl>
                                          <p:spTgt spid="70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2" presetID="45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2000"/>
                                        <p:tgtEl>
                                          <p:spTgt spid="6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5" dur="2000" fill="hold"/>
                                        <p:tgtEl>
                                          <p:spTgt spid="68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 fmla="#ppt_w*sin(2.5*pi*$)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fltVal val="1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6" dur="2000" fill="hold"/>
                                        <p:tgtEl>
                                          <p:spTgt spid="68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h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4" grpId="0"/>
      <p:bldP spid="58" grpId="0"/>
      <p:bldGraphic spid="59" grpId="0">
        <p:bldAsOne/>
      </p:bldGraphic>
      <p:bldP spid="60" grpId="0"/>
      <p:bldP spid="61" grpId="0"/>
      <p:bldP spid="62" grpId="0"/>
      <p:bldP spid="68" grpId="0"/>
      <p:bldP spid="69" grpId="0"/>
      <p:bldP spid="70" grpId="0"/>
      <p:bldP spid="71" grpId="0"/>
      <p:bldP spid="72" grpId="0"/>
    </p:bld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67</TotalTime>
  <Words>242</Words>
  <Application>Microsoft Macintosh PowerPoint</Application>
  <PresentationFormat>Custom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Zeno SWATH DIA Data Acquisition and Processing  with Spectronaut v16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ain Figures</dc:title>
  <dc:creator>Jordan Burton</dc:creator>
  <cp:lastModifiedBy>Jordan Burton</cp:lastModifiedBy>
  <cp:revision>36</cp:revision>
  <cp:lastPrinted>2022-06-23T21:58:45Z</cp:lastPrinted>
  <dcterms:created xsi:type="dcterms:W3CDTF">2022-06-13T21:49:24Z</dcterms:created>
  <dcterms:modified xsi:type="dcterms:W3CDTF">2023-02-25T01:06:22Z</dcterms:modified>
</cp:coreProperties>
</file>